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0"/>
  </p:notesMasterIdLst>
  <p:sldIdLst>
    <p:sldId id="268" r:id="rId2"/>
    <p:sldId id="269" r:id="rId3"/>
    <p:sldId id="265" r:id="rId4"/>
    <p:sldId id="267" r:id="rId5"/>
    <p:sldId id="275" r:id="rId6"/>
    <p:sldId id="273" r:id="rId7"/>
    <p:sldId id="274" r:id="rId8"/>
    <p:sldId id="272" r:id="rId9"/>
  </p:sldIdLst>
  <p:sldSz cx="7019925" cy="915511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3" userDrawn="1">
          <p15:clr>
            <a:srgbClr val="A4A3A4"/>
          </p15:clr>
        </p15:guide>
        <p15:guide id="2" pos="2211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6B63F5E-483E-302C-1E6B-3A06596EF9BB}" name="Toray" initials="東レ" userId="Toray" providerId="None"/>
  <p188:author id="{B7E304F8-21BE-F8B6-FEC1-B58682692E8E}" name="Imamura, Satoshi/TORAY(JP)/今村 聡(臨開部)" initials="IS聡" userId="S::satoshi.imamura.s7@mail.toray::4de07fd6-75ab-46a3-b050-b5fbcff04a3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26" autoAdjust="0"/>
    <p:restoredTop sz="94400" autoAdjust="0"/>
  </p:normalViewPr>
  <p:slideViewPr>
    <p:cSldViewPr snapToGrid="0">
      <p:cViewPr varScale="1">
        <p:scale>
          <a:sx n="75" d="100"/>
          <a:sy n="75" d="100"/>
        </p:scale>
        <p:origin x="150" y="-756"/>
      </p:cViewPr>
      <p:guideLst>
        <p:guide orient="horz" pos="2883"/>
        <p:guide pos="221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D03BA6-7D7E-D443-9915-589AB66B388B}" type="datetimeFigureOut">
              <a:rPr lang="en-US" smtClean="0"/>
              <a:t>1/16/20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4550" y="1241425"/>
            <a:ext cx="25685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BBB9ED-84FF-2449-B002-AF082359E92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76992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6138" y="1241425"/>
            <a:ext cx="2565400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BBB9ED-84FF-2449-B002-AF082359E920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34207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BBB9ED-84FF-2449-B002-AF082359E920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64979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26495" y="1498303"/>
            <a:ext cx="5966936" cy="3187336"/>
          </a:xfrm>
        </p:spPr>
        <p:txBody>
          <a:bodyPr anchor="b"/>
          <a:lstStyle>
            <a:lvl1pPr algn="ctr">
              <a:defRPr sz="45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77491" y="4808554"/>
            <a:ext cx="5264944" cy="2210366"/>
          </a:xfrm>
        </p:spPr>
        <p:txBody>
          <a:bodyPr/>
          <a:lstStyle>
            <a:lvl1pPr marL="0" indent="0" algn="ctr">
              <a:buNone/>
              <a:defRPr sz="1802"/>
            </a:lvl1pPr>
            <a:lvl2pPr marL="343293" indent="0" algn="ctr">
              <a:buNone/>
              <a:defRPr sz="1502"/>
            </a:lvl2pPr>
            <a:lvl3pPr marL="686586" indent="0" algn="ctr">
              <a:buNone/>
              <a:defRPr sz="1352"/>
            </a:lvl3pPr>
            <a:lvl4pPr marL="1029879" indent="0" algn="ctr">
              <a:buNone/>
              <a:defRPr sz="1201"/>
            </a:lvl4pPr>
            <a:lvl5pPr marL="1373173" indent="0" algn="ctr">
              <a:buNone/>
              <a:defRPr sz="1201"/>
            </a:lvl5pPr>
            <a:lvl6pPr marL="1716466" indent="0" algn="ctr">
              <a:buNone/>
              <a:defRPr sz="1201"/>
            </a:lvl6pPr>
            <a:lvl7pPr marL="2059759" indent="0" algn="ctr">
              <a:buNone/>
              <a:defRPr sz="1201"/>
            </a:lvl7pPr>
            <a:lvl8pPr marL="2403052" indent="0" algn="ctr">
              <a:buNone/>
              <a:defRPr sz="1201"/>
            </a:lvl8pPr>
            <a:lvl9pPr marL="2746346" indent="0" algn="ctr">
              <a:buNone/>
              <a:defRPr sz="120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4085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095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23639" y="487426"/>
            <a:ext cx="1513671" cy="775853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2624" y="487426"/>
            <a:ext cx="4453265" cy="775853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676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0526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8969" y="2282425"/>
            <a:ext cx="6054685" cy="3808272"/>
          </a:xfrm>
        </p:spPr>
        <p:txBody>
          <a:bodyPr anchor="b"/>
          <a:lstStyle>
            <a:lvl1pPr>
              <a:defRPr sz="45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8969" y="6126725"/>
            <a:ext cx="6054685" cy="2002680"/>
          </a:xfrm>
        </p:spPr>
        <p:txBody>
          <a:bodyPr/>
          <a:lstStyle>
            <a:lvl1pPr marL="0" indent="0">
              <a:buNone/>
              <a:defRPr sz="1802">
                <a:solidFill>
                  <a:schemeClr val="tx1"/>
                </a:solidFill>
              </a:defRPr>
            </a:lvl1pPr>
            <a:lvl2pPr marL="343293" indent="0">
              <a:buNone/>
              <a:defRPr sz="1502">
                <a:solidFill>
                  <a:schemeClr val="tx1">
                    <a:tint val="75000"/>
                  </a:schemeClr>
                </a:solidFill>
              </a:defRPr>
            </a:lvl2pPr>
            <a:lvl3pPr marL="686586" indent="0">
              <a:buNone/>
              <a:defRPr sz="1352">
                <a:solidFill>
                  <a:schemeClr val="tx1">
                    <a:tint val="75000"/>
                  </a:schemeClr>
                </a:solidFill>
              </a:defRPr>
            </a:lvl3pPr>
            <a:lvl4pPr marL="1029879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4pPr>
            <a:lvl5pPr marL="1373173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5pPr>
            <a:lvl6pPr marL="1716466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6pPr>
            <a:lvl7pPr marL="2059759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7pPr>
            <a:lvl8pPr marL="2403052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8pPr>
            <a:lvl9pPr marL="2746346" indent="0">
              <a:buNone/>
              <a:defRPr sz="120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313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2620" y="2437127"/>
            <a:ext cx="2983468" cy="580883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53838" y="2437127"/>
            <a:ext cx="2983468" cy="580883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9590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8" y="487430"/>
            <a:ext cx="6054685" cy="176956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37" y="2244276"/>
            <a:ext cx="2969757" cy="1099884"/>
          </a:xfrm>
        </p:spPr>
        <p:txBody>
          <a:bodyPr anchor="b"/>
          <a:lstStyle>
            <a:lvl1pPr marL="0" indent="0">
              <a:buNone/>
              <a:defRPr sz="1802" b="1"/>
            </a:lvl1pPr>
            <a:lvl2pPr marL="343293" indent="0">
              <a:buNone/>
              <a:defRPr sz="1502" b="1"/>
            </a:lvl2pPr>
            <a:lvl3pPr marL="686586" indent="0">
              <a:buNone/>
              <a:defRPr sz="1352" b="1"/>
            </a:lvl3pPr>
            <a:lvl4pPr marL="1029879" indent="0">
              <a:buNone/>
              <a:defRPr sz="1201" b="1"/>
            </a:lvl4pPr>
            <a:lvl5pPr marL="1373173" indent="0">
              <a:buNone/>
              <a:defRPr sz="1201" b="1"/>
            </a:lvl5pPr>
            <a:lvl6pPr marL="1716466" indent="0">
              <a:buNone/>
              <a:defRPr sz="1201" b="1"/>
            </a:lvl6pPr>
            <a:lvl7pPr marL="2059759" indent="0">
              <a:buNone/>
              <a:defRPr sz="1201" b="1"/>
            </a:lvl7pPr>
            <a:lvl8pPr marL="2403052" indent="0">
              <a:buNone/>
              <a:defRPr sz="1201" b="1"/>
            </a:lvl8pPr>
            <a:lvl9pPr marL="2746346" indent="0">
              <a:buNone/>
              <a:defRPr sz="120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3537" y="3344161"/>
            <a:ext cx="2969757" cy="49187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53838" y="2244276"/>
            <a:ext cx="2984382" cy="1099884"/>
          </a:xfrm>
        </p:spPr>
        <p:txBody>
          <a:bodyPr anchor="b"/>
          <a:lstStyle>
            <a:lvl1pPr marL="0" indent="0">
              <a:buNone/>
              <a:defRPr sz="1802" b="1"/>
            </a:lvl1pPr>
            <a:lvl2pPr marL="343293" indent="0">
              <a:buNone/>
              <a:defRPr sz="1502" b="1"/>
            </a:lvl2pPr>
            <a:lvl3pPr marL="686586" indent="0">
              <a:buNone/>
              <a:defRPr sz="1352" b="1"/>
            </a:lvl3pPr>
            <a:lvl4pPr marL="1029879" indent="0">
              <a:buNone/>
              <a:defRPr sz="1201" b="1"/>
            </a:lvl4pPr>
            <a:lvl5pPr marL="1373173" indent="0">
              <a:buNone/>
              <a:defRPr sz="1201" b="1"/>
            </a:lvl5pPr>
            <a:lvl6pPr marL="1716466" indent="0">
              <a:buNone/>
              <a:defRPr sz="1201" b="1"/>
            </a:lvl6pPr>
            <a:lvl7pPr marL="2059759" indent="0">
              <a:buNone/>
              <a:defRPr sz="1201" b="1"/>
            </a:lvl7pPr>
            <a:lvl8pPr marL="2403052" indent="0">
              <a:buNone/>
              <a:defRPr sz="1201" b="1"/>
            </a:lvl8pPr>
            <a:lvl9pPr marL="2746346" indent="0">
              <a:buNone/>
              <a:defRPr sz="120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53838" y="3344161"/>
            <a:ext cx="2984382" cy="49187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329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45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7398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8" y="610343"/>
            <a:ext cx="2264109" cy="2136193"/>
          </a:xfrm>
        </p:spPr>
        <p:txBody>
          <a:bodyPr anchor="b"/>
          <a:lstStyle>
            <a:lvl1pPr>
              <a:defRPr sz="240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84382" y="1318170"/>
            <a:ext cx="3553838" cy="6506064"/>
          </a:xfrm>
        </p:spPr>
        <p:txBody>
          <a:bodyPr/>
          <a:lstStyle>
            <a:lvl1pPr>
              <a:defRPr sz="2403"/>
            </a:lvl1pPr>
            <a:lvl2pPr>
              <a:defRPr sz="2103"/>
            </a:lvl2pPr>
            <a:lvl3pPr>
              <a:defRPr sz="1802"/>
            </a:lvl3pPr>
            <a:lvl4pPr>
              <a:defRPr sz="1502"/>
            </a:lvl4pPr>
            <a:lvl5pPr>
              <a:defRPr sz="1502"/>
            </a:lvl5pPr>
            <a:lvl6pPr>
              <a:defRPr sz="1502"/>
            </a:lvl6pPr>
            <a:lvl7pPr>
              <a:defRPr sz="1502"/>
            </a:lvl7pPr>
            <a:lvl8pPr>
              <a:defRPr sz="1502"/>
            </a:lvl8pPr>
            <a:lvl9pPr>
              <a:defRPr sz="150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8" y="2746536"/>
            <a:ext cx="2264109" cy="5088293"/>
          </a:xfrm>
        </p:spPr>
        <p:txBody>
          <a:bodyPr/>
          <a:lstStyle>
            <a:lvl1pPr marL="0" indent="0">
              <a:buNone/>
              <a:defRPr sz="1201"/>
            </a:lvl1pPr>
            <a:lvl2pPr marL="343293" indent="0">
              <a:buNone/>
              <a:defRPr sz="1051"/>
            </a:lvl2pPr>
            <a:lvl3pPr marL="686586" indent="0">
              <a:buNone/>
              <a:defRPr sz="901"/>
            </a:lvl3pPr>
            <a:lvl4pPr marL="1029879" indent="0">
              <a:buNone/>
              <a:defRPr sz="751"/>
            </a:lvl4pPr>
            <a:lvl5pPr marL="1373173" indent="0">
              <a:buNone/>
              <a:defRPr sz="751"/>
            </a:lvl5pPr>
            <a:lvl6pPr marL="1716466" indent="0">
              <a:buNone/>
              <a:defRPr sz="751"/>
            </a:lvl6pPr>
            <a:lvl7pPr marL="2059759" indent="0">
              <a:buNone/>
              <a:defRPr sz="751"/>
            </a:lvl7pPr>
            <a:lvl8pPr marL="2403052" indent="0">
              <a:buNone/>
              <a:defRPr sz="751"/>
            </a:lvl8pPr>
            <a:lvl9pPr marL="2746346" indent="0">
              <a:buNone/>
              <a:defRPr sz="75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1245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8" y="610343"/>
            <a:ext cx="2264109" cy="2136193"/>
          </a:xfrm>
        </p:spPr>
        <p:txBody>
          <a:bodyPr anchor="b"/>
          <a:lstStyle>
            <a:lvl1pPr>
              <a:defRPr sz="240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84382" y="1318170"/>
            <a:ext cx="3553838" cy="6506064"/>
          </a:xfrm>
        </p:spPr>
        <p:txBody>
          <a:bodyPr anchor="t"/>
          <a:lstStyle>
            <a:lvl1pPr marL="0" indent="0">
              <a:buNone/>
              <a:defRPr sz="2403"/>
            </a:lvl1pPr>
            <a:lvl2pPr marL="343293" indent="0">
              <a:buNone/>
              <a:defRPr sz="2103"/>
            </a:lvl2pPr>
            <a:lvl3pPr marL="686586" indent="0">
              <a:buNone/>
              <a:defRPr sz="1802"/>
            </a:lvl3pPr>
            <a:lvl4pPr marL="1029879" indent="0">
              <a:buNone/>
              <a:defRPr sz="1502"/>
            </a:lvl4pPr>
            <a:lvl5pPr marL="1373173" indent="0">
              <a:buNone/>
              <a:defRPr sz="1502"/>
            </a:lvl5pPr>
            <a:lvl6pPr marL="1716466" indent="0">
              <a:buNone/>
              <a:defRPr sz="1502"/>
            </a:lvl6pPr>
            <a:lvl7pPr marL="2059759" indent="0">
              <a:buNone/>
              <a:defRPr sz="1502"/>
            </a:lvl7pPr>
            <a:lvl8pPr marL="2403052" indent="0">
              <a:buNone/>
              <a:defRPr sz="1502"/>
            </a:lvl8pPr>
            <a:lvl9pPr marL="2746346" indent="0">
              <a:buNone/>
              <a:defRPr sz="1502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8" y="2746536"/>
            <a:ext cx="2264109" cy="5088293"/>
          </a:xfrm>
        </p:spPr>
        <p:txBody>
          <a:bodyPr/>
          <a:lstStyle>
            <a:lvl1pPr marL="0" indent="0">
              <a:buNone/>
              <a:defRPr sz="1201"/>
            </a:lvl1pPr>
            <a:lvl2pPr marL="343293" indent="0">
              <a:buNone/>
              <a:defRPr sz="1051"/>
            </a:lvl2pPr>
            <a:lvl3pPr marL="686586" indent="0">
              <a:buNone/>
              <a:defRPr sz="901"/>
            </a:lvl3pPr>
            <a:lvl4pPr marL="1029879" indent="0">
              <a:buNone/>
              <a:defRPr sz="751"/>
            </a:lvl4pPr>
            <a:lvl5pPr marL="1373173" indent="0">
              <a:buNone/>
              <a:defRPr sz="751"/>
            </a:lvl5pPr>
            <a:lvl6pPr marL="1716466" indent="0">
              <a:buNone/>
              <a:defRPr sz="751"/>
            </a:lvl6pPr>
            <a:lvl7pPr marL="2059759" indent="0">
              <a:buNone/>
              <a:defRPr sz="751"/>
            </a:lvl7pPr>
            <a:lvl8pPr marL="2403052" indent="0">
              <a:buNone/>
              <a:defRPr sz="751"/>
            </a:lvl8pPr>
            <a:lvl9pPr marL="2746346" indent="0">
              <a:buNone/>
              <a:defRPr sz="75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3650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2625" y="487430"/>
            <a:ext cx="6054685" cy="17695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2625" y="2437127"/>
            <a:ext cx="6054685" cy="58088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2624" y="8485438"/>
            <a:ext cx="1579483" cy="487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F70A9-7480-435C-81F6-189C5C4B42BF}" type="datetimeFigureOut">
              <a:rPr kumimoji="1" lang="ja-JP" altLang="en-US" smtClean="0"/>
              <a:t>2024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25355" y="8485438"/>
            <a:ext cx="2369225" cy="487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57827" y="8485438"/>
            <a:ext cx="1579483" cy="487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9A51E-6893-457D-8704-BE0B1B2AE9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322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6586" rtl="0" eaLnBrk="1" latinLnBrk="0" hangingPunct="1">
        <a:lnSpc>
          <a:spcPct val="90000"/>
        </a:lnSpc>
        <a:spcBef>
          <a:spcPct val="0"/>
        </a:spcBef>
        <a:buNone/>
        <a:defRPr kumimoji="1" sz="33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647" indent="-171647" algn="l" defTabSz="686586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kumimoji="1" sz="2103" kern="1200">
          <a:solidFill>
            <a:schemeClr val="tx1"/>
          </a:solidFill>
          <a:latin typeface="+mn-lt"/>
          <a:ea typeface="+mn-ea"/>
          <a:cs typeface="+mn-cs"/>
        </a:defRPr>
      </a:lvl1pPr>
      <a:lvl2pPr marL="514940" indent="-171647" algn="l" defTabSz="6865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2" kern="1200">
          <a:solidFill>
            <a:schemeClr val="tx1"/>
          </a:solidFill>
          <a:latin typeface="+mn-lt"/>
          <a:ea typeface="+mn-ea"/>
          <a:cs typeface="+mn-cs"/>
        </a:defRPr>
      </a:lvl2pPr>
      <a:lvl3pPr marL="858234" indent="-171647" algn="l" defTabSz="6865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2" kern="1200">
          <a:solidFill>
            <a:schemeClr val="tx1"/>
          </a:solidFill>
          <a:latin typeface="+mn-lt"/>
          <a:ea typeface="+mn-ea"/>
          <a:cs typeface="+mn-cs"/>
        </a:defRPr>
      </a:lvl3pPr>
      <a:lvl4pPr marL="1201527" indent="-171647" algn="l" defTabSz="6865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4pPr>
      <a:lvl5pPr marL="1544820" indent="-171647" algn="l" defTabSz="6865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5pPr>
      <a:lvl6pPr marL="1888113" indent="-171647" algn="l" defTabSz="6865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6pPr>
      <a:lvl7pPr marL="2231407" indent="-171647" algn="l" defTabSz="6865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7pPr>
      <a:lvl8pPr marL="2574700" indent="-171647" algn="l" defTabSz="6865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8pPr>
      <a:lvl9pPr marL="2917993" indent="-171647" algn="l" defTabSz="6865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6586" rtl="0" eaLnBrk="1" latinLnBrk="0" hangingPunct="1"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1pPr>
      <a:lvl2pPr marL="343293" algn="l" defTabSz="686586" rtl="0" eaLnBrk="1" latinLnBrk="0" hangingPunct="1"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2pPr>
      <a:lvl3pPr marL="686586" algn="l" defTabSz="686586" rtl="0" eaLnBrk="1" latinLnBrk="0" hangingPunct="1"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3pPr>
      <a:lvl4pPr marL="1029879" algn="l" defTabSz="686586" rtl="0" eaLnBrk="1" latinLnBrk="0" hangingPunct="1"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4pPr>
      <a:lvl5pPr marL="1373173" algn="l" defTabSz="686586" rtl="0" eaLnBrk="1" latinLnBrk="0" hangingPunct="1"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5pPr>
      <a:lvl6pPr marL="1716466" algn="l" defTabSz="686586" rtl="0" eaLnBrk="1" latinLnBrk="0" hangingPunct="1"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6pPr>
      <a:lvl7pPr marL="2059759" algn="l" defTabSz="686586" rtl="0" eaLnBrk="1" latinLnBrk="0" hangingPunct="1"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7pPr>
      <a:lvl8pPr marL="2403052" algn="l" defTabSz="686586" rtl="0" eaLnBrk="1" latinLnBrk="0" hangingPunct="1"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8pPr>
      <a:lvl9pPr marL="2746346" algn="l" defTabSz="686586" rtl="0" eaLnBrk="1" latinLnBrk="0" hangingPunct="1">
        <a:defRPr kumimoji="1" sz="13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AD6D5EE0-6E8A-AD4F-5ED9-9F5D31F3E6EA}"/>
              </a:ext>
            </a:extLst>
          </p:cNvPr>
          <p:cNvGrpSpPr/>
          <p:nvPr/>
        </p:nvGrpSpPr>
        <p:grpSpPr>
          <a:xfrm>
            <a:off x="-170888" y="443092"/>
            <a:ext cx="7447837" cy="8712020"/>
            <a:chOff x="-223521" y="263839"/>
            <a:chExt cx="7447837" cy="8712021"/>
          </a:xfrm>
        </p:grpSpPr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xmlns="" id="{F0B8CC43-9294-25B5-9A34-7D4A32878783}"/>
                </a:ext>
              </a:extLst>
            </p:cNvPr>
            <p:cNvCxnSpPr>
              <a:cxnSpLocks/>
            </p:cNvCxnSpPr>
            <p:nvPr/>
          </p:nvCxnSpPr>
          <p:spPr>
            <a:xfrm>
              <a:off x="3461595" y="1709772"/>
              <a:ext cx="0" cy="610486"/>
            </a:xfrm>
            <a:prstGeom prst="line">
              <a:avLst/>
            </a:prstGeom>
            <a:ln w="635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xmlns="" id="{ADBD7DBF-E3FD-89D7-4833-BA9E77190D2E}"/>
                </a:ext>
              </a:extLst>
            </p:cNvPr>
            <p:cNvCxnSpPr>
              <a:cxnSpLocks/>
            </p:cNvCxnSpPr>
            <p:nvPr/>
          </p:nvCxnSpPr>
          <p:spPr>
            <a:xfrm>
              <a:off x="3461595" y="3036063"/>
              <a:ext cx="0" cy="610486"/>
            </a:xfrm>
            <a:prstGeom prst="line">
              <a:avLst/>
            </a:prstGeom>
            <a:ln w="635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xmlns="" id="{938AFBD3-3F1B-A21F-D9B1-63BBFD91E60F}"/>
                </a:ext>
              </a:extLst>
            </p:cNvPr>
            <p:cNvCxnSpPr>
              <a:cxnSpLocks/>
            </p:cNvCxnSpPr>
            <p:nvPr/>
          </p:nvCxnSpPr>
          <p:spPr>
            <a:xfrm>
              <a:off x="4633050" y="433116"/>
              <a:ext cx="1016456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xmlns="" id="{2A83A5BD-90C1-656C-8B2F-E48DC75AF7C5}"/>
                </a:ext>
              </a:extLst>
            </p:cNvPr>
            <p:cNvGrpSpPr/>
            <p:nvPr/>
          </p:nvGrpSpPr>
          <p:grpSpPr>
            <a:xfrm>
              <a:off x="176233" y="3341306"/>
              <a:ext cx="7048083" cy="2017491"/>
              <a:chOff x="328483" y="3970701"/>
              <a:chExt cx="6282811" cy="1893139"/>
            </a:xfrm>
          </p:grpSpPr>
          <p:pic>
            <p:nvPicPr>
              <p:cNvPr id="167" name="図 166">
                <a:extLst>
                  <a:ext uri="{FF2B5EF4-FFF2-40B4-BE49-F238E27FC236}">
                    <a16:creationId xmlns:a16="http://schemas.microsoft.com/office/drawing/2014/main" xmlns="" id="{C8620AB9-9D71-BD9A-BBD7-517BAAEED0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8483" y="4067279"/>
                <a:ext cx="1882589" cy="1628185"/>
              </a:xfrm>
              <a:prstGeom prst="rect">
                <a:avLst/>
              </a:prstGeom>
            </p:spPr>
          </p:pic>
          <p:pic>
            <p:nvPicPr>
              <p:cNvPr id="168" name="図 167">
                <a:extLst>
                  <a:ext uri="{FF2B5EF4-FFF2-40B4-BE49-F238E27FC236}">
                    <a16:creationId xmlns:a16="http://schemas.microsoft.com/office/drawing/2014/main" xmlns="" id="{FBA755DF-4996-6139-4E06-CCD466A730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19556" y="4048493"/>
                <a:ext cx="1919133" cy="1659791"/>
              </a:xfrm>
              <a:prstGeom prst="rect">
                <a:avLst/>
              </a:prstGeom>
            </p:spPr>
          </p:pic>
          <p:pic>
            <p:nvPicPr>
              <p:cNvPr id="169" name="図 168">
                <a:extLst>
                  <a:ext uri="{FF2B5EF4-FFF2-40B4-BE49-F238E27FC236}">
                    <a16:creationId xmlns:a16="http://schemas.microsoft.com/office/drawing/2014/main" xmlns="" id="{B44CA938-6805-008F-556D-B4249B0E03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81070" y="4036879"/>
                <a:ext cx="1949165" cy="1685764"/>
              </a:xfrm>
              <a:prstGeom prst="rect">
                <a:avLst/>
              </a:prstGeom>
            </p:spPr>
          </p:pic>
          <p:pic>
            <p:nvPicPr>
              <p:cNvPr id="170" name="図 169">
                <a:extLst>
                  <a:ext uri="{FF2B5EF4-FFF2-40B4-BE49-F238E27FC236}">
                    <a16:creationId xmlns:a16="http://schemas.microsoft.com/office/drawing/2014/main" xmlns="" id="{888E7DA9-2412-374A-7D80-BD39F36A75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92161" y="3970701"/>
                <a:ext cx="1919133" cy="1893139"/>
              </a:xfrm>
              <a:prstGeom prst="rect">
                <a:avLst/>
              </a:prstGeom>
            </p:spPr>
          </p:pic>
        </p:grp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xmlns="" id="{3441DD96-999C-F05D-B2C1-AB438765A430}"/>
                </a:ext>
              </a:extLst>
            </p:cNvPr>
            <p:cNvCxnSpPr>
              <a:cxnSpLocks/>
            </p:cNvCxnSpPr>
            <p:nvPr/>
          </p:nvCxnSpPr>
          <p:spPr>
            <a:xfrm>
              <a:off x="3461595" y="472030"/>
              <a:ext cx="0" cy="610486"/>
            </a:xfrm>
            <a:prstGeom prst="line">
              <a:avLst/>
            </a:prstGeom>
            <a:ln w="635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xmlns="" id="{94CED3D5-09E8-A95F-6C33-C1B40ADD9D04}"/>
                </a:ext>
              </a:extLst>
            </p:cNvPr>
            <p:cNvCxnSpPr>
              <a:cxnSpLocks/>
            </p:cNvCxnSpPr>
            <p:nvPr/>
          </p:nvCxnSpPr>
          <p:spPr>
            <a:xfrm>
              <a:off x="1630363" y="433116"/>
              <a:ext cx="2167527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xmlns="" id="{B92C29E0-5EE2-C383-F081-F01C3E2868FC}"/>
                </a:ext>
              </a:extLst>
            </p:cNvPr>
            <p:cNvSpPr txBox="1"/>
            <p:nvPr/>
          </p:nvSpPr>
          <p:spPr>
            <a:xfrm>
              <a:off x="1321882" y="263839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xmlns="" id="{CC89665E-7E17-EDD8-0366-317399142AB5}"/>
                </a:ext>
              </a:extLst>
            </p:cNvPr>
            <p:cNvSpPr txBox="1"/>
            <p:nvPr/>
          </p:nvSpPr>
          <p:spPr>
            <a:xfrm>
              <a:off x="1721220" y="263839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xmlns="" id="{D251C21C-8727-C390-EF43-01D5172B17FF}"/>
                </a:ext>
              </a:extLst>
            </p:cNvPr>
            <p:cNvSpPr txBox="1"/>
            <p:nvPr/>
          </p:nvSpPr>
          <p:spPr>
            <a:xfrm>
              <a:off x="2120560" y="263839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xmlns="" id="{2AB0721B-20E4-F5A1-833B-FEE9AEE7595E}"/>
                </a:ext>
              </a:extLst>
            </p:cNvPr>
            <p:cNvSpPr txBox="1"/>
            <p:nvPr/>
          </p:nvSpPr>
          <p:spPr>
            <a:xfrm>
              <a:off x="2519899" y="263839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xmlns="" id="{B42B69E5-A49A-CB0B-A66B-A3C64DBFBABB}"/>
                </a:ext>
              </a:extLst>
            </p:cNvPr>
            <p:cNvSpPr txBox="1"/>
            <p:nvPr/>
          </p:nvSpPr>
          <p:spPr>
            <a:xfrm>
              <a:off x="2908018" y="263839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xmlns="" id="{8E1FF578-9BE8-5E42-B0E2-C02E3DBC838C}"/>
                </a:ext>
              </a:extLst>
            </p:cNvPr>
            <p:cNvSpPr txBox="1"/>
            <p:nvPr/>
          </p:nvSpPr>
          <p:spPr>
            <a:xfrm>
              <a:off x="3296137" y="263839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xmlns="" id="{29DD3533-1C4E-597F-16D5-097E9BD0CD75}"/>
                </a:ext>
              </a:extLst>
            </p:cNvPr>
            <p:cNvSpPr txBox="1"/>
            <p:nvPr/>
          </p:nvSpPr>
          <p:spPr>
            <a:xfrm>
              <a:off x="3695476" y="263839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xmlns="" id="{DBE42BDE-F966-0B36-E4EA-0C6CB9A626BA}"/>
                </a:ext>
              </a:extLst>
            </p:cNvPr>
            <p:cNvSpPr txBox="1"/>
            <p:nvPr/>
          </p:nvSpPr>
          <p:spPr>
            <a:xfrm>
              <a:off x="4486340" y="263839"/>
              <a:ext cx="332142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xmlns="" id="{0AC8CB7C-2E8E-5F3F-FD36-180783D5DD28}"/>
                </a:ext>
              </a:extLst>
            </p:cNvPr>
            <p:cNvSpPr txBox="1"/>
            <p:nvPr/>
          </p:nvSpPr>
          <p:spPr>
            <a:xfrm>
              <a:off x="4879714" y="263839"/>
              <a:ext cx="309700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xmlns="" id="{E5CF9151-1F40-42F3-5E0D-444CB7FD6B10}"/>
                </a:ext>
              </a:extLst>
            </p:cNvPr>
            <p:cNvSpPr txBox="1"/>
            <p:nvPr/>
          </p:nvSpPr>
          <p:spPr>
            <a:xfrm>
              <a:off x="5248535" y="263839"/>
              <a:ext cx="344966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xmlns="" id="{B919484C-767B-64E6-4F0C-46D1324B250C}"/>
                </a:ext>
              </a:extLst>
            </p:cNvPr>
            <p:cNvSpPr txBox="1"/>
            <p:nvPr/>
          </p:nvSpPr>
          <p:spPr>
            <a:xfrm>
              <a:off x="3934428" y="282889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/>
                <a:t>***</a:t>
              </a:r>
              <a:endParaRPr kumimoji="1" lang="ja-JP" altLang="en-US" sz="1600" b="1" dirty="0"/>
            </a:p>
          </p:txBody>
        </p: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xmlns="" id="{106DE369-FF85-08C6-EB17-EDDDC7A337B6}"/>
                </a:ext>
              </a:extLst>
            </p:cNvPr>
            <p:cNvCxnSpPr>
              <a:cxnSpLocks/>
            </p:cNvCxnSpPr>
            <p:nvPr/>
          </p:nvCxnSpPr>
          <p:spPr>
            <a:xfrm>
              <a:off x="4633050" y="1016096"/>
              <a:ext cx="1016456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xmlns="" id="{EF20C3F5-D1FA-F5CF-04B4-0BD7D4062CE5}"/>
                </a:ext>
              </a:extLst>
            </p:cNvPr>
            <p:cNvCxnSpPr>
              <a:cxnSpLocks/>
            </p:cNvCxnSpPr>
            <p:nvPr/>
          </p:nvCxnSpPr>
          <p:spPr>
            <a:xfrm>
              <a:off x="1624791" y="1016096"/>
              <a:ext cx="2167527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xmlns="" id="{8F9AA330-B699-7405-2F6C-47FE800C7A16}"/>
                </a:ext>
              </a:extLst>
            </p:cNvPr>
            <p:cNvSpPr txBox="1"/>
            <p:nvPr/>
          </p:nvSpPr>
          <p:spPr>
            <a:xfrm>
              <a:off x="1321882" y="846819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xmlns="" id="{CF44D94E-927D-0C9F-96A4-34395798DA58}"/>
                </a:ext>
              </a:extLst>
            </p:cNvPr>
            <p:cNvSpPr txBox="1"/>
            <p:nvPr/>
          </p:nvSpPr>
          <p:spPr>
            <a:xfrm>
              <a:off x="1721220" y="846819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xmlns="" id="{DABCD06E-D82B-9406-5C68-64FF00E76C09}"/>
                </a:ext>
              </a:extLst>
            </p:cNvPr>
            <p:cNvSpPr txBox="1"/>
            <p:nvPr/>
          </p:nvSpPr>
          <p:spPr>
            <a:xfrm>
              <a:off x="2120560" y="846819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xmlns="" id="{D79260C7-D1F0-EC37-1887-8F915EC56DDC}"/>
                </a:ext>
              </a:extLst>
            </p:cNvPr>
            <p:cNvSpPr txBox="1"/>
            <p:nvPr/>
          </p:nvSpPr>
          <p:spPr>
            <a:xfrm>
              <a:off x="2519899" y="846819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xmlns="" id="{B41FB7B0-E87F-2BED-B517-02902F7FE8FC}"/>
                </a:ext>
              </a:extLst>
            </p:cNvPr>
            <p:cNvSpPr txBox="1"/>
            <p:nvPr/>
          </p:nvSpPr>
          <p:spPr>
            <a:xfrm>
              <a:off x="2908018" y="846819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xmlns="" id="{12A43887-5C52-39FD-CB2F-F2C709F4AE32}"/>
                </a:ext>
              </a:extLst>
            </p:cNvPr>
            <p:cNvSpPr txBox="1"/>
            <p:nvPr/>
          </p:nvSpPr>
          <p:spPr>
            <a:xfrm>
              <a:off x="3296137" y="846819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xmlns="" id="{9FFE0590-8D2D-84A7-600D-A12B2EC57767}"/>
                </a:ext>
              </a:extLst>
            </p:cNvPr>
            <p:cNvSpPr txBox="1"/>
            <p:nvPr/>
          </p:nvSpPr>
          <p:spPr>
            <a:xfrm>
              <a:off x="3695476" y="846819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xmlns="" id="{6F493D1C-8BB3-3887-0C9C-E47791ED6F5D}"/>
                </a:ext>
              </a:extLst>
            </p:cNvPr>
            <p:cNvSpPr txBox="1"/>
            <p:nvPr/>
          </p:nvSpPr>
          <p:spPr>
            <a:xfrm>
              <a:off x="4486340" y="846819"/>
              <a:ext cx="332142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xmlns="" id="{BA08CA68-CEC8-8343-360D-3BA6D21564F4}"/>
                </a:ext>
              </a:extLst>
            </p:cNvPr>
            <p:cNvSpPr txBox="1"/>
            <p:nvPr/>
          </p:nvSpPr>
          <p:spPr>
            <a:xfrm>
              <a:off x="4879714" y="846819"/>
              <a:ext cx="309700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xmlns="" id="{1A2BB8FF-267A-9015-509B-FD51E1010897}"/>
                </a:ext>
              </a:extLst>
            </p:cNvPr>
            <p:cNvSpPr txBox="1"/>
            <p:nvPr/>
          </p:nvSpPr>
          <p:spPr>
            <a:xfrm>
              <a:off x="5248535" y="846819"/>
              <a:ext cx="344966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xmlns="" id="{28B9F0FE-C4DC-2B98-A339-E37BC4793B5A}"/>
                </a:ext>
              </a:extLst>
            </p:cNvPr>
            <p:cNvSpPr txBox="1"/>
            <p:nvPr/>
          </p:nvSpPr>
          <p:spPr>
            <a:xfrm>
              <a:off x="3934428" y="865869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/>
                <a:t>***</a:t>
              </a:r>
              <a:endParaRPr kumimoji="1" lang="ja-JP" altLang="en-US" sz="1600" b="1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xmlns="" id="{73E2BD03-2823-D113-0536-C1436B793E5C}"/>
                </a:ext>
              </a:extLst>
            </p:cNvPr>
            <p:cNvSpPr txBox="1"/>
            <p:nvPr/>
          </p:nvSpPr>
          <p:spPr>
            <a:xfrm>
              <a:off x="-34408" y="468732"/>
              <a:ext cx="140256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poA2-ATQ/ATQ</a:t>
              </a:r>
            </a:p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eavy isoform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xmlns="" id="{78C23935-0732-04A9-301A-2E665D22F8CA}"/>
                </a:ext>
              </a:extLst>
            </p:cNvPr>
            <p:cNvCxnSpPr>
              <a:cxnSpLocks/>
            </p:cNvCxnSpPr>
            <p:nvPr/>
          </p:nvCxnSpPr>
          <p:spPr>
            <a:xfrm>
              <a:off x="4538054" y="1698081"/>
              <a:ext cx="1111453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xmlns="" id="{72EC98FC-15BC-0AFB-260F-2D9C1EB2E3F5}"/>
                </a:ext>
              </a:extLst>
            </p:cNvPr>
            <p:cNvSpPr txBox="1"/>
            <p:nvPr/>
          </p:nvSpPr>
          <p:spPr>
            <a:xfrm>
              <a:off x="4486342" y="1528804"/>
              <a:ext cx="327272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xmlns="" id="{7F2C78C4-7439-CCB2-4996-2DC67DC96574}"/>
                </a:ext>
              </a:extLst>
            </p:cNvPr>
            <p:cNvSpPr txBox="1"/>
            <p:nvPr/>
          </p:nvSpPr>
          <p:spPr>
            <a:xfrm>
              <a:off x="4879714" y="1528804"/>
              <a:ext cx="303384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xmlns="" id="{21DCD8DE-7837-3B3B-9E06-F3A9B742196B}"/>
                </a:ext>
              </a:extLst>
            </p:cNvPr>
            <p:cNvSpPr txBox="1"/>
            <p:nvPr/>
          </p:nvSpPr>
          <p:spPr>
            <a:xfrm>
              <a:off x="5254285" y="1528804"/>
              <a:ext cx="339216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xmlns="" id="{5D857331-9566-272A-1016-AD88D00538A4}"/>
                </a:ext>
              </a:extLst>
            </p:cNvPr>
            <p:cNvSpPr txBox="1"/>
            <p:nvPr/>
          </p:nvSpPr>
          <p:spPr>
            <a:xfrm>
              <a:off x="3934429" y="1547854"/>
              <a:ext cx="5876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***</a:t>
              </a:r>
              <a:endParaRPr kumimoji="1" lang="ja-JP" altLang="en-US" sz="1600" b="1" dirty="0"/>
            </a:p>
          </p:txBody>
        </p: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xmlns="" id="{1200490D-648E-8BCC-6877-F436A0B07A61}"/>
                </a:ext>
              </a:extLst>
            </p:cNvPr>
            <p:cNvCxnSpPr>
              <a:cxnSpLocks/>
            </p:cNvCxnSpPr>
            <p:nvPr/>
          </p:nvCxnSpPr>
          <p:spPr>
            <a:xfrm>
              <a:off x="4700056" y="2275150"/>
              <a:ext cx="685889" cy="3378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xmlns="" id="{77F02B92-987A-8697-4CCE-24EABF860A52}"/>
                </a:ext>
              </a:extLst>
            </p:cNvPr>
            <p:cNvSpPr txBox="1"/>
            <p:nvPr/>
          </p:nvSpPr>
          <p:spPr>
            <a:xfrm>
              <a:off x="4486342" y="2111784"/>
              <a:ext cx="327272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xmlns="" id="{B8D67199-A1F8-746A-E8F1-5D0AB7377805}"/>
                </a:ext>
              </a:extLst>
            </p:cNvPr>
            <p:cNvSpPr txBox="1"/>
            <p:nvPr/>
          </p:nvSpPr>
          <p:spPr>
            <a:xfrm>
              <a:off x="4879714" y="2111784"/>
              <a:ext cx="303384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xmlns="" id="{105C7551-B701-04CE-DDC7-381BF84F7B08}"/>
                </a:ext>
              </a:extLst>
            </p:cNvPr>
            <p:cNvSpPr txBox="1"/>
            <p:nvPr/>
          </p:nvSpPr>
          <p:spPr>
            <a:xfrm>
              <a:off x="3934430" y="2130834"/>
              <a:ext cx="6642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***</a:t>
              </a:r>
              <a:endParaRPr kumimoji="1" lang="ja-JP" altLang="en-US" sz="1600" b="1" dirty="0"/>
            </a:p>
          </p:txBody>
        </p:sp>
        <p:pic>
          <p:nvPicPr>
            <p:cNvPr id="43" name="Picture 2" descr="ソース画像を表示">
              <a:extLst>
                <a:ext uri="{FF2B5EF4-FFF2-40B4-BE49-F238E27FC236}">
                  <a16:creationId xmlns:a16="http://schemas.microsoft.com/office/drawing/2014/main" xmlns="" id="{062350BC-ABDC-7E00-0660-201A72912D8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9310" y="2025040"/>
              <a:ext cx="399458" cy="3994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xmlns="" id="{36369011-FF49-8684-CD9C-89B77527A123}"/>
                </a:ext>
              </a:extLst>
            </p:cNvPr>
            <p:cNvSpPr txBox="1"/>
            <p:nvPr/>
          </p:nvSpPr>
          <p:spPr>
            <a:xfrm>
              <a:off x="6167205" y="1769405"/>
              <a:ext cx="344966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5" name="Picture 4" descr="ソース画像を表示">
              <a:extLst>
                <a:ext uri="{FF2B5EF4-FFF2-40B4-BE49-F238E27FC236}">
                  <a16:creationId xmlns:a16="http://schemas.microsoft.com/office/drawing/2014/main" xmlns="" id="{2D10A1D2-2821-46EF-863F-6C9999EDFB3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64" t="22330" b="16505"/>
            <a:stretch/>
          </p:blipFill>
          <p:spPr bwMode="auto">
            <a:xfrm>
              <a:off x="6531500" y="1643477"/>
              <a:ext cx="304811" cy="4000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6" name="Picture 4" descr="ソース画像を表示">
              <a:extLst>
                <a:ext uri="{FF2B5EF4-FFF2-40B4-BE49-F238E27FC236}">
                  <a16:creationId xmlns:a16="http://schemas.microsoft.com/office/drawing/2014/main" xmlns="" id="{C5BE41EA-85AE-C157-31EA-09D73FAF0E8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64" t="22330" b="16505"/>
            <a:stretch/>
          </p:blipFill>
          <p:spPr bwMode="auto">
            <a:xfrm flipH="1">
              <a:off x="5878125" y="1654815"/>
              <a:ext cx="274073" cy="4000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7" name="円弧 46">
              <a:extLst>
                <a:ext uri="{FF2B5EF4-FFF2-40B4-BE49-F238E27FC236}">
                  <a16:creationId xmlns:a16="http://schemas.microsoft.com/office/drawing/2014/main" xmlns="" id="{CAABE9B7-2271-B456-E871-E1D242E64891}"/>
                </a:ext>
              </a:extLst>
            </p:cNvPr>
            <p:cNvSpPr/>
            <p:nvPr/>
          </p:nvSpPr>
          <p:spPr>
            <a:xfrm>
              <a:off x="6506423" y="1547785"/>
              <a:ext cx="188118" cy="122971"/>
            </a:xfrm>
            <a:prstGeom prst="arc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48" name="円弧 47">
              <a:extLst>
                <a:ext uri="{FF2B5EF4-FFF2-40B4-BE49-F238E27FC236}">
                  <a16:creationId xmlns:a16="http://schemas.microsoft.com/office/drawing/2014/main" xmlns="" id="{FCC2CF89-5985-9D29-7F05-1768C8463B75}"/>
                </a:ext>
              </a:extLst>
            </p:cNvPr>
            <p:cNvSpPr/>
            <p:nvPr/>
          </p:nvSpPr>
          <p:spPr>
            <a:xfrm>
              <a:off x="6568576" y="1476774"/>
              <a:ext cx="220290" cy="178041"/>
            </a:xfrm>
            <a:prstGeom prst="arc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49" name="円弧 48">
              <a:extLst>
                <a:ext uri="{FF2B5EF4-FFF2-40B4-BE49-F238E27FC236}">
                  <a16:creationId xmlns:a16="http://schemas.microsoft.com/office/drawing/2014/main" xmlns="" id="{D1950E12-0B43-ACD9-B75B-72D41F6541EF}"/>
                </a:ext>
              </a:extLst>
            </p:cNvPr>
            <p:cNvSpPr/>
            <p:nvPr/>
          </p:nvSpPr>
          <p:spPr>
            <a:xfrm rot="16732380">
              <a:off x="5851581" y="1585527"/>
              <a:ext cx="231907" cy="248491"/>
            </a:xfrm>
            <a:prstGeom prst="arc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50" name="円弧 49">
              <a:extLst>
                <a:ext uri="{FF2B5EF4-FFF2-40B4-BE49-F238E27FC236}">
                  <a16:creationId xmlns:a16="http://schemas.microsoft.com/office/drawing/2014/main" xmlns="" id="{D3786296-02CE-32F0-CE61-EC77FB05C0F8}"/>
                </a:ext>
              </a:extLst>
            </p:cNvPr>
            <p:cNvSpPr/>
            <p:nvPr/>
          </p:nvSpPr>
          <p:spPr>
            <a:xfrm rot="16732380">
              <a:off x="5823479" y="1508354"/>
              <a:ext cx="231907" cy="248491"/>
            </a:xfrm>
            <a:prstGeom prst="arc">
              <a:avLst>
                <a:gd name="adj1" fmla="val 16200000"/>
                <a:gd name="adj2" fmla="val 1301975"/>
              </a:avLst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xmlns="" id="{4E6C2051-BDC6-76FE-2D85-5F2E54083130}"/>
                </a:ext>
              </a:extLst>
            </p:cNvPr>
            <p:cNvCxnSpPr>
              <a:cxnSpLocks/>
            </p:cNvCxnSpPr>
            <p:nvPr/>
          </p:nvCxnSpPr>
          <p:spPr>
            <a:xfrm>
              <a:off x="4667602" y="3023778"/>
              <a:ext cx="664376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xmlns="" id="{BE635F0E-9023-CFE3-4E53-2E60B23ECDFA}"/>
                </a:ext>
              </a:extLst>
            </p:cNvPr>
            <p:cNvCxnSpPr>
              <a:cxnSpLocks/>
            </p:cNvCxnSpPr>
            <p:nvPr/>
          </p:nvCxnSpPr>
          <p:spPr>
            <a:xfrm>
              <a:off x="1615334" y="3023778"/>
              <a:ext cx="2167527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xmlns="" id="{6AE3074B-D052-591B-B0A8-5003B0C57774}"/>
                </a:ext>
              </a:extLst>
            </p:cNvPr>
            <p:cNvSpPr txBox="1"/>
            <p:nvPr/>
          </p:nvSpPr>
          <p:spPr>
            <a:xfrm>
              <a:off x="1321882" y="2854501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xmlns="" id="{A3F6CA80-AD9C-073C-1113-564EBAB62850}"/>
                </a:ext>
              </a:extLst>
            </p:cNvPr>
            <p:cNvSpPr txBox="1"/>
            <p:nvPr/>
          </p:nvSpPr>
          <p:spPr>
            <a:xfrm>
              <a:off x="1721220" y="2854501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xmlns="" id="{5454D8BC-C10D-85B4-F875-DDF8BED9DBE3}"/>
                </a:ext>
              </a:extLst>
            </p:cNvPr>
            <p:cNvSpPr txBox="1"/>
            <p:nvPr/>
          </p:nvSpPr>
          <p:spPr>
            <a:xfrm>
              <a:off x="2120560" y="2854501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xmlns="" id="{9D19F969-35FA-C214-B8F0-46D127D45F74}"/>
                </a:ext>
              </a:extLst>
            </p:cNvPr>
            <p:cNvSpPr txBox="1"/>
            <p:nvPr/>
          </p:nvSpPr>
          <p:spPr>
            <a:xfrm>
              <a:off x="2519899" y="2854501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xmlns="" id="{2794401D-A05B-99A3-ABD2-67FBEA34267A}"/>
                </a:ext>
              </a:extLst>
            </p:cNvPr>
            <p:cNvSpPr txBox="1"/>
            <p:nvPr/>
          </p:nvSpPr>
          <p:spPr>
            <a:xfrm>
              <a:off x="2908018" y="2854501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xmlns="" id="{33A06B3E-1D9E-13C6-1446-B3107711DFBF}"/>
                </a:ext>
              </a:extLst>
            </p:cNvPr>
            <p:cNvSpPr txBox="1"/>
            <p:nvPr/>
          </p:nvSpPr>
          <p:spPr>
            <a:xfrm>
              <a:off x="3296137" y="2854501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xmlns="" id="{03E3AC7C-D215-BBFA-1BD0-701DBEFF5938}"/>
                </a:ext>
              </a:extLst>
            </p:cNvPr>
            <p:cNvSpPr txBox="1"/>
            <p:nvPr/>
          </p:nvSpPr>
          <p:spPr>
            <a:xfrm>
              <a:off x="3695476" y="2854501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xmlns="" id="{11F02C54-0B0F-32ED-BA94-0EA8C59973ED}"/>
                </a:ext>
              </a:extLst>
            </p:cNvPr>
            <p:cNvSpPr txBox="1"/>
            <p:nvPr/>
          </p:nvSpPr>
          <p:spPr>
            <a:xfrm>
              <a:off x="4486340" y="2854501"/>
              <a:ext cx="332142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xmlns="" id="{2A04EF44-79A6-9742-BFF2-1BE3CDE5AD14}"/>
                </a:ext>
              </a:extLst>
            </p:cNvPr>
            <p:cNvSpPr txBox="1"/>
            <p:nvPr/>
          </p:nvSpPr>
          <p:spPr>
            <a:xfrm>
              <a:off x="4879714" y="2854501"/>
              <a:ext cx="309700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xmlns="" id="{1EFBC686-EAD2-81E4-DC2B-EDE54F291021}"/>
                </a:ext>
              </a:extLst>
            </p:cNvPr>
            <p:cNvSpPr txBox="1"/>
            <p:nvPr/>
          </p:nvSpPr>
          <p:spPr>
            <a:xfrm>
              <a:off x="3934429" y="2873551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/>
                <a:t>***</a:t>
              </a:r>
              <a:endParaRPr kumimoji="1" lang="ja-JP" altLang="en-US" sz="1600" b="1" dirty="0"/>
            </a:p>
          </p:txBody>
        </p: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xmlns="" id="{E8288336-F72E-FA56-C1FE-B9BDC2B3641F}"/>
                </a:ext>
              </a:extLst>
            </p:cNvPr>
            <p:cNvCxnSpPr>
              <a:cxnSpLocks/>
            </p:cNvCxnSpPr>
            <p:nvPr/>
          </p:nvCxnSpPr>
          <p:spPr>
            <a:xfrm>
              <a:off x="4662030" y="3601700"/>
              <a:ext cx="736410" cy="3378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xmlns="" id="{10A70D5D-2BDA-7B3F-2895-B6D091BF90BD}"/>
                </a:ext>
              </a:extLst>
            </p:cNvPr>
            <p:cNvCxnSpPr>
              <a:cxnSpLocks/>
            </p:cNvCxnSpPr>
            <p:nvPr/>
          </p:nvCxnSpPr>
          <p:spPr>
            <a:xfrm>
              <a:off x="1609762" y="3606758"/>
              <a:ext cx="2167527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xmlns="" id="{F65CA644-CB28-CD3A-05F6-8B0E4D6D39B2}"/>
                </a:ext>
              </a:extLst>
            </p:cNvPr>
            <p:cNvSpPr txBox="1"/>
            <p:nvPr/>
          </p:nvSpPr>
          <p:spPr>
            <a:xfrm>
              <a:off x="1321882" y="3437481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xmlns="" id="{D9E94BCB-0B8E-FB90-7B53-F782622237A5}"/>
                </a:ext>
              </a:extLst>
            </p:cNvPr>
            <p:cNvSpPr txBox="1"/>
            <p:nvPr/>
          </p:nvSpPr>
          <p:spPr>
            <a:xfrm>
              <a:off x="1721220" y="3437481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xmlns="" id="{808F0084-F457-D226-811A-8E2DC284C9D6}"/>
                </a:ext>
              </a:extLst>
            </p:cNvPr>
            <p:cNvSpPr txBox="1"/>
            <p:nvPr/>
          </p:nvSpPr>
          <p:spPr>
            <a:xfrm>
              <a:off x="2120560" y="3437481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xmlns="" id="{A3E31EFE-7405-A712-AB18-7D6541A252EA}"/>
                </a:ext>
              </a:extLst>
            </p:cNvPr>
            <p:cNvSpPr txBox="1"/>
            <p:nvPr/>
          </p:nvSpPr>
          <p:spPr>
            <a:xfrm>
              <a:off x="2519899" y="3437481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xmlns="" id="{47085E53-7B5E-D49B-9191-20339A07C193}"/>
                </a:ext>
              </a:extLst>
            </p:cNvPr>
            <p:cNvSpPr txBox="1"/>
            <p:nvPr/>
          </p:nvSpPr>
          <p:spPr>
            <a:xfrm>
              <a:off x="2908018" y="3437481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xmlns="" id="{BEF9C183-A542-7355-9203-601B38DC3BF7}"/>
                </a:ext>
              </a:extLst>
            </p:cNvPr>
            <p:cNvSpPr txBox="1"/>
            <p:nvPr/>
          </p:nvSpPr>
          <p:spPr>
            <a:xfrm>
              <a:off x="3296137" y="3437481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xmlns="" id="{041733E0-CA51-C79F-F41E-04EFBEDF8BEC}"/>
                </a:ext>
              </a:extLst>
            </p:cNvPr>
            <p:cNvSpPr txBox="1"/>
            <p:nvPr/>
          </p:nvSpPr>
          <p:spPr>
            <a:xfrm>
              <a:off x="3695476" y="3437481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xmlns="" id="{577DA132-8E4A-719C-D186-FFB24B1076E0}"/>
                </a:ext>
              </a:extLst>
            </p:cNvPr>
            <p:cNvSpPr txBox="1"/>
            <p:nvPr/>
          </p:nvSpPr>
          <p:spPr>
            <a:xfrm>
              <a:off x="4486340" y="3437481"/>
              <a:ext cx="332142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xmlns="" id="{ED5F91DE-A944-AE4B-0E63-0CCB48B9EBB4}"/>
                </a:ext>
              </a:extLst>
            </p:cNvPr>
            <p:cNvSpPr txBox="1"/>
            <p:nvPr/>
          </p:nvSpPr>
          <p:spPr>
            <a:xfrm>
              <a:off x="4879714" y="3437481"/>
              <a:ext cx="309700" cy="338554"/>
            </a:xfrm>
            <a:prstGeom prst="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xmlns="" id="{778CA65C-6817-B7F4-9FC1-AF08EC52273C}"/>
                </a:ext>
              </a:extLst>
            </p:cNvPr>
            <p:cNvSpPr txBox="1"/>
            <p:nvPr/>
          </p:nvSpPr>
          <p:spPr>
            <a:xfrm>
              <a:off x="3934429" y="3456531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/>
                <a:t>***</a:t>
              </a:r>
              <a:endParaRPr kumimoji="1" lang="ja-JP" altLang="en-US" sz="1600" b="1" dirty="0"/>
            </a:p>
          </p:txBody>
        </p:sp>
        <p:pic>
          <p:nvPicPr>
            <p:cNvPr id="75" name="Picture 2" descr="ソース画像を表示">
              <a:extLst>
                <a:ext uri="{FF2B5EF4-FFF2-40B4-BE49-F238E27FC236}">
                  <a16:creationId xmlns:a16="http://schemas.microsoft.com/office/drawing/2014/main" xmlns="" id="{A4AD1FA4-E924-F88C-FDCF-92E78C4D785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71807" y="3351589"/>
              <a:ext cx="399458" cy="3994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6" name="グループ化 75">
              <a:extLst>
                <a:ext uri="{FF2B5EF4-FFF2-40B4-BE49-F238E27FC236}">
                  <a16:creationId xmlns:a16="http://schemas.microsoft.com/office/drawing/2014/main" xmlns="" id="{AB2CABAE-F097-AE9E-0D1A-669DE9BD76CC}"/>
                </a:ext>
              </a:extLst>
            </p:cNvPr>
            <p:cNvGrpSpPr/>
            <p:nvPr/>
          </p:nvGrpSpPr>
          <p:grpSpPr>
            <a:xfrm>
              <a:off x="5790917" y="2995896"/>
              <a:ext cx="1077585" cy="631185"/>
              <a:chOff x="5792548" y="1699968"/>
              <a:chExt cx="1077585" cy="631185"/>
            </a:xfrm>
          </p:grpSpPr>
          <p:grpSp>
            <p:nvGrpSpPr>
              <p:cNvPr id="159" name="グループ化 158">
                <a:extLst>
                  <a:ext uri="{FF2B5EF4-FFF2-40B4-BE49-F238E27FC236}">
                    <a16:creationId xmlns:a16="http://schemas.microsoft.com/office/drawing/2014/main" xmlns="" id="{C137CCA8-A154-1AC9-E3CC-F536EE03CCDB}"/>
                  </a:ext>
                </a:extLst>
              </p:cNvPr>
              <p:cNvGrpSpPr/>
              <p:nvPr/>
            </p:nvGrpSpPr>
            <p:grpSpPr>
              <a:xfrm>
                <a:off x="5868061" y="1699968"/>
                <a:ext cx="1002072" cy="631185"/>
                <a:chOff x="5846834" y="1572357"/>
                <a:chExt cx="1002072" cy="631185"/>
              </a:xfrm>
            </p:grpSpPr>
            <p:sp>
              <p:nvSpPr>
                <p:cNvPr id="162" name="テキスト ボックス 161">
                  <a:extLst>
                    <a:ext uri="{FF2B5EF4-FFF2-40B4-BE49-F238E27FC236}">
                      <a16:creationId xmlns:a16="http://schemas.microsoft.com/office/drawing/2014/main" xmlns="" id="{6F7CE86E-F398-A7EF-7678-38A4BD162542}"/>
                    </a:ext>
                  </a:extLst>
                </p:cNvPr>
                <p:cNvSpPr txBox="1"/>
                <p:nvPr/>
              </p:nvSpPr>
              <p:spPr>
                <a:xfrm>
                  <a:off x="6149268" y="1864988"/>
                  <a:ext cx="344966" cy="338554"/>
                </a:xfrm>
                <a:prstGeom prst="rect">
                  <a:avLst/>
                </a:prstGeom>
                <a:solidFill>
                  <a:schemeClr val="accent4">
                    <a:lumMod val="20000"/>
                    <a:lumOff val="80000"/>
                  </a:schemeClr>
                </a:solidFill>
                <a:ln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Q</a:t>
                  </a:r>
                  <a:endParaRPr kumimoji="1" lang="ja-JP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63" name="Picture 4" descr="ソース画像を表示">
                  <a:extLst>
                    <a:ext uri="{FF2B5EF4-FFF2-40B4-BE49-F238E27FC236}">
                      <a16:creationId xmlns:a16="http://schemas.microsoft.com/office/drawing/2014/main" xmlns="" id="{3CCF7793-5A7E-7B94-B9E5-ADBE8DD690CC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964" t="22330" b="16505"/>
                <a:stretch/>
              </p:blipFill>
              <p:spPr bwMode="auto">
                <a:xfrm>
                  <a:off x="6521644" y="1766339"/>
                  <a:ext cx="327262" cy="40005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64" name="Picture 4" descr="ソース画像を表示">
                  <a:extLst>
                    <a:ext uri="{FF2B5EF4-FFF2-40B4-BE49-F238E27FC236}">
                      <a16:creationId xmlns:a16="http://schemas.microsoft.com/office/drawing/2014/main" xmlns="" id="{B7B1C3A3-2A91-6AC9-6723-F6775B2A56D7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964" t="22330" b="16505"/>
                <a:stretch/>
              </p:blipFill>
              <p:spPr bwMode="auto">
                <a:xfrm flipH="1">
                  <a:off x="5846834" y="1751277"/>
                  <a:ext cx="294260" cy="40005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65" name="円弧 164">
                  <a:extLst>
                    <a:ext uri="{FF2B5EF4-FFF2-40B4-BE49-F238E27FC236}">
                      <a16:creationId xmlns:a16="http://schemas.microsoft.com/office/drawing/2014/main" xmlns="" id="{0ADC2282-79E6-CDFE-40D5-ED91499B4F56}"/>
                    </a:ext>
                  </a:extLst>
                </p:cNvPr>
                <p:cNvSpPr/>
                <p:nvPr/>
              </p:nvSpPr>
              <p:spPr>
                <a:xfrm>
                  <a:off x="6513470" y="1643368"/>
                  <a:ext cx="201974" cy="122971"/>
                </a:xfrm>
                <a:prstGeom prst="arc">
                  <a:avLst/>
                </a:prstGeom>
                <a:ln w="254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600"/>
                </a:p>
              </p:txBody>
            </p:sp>
            <p:sp>
              <p:nvSpPr>
                <p:cNvPr id="166" name="円弧 165">
                  <a:extLst>
                    <a:ext uri="{FF2B5EF4-FFF2-40B4-BE49-F238E27FC236}">
                      <a16:creationId xmlns:a16="http://schemas.microsoft.com/office/drawing/2014/main" xmlns="" id="{72D55BDF-A1C4-1F00-DA2C-7AEB7A218D20}"/>
                    </a:ext>
                  </a:extLst>
                </p:cNvPr>
                <p:cNvSpPr/>
                <p:nvPr/>
              </p:nvSpPr>
              <p:spPr>
                <a:xfrm>
                  <a:off x="6580201" y="1572357"/>
                  <a:ext cx="236516" cy="178041"/>
                </a:xfrm>
                <a:prstGeom prst="arc">
                  <a:avLst/>
                </a:prstGeom>
                <a:ln w="254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600"/>
                </a:p>
              </p:txBody>
            </p:sp>
          </p:grpSp>
          <p:sp>
            <p:nvSpPr>
              <p:cNvPr id="160" name="円弧 159">
                <a:extLst>
                  <a:ext uri="{FF2B5EF4-FFF2-40B4-BE49-F238E27FC236}">
                    <a16:creationId xmlns:a16="http://schemas.microsoft.com/office/drawing/2014/main" xmlns="" id="{C56BD0F9-31D8-A633-4C5C-99A260BB6356}"/>
                  </a:ext>
                </a:extLst>
              </p:cNvPr>
              <p:cNvSpPr/>
              <p:nvPr/>
            </p:nvSpPr>
            <p:spPr>
              <a:xfrm rot="16732380">
                <a:off x="5840161" y="1799568"/>
                <a:ext cx="231907" cy="266794"/>
              </a:xfrm>
              <a:prstGeom prst="arc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/>
              </a:p>
            </p:txBody>
          </p:sp>
          <p:sp>
            <p:nvSpPr>
              <p:cNvPr id="161" name="円弧 160">
                <a:extLst>
                  <a:ext uri="{FF2B5EF4-FFF2-40B4-BE49-F238E27FC236}">
                    <a16:creationId xmlns:a16="http://schemas.microsoft.com/office/drawing/2014/main" xmlns="" id="{0EBCE068-C288-B402-0387-91E3BA75215A}"/>
                  </a:ext>
                </a:extLst>
              </p:cNvPr>
              <p:cNvSpPr/>
              <p:nvPr/>
            </p:nvSpPr>
            <p:spPr>
              <a:xfrm rot="16732380">
                <a:off x="5809991" y="1722395"/>
                <a:ext cx="231907" cy="266794"/>
              </a:xfrm>
              <a:prstGeom prst="arc">
                <a:avLst>
                  <a:gd name="adj1" fmla="val 16200000"/>
                  <a:gd name="adj2" fmla="val 1301975"/>
                </a:avLst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/>
              </a:p>
            </p:txBody>
          </p:sp>
        </p:grpSp>
        <p:sp>
          <p:nvSpPr>
            <p:cNvPr id="77" name="矢印: 右 76">
              <a:extLst>
                <a:ext uri="{FF2B5EF4-FFF2-40B4-BE49-F238E27FC236}">
                  <a16:creationId xmlns:a16="http://schemas.microsoft.com/office/drawing/2014/main" xmlns="" id="{12C3ED04-6CDA-780D-8AE9-0BA13635D24F}"/>
                </a:ext>
              </a:extLst>
            </p:cNvPr>
            <p:cNvSpPr/>
            <p:nvPr/>
          </p:nvSpPr>
          <p:spPr>
            <a:xfrm rot="19823011">
              <a:off x="5674115" y="2052937"/>
              <a:ext cx="257679" cy="158715"/>
            </a:xfrm>
            <a:prstGeom prst="rightArrow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pic>
          <p:nvPicPr>
            <p:cNvPr id="78" name="Picture 2" descr="ソース画像を表示">
              <a:extLst>
                <a:ext uri="{FF2B5EF4-FFF2-40B4-BE49-F238E27FC236}">
                  <a16:creationId xmlns:a16="http://schemas.microsoft.com/office/drawing/2014/main" xmlns="" id="{5BCA087E-C435-7C36-13BB-E993935D71C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71807" y="2746545"/>
              <a:ext cx="399458" cy="3994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9" name="グループ化 78">
              <a:extLst>
                <a:ext uri="{FF2B5EF4-FFF2-40B4-BE49-F238E27FC236}">
                  <a16:creationId xmlns:a16="http://schemas.microsoft.com/office/drawing/2014/main" xmlns="" id="{02CCE650-BC3C-373D-CAC7-43640DC7DD40}"/>
                </a:ext>
              </a:extLst>
            </p:cNvPr>
            <p:cNvGrpSpPr/>
            <p:nvPr/>
          </p:nvGrpSpPr>
          <p:grpSpPr>
            <a:xfrm>
              <a:off x="5847379" y="2289057"/>
              <a:ext cx="1021123" cy="631185"/>
              <a:chOff x="5792548" y="1699968"/>
              <a:chExt cx="1096336" cy="631185"/>
            </a:xfrm>
          </p:grpSpPr>
          <p:grpSp>
            <p:nvGrpSpPr>
              <p:cNvPr id="151" name="グループ化 150">
                <a:extLst>
                  <a:ext uri="{FF2B5EF4-FFF2-40B4-BE49-F238E27FC236}">
                    <a16:creationId xmlns:a16="http://schemas.microsoft.com/office/drawing/2014/main" xmlns="" id="{EB917FCB-933D-E046-A8D5-88E76AC98306}"/>
                  </a:ext>
                </a:extLst>
              </p:cNvPr>
              <p:cNvGrpSpPr/>
              <p:nvPr/>
            </p:nvGrpSpPr>
            <p:grpSpPr>
              <a:xfrm>
                <a:off x="5849311" y="1699968"/>
                <a:ext cx="1039573" cy="631185"/>
                <a:chOff x="5828084" y="1572357"/>
                <a:chExt cx="1039573" cy="631185"/>
              </a:xfrm>
            </p:grpSpPr>
            <p:sp>
              <p:nvSpPr>
                <p:cNvPr id="154" name="テキスト ボックス 153">
                  <a:extLst>
                    <a:ext uri="{FF2B5EF4-FFF2-40B4-BE49-F238E27FC236}">
                      <a16:creationId xmlns:a16="http://schemas.microsoft.com/office/drawing/2014/main" xmlns="" id="{0CA597F2-C9E0-CDF5-947B-221FC6258959}"/>
                    </a:ext>
                  </a:extLst>
                </p:cNvPr>
                <p:cNvSpPr txBox="1"/>
                <p:nvPr/>
              </p:nvSpPr>
              <p:spPr>
                <a:xfrm>
                  <a:off x="6149268" y="1864988"/>
                  <a:ext cx="370375" cy="338554"/>
                </a:xfrm>
                <a:prstGeom prst="rect">
                  <a:avLst/>
                </a:prstGeom>
                <a:solidFill>
                  <a:schemeClr val="accent4">
                    <a:lumMod val="20000"/>
                    <a:lumOff val="80000"/>
                  </a:schemeClr>
                </a:solidFill>
                <a:ln>
                  <a:solidFill>
                    <a:schemeClr val="tx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Q</a:t>
                  </a:r>
                  <a:endParaRPr kumimoji="1" lang="ja-JP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55" name="Picture 4" descr="ソース画像を表示">
                  <a:extLst>
                    <a:ext uri="{FF2B5EF4-FFF2-40B4-BE49-F238E27FC236}">
                      <a16:creationId xmlns:a16="http://schemas.microsoft.com/office/drawing/2014/main" xmlns="" id="{A9227B62-BB8D-FE60-7332-59AE39B8D082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964" t="22330" b="16505"/>
                <a:stretch/>
              </p:blipFill>
              <p:spPr bwMode="auto">
                <a:xfrm>
                  <a:off x="6540395" y="1739060"/>
                  <a:ext cx="327262" cy="40005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56" name="Picture 4" descr="ソース画像を表示">
                  <a:extLst>
                    <a:ext uri="{FF2B5EF4-FFF2-40B4-BE49-F238E27FC236}">
                      <a16:creationId xmlns:a16="http://schemas.microsoft.com/office/drawing/2014/main" xmlns="" id="{B8CA2A1F-3293-054F-8A40-1375D75F31B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964" t="22330" b="16505"/>
                <a:stretch/>
              </p:blipFill>
              <p:spPr bwMode="auto">
                <a:xfrm flipH="1">
                  <a:off x="5828084" y="1750398"/>
                  <a:ext cx="294260" cy="40005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57" name="円弧 156">
                  <a:extLst>
                    <a:ext uri="{FF2B5EF4-FFF2-40B4-BE49-F238E27FC236}">
                      <a16:creationId xmlns:a16="http://schemas.microsoft.com/office/drawing/2014/main" xmlns="" id="{07338397-2230-33FD-3DBB-054C3E622B3B}"/>
                    </a:ext>
                  </a:extLst>
                </p:cNvPr>
                <p:cNvSpPr/>
                <p:nvPr/>
              </p:nvSpPr>
              <p:spPr>
                <a:xfrm>
                  <a:off x="6513470" y="1643368"/>
                  <a:ext cx="201974" cy="122971"/>
                </a:xfrm>
                <a:prstGeom prst="arc">
                  <a:avLst/>
                </a:prstGeom>
                <a:ln w="254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600"/>
                </a:p>
              </p:txBody>
            </p:sp>
            <p:sp>
              <p:nvSpPr>
                <p:cNvPr id="158" name="円弧 157">
                  <a:extLst>
                    <a:ext uri="{FF2B5EF4-FFF2-40B4-BE49-F238E27FC236}">
                      <a16:creationId xmlns:a16="http://schemas.microsoft.com/office/drawing/2014/main" xmlns="" id="{FF1CD817-3383-3D04-5A80-FFF5652267AD}"/>
                    </a:ext>
                  </a:extLst>
                </p:cNvPr>
                <p:cNvSpPr/>
                <p:nvPr/>
              </p:nvSpPr>
              <p:spPr>
                <a:xfrm>
                  <a:off x="6580201" y="1572357"/>
                  <a:ext cx="236516" cy="178041"/>
                </a:xfrm>
                <a:prstGeom prst="arc">
                  <a:avLst/>
                </a:prstGeom>
                <a:ln w="254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600"/>
                </a:p>
              </p:txBody>
            </p:sp>
          </p:grpSp>
          <p:sp>
            <p:nvSpPr>
              <p:cNvPr id="152" name="円弧 151">
                <a:extLst>
                  <a:ext uri="{FF2B5EF4-FFF2-40B4-BE49-F238E27FC236}">
                    <a16:creationId xmlns:a16="http://schemas.microsoft.com/office/drawing/2014/main" xmlns="" id="{09CA3AF4-0061-0EF9-4095-2C0751645F9C}"/>
                  </a:ext>
                </a:extLst>
              </p:cNvPr>
              <p:cNvSpPr/>
              <p:nvPr/>
            </p:nvSpPr>
            <p:spPr>
              <a:xfrm rot="16732380">
                <a:off x="5840161" y="1799568"/>
                <a:ext cx="231907" cy="266794"/>
              </a:xfrm>
              <a:prstGeom prst="arc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/>
              </a:p>
            </p:txBody>
          </p:sp>
          <p:sp>
            <p:nvSpPr>
              <p:cNvPr id="153" name="円弧 152">
                <a:extLst>
                  <a:ext uri="{FF2B5EF4-FFF2-40B4-BE49-F238E27FC236}">
                    <a16:creationId xmlns:a16="http://schemas.microsoft.com/office/drawing/2014/main" xmlns="" id="{C33166C3-A056-E496-F2AC-147A432F8FCA}"/>
                  </a:ext>
                </a:extLst>
              </p:cNvPr>
              <p:cNvSpPr/>
              <p:nvPr/>
            </p:nvSpPr>
            <p:spPr>
              <a:xfrm rot="16732380">
                <a:off x="5809991" y="1722395"/>
                <a:ext cx="231907" cy="266794"/>
              </a:xfrm>
              <a:prstGeom prst="arc">
                <a:avLst>
                  <a:gd name="adj1" fmla="val 16200000"/>
                  <a:gd name="adj2" fmla="val 1301975"/>
                </a:avLst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/>
              </a:p>
            </p:txBody>
          </p:sp>
        </p:grpSp>
        <p:sp>
          <p:nvSpPr>
            <p:cNvPr id="80" name="矢印: 右 79">
              <a:extLst>
                <a:ext uri="{FF2B5EF4-FFF2-40B4-BE49-F238E27FC236}">
                  <a16:creationId xmlns:a16="http://schemas.microsoft.com/office/drawing/2014/main" xmlns="" id="{0DE8198E-328F-F77F-2A2F-76A4902EAC06}"/>
                </a:ext>
              </a:extLst>
            </p:cNvPr>
            <p:cNvSpPr/>
            <p:nvPr/>
          </p:nvSpPr>
          <p:spPr>
            <a:xfrm rot="19823011">
              <a:off x="5701970" y="3405724"/>
              <a:ext cx="257679" cy="158715"/>
            </a:xfrm>
            <a:prstGeom prst="rightArrow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81" name="矢印: 右 80">
              <a:extLst>
                <a:ext uri="{FF2B5EF4-FFF2-40B4-BE49-F238E27FC236}">
                  <a16:creationId xmlns:a16="http://schemas.microsoft.com/office/drawing/2014/main" xmlns="" id="{A2550719-F0FB-1001-6D73-EE7C34FDE098}"/>
                </a:ext>
              </a:extLst>
            </p:cNvPr>
            <p:cNvSpPr/>
            <p:nvPr/>
          </p:nvSpPr>
          <p:spPr>
            <a:xfrm rot="19823011">
              <a:off x="5674117" y="2739140"/>
              <a:ext cx="257679" cy="158715"/>
            </a:xfrm>
            <a:prstGeom prst="rightArrow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xmlns="" id="{B507C173-4D51-1BD8-BECA-9A5680D1810C}"/>
                </a:ext>
              </a:extLst>
            </p:cNvPr>
            <p:cNvSpPr txBox="1"/>
            <p:nvPr/>
          </p:nvSpPr>
          <p:spPr>
            <a:xfrm>
              <a:off x="-34407" y="1650558"/>
              <a:ext cx="1282339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poA2-ATQ/AT</a:t>
              </a:r>
            </a:p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ntermediate</a:t>
              </a:r>
            </a:p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isoform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xmlns="" id="{C01EDE3F-D3FB-66B9-588E-0DD34A2C9D7E}"/>
                </a:ext>
              </a:extLst>
            </p:cNvPr>
            <p:cNvSpPr txBox="1"/>
            <p:nvPr/>
          </p:nvSpPr>
          <p:spPr>
            <a:xfrm>
              <a:off x="-34407" y="3072239"/>
              <a:ext cx="117051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poA2-AT/AT</a:t>
              </a:r>
            </a:p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ight isoform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矢印: 右 83">
              <a:extLst>
                <a:ext uri="{FF2B5EF4-FFF2-40B4-BE49-F238E27FC236}">
                  <a16:creationId xmlns:a16="http://schemas.microsoft.com/office/drawing/2014/main" xmlns="" id="{6980FE64-BC2C-731F-6392-202480A5D603}"/>
                </a:ext>
              </a:extLst>
            </p:cNvPr>
            <p:cNvSpPr/>
            <p:nvPr/>
          </p:nvSpPr>
          <p:spPr>
            <a:xfrm>
              <a:off x="1605138" y="4546570"/>
              <a:ext cx="198558" cy="258480"/>
            </a:xfrm>
            <a:prstGeom prst="rightArrow">
              <a:avLst>
                <a:gd name="adj1" fmla="val 50000"/>
                <a:gd name="adj2" fmla="val 42325"/>
              </a:avLst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5" name="矢印: 右 84">
              <a:extLst>
                <a:ext uri="{FF2B5EF4-FFF2-40B4-BE49-F238E27FC236}">
                  <a16:creationId xmlns:a16="http://schemas.microsoft.com/office/drawing/2014/main" xmlns="" id="{25E5A620-F419-7D56-3348-CB35367ABC69}"/>
                </a:ext>
              </a:extLst>
            </p:cNvPr>
            <p:cNvSpPr/>
            <p:nvPr/>
          </p:nvSpPr>
          <p:spPr>
            <a:xfrm>
              <a:off x="3064244" y="4533582"/>
              <a:ext cx="198558" cy="258480"/>
            </a:xfrm>
            <a:prstGeom prst="rightArrow">
              <a:avLst>
                <a:gd name="adj1" fmla="val 50000"/>
                <a:gd name="adj2" fmla="val 42325"/>
              </a:avLst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6" name="矢印: 右 85">
              <a:extLst>
                <a:ext uri="{FF2B5EF4-FFF2-40B4-BE49-F238E27FC236}">
                  <a16:creationId xmlns:a16="http://schemas.microsoft.com/office/drawing/2014/main" xmlns="" id="{FC240A51-9080-9830-6329-7D988A7885FB}"/>
                </a:ext>
              </a:extLst>
            </p:cNvPr>
            <p:cNvSpPr/>
            <p:nvPr/>
          </p:nvSpPr>
          <p:spPr>
            <a:xfrm>
              <a:off x="4731272" y="4524700"/>
              <a:ext cx="198558" cy="258480"/>
            </a:xfrm>
            <a:prstGeom prst="rightArrow">
              <a:avLst>
                <a:gd name="adj1" fmla="val 50000"/>
                <a:gd name="adj2" fmla="val 42325"/>
              </a:avLst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7" name="二等辺三角形 86">
              <a:extLst>
                <a:ext uri="{FF2B5EF4-FFF2-40B4-BE49-F238E27FC236}">
                  <a16:creationId xmlns:a16="http://schemas.microsoft.com/office/drawing/2014/main" xmlns="" id="{B855CEF8-7DB3-2C94-7D01-96ECC7D96096}"/>
                </a:ext>
              </a:extLst>
            </p:cNvPr>
            <p:cNvSpPr/>
            <p:nvPr/>
          </p:nvSpPr>
          <p:spPr>
            <a:xfrm rot="5400000">
              <a:off x="3225908" y="2265806"/>
              <a:ext cx="860247" cy="5998767"/>
            </a:xfrm>
            <a:prstGeom prst="triangle">
              <a:avLst>
                <a:gd name="adj" fmla="val 100000"/>
              </a:avLst>
            </a:prstGeom>
            <a:gradFill flip="none" rotWithShape="1">
              <a:gsLst>
                <a:gs pos="63000">
                  <a:schemeClr val="accent2">
                    <a:lumMod val="0"/>
                    <a:lumOff val="100000"/>
                  </a:schemeClr>
                </a:gs>
                <a:gs pos="100000">
                  <a:schemeClr val="accent6">
                    <a:lumMod val="20000"/>
                    <a:lumOff val="80000"/>
                  </a:schemeClr>
                </a:gs>
                <a:gs pos="64000">
                  <a:schemeClr val="accent6">
                    <a:lumMod val="20000"/>
                    <a:lumOff val="80000"/>
                  </a:schemeClr>
                </a:gs>
                <a:gs pos="31000">
                  <a:srgbClr val="FFFFFF"/>
                </a:gs>
                <a:gs pos="53000">
                  <a:srgbClr val="FFFFFF"/>
                </a:gs>
                <a:gs pos="76000">
                  <a:schemeClr val="accent2"/>
                </a:gs>
              </a:gsLst>
              <a:path path="circle">
                <a:fillToRect l="50000" t="-80000" r="50000" b="180000"/>
              </a:path>
              <a:tileRect/>
            </a:gradFill>
            <a:ln>
              <a:solidFill>
                <a:schemeClr val="accent1">
                  <a:shade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xmlns="" id="{3F37C28E-1D76-2BD7-8184-638B7CDCCC78}"/>
                </a:ext>
              </a:extLst>
            </p:cNvPr>
            <p:cNvSpPr txBox="1"/>
            <p:nvPr/>
          </p:nvSpPr>
          <p:spPr>
            <a:xfrm>
              <a:off x="866755" y="5207098"/>
              <a:ext cx="3466952" cy="523220"/>
            </a:xfrm>
            <a:prstGeom prst="rect">
              <a:avLst/>
            </a:prstGeom>
            <a:noFill/>
            <a:effectLst>
              <a:outerShdw blurRad="38100" dist="50800" dir="6120000" algn="ctr" rotWithShape="0">
                <a:schemeClr val="bg1"/>
              </a:outerShdw>
            </a:effectLst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kumimoji="1" lang="en-US" altLang="ja-JP" sz="1400" b="1" dirty="0">
                  <a:solidFill>
                    <a:srgbClr val="0046D2"/>
                  </a:solidFill>
                  <a:effectLst>
                    <a:outerShdw blurRad="38100" dir="5400000" algn="ctr" rotWithShape="0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ea typeface="游ゴシック"/>
                  <a:cs typeface="Arial" panose="020B0604020202020204" pitchFamily="34" charset="0"/>
                </a:rPr>
                <a:t>Leakage of pancreatic enzymes</a:t>
              </a:r>
              <a:endParaRPr kumimoji="1" lang="ja-JP" altLang="en-US" sz="1400" b="1" dirty="0">
                <a:solidFill>
                  <a:srgbClr val="0046D2"/>
                </a:solidFill>
                <a:effectLst>
                  <a:outerShdw blurRad="38100" dir="5400000" algn="ctr" rotWithShape="0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游ゴシック"/>
                <a:cs typeface="Arial" panose="020B0604020202020204" pitchFamily="34" charset="0"/>
              </a:endParaRPr>
            </a:p>
            <a:p>
              <a:pPr algn="ctr"/>
              <a:r>
                <a:rPr kumimoji="1" lang="en-US" altLang="ja-JP" sz="1400" b="1" dirty="0">
                  <a:solidFill>
                    <a:srgbClr val="0046D2"/>
                  </a:solidFill>
                  <a:effectLst>
                    <a:outerShdw blurRad="38100" dir="5400000" algn="ctr" rotWithShape="0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ea typeface="游ゴシック"/>
                  <a:cs typeface="Arial" panose="020B0604020202020204" pitchFamily="34" charset="0"/>
                </a:rPr>
                <a:t>into the blood stream</a:t>
              </a:r>
              <a:endParaRPr lang="ja-JP" altLang="en-US" sz="1400" b="1" dirty="0">
                <a:solidFill>
                  <a:srgbClr val="0046D2"/>
                </a:solidFill>
                <a:effectLst>
                  <a:outerShdw blurRad="38100" dir="5400000" algn="ctr" rotWithShape="0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ea typeface="游ゴシック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xmlns="" id="{6F04719C-1F79-AC91-33A8-9F32F202DB02}"/>
                </a:ext>
              </a:extLst>
            </p:cNvPr>
            <p:cNvSpPr txBox="1"/>
            <p:nvPr/>
          </p:nvSpPr>
          <p:spPr>
            <a:xfrm>
              <a:off x="-223521" y="6031799"/>
              <a:ext cx="25755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alance of apoA2-isoforms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二等辺三角形 89">
              <a:extLst>
                <a:ext uri="{FF2B5EF4-FFF2-40B4-BE49-F238E27FC236}">
                  <a16:creationId xmlns:a16="http://schemas.microsoft.com/office/drawing/2014/main" xmlns="" id="{DB9C8520-C8EB-0A97-00DF-1859E9D00F9C}"/>
                </a:ext>
              </a:extLst>
            </p:cNvPr>
            <p:cNvSpPr/>
            <p:nvPr/>
          </p:nvSpPr>
          <p:spPr>
            <a:xfrm>
              <a:off x="977866" y="8184364"/>
              <a:ext cx="375348" cy="413578"/>
            </a:xfrm>
            <a:prstGeom prst="triangle">
              <a:avLst>
                <a:gd name="adj" fmla="val 48068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xmlns="" id="{E3C60249-7825-0443-CC10-0D038BDFAB51}"/>
                </a:ext>
              </a:extLst>
            </p:cNvPr>
            <p:cNvSpPr/>
            <p:nvPr/>
          </p:nvSpPr>
          <p:spPr>
            <a:xfrm>
              <a:off x="656646" y="7903608"/>
              <a:ext cx="1054302" cy="13637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四角形: 角を丸くする 91">
              <a:extLst>
                <a:ext uri="{FF2B5EF4-FFF2-40B4-BE49-F238E27FC236}">
                  <a16:creationId xmlns:a16="http://schemas.microsoft.com/office/drawing/2014/main" xmlns="" id="{ACFBC7D4-0734-334C-085C-CE3AA1E2906D}"/>
                </a:ext>
              </a:extLst>
            </p:cNvPr>
            <p:cNvSpPr/>
            <p:nvPr/>
          </p:nvSpPr>
          <p:spPr>
            <a:xfrm>
              <a:off x="190305" y="7273857"/>
              <a:ext cx="873937" cy="606517"/>
            </a:xfrm>
            <a:prstGeom prst="roundRect">
              <a:avLst/>
            </a:prstGeom>
            <a:solidFill>
              <a:srgbClr val="070BB7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T/AT</a:t>
              </a:r>
              <a:endParaRPr kumimoji="1" lang="ja-JP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四角形: 角を丸くする 92">
              <a:extLst>
                <a:ext uri="{FF2B5EF4-FFF2-40B4-BE49-F238E27FC236}">
                  <a16:creationId xmlns:a16="http://schemas.microsoft.com/office/drawing/2014/main" xmlns="" id="{54EB1C90-3BE8-BB7A-6FA1-23D11E486B5C}"/>
                </a:ext>
              </a:extLst>
            </p:cNvPr>
            <p:cNvSpPr/>
            <p:nvPr/>
          </p:nvSpPr>
          <p:spPr>
            <a:xfrm>
              <a:off x="1165152" y="7273859"/>
              <a:ext cx="873937" cy="606517"/>
            </a:xfrm>
            <a:prstGeom prst="round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TQ/ATQ</a:t>
              </a:r>
              <a:endParaRPr kumimoji="1" lang="ja-JP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四角形: 角を丸くする 93">
              <a:extLst>
                <a:ext uri="{FF2B5EF4-FFF2-40B4-BE49-F238E27FC236}">
                  <a16:creationId xmlns:a16="http://schemas.microsoft.com/office/drawing/2014/main" xmlns="" id="{80BD4F9B-3268-6736-8966-707C93EF0D53}"/>
                </a:ext>
              </a:extLst>
            </p:cNvPr>
            <p:cNvSpPr/>
            <p:nvPr/>
          </p:nvSpPr>
          <p:spPr>
            <a:xfrm>
              <a:off x="633861" y="6631695"/>
              <a:ext cx="960600" cy="606517"/>
            </a:xfrm>
            <a:prstGeom prst="round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TQ/AT</a:t>
              </a:r>
              <a:endParaRPr kumimoji="1" lang="ja-JP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円弧 94">
              <a:extLst>
                <a:ext uri="{FF2B5EF4-FFF2-40B4-BE49-F238E27FC236}">
                  <a16:creationId xmlns:a16="http://schemas.microsoft.com/office/drawing/2014/main" xmlns="" id="{9A106709-4FCD-35A6-C771-879C6BA46D99}"/>
                </a:ext>
              </a:extLst>
            </p:cNvPr>
            <p:cNvSpPr/>
            <p:nvPr/>
          </p:nvSpPr>
          <p:spPr>
            <a:xfrm>
              <a:off x="1851021" y="7184862"/>
              <a:ext cx="179031" cy="120146"/>
            </a:xfrm>
            <a:prstGeom prst="arc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円弧 95">
              <a:extLst>
                <a:ext uri="{FF2B5EF4-FFF2-40B4-BE49-F238E27FC236}">
                  <a16:creationId xmlns:a16="http://schemas.microsoft.com/office/drawing/2014/main" xmlns="" id="{F31E8645-6FDC-4B56-591B-D79A3149CE5C}"/>
                </a:ext>
              </a:extLst>
            </p:cNvPr>
            <p:cNvSpPr/>
            <p:nvPr/>
          </p:nvSpPr>
          <p:spPr>
            <a:xfrm>
              <a:off x="1910171" y="7115484"/>
              <a:ext cx="209649" cy="173951"/>
            </a:xfrm>
            <a:prstGeom prst="arc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円弧 96">
              <a:extLst>
                <a:ext uri="{FF2B5EF4-FFF2-40B4-BE49-F238E27FC236}">
                  <a16:creationId xmlns:a16="http://schemas.microsoft.com/office/drawing/2014/main" xmlns="" id="{25E8DD4D-92C3-ABC9-B90E-65281A97B92D}"/>
                </a:ext>
              </a:extLst>
            </p:cNvPr>
            <p:cNvSpPr/>
            <p:nvPr/>
          </p:nvSpPr>
          <p:spPr>
            <a:xfrm rot="16732380">
              <a:off x="80745" y="7194281"/>
              <a:ext cx="226580" cy="236487"/>
            </a:xfrm>
            <a:prstGeom prst="arc">
              <a:avLst>
                <a:gd name="adj1" fmla="val 16200000"/>
                <a:gd name="adj2" fmla="val 1301975"/>
              </a:avLst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円弧 97">
              <a:extLst>
                <a:ext uri="{FF2B5EF4-FFF2-40B4-BE49-F238E27FC236}">
                  <a16:creationId xmlns:a16="http://schemas.microsoft.com/office/drawing/2014/main" xmlns="" id="{8DE8AC89-CE6A-33CD-4C79-8BAD34F25678}"/>
                </a:ext>
              </a:extLst>
            </p:cNvPr>
            <p:cNvSpPr/>
            <p:nvPr/>
          </p:nvSpPr>
          <p:spPr>
            <a:xfrm rot="16732380">
              <a:off x="42628" y="7119967"/>
              <a:ext cx="226580" cy="236487"/>
            </a:xfrm>
            <a:prstGeom prst="arc">
              <a:avLst>
                <a:gd name="adj1" fmla="val 16200000"/>
                <a:gd name="adj2" fmla="val 1301975"/>
              </a:avLst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二等辺三角形 98">
              <a:extLst>
                <a:ext uri="{FF2B5EF4-FFF2-40B4-BE49-F238E27FC236}">
                  <a16:creationId xmlns:a16="http://schemas.microsoft.com/office/drawing/2014/main" xmlns="" id="{BECE95C3-1E45-4A54-0324-C29181C890A1}"/>
                </a:ext>
              </a:extLst>
            </p:cNvPr>
            <p:cNvSpPr/>
            <p:nvPr/>
          </p:nvSpPr>
          <p:spPr>
            <a:xfrm>
              <a:off x="3305683" y="8174943"/>
              <a:ext cx="394400" cy="423000"/>
            </a:xfrm>
            <a:prstGeom prst="triangle">
              <a:avLst>
                <a:gd name="adj" fmla="val 48068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正方形/長方形 99">
              <a:extLst>
                <a:ext uri="{FF2B5EF4-FFF2-40B4-BE49-F238E27FC236}">
                  <a16:creationId xmlns:a16="http://schemas.microsoft.com/office/drawing/2014/main" xmlns="" id="{A8B84B4B-9300-3A8B-D8BE-21345C52290C}"/>
                </a:ext>
              </a:extLst>
            </p:cNvPr>
            <p:cNvSpPr/>
            <p:nvPr/>
          </p:nvSpPr>
          <p:spPr>
            <a:xfrm rot="19425798">
              <a:off x="2887907" y="8031731"/>
              <a:ext cx="1107817" cy="13948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四角形: 角を丸くする 100">
              <a:extLst>
                <a:ext uri="{FF2B5EF4-FFF2-40B4-BE49-F238E27FC236}">
                  <a16:creationId xmlns:a16="http://schemas.microsoft.com/office/drawing/2014/main" xmlns="" id="{D8C47C83-D51B-2BF2-FACE-0BBE8ADF636E}"/>
                </a:ext>
              </a:extLst>
            </p:cNvPr>
            <p:cNvSpPr/>
            <p:nvPr/>
          </p:nvSpPr>
          <p:spPr>
            <a:xfrm>
              <a:off x="3502883" y="7425326"/>
              <a:ext cx="931210" cy="282445"/>
            </a:xfrm>
            <a:prstGeom prst="round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TQ/ATQ</a:t>
              </a:r>
              <a:endParaRPr kumimoji="1" lang="ja-JP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四角形: 角を丸くする 101">
              <a:extLst>
                <a:ext uri="{FF2B5EF4-FFF2-40B4-BE49-F238E27FC236}">
                  <a16:creationId xmlns:a16="http://schemas.microsoft.com/office/drawing/2014/main" xmlns="" id="{5C9F728E-0BC9-F07E-EA36-66E5C1A27EF1}"/>
                </a:ext>
              </a:extLst>
            </p:cNvPr>
            <p:cNvSpPr/>
            <p:nvPr/>
          </p:nvSpPr>
          <p:spPr>
            <a:xfrm>
              <a:off x="2973250" y="7044756"/>
              <a:ext cx="854089" cy="272904"/>
            </a:xfrm>
            <a:prstGeom prst="round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TQ/AT</a:t>
              </a:r>
              <a:endParaRPr kumimoji="1" lang="ja-JP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" name="Picture 2" descr="ソース画像を表示">
              <a:extLst>
                <a:ext uri="{FF2B5EF4-FFF2-40B4-BE49-F238E27FC236}">
                  <a16:creationId xmlns:a16="http://schemas.microsoft.com/office/drawing/2014/main" xmlns="" id="{F9CEC086-5AD4-24F8-136E-AD21FF01744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45985" y="6909252"/>
              <a:ext cx="399458" cy="3991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4" name="Picture 2" descr="ソース画像を表示">
              <a:extLst>
                <a:ext uri="{FF2B5EF4-FFF2-40B4-BE49-F238E27FC236}">
                  <a16:creationId xmlns:a16="http://schemas.microsoft.com/office/drawing/2014/main" xmlns="" id="{C83BA8B6-3A4C-C62B-D02D-1FBE5AB057E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93101" y="6861364"/>
              <a:ext cx="399458" cy="3991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5" name="Picture 2" descr="ソース画像を表示">
              <a:extLst>
                <a:ext uri="{FF2B5EF4-FFF2-40B4-BE49-F238E27FC236}">
                  <a16:creationId xmlns:a16="http://schemas.microsoft.com/office/drawing/2014/main" xmlns="" id="{D5E31E5D-C8AF-6E24-15E5-F29E10BF6FE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75306" y="6508560"/>
              <a:ext cx="399458" cy="3991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6" name="グループ化 105">
              <a:extLst>
                <a:ext uri="{FF2B5EF4-FFF2-40B4-BE49-F238E27FC236}">
                  <a16:creationId xmlns:a16="http://schemas.microsoft.com/office/drawing/2014/main" xmlns="" id="{5A16FBA5-1A42-1420-D247-6B1B6789E6D4}"/>
                </a:ext>
              </a:extLst>
            </p:cNvPr>
            <p:cNvGrpSpPr/>
            <p:nvPr/>
          </p:nvGrpSpPr>
          <p:grpSpPr>
            <a:xfrm>
              <a:off x="3163477" y="5972362"/>
              <a:ext cx="841611" cy="501740"/>
              <a:chOff x="4003788" y="6293836"/>
              <a:chExt cx="931579" cy="596772"/>
            </a:xfrm>
          </p:grpSpPr>
          <p:sp>
            <p:nvSpPr>
              <p:cNvPr id="143" name="テキスト ボックス 142">
                <a:extLst>
                  <a:ext uri="{FF2B5EF4-FFF2-40B4-BE49-F238E27FC236}">
                    <a16:creationId xmlns:a16="http://schemas.microsoft.com/office/drawing/2014/main" xmlns="" id="{D808F484-5806-0910-3936-B3DAFAC2554F}"/>
                  </a:ext>
                </a:extLst>
              </p:cNvPr>
              <p:cNvSpPr txBox="1"/>
              <p:nvPr/>
            </p:nvSpPr>
            <p:spPr>
              <a:xfrm>
                <a:off x="4275095" y="6588599"/>
                <a:ext cx="319741" cy="3020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endParaRPr kumimoji="1" lang="ja-JP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楕円 143">
                <a:extLst>
                  <a:ext uri="{FF2B5EF4-FFF2-40B4-BE49-F238E27FC236}">
                    <a16:creationId xmlns:a16="http://schemas.microsoft.com/office/drawing/2014/main" xmlns="" id="{83EEBA5A-E158-8FA2-669B-EE155B2993EA}"/>
                  </a:ext>
                </a:extLst>
              </p:cNvPr>
              <p:cNvSpPr/>
              <p:nvPr/>
            </p:nvSpPr>
            <p:spPr>
              <a:xfrm>
                <a:off x="4300879" y="6588599"/>
                <a:ext cx="250705" cy="273761"/>
              </a:xfrm>
              <a:prstGeom prst="ellipse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/>
              </a:p>
            </p:txBody>
          </p:sp>
          <p:pic>
            <p:nvPicPr>
              <p:cNvPr id="145" name="Picture 4" descr="ソース画像を表示">
                <a:extLst>
                  <a:ext uri="{FF2B5EF4-FFF2-40B4-BE49-F238E27FC236}">
                    <a16:creationId xmlns:a16="http://schemas.microsoft.com/office/drawing/2014/main" xmlns="" id="{DE7E2F0A-0BE9-52B0-0AD7-4DCDD62C30A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64" t="22330" b="16505"/>
              <a:stretch/>
            </p:blipFill>
            <p:spPr bwMode="auto">
              <a:xfrm>
                <a:off x="4551584" y="6466140"/>
                <a:ext cx="236483" cy="30443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6" name="Picture 4" descr="ソース画像を表示">
                <a:extLst>
                  <a:ext uri="{FF2B5EF4-FFF2-40B4-BE49-F238E27FC236}">
                    <a16:creationId xmlns:a16="http://schemas.microsoft.com/office/drawing/2014/main" xmlns="" id="{252DA67D-23B1-540D-6A88-FB5CD0981FB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64" t="22330" b="16505"/>
              <a:stretch/>
            </p:blipFill>
            <p:spPr bwMode="auto">
              <a:xfrm flipH="1">
                <a:off x="4081714" y="6466140"/>
                <a:ext cx="206034" cy="30443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47" name="円弧 146">
                <a:extLst>
                  <a:ext uri="{FF2B5EF4-FFF2-40B4-BE49-F238E27FC236}">
                    <a16:creationId xmlns:a16="http://schemas.microsoft.com/office/drawing/2014/main" xmlns="" id="{F1C820F1-F717-4195-6E6E-AA835808D448}"/>
                  </a:ext>
                </a:extLst>
              </p:cNvPr>
              <p:cNvSpPr/>
              <p:nvPr/>
            </p:nvSpPr>
            <p:spPr>
              <a:xfrm>
                <a:off x="4652924" y="6397784"/>
                <a:ext cx="188118" cy="122971"/>
              </a:xfrm>
              <a:prstGeom prst="arc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円弧 147">
                <a:extLst>
                  <a:ext uri="{FF2B5EF4-FFF2-40B4-BE49-F238E27FC236}">
                    <a16:creationId xmlns:a16="http://schemas.microsoft.com/office/drawing/2014/main" xmlns="" id="{B391E0BD-C339-4E52-7C55-3DB5DAC29C21}"/>
                  </a:ext>
                </a:extLst>
              </p:cNvPr>
              <p:cNvSpPr/>
              <p:nvPr/>
            </p:nvSpPr>
            <p:spPr>
              <a:xfrm>
                <a:off x="4715077" y="6326773"/>
                <a:ext cx="220290" cy="178041"/>
              </a:xfrm>
              <a:prstGeom prst="arc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円弧 148">
                <a:extLst>
                  <a:ext uri="{FF2B5EF4-FFF2-40B4-BE49-F238E27FC236}">
                    <a16:creationId xmlns:a16="http://schemas.microsoft.com/office/drawing/2014/main" xmlns="" id="{1B13E2CA-09D8-1F1C-080A-17E276EECD75}"/>
                  </a:ext>
                </a:extLst>
              </p:cNvPr>
              <p:cNvSpPr/>
              <p:nvPr/>
            </p:nvSpPr>
            <p:spPr>
              <a:xfrm rot="16732380">
                <a:off x="4036237" y="6376214"/>
                <a:ext cx="231907" cy="248491"/>
              </a:xfrm>
              <a:prstGeom prst="arc">
                <a:avLst>
                  <a:gd name="adj1" fmla="val 16200000"/>
                  <a:gd name="adj2" fmla="val 1301975"/>
                </a:avLst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円弧 149">
                <a:extLst>
                  <a:ext uri="{FF2B5EF4-FFF2-40B4-BE49-F238E27FC236}">
                    <a16:creationId xmlns:a16="http://schemas.microsoft.com/office/drawing/2014/main" xmlns="" id="{2C12034B-E1F8-6CCC-D96A-8A1CD6D6E40D}"/>
                  </a:ext>
                </a:extLst>
              </p:cNvPr>
              <p:cNvSpPr/>
              <p:nvPr/>
            </p:nvSpPr>
            <p:spPr>
              <a:xfrm rot="16732380">
                <a:off x="4012080" y="6285544"/>
                <a:ext cx="231907" cy="248491"/>
              </a:xfrm>
              <a:prstGeom prst="arc">
                <a:avLst>
                  <a:gd name="adj1" fmla="val 16200000"/>
                  <a:gd name="adj2" fmla="val 1301975"/>
                </a:avLst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7" name="グループ化 106">
              <a:extLst>
                <a:ext uri="{FF2B5EF4-FFF2-40B4-BE49-F238E27FC236}">
                  <a16:creationId xmlns:a16="http://schemas.microsoft.com/office/drawing/2014/main" xmlns="" id="{6C669AA3-7B0C-5F80-B6E0-A6530B127E4F}"/>
                </a:ext>
              </a:extLst>
            </p:cNvPr>
            <p:cNvGrpSpPr/>
            <p:nvPr/>
          </p:nvGrpSpPr>
          <p:grpSpPr>
            <a:xfrm>
              <a:off x="3724134" y="6358116"/>
              <a:ext cx="778000" cy="498234"/>
              <a:chOff x="4003788" y="6293836"/>
              <a:chExt cx="931579" cy="601106"/>
            </a:xfrm>
          </p:grpSpPr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xmlns="" id="{3C781F40-5A2C-EB9D-3D64-2FBAC77F2682}"/>
                  </a:ext>
                </a:extLst>
              </p:cNvPr>
              <p:cNvSpPr txBox="1"/>
              <p:nvPr/>
            </p:nvSpPr>
            <p:spPr>
              <a:xfrm>
                <a:off x="4275095" y="6588599"/>
                <a:ext cx="345884" cy="3063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endParaRPr kumimoji="1" lang="ja-JP" alt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楕円 135">
                <a:extLst>
                  <a:ext uri="{FF2B5EF4-FFF2-40B4-BE49-F238E27FC236}">
                    <a16:creationId xmlns:a16="http://schemas.microsoft.com/office/drawing/2014/main" xmlns="" id="{B1AA7167-596C-AF3C-DC03-2C6D8A865F3D}"/>
                  </a:ext>
                </a:extLst>
              </p:cNvPr>
              <p:cNvSpPr/>
              <p:nvPr/>
            </p:nvSpPr>
            <p:spPr>
              <a:xfrm>
                <a:off x="4300879" y="6588599"/>
                <a:ext cx="250705" cy="273761"/>
              </a:xfrm>
              <a:prstGeom prst="ellipse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/>
              </a:p>
            </p:txBody>
          </p:sp>
          <p:pic>
            <p:nvPicPr>
              <p:cNvPr id="137" name="Picture 4" descr="ソース画像を表示">
                <a:extLst>
                  <a:ext uri="{FF2B5EF4-FFF2-40B4-BE49-F238E27FC236}">
                    <a16:creationId xmlns:a16="http://schemas.microsoft.com/office/drawing/2014/main" xmlns="" id="{B0899739-F362-B7A5-CFAA-A97594266AC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64" t="22330" b="16505"/>
              <a:stretch/>
            </p:blipFill>
            <p:spPr bwMode="auto">
              <a:xfrm>
                <a:off x="4551584" y="6466140"/>
                <a:ext cx="236483" cy="30443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8" name="Picture 4" descr="ソース画像を表示">
                <a:extLst>
                  <a:ext uri="{FF2B5EF4-FFF2-40B4-BE49-F238E27FC236}">
                    <a16:creationId xmlns:a16="http://schemas.microsoft.com/office/drawing/2014/main" xmlns="" id="{0232C031-5794-8C88-D7A4-CC6A2F6ECB2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64" t="22330" b="16505"/>
              <a:stretch/>
            </p:blipFill>
            <p:spPr bwMode="auto">
              <a:xfrm flipH="1">
                <a:off x="4081714" y="6466140"/>
                <a:ext cx="206034" cy="30443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39" name="円弧 138">
                <a:extLst>
                  <a:ext uri="{FF2B5EF4-FFF2-40B4-BE49-F238E27FC236}">
                    <a16:creationId xmlns:a16="http://schemas.microsoft.com/office/drawing/2014/main" xmlns="" id="{56E00F03-EE9C-3E53-863C-F63B0DD2F81F}"/>
                  </a:ext>
                </a:extLst>
              </p:cNvPr>
              <p:cNvSpPr/>
              <p:nvPr/>
            </p:nvSpPr>
            <p:spPr>
              <a:xfrm>
                <a:off x="4652924" y="6397784"/>
                <a:ext cx="188118" cy="122971"/>
              </a:xfrm>
              <a:prstGeom prst="arc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円弧 139">
                <a:extLst>
                  <a:ext uri="{FF2B5EF4-FFF2-40B4-BE49-F238E27FC236}">
                    <a16:creationId xmlns:a16="http://schemas.microsoft.com/office/drawing/2014/main" xmlns="" id="{EEBFE36D-0259-2C63-4808-82C653DCB626}"/>
                  </a:ext>
                </a:extLst>
              </p:cNvPr>
              <p:cNvSpPr/>
              <p:nvPr/>
            </p:nvSpPr>
            <p:spPr>
              <a:xfrm>
                <a:off x="4715077" y="6326773"/>
                <a:ext cx="220290" cy="178041"/>
              </a:xfrm>
              <a:prstGeom prst="arc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円弧 140">
                <a:extLst>
                  <a:ext uri="{FF2B5EF4-FFF2-40B4-BE49-F238E27FC236}">
                    <a16:creationId xmlns:a16="http://schemas.microsoft.com/office/drawing/2014/main" xmlns="" id="{4AD57BB0-DE20-7E3F-4743-5C517CF1168E}"/>
                  </a:ext>
                </a:extLst>
              </p:cNvPr>
              <p:cNvSpPr/>
              <p:nvPr/>
            </p:nvSpPr>
            <p:spPr>
              <a:xfrm rot="16732380">
                <a:off x="4036237" y="6376214"/>
                <a:ext cx="231907" cy="248491"/>
              </a:xfrm>
              <a:prstGeom prst="arc">
                <a:avLst>
                  <a:gd name="adj1" fmla="val 16200000"/>
                  <a:gd name="adj2" fmla="val 1301975"/>
                </a:avLst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円弧 141">
                <a:extLst>
                  <a:ext uri="{FF2B5EF4-FFF2-40B4-BE49-F238E27FC236}">
                    <a16:creationId xmlns:a16="http://schemas.microsoft.com/office/drawing/2014/main" xmlns="" id="{C4B58B0D-90F6-5F28-05C0-47FB4713F7E1}"/>
                  </a:ext>
                </a:extLst>
              </p:cNvPr>
              <p:cNvSpPr/>
              <p:nvPr/>
            </p:nvSpPr>
            <p:spPr>
              <a:xfrm rot="16732380">
                <a:off x="4012080" y="6285544"/>
                <a:ext cx="231907" cy="248491"/>
              </a:xfrm>
              <a:prstGeom prst="arc">
                <a:avLst>
                  <a:gd name="adj1" fmla="val 16200000"/>
                  <a:gd name="adj2" fmla="val 1301975"/>
                </a:avLst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8" name="二等辺三角形 107">
              <a:extLst>
                <a:ext uri="{FF2B5EF4-FFF2-40B4-BE49-F238E27FC236}">
                  <a16:creationId xmlns:a16="http://schemas.microsoft.com/office/drawing/2014/main" xmlns="" id="{0A9E9BE8-9593-AC97-F0A8-7F2B7FEEEBCC}"/>
                </a:ext>
              </a:extLst>
            </p:cNvPr>
            <p:cNvSpPr/>
            <p:nvPr/>
          </p:nvSpPr>
          <p:spPr>
            <a:xfrm>
              <a:off x="5437524" y="8169638"/>
              <a:ext cx="394400" cy="428305"/>
            </a:xfrm>
            <a:prstGeom prst="triangle">
              <a:avLst>
                <a:gd name="adj" fmla="val 48068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四角形: 角を丸くする 108">
              <a:extLst>
                <a:ext uri="{FF2B5EF4-FFF2-40B4-BE49-F238E27FC236}">
                  <a16:creationId xmlns:a16="http://schemas.microsoft.com/office/drawing/2014/main" xmlns="" id="{1B566F20-D3D3-BF26-B434-191C252B0E66}"/>
                </a:ext>
              </a:extLst>
            </p:cNvPr>
            <p:cNvSpPr/>
            <p:nvPr/>
          </p:nvSpPr>
          <p:spPr>
            <a:xfrm>
              <a:off x="4708165" y="7412434"/>
              <a:ext cx="918297" cy="275393"/>
            </a:xfrm>
            <a:prstGeom prst="roundRect">
              <a:avLst/>
            </a:prstGeom>
            <a:solidFill>
              <a:srgbClr val="070BB7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T/AT</a:t>
              </a:r>
              <a:endParaRPr kumimoji="1" lang="ja-JP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四角形: 角を丸くする 109">
              <a:extLst>
                <a:ext uri="{FF2B5EF4-FFF2-40B4-BE49-F238E27FC236}">
                  <a16:creationId xmlns:a16="http://schemas.microsoft.com/office/drawing/2014/main" xmlns="" id="{CFD3F9BA-DF8B-8B6A-088B-357BEE824020}"/>
                </a:ext>
              </a:extLst>
            </p:cNvPr>
            <p:cNvSpPr/>
            <p:nvPr/>
          </p:nvSpPr>
          <p:spPr>
            <a:xfrm>
              <a:off x="5843845" y="7445105"/>
              <a:ext cx="944578" cy="754444"/>
            </a:xfrm>
            <a:prstGeom prst="round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TQ/ATQ</a:t>
              </a:r>
              <a:endParaRPr kumimoji="1" lang="ja-JP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1" name="Picture 6" descr="ハサミ禁止のイラスト素材 - PIXTA">
              <a:extLst>
                <a:ext uri="{FF2B5EF4-FFF2-40B4-BE49-F238E27FC236}">
                  <a16:creationId xmlns:a16="http://schemas.microsoft.com/office/drawing/2014/main" xmlns="" id="{A1D32911-66FB-7F4F-12A4-196F9DABB3B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408" t="181" r="1552" b="53291"/>
            <a:stretch/>
          </p:blipFill>
          <p:spPr bwMode="auto">
            <a:xfrm>
              <a:off x="5904525" y="6241745"/>
              <a:ext cx="803756" cy="76193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xmlns="" id="{E1EC69ED-3E98-3839-5AC6-DA38E65F15FF}"/>
                </a:ext>
              </a:extLst>
            </p:cNvPr>
            <p:cNvCxnSpPr>
              <a:cxnSpLocks/>
            </p:cNvCxnSpPr>
            <p:nvPr/>
          </p:nvCxnSpPr>
          <p:spPr>
            <a:xfrm>
              <a:off x="1633727" y="1698081"/>
              <a:ext cx="2167527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xmlns="" id="{43383984-F72C-6189-79EC-81C15A0FCD0F}"/>
                </a:ext>
              </a:extLst>
            </p:cNvPr>
            <p:cNvSpPr txBox="1"/>
            <p:nvPr/>
          </p:nvSpPr>
          <p:spPr>
            <a:xfrm>
              <a:off x="1321882" y="1528804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xmlns="" id="{0597849D-E84B-505D-9DFA-502B2EDE9025}"/>
                </a:ext>
              </a:extLst>
            </p:cNvPr>
            <p:cNvSpPr txBox="1"/>
            <p:nvPr/>
          </p:nvSpPr>
          <p:spPr>
            <a:xfrm>
              <a:off x="1721220" y="1528804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xmlns="" id="{2523E6A3-D80F-7B16-619B-18EB9FD8C7CB}"/>
                </a:ext>
              </a:extLst>
            </p:cNvPr>
            <p:cNvSpPr txBox="1"/>
            <p:nvPr/>
          </p:nvSpPr>
          <p:spPr>
            <a:xfrm>
              <a:off x="2120560" y="1528804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xmlns="" id="{F66193E8-2C63-E82D-35A6-7528A75F8096}"/>
                </a:ext>
              </a:extLst>
            </p:cNvPr>
            <p:cNvSpPr txBox="1"/>
            <p:nvPr/>
          </p:nvSpPr>
          <p:spPr>
            <a:xfrm>
              <a:off x="2519899" y="1528804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xmlns="" id="{F88FA16A-EFAF-2D10-F17D-19FCFE37EDB3}"/>
                </a:ext>
              </a:extLst>
            </p:cNvPr>
            <p:cNvSpPr txBox="1"/>
            <p:nvPr/>
          </p:nvSpPr>
          <p:spPr>
            <a:xfrm>
              <a:off x="2908018" y="1528804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xmlns="" id="{9BF9EE75-0EB8-9650-D520-DF19A7E6C64E}"/>
                </a:ext>
              </a:extLst>
            </p:cNvPr>
            <p:cNvSpPr txBox="1"/>
            <p:nvPr/>
          </p:nvSpPr>
          <p:spPr>
            <a:xfrm>
              <a:off x="3296137" y="1528804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xmlns="" id="{8958CA17-BA9E-B56E-6252-B0EBFC63A35E}"/>
                </a:ext>
              </a:extLst>
            </p:cNvPr>
            <p:cNvSpPr txBox="1"/>
            <p:nvPr/>
          </p:nvSpPr>
          <p:spPr>
            <a:xfrm>
              <a:off x="3695476" y="1528804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xmlns="" id="{1E2F34FC-7643-5016-4CD3-1AE017326888}"/>
                </a:ext>
              </a:extLst>
            </p:cNvPr>
            <p:cNvCxnSpPr>
              <a:cxnSpLocks/>
            </p:cNvCxnSpPr>
            <p:nvPr/>
          </p:nvCxnSpPr>
          <p:spPr>
            <a:xfrm>
              <a:off x="1628156" y="2281061"/>
              <a:ext cx="2167527" cy="0"/>
            </a:xfrm>
            <a:prstGeom prst="line">
              <a:avLst/>
            </a:prstGeom>
            <a:ln w="508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xmlns="" id="{68024B4B-6E6E-AF69-318D-FE52F06B1B62}"/>
                </a:ext>
              </a:extLst>
            </p:cNvPr>
            <p:cNvSpPr txBox="1"/>
            <p:nvPr/>
          </p:nvSpPr>
          <p:spPr>
            <a:xfrm>
              <a:off x="1321882" y="2111784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xmlns="" id="{41030F4C-6270-BE69-C996-5F97FB989C70}"/>
                </a:ext>
              </a:extLst>
            </p:cNvPr>
            <p:cNvSpPr txBox="1"/>
            <p:nvPr/>
          </p:nvSpPr>
          <p:spPr>
            <a:xfrm>
              <a:off x="1721220" y="2111784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xmlns="" id="{6B950D0C-7C8C-6410-9AAD-7F9FCA14FFCA}"/>
                </a:ext>
              </a:extLst>
            </p:cNvPr>
            <p:cNvSpPr txBox="1"/>
            <p:nvPr/>
          </p:nvSpPr>
          <p:spPr>
            <a:xfrm>
              <a:off x="2120560" y="2111784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xmlns="" id="{D5A94902-6390-8ED9-0405-01103869EF5A}"/>
                </a:ext>
              </a:extLst>
            </p:cNvPr>
            <p:cNvSpPr txBox="1"/>
            <p:nvPr/>
          </p:nvSpPr>
          <p:spPr>
            <a:xfrm>
              <a:off x="2519899" y="2111784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xmlns="" id="{6305D8EC-AA6E-111E-9AA2-9755E26FE7B1}"/>
                </a:ext>
              </a:extLst>
            </p:cNvPr>
            <p:cNvSpPr txBox="1"/>
            <p:nvPr/>
          </p:nvSpPr>
          <p:spPr>
            <a:xfrm>
              <a:off x="2908018" y="2111784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xmlns="" id="{8380A61E-A730-AA8D-8D13-CB66D8088DEF}"/>
                </a:ext>
              </a:extLst>
            </p:cNvPr>
            <p:cNvSpPr txBox="1"/>
            <p:nvPr/>
          </p:nvSpPr>
          <p:spPr>
            <a:xfrm>
              <a:off x="3296137" y="2111784"/>
              <a:ext cx="33214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xmlns="" id="{431882B8-5E67-6C04-AB02-4FBF10F16ABA}"/>
                </a:ext>
              </a:extLst>
            </p:cNvPr>
            <p:cNvSpPr txBox="1"/>
            <p:nvPr/>
          </p:nvSpPr>
          <p:spPr>
            <a:xfrm>
              <a:off x="3695476" y="2111784"/>
              <a:ext cx="320922" cy="338554"/>
            </a:xfrm>
            <a:prstGeom prst="rect">
              <a:avLst/>
            </a:prstGeom>
            <a:solidFill>
              <a:srgbClr val="0046D2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xmlns="" id="{5C353171-E78B-3298-DB5A-CD196F1B2942}"/>
                </a:ext>
              </a:extLst>
            </p:cNvPr>
            <p:cNvSpPr txBox="1"/>
            <p:nvPr/>
          </p:nvSpPr>
          <p:spPr>
            <a:xfrm>
              <a:off x="219370" y="8605653"/>
              <a:ext cx="19330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Normal processing</a:t>
              </a:r>
              <a:endParaRPr kumimoji="1" lang="ja-JP" altLang="en-US" dirty="0"/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xmlns="" id="{B11DACDE-6DB2-2113-AFE9-32C28BFB1AD0}"/>
                </a:ext>
              </a:extLst>
            </p:cNvPr>
            <p:cNvSpPr txBox="1"/>
            <p:nvPr/>
          </p:nvSpPr>
          <p:spPr>
            <a:xfrm>
              <a:off x="2588051" y="8606528"/>
              <a:ext cx="18176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Hyper-processing</a:t>
              </a:r>
              <a:endParaRPr kumimoji="1" lang="ja-JP" altLang="en-US" dirty="0"/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xmlns="" id="{56C1332B-9088-64D0-EFBC-7F93945A6843}"/>
                </a:ext>
              </a:extLst>
            </p:cNvPr>
            <p:cNvSpPr txBox="1"/>
            <p:nvPr/>
          </p:nvSpPr>
          <p:spPr>
            <a:xfrm>
              <a:off x="4929831" y="8586851"/>
              <a:ext cx="17438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Hypo-processing</a:t>
              </a:r>
              <a:endParaRPr kumimoji="1" lang="ja-JP" altLang="en-US" dirty="0"/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xmlns="" id="{C5ABDF20-84D1-86EE-F701-22780C5C67A0}"/>
                </a:ext>
              </a:extLst>
            </p:cNvPr>
            <p:cNvSpPr txBox="1"/>
            <p:nvPr/>
          </p:nvSpPr>
          <p:spPr>
            <a:xfrm rot="16200000">
              <a:off x="-203911" y="5133552"/>
              <a:ext cx="1183661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xocrine </a:t>
              </a:r>
            </a:p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unction </a:t>
              </a:r>
              <a:endParaRPr lang="ja-JP" altLang="en-US" sz="1200" dirty="0"/>
            </a:p>
          </p:txBody>
        </p:sp>
        <p:sp>
          <p:nvSpPr>
            <p:cNvPr id="132" name="正方形/長方形 131">
              <a:extLst>
                <a:ext uri="{FF2B5EF4-FFF2-40B4-BE49-F238E27FC236}">
                  <a16:creationId xmlns:a16="http://schemas.microsoft.com/office/drawing/2014/main" xmlns="" id="{6E02A7CF-ED43-931A-B877-636AE3C5CE0F}"/>
                </a:ext>
              </a:extLst>
            </p:cNvPr>
            <p:cNvSpPr/>
            <p:nvPr/>
          </p:nvSpPr>
          <p:spPr>
            <a:xfrm rot="2174202" flipH="1">
              <a:off x="5132414" y="8031731"/>
              <a:ext cx="1107817" cy="13948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四角形: 角を丸くする 132">
              <a:extLst>
                <a:ext uri="{FF2B5EF4-FFF2-40B4-BE49-F238E27FC236}">
                  <a16:creationId xmlns:a16="http://schemas.microsoft.com/office/drawing/2014/main" xmlns="" id="{39A2223E-D590-7D56-DCC1-C28E8CF59E50}"/>
                </a:ext>
              </a:extLst>
            </p:cNvPr>
            <p:cNvSpPr/>
            <p:nvPr/>
          </p:nvSpPr>
          <p:spPr>
            <a:xfrm>
              <a:off x="2310767" y="7445105"/>
              <a:ext cx="944578" cy="754444"/>
            </a:xfrm>
            <a:prstGeom prst="roundRect">
              <a:avLst/>
            </a:prstGeom>
            <a:solidFill>
              <a:srgbClr val="070BB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T/AT</a:t>
              </a:r>
              <a:endParaRPr kumimoji="1" lang="ja-JP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四角形: 角を丸くする 133">
              <a:extLst>
                <a:ext uri="{FF2B5EF4-FFF2-40B4-BE49-F238E27FC236}">
                  <a16:creationId xmlns:a16="http://schemas.microsoft.com/office/drawing/2014/main" xmlns="" id="{17170335-0E79-FD97-0316-E673AB4A2E4A}"/>
                </a:ext>
              </a:extLst>
            </p:cNvPr>
            <p:cNvSpPr/>
            <p:nvPr/>
          </p:nvSpPr>
          <p:spPr>
            <a:xfrm>
              <a:off x="5279071" y="7044756"/>
              <a:ext cx="854089" cy="272904"/>
            </a:xfrm>
            <a:prstGeom prst="round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TQ/AT</a:t>
              </a:r>
              <a:endParaRPr kumimoji="1" lang="ja-JP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1" name="タイトル 1">
            <a:extLst>
              <a:ext uri="{FF2B5EF4-FFF2-40B4-BE49-F238E27FC236}">
                <a16:creationId xmlns:a16="http://schemas.microsoft.com/office/drawing/2014/main" xmlns="" id="{A7FA7D28-D8F9-7232-3CB4-F3AEFAC8E3D1}"/>
              </a:ext>
            </a:extLst>
          </p:cNvPr>
          <p:cNvSpPr txBox="1">
            <a:spLocks/>
          </p:cNvSpPr>
          <p:nvPr/>
        </p:nvSpPr>
        <p:spPr>
          <a:xfrm rot="10800000" flipV="1">
            <a:off x="145512" y="38370"/>
            <a:ext cx="2661757" cy="366965"/>
          </a:xfrm>
          <a:prstGeom prst="rect">
            <a:avLst/>
          </a:prstGeom>
        </p:spPr>
        <p:txBody>
          <a:bodyPr vert="horz" lIns="91551" tIns="45776" rIns="91551" bIns="45776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86586"/>
            <a:r>
              <a:rPr lang="en-US" altLang="ja-JP" sz="1802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1</a:t>
            </a:r>
            <a:endParaRPr lang="ja-JP" altLang="en-US" sz="1802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10693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>
            <a:extLst>
              <a:ext uri="{FF2B5EF4-FFF2-40B4-BE49-F238E27FC236}">
                <a16:creationId xmlns:a16="http://schemas.microsoft.com/office/drawing/2014/main" xmlns="" id="{5B374EEB-59BD-2449-BC44-398FAF3E9D6B}"/>
              </a:ext>
            </a:extLst>
          </p:cNvPr>
          <p:cNvSpPr txBox="1">
            <a:spLocks/>
          </p:cNvSpPr>
          <p:nvPr/>
        </p:nvSpPr>
        <p:spPr>
          <a:xfrm rot="10800000" flipV="1">
            <a:off x="178380" y="1178691"/>
            <a:ext cx="6891323" cy="980938"/>
          </a:xfrm>
          <a:prstGeom prst="rect">
            <a:avLst/>
          </a:prstGeom>
        </p:spPr>
        <p:txBody>
          <a:bodyPr vert="horz" lIns="91551" tIns="45776" rIns="91551" bIns="45776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86586"/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1. Scheme of apoA2-dimers and aberrant processing of C-terminal amino acids in circulating apoA2-dimers, as reflected in pancreatic exocrine function.</a:t>
            </a:r>
            <a:r>
              <a:rPr lang="en-US" altLang="ja-JP" sz="1200" b="1" baseline="300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1, 2</a:t>
            </a:r>
            <a:endParaRPr lang="en-US" altLang="ja-JP" sz="1200" b="1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86586"/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Amino acid sequences of apolipoprotein A2-isoforms (apoA2-is) (heavy isoforms, apoA2-ATQ/ATQ; intermediate isoforms, apoA2-ATQ/AT; and light isoforms, apoA2-AT/AT). Circulating apoA2-ATQ/AT levels decrease with decreasing exocrine function of the pancreas. It is considered that C-terminal amino acids of apoA2-is are aberrantly cleaved by carboxypeptidases leaked from the pancreas and indicate pancreatic exocrine function.</a:t>
            </a:r>
          </a:p>
          <a:p>
            <a:pPr defTabSz="686586"/>
            <a:endParaRPr lang="en-US" altLang="ja-JP" sz="1200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86586"/>
            <a:endParaRPr lang="en-US" altLang="ja-JP" sz="1200" b="1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86586"/>
            <a:endParaRPr lang="en-US" altLang="ja-JP" sz="1200" b="1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3072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タイトル 1">
            <a:extLst>
              <a:ext uri="{FF2B5EF4-FFF2-40B4-BE49-F238E27FC236}">
                <a16:creationId xmlns:a16="http://schemas.microsoft.com/office/drawing/2014/main" xmlns="" id="{7C2BB576-45DC-9FED-0084-7C368FC21773}"/>
              </a:ext>
            </a:extLst>
          </p:cNvPr>
          <p:cNvSpPr txBox="1">
            <a:spLocks/>
          </p:cNvSpPr>
          <p:nvPr/>
        </p:nvSpPr>
        <p:spPr>
          <a:xfrm rot="10800000" flipV="1">
            <a:off x="145512" y="38370"/>
            <a:ext cx="2661757" cy="366965"/>
          </a:xfrm>
          <a:prstGeom prst="rect">
            <a:avLst/>
          </a:prstGeom>
        </p:spPr>
        <p:txBody>
          <a:bodyPr vert="horz" lIns="91551" tIns="45776" rIns="91551" bIns="45776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86586"/>
            <a:r>
              <a:rPr lang="en-US" altLang="ja-JP" sz="1802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2</a:t>
            </a:r>
            <a:endParaRPr lang="ja-JP" altLang="en-US" sz="1802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xmlns="" id="{CD796973-5C80-6124-1E4A-97FB54EEBB3C}"/>
              </a:ext>
            </a:extLst>
          </p:cNvPr>
          <p:cNvSpPr txBox="1">
            <a:spLocks/>
          </p:cNvSpPr>
          <p:nvPr/>
        </p:nvSpPr>
        <p:spPr>
          <a:xfrm rot="10800000" flipV="1">
            <a:off x="64298" y="7168943"/>
            <a:ext cx="6891323" cy="980938"/>
          </a:xfrm>
          <a:prstGeom prst="rect">
            <a:avLst/>
          </a:prstGeom>
        </p:spPr>
        <p:txBody>
          <a:bodyPr vert="horz" lIns="91551" tIns="45776" rIns="91551" bIns="45776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86586"/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2.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(A) Kernel density estimation of apoA2-AT in the cut-off setting test. The 5th percentile of apoA2-AT is </a:t>
            </a:r>
            <a:r>
              <a:rPr lang="en-US" altLang="ja-JP" sz="1200" dirty="0"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26.735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μg/mL (dashed line: 95% specificity). (B) Kernel density estimation of apoA2-AT in the cut-off evaluation test. The specificity of 26.735 μg/mL of apoA2-AT is 94.75% (dashed line: apoA2-AT 26.735 μg/mL). </a:t>
            </a:r>
            <a:endParaRPr lang="en-US" altLang="ja-JP" sz="1200" b="1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4A727792-21BE-EC5E-ACB6-64F3C589AFD5}"/>
              </a:ext>
            </a:extLst>
          </p:cNvPr>
          <p:cNvSpPr txBox="1"/>
          <p:nvPr/>
        </p:nvSpPr>
        <p:spPr>
          <a:xfrm>
            <a:off x="244047" y="48268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3D27D9BC-6C49-3F8C-52DB-EC43421B38D7}"/>
              </a:ext>
            </a:extLst>
          </p:cNvPr>
          <p:cNvSpPr txBox="1"/>
          <p:nvPr/>
        </p:nvSpPr>
        <p:spPr>
          <a:xfrm>
            <a:off x="213916" y="399188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xmlns="" id="{99A0A3C8-75C8-4723-91DD-4EBFEDE66FBB}"/>
              </a:ext>
            </a:extLst>
          </p:cNvPr>
          <p:cNvGrpSpPr/>
          <p:nvPr/>
        </p:nvGrpSpPr>
        <p:grpSpPr>
          <a:xfrm>
            <a:off x="709865" y="537262"/>
            <a:ext cx="5343835" cy="6463170"/>
            <a:chOff x="3052762" y="64119"/>
            <a:chExt cx="6139553" cy="9292808"/>
          </a:xfrm>
        </p:grpSpPr>
        <p:grpSp>
          <p:nvGrpSpPr>
            <p:cNvPr id="106" name="グラフィックス 355">
              <a:extLst>
                <a:ext uri="{FF2B5EF4-FFF2-40B4-BE49-F238E27FC236}">
                  <a16:creationId xmlns:a16="http://schemas.microsoft.com/office/drawing/2014/main" xmlns="" id="{46B109BE-F7F2-4591-BC4C-46BF9311C12C}"/>
                </a:ext>
              </a:extLst>
            </p:cNvPr>
            <p:cNvGrpSpPr/>
            <p:nvPr/>
          </p:nvGrpSpPr>
          <p:grpSpPr>
            <a:xfrm>
              <a:off x="3062287" y="64119"/>
              <a:ext cx="6130028" cy="4594274"/>
              <a:chOff x="2622132" y="1370946"/>
              <a:chExt cx="6130028" cy="4594274"/>
            </a:xfrm>
          </p:grpSpPr>
          <p:sp>
            <p:nvSpPr>
              <p:cNvPr id="108" name="フリーフォーム: 図形 107">
                <a:extLst>
                  <a:ext uri="{FF2B5EF4-FFF2-40B4-BE49-F238E27FC236}">
                    <a16:creationId xmlns:a16="http://schemas.microsoft.com/office/drawing/2014/main" xmlns="" id="{4BB6AD3B-05A9-4D61-89DB-932740EA9E3E}"/>
                  </a:ext>
                </a:extLst>
              </p:cNvPr>
              <p:cNvSpPr/>
              <p:nvPr/>
            </p:nvSpPr>
            <p:spPr>
              <a:xfrm>
                <a:off x="2622132" y="1370946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0" name="フリーフォーム: 図形 109">
                <a:extLst>
                  <a:ext uri="{FF2B5EF4-FFF2-40B4-BE49-F238E27FC236}">
                    <a16:creationId xmlns:a16="http://schemas.microsoft.com/office/drawing/2014/main" xmlns="" id="{13191A2A-A62D-4634-9B40-040C6949C8EB}"/>
                  </a:ext>
                </a:extLst>
              </p:cNvPr>
              <p:cNvSpPr/>
              <p:nvPr/>
            </p:nvSpPr>
            <p:spPr>
              <a:xfrm>
                <a:off x="2622132" y="1370946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2" name="フリーフォーム: 図形 111">
                <a:extLst>
                  <a:ext uri="{FF2B5EF4-FFF2-40B4-BE49-F238E27FC236}">
                    <a16:creationId xmlns:a16="http://schemas.microsoft.com/office/drawing/2014/main" xmlns="" id="{7BC06FEE-CE69-41C0-A61E-8A168BC368C1}"/>
                  </a:ext>
                </a:extLst>
              </p:cNvPr>
              <p:cNvSpPr/>
              <p:nvPr/>
            </p:nvSpPr>
            <p:spPr>
              <a:xfrm>
                <a:off x="2622132" y="1370946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noFill/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grpSp>
            <p:nvGrpSpPr>
              <p:cNvPr id="113" name="グラフィックス 355">
                <a:extLst>
                  <a:ext uri="{FF2B5EF4-FFF2-40B4-BE49-F238E27FC236}">
                    <a16:creationId xmlns:a16="http://schemas.microsoft.com/office/drawing/2014/main" xmlns="" id="{19E90FBA-4AF9-428E-8551-156266EBEA49}"/>
                  </a:ext>
                </a:extLst>
              </p:cNvPr>
              <p:cNvGrpSpPr/>
              <p:nvPr/>
            </p:nvGrpSpPr>
            <p:grpSpPr>
              <a:xfrm>
                <a:off x="2667950" y="1439401"/>
                <a:ext cx="6084210" cy="4525819"/>
                <a:chOff x="2667950" y="1439401"/>
                <a:chExt cx="6084210" cy="4525819"/>
              </a:xfrm>
            </p:grpSpPr>
            <p:sp>
              <p:nvSpPr>
                <p:cNvPr id="125" name="フリーフォーム: 図形 124">
                  <a:extLst>
                    <a:ext uri="{FF2B5EF4-FFF2-40B4-BE49-F238E27FC236}">
                      <a16:creationId xmlns:a16="http://schemas.microsoft.com/office/drawing/2014/main" xmlns="" id="{FD2BEA5A-0B4E-4878-A667-B27D649FA309}"/>
                    </a:ext>
                  </a:extLst>
                </p:cNvPr>
                <p:cNvSpPr/>
                <p:nvPr/>
              </p:nvSpPr>
              <p:spPr>
                <a:xfrm>
                  <a:off x="3373560" y="1489977"/>
                  <a:ext cx="5192248" cy="3896744"/>
                </a:xfrm>
                <a:custGeom>
                  <a:avLst/>
                  <a:gdLst>
                    <a:gd name="connsiteX0" fmla="*/ 11 w 5192248"/>
                    <a:gd name="connsiteY0" fmla="*/ 11 h 3896744"/>
                    <a:gd name="connsiteX1" fmla="*/ 5192260 w 5192248"/>
                    <a:gd name="connsiteY1" fmla="*/ 11 h 3896744"/>
                    <a:gd name="connsiteX2" fmla="*/ 5192260 w 5192248"/>
                    <a:gd name="connsiteY2" fmla="*/ 3896755 h 3896744"/>
                    <a:gd name="connsiteX3" fmla="*/ 11 w 5192248"/>
                    <a:gd name="connsiteY3" fmla="*/ 3896755 h 389674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5192248" h="3896744">
                      <a:moveTo>
                        <a:pt x="11" y="11"/>
                      </a:moveTo>
                      <a:lnTo>
                        <a:pt x="5192260" y="11"/>
                      </a:lnTo>
                      <a:lnTo>
                        <a:pt x="5192260" y="3896755"/>
                      </a:lnTo>
                      <a:lnTo>
                        <a:pt x="11" y="3896755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/>
                </a:p>
              </p:txBody>
            </p:sp>
            <p:grpSp>
              <p:nvGrpSpPr>
                <p:cNvPr id="126" name="グラフィックス 355">
                  <a:extLst>
                    <a:ext uri="{FF2B5EF4-FFF2-40B4-BE49-F238E27FC236}">
                      <a16:creationId xmlns:a16="http://schemas.microsoft.com/office/drawing/2014/main" xmlns="" id="{A8D506C8-ACF9-4812-A03D-ACF9A333E3F7}"/>
                    </a:ext>
                  </a:extLst>
                </p:cNvPr>
                <p:cNvGrpSpPr/>
                <p:nvPr/>
              </p:nvGrpSpPr>
              <p:grpSpPr>
                <a:xfrm>
                  <a:off x="3190393" y="1485225"/>
                  <a:ext cx="4591840" cy="3906242"/>
                  <a:chOff x="3190393" y="1485225"/>
                  <a:chExt cx="4591840" cy="3906242"/>
                </a:xfrm>
                <a:noFill/>
              </p:grpSpPr>
              <p:sp>
                <p:nvSpPr>
                  <p:cNvPr id="182" name="フリーフォーム: 図形 181">
                    <a:extLst>
                      <a:ext uri="{FF2B5EF4-FFF2-40B4-BE49-F238E27FC236}">
                        <a16:creationId xmlns:a16="http://schemas.microsoft.com/office/drawing/2014/main" xmlns="" id="{BA9DA37F-186A-4D9C-9FE9-A7D7B058CF18}"/>
                      </a:ext>
                    </a:extLst>
                  </p:cNvPr>
                  <p:cNvSpPr/>
                  <p:nvPr/>
                </p:nvSpPr>
                <p:spPr>
                  <a:xfrm>
                    <a:off x="3190393" y="1734494"/>
                    <a:ext cx="4591840" cy="3656382"/>
                  </a:xfrm>
                  <a:custGeom>
                    <a:avLst/>
                    <a:gdLst>
                      <a:gd name="connsiteX0" fmla="*/ 11 w 4591840"/>
                      <a:gd name="connsiteY0" fmla="*/ 3656165 h 3656382"/>
                      <a:gd name="connsiteX1" fmla="*/ 30623 w 4591840"/>
                      <a:gd name="connsiteY1" fmla="*/ 3655384 h 3656382"/>
                      <a:gd name="connsiteX2" fmla="*/ 61236 w 4591840"/>
                      <a:gd name="connsiteY2" fmla="*/ 3654032 h 3656382"/>
                      <a:gd name="connsiteX3" fmla="*/ 91848 w 4591840"/>
                      <a:gd name="connsiteY3" fmla="*/ 3651746 h 3656382"/>
                      <a:gd name="connsiteX4" fmla="*/ 122460 w 4591840"/>
                      <a:gd name="connsiteY4" fmla="*/ 3648078 h 3656382"/>
                      <a:gd name="connsiteX5" fmla="*/ 153072 w 4591840"/>
                      <a:gd name="connsiteY5" fmla="*/ 3642459 h 3656382"/>
                      <a:gd name="connsiteX6" fmla="*/ 183684 w 4591840"/>
                      <a:gd name="connsiteY6" fmla="*/ 3634162 h 3656382"/>
                      <a:gd name="connsiteX7" fmla="*/ 214297 w 4591840"/>
                      <a:gd name="connsiteY7" fmla="*/ 3622399 h 3656382"/>
                      <a:gd name="connsiteX8" fmla="*/ 244909 w 4591840"/>
                      <a:gd name="connsiteY8" fmla="*/ 3606302 h 3656382"/>
                      <a:gd name="connsiteX9" fmla="*/ 275522 w 4591840"/>
                      <a:gd name="connsiteY9" fmla="*/ 3584956 h 3656382"/>
                      <a:gd name="connsiteX10" fmla="*/ 306134 w 4591840"/>
                      <a:gd name="connsiteY10" fmla="*/ 3557448 h 3656382"/>
                      <a:gd name="connsiteX11" fmla="*/ 336746 w 4591840"/>
                      <a:gd name="connsiteY11" fmla="*/ 3522882 h 3656382"/>
                      <a:gd name="connsiteX12" fmla="*/ 367359 w 4591840"/>
                      <a:gd name="connsiteY12" fmla="*/ 3480438 h 3656382"/>
                      <a:gd name="connsiteX13" fmla="*/ 397971 w 4591840"/>
                      <a:gd name="connsiteY13" fmla="*/ 3429346 h 3656382"/>
                      <a:gd name="connsiteX14" fmla="*/ 428583 w 4591840"/>
                      <a:gd name="connsiteY14" fmla="*/ 3369015 h 3656382"/>
                      <a:gd name="connsiteX15" fmla="*/ 459195 w 4591840"/>
                      <a:gd name="connsiteY15" fmla="*/ 3299083 h 3656382"/>
                      <a:gd name="connsiteX16" fmla="*/ 489806 w 4591840"/>
                      <a:gd name="connsiteY16" fmla="*/ 3219492 h 3656382"/>
                      <a:gd name="connsiteX17" fmla="*/ 520419 w 4591840"/>
                      <a:gd name="connsiteY17" fmla="*/ 3130528 h 3656382"/>
                      <a:gd name="connsiteX18" fmla="*/ 551032 w 4591840"/>
                      <a:gd name="connsiteY18" fmla="*/ 3032830 h 3656382"/>
                      <a:gd name="connsiteX19" fmla="*/ 581646 w 4591840"/>
                      <a:gd name="connsiteY19" fmla="*/ 2927341 h 3656382"/>
                      <a:gd name="connsiteX20" fmla="*/ 612259 w 4591840"/>
                      <a:gd name="connsiteY20" fmla="*/ 2815155 h 3656382"/>
                      <a:gd name="connsiteX21" fmla="*/ 642872 w 4591840"/>
                      <a:gd name="connsiteY21" fmla="*/ 2697417 h 3656382"/>
                      <a:gd name="connsiteX22" fmla="*/ 704090 w 4591840"/>
                      <a:gd name="connsiteY22" fmla="*/ 2449719 h 3656382"/>
                      <a:gd name="connsiteX23" fmla="*/ 1040827 w 4591840"/>
                      <a:gd name="connsiteY23" fmla="*/ 1031256 h 3656382"/>
                      <a:gd name="connsiteX24" fmla="*/ 1132667 w 4591840"/>
                      <a:gd name="connsiteY24" fmla="*/ 617606 h 3656382"/>
                      <a:gd name="connsiteX25" fmla="*/ 1163280 w 4591840"/>
                      <a:gd name="connsiteY25" fmla="*/ 491535 h 3656382"/>
                      <a:gd name="connsiteX26" fmla="*/ 1193894 w 4591840"/>
                      <a:gd name="connsiteY26" fmla="*/ 378534 h 3656382"/>
                      <a:gd name="connsiteX27" fmla="*/ 1224507 w 4591840"/>
                      <a:gd name="connsiteY27" fmla="*/ 281445 h 3656382"/>
                      <a:gd name="connsiteX28" fmla="*/ 1255111 w 4591840"/>
                      <a:gd name="connsiteY28" fmla="*/ 201404 h 3656382"/>
                      <a:gd name="connsiteX29" fmla="*/ 1285724 w 4591840"/>
                      <a:gd name="connsiteY29" fmla="*/ 137916 h 3656382"/>
                      <a:gd name="connsiteX30" fmla="*/ 1316337 w 4591840"/>
                      <a:gd name="connsiteY30" fmla="*/ 89312 h 3656382"/>
                      <a:gd name="connsiteX31" fmla="*/ 1346951 w 4591840"/>
                      <a:gd name="connsiteY31" fmla="*/ 53381 h 3656382"/>
                      <a:gd name="connsiteX32" fmla="*/ 1377564 w 4591840"/>
                      <a:gd name="connsiteY32" fmla="*/ 27947 h 3656382"/>
                      <a:gd name="connsiteX33" fmla="*/ 1408177 w 4591840"/>
                      <a:gd name="connsiteY33" fmla="*/ 11260 h 3656382"/>
                      <a:gd name="connsiteX34" fmla="*/ 1438791 w 4591840"/>
                      <a:gd name="connsiteY34" fmla="*/ 2148 h 3656382"/>
                      <a:gd name="connsiteX35" fmla="*/ 1469404 w 4591840"/>
                      <a:gd name="connsiteY35" fmla="*/ 11 h 3656382"/>
                      <a:gd name="connsiteX36" fmla="*/ 1500018 w 4591840"/>
                      <a:gd name="connsiteY36" fmla="*/ 4723 h 3656382"/>
                      <a:gd name="connsiteX37" fmla="*/ 1530621 w 4591840"/>
                      <a:gd name="connsiteY37" fmla="*/ 16541 h 3656382"/>
                      <a:gd name="connsiteX38" fmla="*/ 1561235 w 4591840"/>
                      <a:gd name="connsiteY38" fmla="*/ 36015 h 3656382"/>
                      <a:gd name="connsiteX39" fmla="*/ 1591848 w 4591840"/>
                      <a:gd name="connsiteY39" fmla="*/ 63896 h 3656382"/>
                      <a:gd name="connsiteX40" fmla="*/ 1622461 w 4591840"/>
                      <a:gd name="connsiteY40" fmla="*/ 101021 h 3656382"/>
                      <a:gd name="connsiteX41" fmla="*/ 1653075 w 4591840"/>
                      <a:gd name="connsiteY41" fmla="*/ 148183 h 3656382"/>
                      <a:gd name="connsiteX42" fmla="*/ 1683688 w 4591840"/>
                      <a:gd name="connsiteY42" fmla="*/ 206017 h 3656382"/>
                      <a:gd name="connsiteX43" fmla="*/ 1714302 w 4591840"/>
                      <a:gd name="connsiteY43" fmla="*/ 274906 h 3656382"/>
                      <a:gd name="connsiteX44" fmla="*/ 1744915 w 4591840"/>
                      <a:gd name="connsiteY44" fmla="*/ 354921 h 3656382"/>
                      <a:gd name="connsiteX45" fmla="*/ 1775528 w 4591840"/>
                      <a:gd name="connsiteY45" fmla="*/ 445757 h 3656382"/>
                      <a:gd name="connsiteX46" fmla="*/ 1806132 w 4591840"/>
                      <a:gd name="connsiteY46" fmla="*/ 546627 h 3656382"/>
                      <a:gd name="connsiteX47" fmla="*/ 1836745 w 4591840"/>
                      <a:gd name="connsiteY47" fmla="*/ 656144 h 3656382"/>
                      <a:gd name="connsiteX48" fmla="*/ 1867359 w 4591840"/>
                      <a:gd name="connsiteY48" fmla="*/ 772233 h 3656382"/>
                      <a:gd name="connsiteX49" fmla="*/ 1989812 w 4591840"/>
                      <a:gd name="connsiteY49" fmla="*/ 1244902 h 3656382"/>
                      <a:gd name="connsiteX50" fmla="*/ 2020426 w 4591840"/>
                      <a:gd name="connsiteY50" fmla="*/ 1352220 h 3656382"/>
                      <a:gd name="connsiteX51" fmla="*/ 2051039 w 4591840"/>
                      <a:gd name="connsiteY51" fmla="*/ 1453080 h 3656382"/>
                      <a:gd name="connsiteX52" fmla="*/ 2081643 w 4591840"/>
                      <a:gd name="connsiteY52" fmla="*/ 1548492 h 3656382"/>
                      <a:gd name="connsiteX53" fmla="*/ 2295936 w 4591840"/>
                      <a:gd name="connsiteY53" fmla="*/ 2182629 h 3656382"/>
                      <a:gd name="connsiteX54" fmla="*/ 2326549 w 4591840"/>
                      <a:gd name="connsiteY54" fmla="*/ 2268649 h 3656382"/>
                      <a:gd name="connsiteX55" fmla="*/ 2357153 w 4591840"/>
                      <a:gd name="connsiteY55" fmla="*/ 2350954 h 3656382"/>
                      <a:gd name="connsiteX56" fmla="*/ 2387767 w 4591840"/>
                      <a:gd name="connsiteY56" fmla="*/ 2429536 h 3656382"/>
                      <a:gd name="connsiteX57" fmla="*/ 2448993 w 4591840"/>
                      <a:gd name="connsiteY57" fmla="*/ 2578230 h 3656382"/>
                      <a:gd name="connsiteX58" fmla="*/ 2510220 w 4591840"/>
                      <a:gd name="connsiteY58" fmla="*/ 2720925 h 3656382"/>
                      <a:gd name="connsiteX59" fmla="*/ 2540833 w 4591840"/>
                      <a:gd name="connsiteY59" fmla="*/ 2790505 h 3656382"/>
                      <a:gd name="connsiteX60" fmla="*/ 2571447 w 4591840"/>
                      <a:gd name="connsiteY60" fmla="*/ 2857846 h 3656382"/>
                      <a:gd name="connsiteX61" fmla="*/ 2602060 w 4591840"/>
                      <a:gd name="connsiteY61" fmla="*/ 2921511 h 3656382"/>
                      <a:gd name="connsiteX62" fmla="*/ 2632664 w 4591840"/>
                      <a:gd name="connsiteY62" fmla="*/ 2979966 h 3656382"/>
                      <a:gd name="connsiteX63" fmla="*/ 2663277 w 4591840"/>
                      <a:gd name="connsiteY63" fmla="*/ 3032040 h 3656382"/>
                      <a:gd name="connsiteX64" fmla="*/ 2693891 w 4591840"/>
                      <a:gd name="connsiteY64" fmla="*/ 3077169 h 3656382"/>
                      <a:gd name="connsiteX65" fmla="*/ 2724504 w 4591840"/>
                      <a:gd name="connsiteY65" fmla="*/ 3115621 h 3656382"/>
                      <a:gd name="connsiteX66" fmla="*/ 2755117 w 4591840"/>
                      <a:gd name="connsiteY66" fmla="*/ 3148264 h 3656382"/>
                      <a:gd name="connsiteX67" fmla="*/ 2785731 w 4591840"/>
                      <a:gd name="connsiteY67" fmla="*/ 3176362 h 3656382"/>
                      <a:gd name="connsiteX68" fmla="*/ 2816344 w 4591840"/>
                      <a:gd name="connsiteY68" fmla="*/ 3201194 h 3656382"/>
                      <a:gd name="connsiteX69" fmla="*/ 2846957 w 4591840"/>
                      <a:gd name="connsiteY69" fmla="*/ 3223778 h 3656382"/>
                      <a:gd name="connsiteX70" fmla="*/ 2877571 w 4591840"/>
                      <a:gd name="connsiteY70" fmla="*/ 3244771 h 3656382"/>
                      <a:gd name="connsiteX71" fmla="*/ 2908175 w 4591840"/>
                      <a:gd name="connsiteY71" fmla="*/ 3264450 h 3656382"/>
                      <a:gd name="connsiteX72" fmla="*/ 2938788 w 4591840"/>
                      <a:gd name="connsiteY72" fmla="*/ 3282804 h 3656382"/>
                      <a:gd name="connsiteX73" fmla="*/ 2969401 w 4591840"/>
                      <a:gd name="connsiteY73" fmla="*/ 3299654 h 3656382"/>
                      <a:gd name="connsiteX74" fmla="*/ 3000015 w 4591840"/>
                      <a:gd name="connsiteY74" fmla="*/ 3314751 h 3656382"/>
                      <a:gd name="connsiteX75" fmla="*/ 3030628 w 4591840"/>
                      <a:gd name="connsiteY75" fmla="*/ 3327876 h 3656382"/>
                      <a:gd name="connsiteX76" fmla="*/ 3061241 w 4591840"/>
                      <a:gd name="connsiteY76" fmla="*/ 3338954 h 3656382"/>
                      <a:gd name="connsiteX77" fmla="*/ 3091855 w 4591840"/>
                      <a:gd name="connsiteY77" fmla="*/ 3348165 h 3656382"/>
                      <a:gd name="connsiteX78" fmla="*/ 3122468 w 4591840"/>
                      <a:gd name="connsiteY78" fmla="*/ 3356051 h 3656382"/>
                      <a:gd name="connsiteX79" fmla="*/ 3153081 w 4591840"/>
                      <a:gd name="connsiteY79" fmla="*/ 3363509 h 3656382"/>
                      <a:gd name="connsiteX80" fmla="*/ 3183685 w 4591840"/>
                      <a:gd name="connsiteY80" fmla="*/ 3371682 h 3656382"/>
                      <a:gd name="connsiteX81" fmla="*/ 3214299 w 4591840"/>
                      <a:gd name="connsiteY81" fmla="*/ 3381712 h 3656382"/>
                      <a:gd name="connsiteX82" fmla="*/ 3244912 w 4591840"/>
                      <a:gd name="connsiteY82" fmla="*/ 3394485 h 3656382"/>
                      <a:gd name="connsiteX83" fmla="*/ 3275525 w 4591840"/>
                      <a:gd name="connsiteY83" fmla="*/ 3410325 h 3656382"/>
                      <a:gd name="connsiteX84" fmla="*/ 3306139 w 4591840"/>
                      <a:gd name="connsiteY84" fmla="*/ 3428927 h 3656382"/>
                      <a:gd name="connsiteX85" fmla="*/ 3336752 w 4591840"/>
                      <a:gd name="connsiteY85" fmla="*/ 3449435 h 3656382"/>
                      <a:gd name="connsiteX86" fmla="*/ 3397979 w 4591840"/>
                      <a:gd name="connsiteY86" fmla="*/ 3491230 h 3656382"/>
                      <a:gd name="connsiteX87" fmla="*/ 3428592 w 4591840"/>
                      <a:gd name="connsiteY87" fmla="*/ 3510185 h 3656382"/>
                      <a:gd name="connsiteX88" fmla="*/ 3459196 w 4591840"/>
                      <a:gd name="connsiteY88" fmla="*/ 3526778 h 3656382"/>
                      <a:gd name="connsiteX89" fmla="*/ 3489809 w 4591840"/>
                      <a:gd name="connsiteY89" fmla="*/ 3540713 h 3656382"/>
                      <a:gd name="connsiteX90" fmla="*/ 3520422 w 4591840"/>
                      <a:gd name="connsiteY90" fmla="*/ 3552085 h 3656382"/>
                      <a:gd name="connsiteX91" fmla="*/ 3551036 w 4591840"/>
                      <a:gd name="connsiteY91" fmla="*/ 3561220 h 3656382"/>
                      <a:gd name="connsiteX92" fmla="*/ 3581649 w 4591840"/>
                      <a:gd name="connsiteY92" fmla="*/ 3568621 h 3656382"/>
                      <a:gd name="connsiteX93" fmla="*/ 3612262 w 4591840"/>
                      <a:gd name="connsiteY93" fmla="*/ 3574831 h 3656382"/>
                      <a:gd name="connsiteX94" fmla="*/ 3642876 w 4591840"/>
                      <a:gd name="connsiteY94" fmla="*/ 3580375 h 3656382"/>
                      <a:gd name="connsiteX95" fmla="*/ 3795933 w 4591840"/>
                      <a:gd name="connsiteY95" fmla="*/ 3606683 h 3656382"/>
                      <a:gd name="connsiteX96" fmla="*/ 3826546 w 4591840"/>
                      <a:gd name="connsiteY96" fmla="*/ 3611207 h 3656382"/>
                      <a:gd name="connsiteX97" fmla="*/ 3857160 w 4591840"/>
                      <a:gd name="connsiteY97" fmla="*/ 3614874 h 3656382"/>
                      <a:gd name="connsiteX98" fmla="*/ 3887773 w 4591840"/>
                      <a:gd name="connsiteY98" fmla="*/ 3617475 h 3656382"/>
                      <a:gd name="connsiteX99" fmla="*/ 3918387 w 4591840"/>
                      <a:gd name="connsiteY99" fmla="*/ 3618875 h 3656382"/>
                      <a:gd name="connsiteX100" fmla="*/ 3949000 w 4591840"/>
                      <a:gd name="connsiteY100" fmla="*/ 3619113 h 3656382"/>
                      <a:gd name="connsiteX101" fmla="*/ 3979613 w 4591840"/>
                      <a:gd name="connsiteY101" fmla="*/ 3618342 h 3656382"/>
                      <a:gd name="connsiteX102" fmla="*/ 4010217 w 4591840"/>
                      <a:gd name="connsiteY102" fmla="*/ 3616865 h 3656382"/>
                      <a:gd name="connsiteX103" fmla="*/ 4040831 w 4591840"/>
                      <a:gd name="connsiteY103" fmla="*/ 3615055 h 3656382"/>
                      <a:gd name="connsiteX104" fmla="*/ 4071444 w 4591840"/>
                      <a:gd name="connsiteY104" fmla="*/ 3613341 h 3656382"/>
                      <a:gd name="connsiteX105" fmla="*/ 4102057 w 4591840"/>
                      <a:gd name="connsiteY105" fmla="*/ 3612150 h 3656382"/>
                      <a:gd name="connsiteX106" fmla="*/ 4132671 w 4591840"/>
                      <a:gd name="connsiteY106" fmla="*/ 3611836 h 3656382"/>
                      <a:gd name="connsiteX107" fmla="*/ 4163284 w 4591840"/>
                      <a:gd name="connsiteY107" fmla="*/ 3612655 h 3656382"/>
                      <a:gd name="connsiteX108" fmla="*/ 4193897 w 4591840"/>
                      <a:gd name="connsiteY108" fmla="*/ 3614703 h 3656382"/>
                      <a:gd name="connsiteX109" fmla="*/ 4224511 w 4591840"/>
                      <a:gd name="connsiteY109" fmla="*/ 3617932 h 3656382"/>
                      <a:gd name="connsiteX110" fmla="*/ 4255124 w 4591840"/>
                      <a:gd name="connsiteY110" fmla="*/ 3622152 h 3656382"/>
                      <a:gd name="connsiteX111" fmla="*/ 4285728 w 4591840"/>
                      <a:gd name="connsiteY111" fmla="*/ 3627038 h 3656382"/>
                      <a:gd name="connsiteX112" fmla="*/ 4346955 w 4591840"/>
                      <a:gd name="connsiteY112" fmla="*/ 3637334 h 3656382"/>
                      <a:gd name="connsiteX113" fmla="*/ 4377568 w 4591840"/>
                      <a:gd name="connsiteY113" fmla="*/ 3642040 h 3656382"/>
                      <a:gd name="connsiteX114" fmla="*/ 4408181 w 4591840"/>
                      <a:gd name="connsiteY114" fmla="*/ 3646116 h 3656382"/>
                      <a:gd name="connsiteX115" fmla="*/ 4438795 w 4591840"/>
                      <a:gd name="connsiteY115" fmla="*/ 3649431 h 3656382"/>
                      <a:gd name="connsiteX116" fmla="*/ 4469408 w 4591840"/>
                      <a:gd name="connsiteY116" fmla="*/ 3651974 h 3656382"/>
                      <a:gd name="connsiteX117" fmla="*/ 4500021 w 4591840"/>
                      <a:gd name="connsiteY117" fmla="*/ 3653822 h 3656382"/>
                      <a:gd name="connsiteX118" fmla="*/ 4530634 w 4591840"/>
                      <a:gd name="connsiteY118" fmla="*/ 3655079 h 3656382"/>
                      <a:gd name="connsiteX119" fmla="*/ 4561238 w 4591840"/>
                      <a:gd name="connsiteY119" fmla="*/ 3655899 h 3656382"/>
                      <a:gd name="connsiteX120" fmla="*/ 4591852 w 4591840"/>
                      <a:gd name="connsiteY120" fmla="*/ 3656394 h 365638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  <a:cxn ang="0">
                        <a:pos x="connsiteX101" y="connsiteY101"/>
                      </a:cxn>
                      <a:cxn ang="0">
                        <a:pos x="connsiteX102" y="connsiteY102"/>
                      </a:cxn>
                      <a:cxn ang="0">
                        <a:pos x="connsiteX103" y="connsiteY103"/>
                      </a:cxn>
                      <a:cxn ang="0">
                        <a:pos x="connsiteX104" y="connsiteY104"/>
                      </a:cxn>
                      <a:cxn ang="0">
                        <a:pos x="connsiteX105" y="connsiteY105"/>
                      </a:cxn>
                      <a:cxn ang="0">
                        <a:pos x="connsiteX106" y="connsiteY106"/>
                      </a:cxn>
                      <a:cxn ang="0">
                        <a:pos x="connsiteX107" y="connsiteY107"/>
                      </a:cxn>
                      <a:cxn ang="0">
                        <a:pos x="connsiteX108" y="connsiteY108"/>
                      </a:cxn>
                      <a:cxn ang="0">
                        <a:pos x="connsiteX109" y="connsiteY109"/>
                      </a:cxn>
                      <a:cxn ang="0">
                        <a:pos x="connsiteX110" y="connsiteY110"/>
                      </a:cxn>
                      <a:cxn ang="0">
                        <a:pos x="connsiteX111" y="connsiteY111"/>
                      </a:cxn>
                      <a:cxn ang="0">
                        <a:pos x="connsiteX112" y="connsiteY112"/>
                      </a:cxn>
                      <a:cxn ang="0">
                        <a:pos x="connsiteX113" y="connsiteY113"/>
                      </a:cxn>
                      <a:cxn ang="0">
                        <a:pos x="connsiteX114" y="connsiteY114"/>
                      </a:cxn>
                      <a:cxn ang="0">
                        <a:pos x="connsiteX115" y="connsiteY115"/>
                      </a:cxn>
                      <a:cxn ang="0">
                        <a:pos x="connsiteX116" y="connsiteY116"/>
                      </a:cxn>
                      <a:cxn ang="0">
                        <a:pos x="connsiteX117" y="connsiteY117"/>
                      </a:cxn>
                      <a:cxn ang="0">
                        <a:pos x="connsiteX118" y="connsiteY118"/>
                      </a:cxn>
                      <a:cxn ang="0">
                        <a:pos x="connsiteX119" y="connsiteY119"/>
                      </a:cxn>
                      <a:cxn ang="0">
                        <a:pos x="connsiteX120" y="connsiteY120"/>
                      </a:cxn>
                    </a:cxnLst>
                    <a:rect l="l" t="t" r="r" b="b"/>
                    <a:pathLst>
                      <a:path w="4591840" h="3656382">
                        <a:moveTo>
                          <a:pt x="11" y="3656165"/>
                        </a:moveTo>
                        <a:lnTo>
                          <a:pt x="30623" y="3655384"/>
                        </a:lnTo>
                        <a:lnTo>
                          <a:pt x="61236" y="3654032"/>
                        </a:lnTo>
                        <a:lnTo>
                          <a:pt x="91848" y="3651746"/>
                        </a:lnTo>
                        <a:lnTo>
                          <a:pt x="122460" y="3648078"/>
                        </a:lnTo>
                        <a:lnTo>
                          <a:pt x="153072" y="3642459"/>
                        </a:lnTo>
                        <a:lnTo>
                          <a:pt x="183684" y="3634162"/>
                        </a:lnTo>
                        <a:lnTo>
                          <a:pt x="214297" y="3622399"/>
                        </a:lnTo>
                        <a:lnTo>
                          <a:pt x="244909" y="3606302"/>
                        </a:lnTo>
                        <a:lnTo>
                          <a:pt x="275522" y="3584956"/>
                        </a:lnTo>
                        <a:lnTo>
                          <a:pt x="306134" y="3557448"/>
                        </a:lnTo>
                        <a:lnTo>
                          <a:pt x="336746" y="3522882"/>
                        </a:lnTo>
                        <a:lnTo>
                          <a:pt x="367359" y="3480438"/>
                        </a:lnTo>
                        <a:lnTo>
                          <a:pt x="397971" y="3429346"/>
                        </a:lnTo>
                        <a:lnTo>
                          <a:pt x="428583" y="3369015"/>
                        </a:lnTo>
                        <a:lnTo>
                          <a:pt x="459195" y="3299083"/>
                        </a:lnTo>
                        <a:lnTo>
                          <a:pt x="489806" y="3219492"/>
                        </a:lnTo>
                        <a:lnTo>
                          <a:pt x="520419" y="3130528"/>
                        </a:lnTo>
                        <a:lnTo>
                          <a:pt x="551032" y="3032830"/>
                        </a:lnTo>
                        <a:lnTo>
                          <a:pt x="581646" y="2927341"/>
                        </a:lnTo>
                        <a:lnTo>
                          <a:pt x="612259" y="2815155"/>
                        </a:lnTo>
                        <a:lnTo>
                          <a:pt x="642872" y="2697417"/>
                        </a:lnTo>
                        <a:lnTo>
                          <a:pt x="704090" y="2449719"/>
                        </a:lnTo>
                        <a:lnTo>
                          <a:pt x="1040827" y="1031256"/>
                        </a:lnTo>
                        <a:lnTo>
                          <a:pt x="1132667" y="617606"/>
                        </a:lnTo>
                        <a:lnTo>
                          <a:pt x="1163280" y="491535"/>
                        </a:lnTo>
                        <a:lnTo>
                          <a:pt x="1193894" y="378534"/>
                        </a:lnTo>
                        <a:lnTo>
                          <a:pt x="1224507" y="281445"/>
                        </a:lnTo>
                        <a:lnTo>
                          <a:pt x="1255111" y="201404"/>
                        </a:lnTo>
                        <a:lnTo>
                          <a:pt x="1285724" y="137916"/>
                        </a:lnTo>
                        <a:lnTo>
                          <a:pt x="1316337" y="89312"/>
                        </a:lnTo>
                        <a:lnTo>
                          <a:pt x="1346951" y="53381"/>
                        </a:lnTo>
                        <a:lnTo>
                          <a:pt x="1377564" y="27947"/>
                        </a:lnTo>
                        <a:lnTo>
                          <a:pt x="1408177" y="11260"/>
                        </a:lnTo>
                        <a:lnTo>
                          <a:pt x="1438791" y="2148"/>
                        </a:lnTo>
                        <a:lnTo>
                          <a:pt x="1469404" y="11"/>
                        </a:lnTo>
                        <a:lnTo>
                          <a:pt x="1500018" y="4723"/>
                        </a:lnTo>
                        <a:lnTo>
                          <a:pt x="1530621" y="16541"/>
                        </a:lnTo>
                        <a:lnTo>
                          <a:pt x="1561235" y="36015"/>
                        </a:lnTo>
                        <a:lnTo>
                          <a:pt x="1591848" y="63896"/>
                        </a:lnTo>
                        <a:lnTo>
                          <a:pt x="1622461" y="101021"/>
                        </a:lnTo>
                        <a:lnTo>
                          <a:pt x="1653075" y="148183"/>
                        </a:lnTo>
                        <a:lnTo>
                          <a:pt x="1683688" y="206017"/>
                        </a:lnTo>
                        <a:lnTo>
                          <a:pt x="1714302" y="274906"/>
                        </a:lnTo>
                        <a:lnTo>
                          <a:pt x="1744915" y="354921"/>
                        </a:lnTo>
                        <a:lnTo>
                          <a:pt x="1775528" y="445757"/>
                        </a:lnTo>
                        <a:lnTo>
                          <a:pt x="1806132" y="546627"/>
                        </a:lnTo>
                        <a:lnTo>
                          <a:pt x="1836745" y="656144"/>
                        </a:lnTo>
                        <a:lnTo>
                          <a:pt x="1867359" y="772233"/>
                        </a:lnTo>
                        <a:lnTo>
                          <a:pt x="1989812" y="1244902"/>
                        </a:lnTo>
                        <a:lnTo>
                          <a:pt x="2020426" y="1352220"/>
                        </a:lnTo>
                        <a:lnTo>
                          <a:pt x="2051039" y="1453080"/>
                        </a:lnTo>
                        <a:lnTo>
                          <a:pt x="2081643" y="1548492"/>
                        </a:lnTo>
                        <a:lnTo>
                          <a:pt x="2295936" y="2182629"/>
                        </a:lnTo>
                        <a:lnTo>
                          <a:pt x="2326549" y="2268649"/>
                        </a:lnTo>
                        <a:lnTo>
                          <a:pt x="2357153" y="2350954"/>
                        </a:lnTo>
                        <a:lnTo>
                          <a:pt x="2387767" y="2429536"/>
                        </a:lnTo>
                        <a:lnTo>
                          <a:pt x="2448993" y="2578230"/>
                        </a:lnTo>
                        <a:lnTo>
                          <a:pt x="2510220" y="2720925"/>
                        </a:lnTo>
                        <a:lnTo>
                          <a:pt x="2540833" y="2790505"/>
                        </a:lnTo>
                        <a:lnTo>
                          <a:pt x="2571447" y="2857846"/>
                        </a:lnTo>
                        <a:lnTo>
                          <a:pt x="2602060" y="2921511"/>
                        </a:lnTo>
                        <a:lnTo>
                          <a:pt x="2632664" y="2979966"/>
                        </a:lnTo>
                        <a:lnTo>
                          <a:pt x="2663277" y="3032040"/>
                        </a:lnTo>
                        <a:lnTo>
                          <a:pt x="2693891" y="3077169"/>
                        </a:lnTo>
                        <a:lnTo>
                          <a:pt x="2724504" y="3115621"/>
                        </a:lnTo>
                        <a:lnTo>
                          <a:pt x="2755117" y="3148264"/>
                        </a:lnTo>
                        <a:lnTo>
                          <a:pt x="2785731" y="3176362"/>
                        </a:lnTo>
                        <a:lnTo>
                          <a:pt x="2816344" y="3201194"/>
                        </a:lnTo>
                        <a:lnTo>
                          <a:pt x="2846957" y="3223778"/>
                        </a:lnTo>
                        <a:lnTo>
                          <a:pt x="2877571" y="3244771"/>
                        </a:lnTo>
                        <a:lnTo>
                          <a:pt x="2908175" y="3264450"/>
                        </a:lnTo>
                        <a:lnTo>
                          <a:pt x="2938788" y="3282804"/>
                        </a:lnTo>
                        <a:lnTo>
                          <a:pt x="2969401" y="3299654"/>
                        </a:lnTo>
                        <a:lnTo>
                          <a:pt x="3000015" y="3314751"/>
                        </a:lnTo>
                        <a:lnTo>
                          <a:pt x="3030628" y="3327876"/>
                        </a:lnTo>
                        <a:lnTo>
                          <a:pt x="3061241" y="3338954"/>
                        </a:lnTo>
                        <a:lnTo>
                          <a:pt x="3091855" y="3348165"/>
                        </a:lnTo>
                        <a:lnTo>
                          <a:pt x="3122468" y="3356051"/>
                        </a:lnTo>
                        <a:lnTo>
                          <a:pt x="3153081" y="3363509"/>
                        </a:lnTo>
                        <a:lnTo>
                          <a:pt x="3183685" y="3371682"/>
                        </a:lnTo>
                        <a:lnTo>
                          <a:pt x="3214299" y="3381712"/>
                        </a:lnTo>
                        <a:lnTo>
                          <a:pt x="3244912" y="3394485"/>
                        </a:lnTo>
                        <a:lnTo>
                          <a:pt x="3275525" y="3410325"/>
                        </a:lnTo>
                        <a:lnTo>
                          <a:pt x="3306139" y="3428927"/>
                        </a:lnTo>
                        <a:lnTo>
                          <a:pt x="3336752" y="3449435"/>
                        </a:lnTo>
                        <a:lnTo>
                          <a:pt x="3397979" y="3491230"/>
                        </a:lnTo>
                        <a:lnTo>
                          <a:pt x="3428592" y="3510185"/>
                        </a:lnTo>
                        <a:lnTo>
                          <a:pt x="3459196" y="3526778"/>
                        </a:lnTo>
                        <a:lnTo>
                          <a:pt x="3489809" y="3540713"/>
                        </a:lnTo>
                        <a:lnTo>
                          <a:pt x="3520422" y="3552085"/>
                        </a:lnTo>
                        <a:lnTo>
                          <a:pt x="3551036" y="3561220"/>
                        </a:lnTo>
                        <a:lnTo>
                          <a:pt x="3581649" y="3568621"/>
                        </a:lnTo>
                        <a:lnTo>
                          <a:pt x="3612262" y="3574831"/>
                        </a:lnTo>
                        <a:lnTo>
                          <a:pt x="3642876" y="3580375"/>
                        </a:lnTo>
                        <a:lnTo>
                          <a:pt x="3795933" y="3606683"/>
                        </a:lnTo>
                        <a:lnTo>
                          <a:pt x="3826546" y="3611207"/>
                        </a:lnTo>
                        <a:lnTo>
                          <a:pt x="3857160" y="3614874"/>
                        </a:lnTo>
                        <a:lnTo>
                          <a:pt x="3887773" y="3617475"/>
                        </a:lnTo>
                        <a:lnTo>
                          <a:pt x="3918387" y="3618875"/>
                        </a:lnTo>
                        <a:lnTo>
                          <a:pt x="3949000" y="3619113"/>
                        </a:lnTo>
                        <a:lnTo>
                          <a:pt x="3979613" y="3618342"/>
                        </a:lnTo>
                        <a:lnTo>
                          <a:pt x="4010217" y="3616865"/>
                        </a:lnTo>
                        <a:lnTo>
                          <a:pt x="4040831" y="3615055"/>
                        </a:lnTo>
                        <a:lnTo>
                          <a:pt x="4071444" y="3613341"/>
                        </a:lnTo>
                        <a:lnTo>
                          <a:pt x="4102057" y="3612150"/>
                        </a:lnTo>
                        <a:lnTo>
                          <a:pt x="4132671" y="3611836"/>
                        </a:lnTo>
                        <a:lnTo>
                          <a:pt x="4163284" y="3612655"/>
                        </a:lnTo>
                        <a:lnTo>
                          <a:pt x="4193897" y="3614703"/>
                        </a:lnTo>
                        <a:lnTo>
                          <a:pt x="4224511" y="3617932"/>
                        </a:lnTo>
                        <a:lnTo>
                          <a:pt x="4255124" y="3622152"/>
                        </a:lnTo>
                        <a:lnTo>
                          <a:pt x="4285728" y="3627038"/>
                        </a:lnTo>
                        <a:lnTo>
                          <a:pt x="4346955" y="3637334"/>
                        </a:lnTo>
                        <a:lnTo>
                          <a:pt x="4377568" y="3642040"/>
                        </a:lnTo>
                        <a:lnTo>
                          <a:pt x="4408181" y="3646116"/>
                        </a:lnTo>
                        <a:lnTo>
                          <a:pt x="4438795" y="3649431"/>
                        </a:lnTo>
                        <a:lnTo>
                          <a:pt x="4469408" y="3651974"/>
                        </a:lnTo>
                        <a:lnTo>
                          <a:pt x="4500021" y="3653822"/>
                        </a:lnTo>
                        <a:lnTo>
                          <a:pt x="4530634" y="3655079"/>
                        </a:lnTo>
                        <a:lnTo>
                          <a:pt x="4561238" y="3655899"/>
                        </a:lnTo>
                        <a:lnTo>
                          <a:pt x="4591852" y="3656394"/>
                        </a:lnTo>
                      </a:path>
                    </a:pathLst>
                  </a:custGeom>
                  <a:noFill/>
                  <a:ln w="19050" cap="flat">
                    <a:solidFill>
                      <a:srgbClr val="003178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83" name="フリーフォーム: 図形 182">
                    <a:extLst>
                      <a:ext uri="{FF2B5EF4-FFF2-40B4-BE49-F238E27FC236}">
                        <a16:creationId xmlns:a16="http://schemas.microsoft.com/office/drawing/2014/main" xmlns="" id="{0683E85D-777A-45D3-8AA0-1DDECFDDDABC}"/>
                      </a:ext>
                    </a:extLst>
                  </p:cNvPr>
                  <p:cNvSpPr/>
                  <p:nvPr/>
                </p:nvSpPr>
                <p:spPr>
                  <a:xfrm>
                    <a:off x="3949212" y="1485225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custDash>
                      <a:ds d="75000" sp="225000"/>
                    </a:custDash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84" name="フリーフォーム: 図形 183">
                    <a:extLst>
                      <a:ext uri="{FF2B5EF4-FFF2-40B4-BE49-F238E27FC236}">
                        <a16:creationId xmlns:a16="http://schemas.microsoft.com/office/drawing/2014/main" xmlns="" id="{B09B5A57-8121-407F-A615-619E300E40F9}"/>
                      </a:ext>
                    </a:extLst>
                  </p:cNvPr>
                  <p:cNvSpPr/>
                  <p:nvPr/>
                </p:nvSpPr>
                <p:spPr>
                  <a:xfrm>
                    <a:off x="3946107" y="1485225"/>
                    <a:ext cx="3105" cy="9545"/>
                  </a:xfrm>
                  <a:custGeom>
                    <a:avLst/>
                    <a:gdLst>
                      <a:gd name="connsiteX0" fmla="*/ 11 w 3105"/>
                      <a:gd name="connsiteY0" fmla="*/ 9557 h 9545"/>
                      <a:gd name="connsiteX1" fmla="*/ 3116 w 3105"/>
                      <a:gd name="connsiteY1" fmla="*/ 11 h 954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3105" h="9545">
                        <a:moveTo>
                          <a:pt x="11" y="9557"/>
                        </a:moveTo>
                        <a:lnTo>
                          <a:pt x="3116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</p:grpSp>
            <p:grpSp>
              <p:nvGrpSpPr>
                <p:cNvPr id="127" name="グラフィックス 355">
                  <a:extLst>
                    <a:ext uri="{FF2B5EF4-FFF2-40B4-BE49-F238E27FC236}">
                      <a16:creationId xmlns:a16="http://schemas.microsoft.com/office/drawing/2014/main" xmlns="" id="{926F6C70-0774-4848-B81B-B0D859D51612}"/>
                    </a:ext>
                  </a:extLst>
                </p:cNvPr>
                <p:cNvGrpSpPr/>
                <p:nvPr/>
              </p:nvGrpSpPr>
              <p:grpSpPr>
                <a:xfrm>
                  <a:off x="2667950" y="1439401"/>
                  <a:ext cx="6084210" cy="4525819"/>
                  <a:chOff x="2667950" y="1439401"/>
                  <a:chExt cx="6084210" cy="4525819"/>
                </a:xfrm>
              </p:grpSpPr>
              <p:sp>
                <p:nvSpPr>
                  <p:cNvPr id="128" name="フリーフォーム: 図形 127">
                    <a:extLst>
                      <a:ext uri="{FF2B5EF4-FFF2-40B4-BE49-F238E27FC236}">
                        <a16:creationId xmlns:a16="http://schemas.microsoft.com/office/drawing/2014/main" xmlns="" id="{DCE9D199-D8F6-4472-B2D8-60B702790CB0}"/>
                      </a:ext>
                    </a:extLst>
                  </p:cNvPr>
                  <p:cNvSpPr/>
                  <p:nvPr/>
                </p:nvSpPr>
                <p:spPr>
                  <a:xfrm>
                    <a:off x="3373560" y="5391467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29" name="フリーフォーム: 図形 128">
                    <a:extLst>
                      <a:ext uri="{FF2B5EF4-FFF2-40B4-BE49-F238E27FC236}">
                        <a16:creationId xmlns:a16="http://schemas.microsoft.com/office/drawing/2014/main" xmlns="" id="{65A64398-710B-44EE-8D43-F9FF32CF7E84}"/>
                      </a:ext>
                    </a:extLst>
                  </p:cNvPr>
                  <p:cNvSpPr/>
                  <p:nvPr/>
                </p:nvSpPr>
                <p:spPr>
                  <a:xfrm>
                    <a:off x="8565808" y="1485225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30" name="フリーフォーム: 図形 129">
                    <a:extLst>
                      <a:ext uri="{FF2B5EF4-FFF2-40B4-BE49-F238E27FC236}">
                        <a16:creationId xmlns:a16="http://schemas.microsoft.com/office/drawing/2014/main" xmlns="" id="{A43AFBB7-DE0A-463A-9C71-AEFEC425C78B}"/>
                      </a:ext>
                    </a:extLst>
                  </p:cNvPr>
                  <p:cNvSpPr/>
                  <p:nvPr/>
                </p:nvSpPr>
                <p:spPr>
                  <a:xfrm>
                    <a:off x="3373560" y="1485225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31" name="フリーフォーム: 図形 130">
                    <a:extLst>
                      <a:ext uri="{FF2B5EF4-FFF2-40B4-BE49-F238E27FC236}">
                        <a16:creationId xmlns:a16="http://schemas.microsoft.com/office/drawing/2014/main" xmlns="" id="{EDD00653-838A-47A1-9754-CDB05D9EA5C6}"/>
                      </a:ext>
                    </a:extLst>
                  </p:cNvPr>
                  <p:cNvSpPr/>
                  <p:nvPr/>
                </p:nvSpPr>
                <p:spPr>
                  <a:xfrm>
                    <a:off x="3373560" y="1485225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32" name="フリーフォーム: 図形 131">
                    <a:extLst>
                      <a:ext uri="{FF2B5EF4-FFF2-40B4-BE49-F238E27FC236}">
                        <a16:creationId xmlns:a16="http://schemas.microsoft.com/office/drawing/2014/main" xmlns="" id="{B728282A-BBFE-4D70-8F4D-72E4BB5E6A3E}"/>
                      </a:ext>
                    </a:extLst>
                  </p:cNvPr>
                  <p:cNvSpPr/>
                  <p:nvPr/>
                </p:nvSpPr>
                <p:spPr>
                  <a:xfrm>
                    <a:off x="3373560" y="5391467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33" name="フリーフォーム: 図形 132">
                    <a:extLst>
                      <a:ext uri="{FF2B5EF4-FFF2-40B4-BE49-F238E27FC236}">
                        <a16:creationId xmlns:a16="http://schemas.microsoft.com/office/drawing/2014/main" xmlns="" id="{0C63838D-3EBA-443C-A567-E1D87A5DC492}"/>
                      </a:ext>
                    </a:extLst>
                  </p:cNvPr>
                  <p:cNvSpPr/>
                  <p:nvPr/>
                </p:nvSpPr>
                <p:spPr>
                  <a:xfrm>
                    <a:off x="3913702" y="5391467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40" name="フリーフォーム: 図形 139">
                    <a:extLst>
                      <a:ext uri="{FF2B5EF4-FFF2-40B4-BE49-F238E27FC236}">
                        <a16:creationId xmlns:a16="http://schemas.microsoft.com/office/drawing/2014/main" xmlns="" id="{F5D5C7F0-28FF-4895-B74C-F2CB1907A316}"/>
                      </a:ext>
                    </a:extLst>
                  </p:cNvPr>
                  <p:cNvSpPr/>
                  <p:nvPr/>
                </p:nvSpPr>
                <p:spPr>
                  <a:xfrm>
                    <a:off x="4936945" y="5391467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44" name="フリーフォーム: 図形 143">
                    <a:extLst>
                      <a:ext uri="{FF2B5EF4-FFF2-40B4-BE49-F238E27FC236}">
                        <a16:creationId xmlns:a16="http://schemas.microsoft.com/office/drawing/2014/main" xmlns="" id="{D1FEC412-8187-410C-99E0-6838F398998C}"/>
                      </a:ext>
                    </a:extLst>
                  </p:cNvPr>
                  <p:cNvSpPr/>
                  <p:nvPr/>
                </p:nvSpPr>
                <p:spPr>
                  <a:xfrm>
                    <a:off x="5960177" y="5391467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45" name="フリーフォーム: 図形 144">
                    <a:extLst>
                      <a:ext uri="{FF2B5EF4-FFF2-40B4-BE49-F238E27FC236}">
                        <a16:creationId xmlns:a16="http://schemas.microsoft.com/office/drawing/2014/main" xmlns="" id="{71E896C1-3885-4217-BCB5-8DEE8D5127A4}"/>
                      </a:ext>
                    </a:extLst>
                  </p:cNvPr>
                  <p:cNvSpPr/>
                  <p:nvPr/>
                </p:nvSpPr>
                <p:spPr>
                  <a:xfrm>
                    <a:off x="6983410" y="5391467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46" name="フリーフォーム: 図形 145">
                    <a:extLst>
                      <a:ext uri="{FF2B5EF4-FFF2-40B4-BE49-F238E27FC236}">
                        <a16:creationId xmlns:a16="http://schemas.microsoft.com/office/drawing/2014/main" xmlns="" id="{82F839D9-BDC3-418E-B315-F42E96947A17}"/>
                      </a:ext>
                    </a:extLst>
                  </p:cNvPr>
                  <p:cNvSpPr/>
                  <p:nvPr/>
                </p:nvSpPr>
                <p:spPr>
                  <a:xfrm>
                    <a:off x="8006642" y="5391467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47" name="フリーフォーム: 図形 146">
                    <a:extLst>
                      <a:ext uri="{FF2B5EF4-FFF2-40B4-BE49-F238E27FC236}">
                        <a16:creationId xmlns:a16="http://schemas.microsoft.com/office/drawing/2014/main" xmlns="" id="{42C14FB1-B8B4-4F38-B71D-2CE61482D859}"/>
                      </a:ext>
                    </a:extLst>
                  </p:cNvPr>
                  <p:cNvSpPr/>
                  <p:nvPr/>
                </p:nvSpPr>
                <p:spPr>
                  <a:xfrm>
                    <a:off x="3402089" y="5391467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48" name="テキスト ボックス 147">
                    <a:extLst>
                      <a:ext uri="{FF2B5EF4-FFF2-40B4-BE49-F238E27FC236}">
                        <a16:creationId xmlns:a16="http://schemas.microsoft.com/office/drawing/2014/main" xmlns="" id="{A401117C-EF61-4078-8F53-3AA149C65418}"/>
                      </a:ext>
                    </a:extLst>
                  </p:cNvPr>
                  <p:cNvSpPr txBox="1"/>
                  <p:nvPr/>
                </p:nvSpPr>
                <p:spPr>
                  <a:xfrm>
                    <a:off x="3282073" y="5440521"/>
                    <a:ext cx="278464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</a:t>
                    </a:r>
                  </a:p>
                </p:txBody>
              </p:sp>
              <p:sp>
                <p:nvSpPr>
                  <p:cNvPr id="149" name="フリーフォーム: 図形 148">
                    <a:extLst>
                      <a:ext uri="{FF2B5EF4-FFF2-40B4-BE49-F238E27FC236}">
                        <a16:creationId xmlns:a16="http://schemas.microsoft.com/office/drawing/2014/main" xmlns="" id="{599A8D3E-D54E-4C8E-8B20-EF89F161A3E1}"/>
                      </a:ext>
                    </a:extLst>
                  </p:cNvPr>
                  <p:cNvSpPr/>
                  <p:nvPr/>
                </p:nvSpPr>
                <p:spPr>
                  <a:xfrm>
                    <a:off x="4425319" y="5391467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0" name="テキスト ボックス 149">
                    <a:extLst>
                      <a:ext uri="{FF2B5EF4-FFF2-40B4-BE49-F238E27FC236}">
                        <a16:creationId xmlns:a16="http://schemas.microsoft.com/office/drawing/2014/main" xmlns="" id="{FD4F31FE-5552-476E-AAB2-F14AF627FBBA}"/>
                      </a:ext>
                    </a:extLst>
                  </p:cNvPr>
                  <p:cNvSpPr txBox="1"/>
                  <p:nvPr/>
                </p:nvSpPr>
                <p:spPr>
                  <a:xfrm>
                    <a:off x="4276729" y="5440521"/>
                    <a:ext cx="344765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50</a:t>
                    </a:r>
                  </a:p>
                </p:txBody>
              </p:sp>
              <p:sp>
                <p:nvSpPr>
                  <p:cNvPr id="151" name="フリーフォーム: 図形 150">
                    <a:extLst>
                      <a:ext uri="{FF2B5EF4-FFF2-40B4-BE49-F238E27FC236}">
                        <a16:creationId xmlns:a16="http://schemas.microsoft.com/office/drawing/2014/main" xmlns="" id="{363C3FF8-8E9B-43EE-A0C5-C20B75FE1543}"/>
                      </a:ext>
                    </a:extLst>
                  </p:cNvPr>
                  <p:cNvSpPr/>
                  <p:nvPr/>
                </p:nvSpPr>
                <p:spPr>
                  <a:xfrm>
                    <a:off x="5448561" y="5391467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2" name="テキスト ボックス 151">
                    <a:extLst>
                      <a:ext uri="{FF2B5EF4-FFF2-40B4-BE49-F238E27FC236}">
                        <a16:creationId xmlns:a16="http://schemas.microsoft.com/office/drawing/2014/main" xmlns="" id="{AD442CA6-8C15-4051-BB49-BFD0381921DF}"/>
                      </a:ext>
                    </a:extLst>
                  </p:cNvPr>
                  <p:cNvSpPr txBox="1"/>
                  <p:nvPr/>
                </p:nvSpPr>
                <p:spPr>
                  <a:xfrm>
                    <a:off x="5271396" y="5440521"/>
                    <a:ext cx="411066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100</a:t>
                    </a:r>
                  </a:p>
                </p:txBody>
              </p:sp>
              <p:sp>
                <p:nvSpPr>
                  <p:cNvPr id="153" name="フリーフォーム: 図形 152">
                    <a:extLst>
                      <a:ext uri="{FF2B5EF4-FFF2-40B4-BE49-F238E27FC236}">
                        <a16:creationId xmlns:a16="http://schemas.microsoft.com/office/drawing/2014/main" xmlns="" id="{3C92BBD4-FE62-438F-B461-0E339EE2747D}"/>
                      </a:ext>
                    </a:extLst>
                  </p:cNvPr>
                  <p:cNvSpPr/>
                  <p:nvPr/>
                </p:nvSpPr>
                <p:spPr>
                  <a:xfrm>
                    <a:off x="6471794" y="5391467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4" name="テキスト ボックス 153">
                    <a:extLst>
                      <a:ext uri="{FF2B5EF4-FFF2-40B4-BE49-F238E27FC236}">
                        <a16:creationId xmlns:a16="http://schemas.microsoft.com/office/drawing/2014/main" xmlns="" id="{ECFE7D88-3172-4263-AB91-F300DE0DECB6}"/>
                      </a:ext>
                    </a:extLst>
                  </p:cNvPr>
                  <p:cNvSpPr txBox="1"/>
                  <p:nvPr/>
                </p:nvSpPr>
                <p:spPr>
                  <a:xfrm>
                    <a:off x="6294629" y="5440521"/>
                    <a:ext cx="411066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150</a:t>
                    </a:r>
                  </a:p>
                </p:txBody>
              </p:sp>
              <p:sp>
                <p:nvSpPr>
                  <p:cNvPr id="155" name="フリーフォーム: 図形 154">
                    <a:extLst>
                      <a:ext uri="{FF2B5EF4-FFF2-40B4-BE49-F238E27FC236}">
                        <a16:creationId xmlns:a16="http://schemas.microsoft.com/office/drawing/2014/main" xmlns="" id="{CD58F098-14C9-4594-939C-9A8782D15A52}"/>
                      </a:ext>
                    </a:extLst>
                  </p:cNvPr>
                  <p:cNvSpPr/>
                  <p:nvPr/>
                </p:nvSpPr>
                <p:spPr>
                  <a:xfrm>
                    <a:off x="7495026" y="5391467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6" name="テキスト ボックス 155">
                    <a:extLst>
                      <a:ext uri="{FF2B5EF4-FFF2-40B4-BE49-F238E27FC236}">
                        <a16:creationId xmlns:a16="http://schemas.microsoft.com/office/drawing/2014/main" xmlns="" id="{ACA011E8-3B9C-4596-962D-1FBE4F02CBC0}"/>
                      </a:ext>
                    </a:extLst>
                  </p:cNvPr>
                  <p:cNvSpPr txBox="1"/>
                  <p:nvPr/>
                </p:nvSpPr>
                <p:spPr>
                  <a:xfrm>
                    <a:off x="7317860" y="5440521"/>
                    <a:ext cx="411066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200</a:t>
                    </a:r>
                  </a:p>
                </p:txBody>
              </p:sp>
              <p:sp>
                <p:nvSpPr>
                  <p:cNvPr id="157" name="フリーフォーム: 図形 156">
                    <a:extLst>
                      <a:ext uri="{FF2B5EF4-FFF2-40B4-BE49-F238E27FC236}">
                        <a16:creationId xmlns:a16="http://schemas.microsoft.com/office/drawing/2014/main" xmlns="" id="{8CCDEEBC-87B2-44D8-99D0-5D2F0F89D6B9}"/>
                      </a:ext>
                    </a:extLst>
                  </p:cNvPr>
                  <p:cNvSpPr/>
                  <p:nvPr/>
                </p:nvSpPr>
                <p:spPr>
                  <a:xfrm>
                    <a:off x="8518259" y="5391467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8" name="テキスト ボックス 157">
                    <a:extLst>
                      <a:ext uri="{FF2B5EF4-FFF2-40B4-BE49-F238E27FC236}">
                        <a16:creationId xmlns:a16="http://schemas.microsoft.com/office/drawing/2014/main" xmlns="" id="{60583C8B-28EB-44E1-88A7-41648552DE27}"/>
                      </a:ext>
                    </a:extLst>
                  </p:cNvPr>
                  <p:cNvSpPr txBox="1"/>
                  <p:nvPr/>
                </p:nvSpPr>
                <p:spPr>
                  <a:xfrm>
                    <a:off x="8341094" y="5440521"/>
                    <a:ext cx="411066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250</a:t>
                    </a:r>
                  </a:p>
                </p:txBody>
              </p:sp>
              <p:sp>
                <p:nvSpPr>
                  <p:cNvPr id="159" name="テキスト ボックス 158">
                    <a:extLst>
                      <a:ext uri="{FF2B5EF4-FFF2-40B4-BE49-F238E27FC236}">
                        <a16:creationId xmlns:a16="http://schemas.microsoft.com/office/drawing/2014/main" xmlns="" id="{59E41CCD-DF22-41C1-87FF-B1C837C28506}"/>
                      </a:ext>
                    </a:extLst>
                  </p:cNvPr>
                  <p:cNvSpPr txBox="1"/>
                  <p:nvPr/>
                </p:nvSpPr>
                <p:spPr>
                  <a:xfrm>
                    <a:off x="5340081" y="5616732"/>
                    <a:ext cx="1460834" cy="3484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 Unicode MS"/>
                        <a:cs typeface="Arial" panose="020B0604020202020204" pitchFamily="34" charset="0"/>
                        <a:sym typeface="Arial Unicode MS"/>
                        <a:rtl val="0"/>
                      </a:rPr>
                      <a:t>APOA2-AT (µg/mL)</a:t>
                    </a:r>
                  </a:p>
                </p:txBody>
              </p:sp>
              <p:sp>
                <p:nvSpPr>
                  <p:cNvPr id="160" name="フリーフォーム: 図形 159">
                    <a:extLst>
                      <a:ext uri="{FF2B5EF4-FFF2-40B4-BE49-F238E27FC236}">
                        <a16:creationId xmlns:a16="http://schemas.microsoft.com/office/drawing/2014/main" xmlns="" id="{0F10D06C-AD2F-4C0A-8A5B-4B8C9BBE7E83}"/>
                      </a:ext>
                    </a:extLst>
                  </p:cNvPr>
                  <p:cNvSpPr/>
                  <p:nvPr/>
                </p:nvSpPr>
                <p:spPr>
                  <a:xfrm>
                    <a:off x="3373560" y="1485225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1" name="フリーフォーム: 図形 160">
                    <a:extLst>
                      <a:ext uri="{FF2B5EF4-FFF2-40B4-BE49-F238E27FC236}">
                        <a16:creationId xmlns:a16="http://schemas.microsoft.com/office/drawing/2014/main" xmlns="" id="{C5309703-9107-4208-B906-75A460FCB6E7}"/>
                      </a:ext>
                    </a:extLst>
                  </p:cNvPr>
                  <p:cNvSpPr/>
                  <p:nvPr/>
                </p:nvSpPr>
                <p:spPr>
                  <a:xfrm>
                    <a:off x="3348781" y="5069912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2" name="フリーフォーム: 図形 161">
                    <a:extLst>
                      <a:ext uri="{FF2B5EF4-FFF2-40B4-BE49-F238E27FC236}">
                        <a16:creationId xmlns:a16="http://schemas.microsoft.com/office/drawing/2014/main" xmlns="" id="{F4BA9E81-F947-4DA5-A43A-37C18E6DC5FD}"/>
                      </a:ext>
                    </a:extLst>
                  </p:cNvPr>
                  <p:cNvSpPr/>
                  <p:nvPr/>
                </p:nvSpPr>
                <p:spPr>
                  <a:xfrm>
                    <a:off x="3348781" y="4426794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3" name="フリーフォーム: 図形 162">
                    <a:extLst>
                      <a:ext uri="{FF2B5EF4-FFF2-40B4-BE49-F238E27FC236}">
                        <a16:creationId xmlns:a16="http://schemas.microsoft.com/office/drawing/2014/main" xmlns="" id="{7C7E9D31-B1B6-4758-B5D9-C5FF3E68A318}"/>
                      </a:ext>
                    </a:extLst>
                  </p:cNvPr>
                  <p:cNvSpPr/>
                  <p:nvPr/>
                </p:nvSpPr>
                <p:spPr>
                  <a:xfrm>
                    <a:off x="3348781" y="3783666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4" name="フリーフォーム: 図形 163">
                    <a:extLst>
                      <a:ext uri="{FF2B5EF4-FFF2-40B4-BE49-F238E27FC236}">
                        <a16:creationId xmlns:a16="http://schemas.microsoft.com/office/drawing/2014/main" xmlns="" id="{62B97100-48FB-455E-A176-F661CCDDCFAE}"/>
                      </a:ext>
                    </a:extLst>
                  </p:cNvPr>
                  <p:cNvSpPr/>
                  <p:nvPr/>
                </p:nvSpPr>
                <p:spPr>
                  <a:xfrm>
                    <a:off x="3348781" y="3140548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5" name="フリーフォーム: 図形 164">
                    <a:extLst>
                      <a:ext uri="{FF2B5EF4-FFF2-40B4-BE49-F238E27FC236}">
                        <a16:creationId xmlns:a16="http://schemas.microsoft.com/office/drawing/2014/main" xmlns="" id="{79C07704-1491-4E10-8717-78EBD42C32DA}"/>
                      </a:ext>
                    </a:extLst>
                  </p:cNvPr>
                  <p:cNvSpPr/>
                  <p:nvPr/>
                </p:nvSpPr>
                <p:spPr>
                  <a:xfrm>
                    <a:off x="3348781" y="2497429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6" name="フリーフォーム: 図形 165">
                    <a:extLst>
                      <a:ext uri="{FF2B5EF4-FFF2-40B4-BE49-F238E27FC236}">
                        <a16:creationId xmlns:a16="http://schemas.microsoft.com/office/drawing/2014/main" xmlns="" id="{E68151D6-7FA5-4E59-A73F-092C449CFDDE}"/>
                      </a:ext>
                    </a:extLst>
                  </p:cNvPr>
                  <p:cNvSpPr/>
                  <p:nvPr/>
                </p:nvSpPr>
                <p:spPr>
                  <a:xfrm>
                    <a:off x="3348781" y="1854307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7" name="フリーフォーム: 図形 166">
                    <a:extLst>
                      <a:ext uri="{FF2B5EF4-FFF2-40B4-BE49-F238E27FC236}">
                        <a16:creationId xmlns:a16="http://schemas.microsoft.com/office/drawing/2014/main" xmlns="" id="{940329D8-2DF1-4762-BB40-1796F2AF0B66}"/>
                      </a:ext>
                    </a:extLst>
                  </p:cNvPr>
                  <p:cNvSpPr/>
                  <p:nvPr/>
                </p:nvSpPr>
                <p:spPr>
                  <a:xfrm>
                    <a:off x="3324002" y="5391467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8" name="テキスト ボックス 167">
                    <a:extLst>
                      <a:ext uri="{FF2B5EF4-FFF2-40B4-BE49-F238E27FC236}">
                        <a16:creationId xmlns:a16="http://schemas.microsoft.com/office/drawing/2014/main" xmlns="" id="{A48D6D69-B992-46D6-8574-E2DE904B35F4}"/>
                      </a:ext>
                    </a:extLst>
                  </p:cNvPr>
                  <p:cNvSpPr txBox="1"/>
                  <p:nvPr/>
                </p:nvSpPr>
                <p:spPr>
                  <a:xfrm>
                    <a:off x="2896789" y="5298122"/>
                    <a:ext cx="571295" cy="33189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00</a:t>
                    </a:r>
                  </a:p>
                </p:txBody>
              </p:sp>
              <p:sp>
                <p:nvSpPr>
                  <p:cNvPr id="169" name="フリーフォーム: 図形 168">
                    <a:extLst>
                      <a:ext uri="{FF2B5EF4-FFF2-40B4-BE49-F238E27FC236}">
                        <a16:creationId xmlns:a16="http://schemas.microsoft.com/office/drawing/2014/main" xmlns="" id="{7DAA91B5-350C-4C0D-97F4-2A1F2869C783}"/>
                      </a:ext>
                    </a:extLst>
                  </p:cNvPr>
                  <p:cNvSpPr/>
                  <p:nvPr/>
                </p:nvSpPr>
                <p:spPr>
                  <a:xfrm>
                    <a:off x="3324002" y="4748349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70" name="テキスト ボックス 169">
                    <a:extLst>
                      <a:ext uri="{FF2B5EF4-FFF2-40B4-BE49-F238E27FC236}">
                        <a16:creationId xmlns:a16="http://schemas.microsoft.com/office/drawing/2014/main" xmlns="" id="{242D9088-7910-41BA-8118-3C3D19BC8C3B}"/>
                      </a:ext>
                    </a:extLst>
                  </p:cNvPr>
                  <p:cNvSpPr txBox="1"/>
                  <p:nvPr/>
                </p:nvSpPr>
                <p:spPr>
                  <a:xfrm>
                    <a:off x="2896789" y="4655005"/>
                    <a:ext cx="571295" cy="33189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25</a:t>
                    </a:r>
                  </a:p>
                </p:txBody>
              </p:sp>
              <p:sp>
                <p:nvSpPr>
                  <p:cNvPr id="171" name="フリーフォーム: 図形 170">
                    <a:extLst>
                      <a:ext uri="{FF2B5EF4-FFF2-40B4-BE49-F238E27FC236}">
                        <a16:creationId xmlns:a16="http://schemas.microsoft.com/office/drawing/2014/main" xmlns="" id="{529CB204-6F94-4471-AEDE-9CCE530BF574}"/>
                      </a:ext>
                    </a:extLst>
                  </p:cNvPr>
                  <p:cNvSpPr/>
                  <p:nvPr/>
                </p:nvSpPr>
                <p:spPr>
                  <a:xfrm>
                    <a:off x="3324002" y="4105230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72" name="テキスト ボックス 171">
                    <a:extLst>
                      <a:ext uri="{FF2B5EF4-FFF2-40B4-BE49-F238E27FC236}">
                        <a16:creationId xmlns:a16="http://schemas.microsoft.com/office/drawing/2014/main" xmlns="" id="{90F73EAE-F464-4EE7-AAD0-081E1747502A}"/>
                      </a:ext>
                    </a:extLst>
                  </p:cNvPr>
                  <p:cNvSpPr txBox="1"/>
                  <p:nvPr/>
                </p:nvSpPr>
                <p:spPr>
                  <a:xfrm>
                    <a:off x="2896789" y="4011885"/>
                    <a:ext cx="571295" cy="33189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50</a:t>
                    </a:r>
                  </a:p>
                </p:txBody>
              </p:sp>
              <p:sp>
                <p:nvSpPr>
                  <p:cNvPr id="173" name="フリーフォーム: 図形 172">
                    <a:extLst>
                      <a:ext uri="{FF2B5EF4-FFF2-40B4-BE49-F238E27FC236}">
                        <a16:creationId xmlns:a16="http://schemas.microsoft.com/office/drawing/2014/main" xmlns="" id="{DFED9AEE-CD8B-4CCF-AB7F-544D46ADEC84}"/>
                      </a:ext>
                    </a:extLst>
                  </p:cNvPr>
                  <p:cNvSpPr/>
                  <p:nvPr/>
                </p:nvSpPr>
                <p:spPr>
                  <a:xfrm>
                    <a:off x="3324002" y="3462112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74" name="テキスト ボックス 173">
                    <a:extLst>
                      <a:ext uri="{FF2B5EF4-FFF2-40B4-BE49-F238E27FC236}">
                        <a16:creationId xmlns:a16="http://schemas.microsoft.com/office/drawing/2014/main" xmlns="" id="{D55359FC-0535-4615-9E38-B46930C70F46}"/>
                      </a:ext>
                    </a:extLst>
                  </p:cNvPr>
                  <p:cNvSpPr txBox="1"/>
                  <p:nvPr/>
                </p:nvSpPr>
                <p:spPr>
                  <a:xfrm>
                    <a:off x="2896789" y="3368766"/>
                    <a:ext cx="571295" cy="33189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75</a:t>
                    </a:r>
                  </a:p>
                </p:txBody>
              </p:sp>
              <p:sp>
                <p:nvSpPr>
                  <p:cNvPr id="175" name="フリーフォーム: 図形 174">
                    <a:extLst>
                      <a:ext uri="{FF2B5EF4-FFF2-40B4-BE49-F238E27FC236}">
                        <a16:creationId xmlns:a16="http://schemas.microsoft.com/office/drawing/2014/main" xmlns="" id="{8C76071B-B3EF-45AC-B539-DE76837F35FE}"/>
                      </a:ext>
                    </a:extLst>
                  </p:cNvPr>
                  <p:cNvSpPr/>
                  <p:nvPr/>
                </p:nvSpPr>
                <p:spPr>
                  <a:xfrm>
                    <a:off x="3324002" y="2818984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76" name="テキスト ボックス 175">
                    <a:extLst>
                      <a:ext uri="{FF2B5EF4-FFF2-40B4-BE49-F238E27FC236}">
                        <a16:creationId xmlns:a16="http://schemas.microsoft.com/office/drawing/2014/main" xmlns="" id="{C4D9DCE5-F6F6-4ED9-8C97-09AFDCE6BC35}"/>
                      </a:ext>
                    </a:extLst>
                  </p:cNvPr>
                  <p:cNvSpPr txBox="1"/>
                  <p:nvPr/>
                </p:nvSpPr>
                <p:spPr>
                  <a:xfrm>
                    <a:off x="2896789" y="2725638"/>
                    <a:ext cx="571295" cy="33189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00</a:t>
                    </a:r>
                  </a:p>
                </p:txBody>
              </p:sp>
              <p:sp>
                <p:nvSpPr>
                  <p:cNvPr id="177" name="フリーフォーム: 図形 176">
                    <a:extLst>
                      <a:ext uri="{FF2B5EF4-FFF2-40B4-BE49-F238E27FC236}">
                        <a16:creationId xmlns:a16="http://schemas.microsoft.com/office/drawing/2014/main" xmlns="" id="{F178CFC1-80E7-46F4-BEE8-36BA4C99F437}"/>
                      </a:ext>
                    </a:extLst>
                  </p:cNvPr>
                  <p:cNvSpPr/>
                  <p:nvPr/>
                </p:nvSpPr>
                <p:spPr>
                  <a:xfrm>
                    <a:off x="3324002" y="2175867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78" name="テキスト ボックス 177">
                    <a:extLst>
                      <a:ext uri="{FF2B5EF4-FFF2-40B4-BE49-F238E27FC236}">
                        <a16:creationId xmlns:a16="http://schemas.microsoft.com/office/drawing/2014/main" xmlns="" id="{27AE5C81-D552-4B9D-A15F-1C0AFCF148B4}"/>
                      </a:ext>
                    </a:extLst>
                  </p:cNvPr>
                  <p:cNvSpPr txBox="1"/>
                  <p:nvPr/>
                </p:nvSpPr>
                <p:spPr>
                  <a:xfrm>
                    <a:off x="2896789" y="2082522"/>
                    <a:ext cx="571295" cy="33189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25</a:t>
                    </a:r>
                  </a:p>
                </p:txBody>
              </p:sp>
              <p:sp>
                <p:nvSpPr>
                  <p:cNvPr id="179" name="フリーフォーム: 図形 178">
                    <a:extLst>
                      <a:ext uri="{FF2B5EF4-FFF2-40B4-BE49-F238E27FC236}">
                        <a16:creationId xmlns:a16="http://schemas.microsoft.com/office/drawing/2014/main" xmlns="" id="{27569363-0D06-4C9F-8DE9-1ACC317DC4FE}"/>
                      </a:ext>
                    </a:extLst>
                  </p:cNvPr>
                  <p:cNvSpPr/>
                  <p:nvPr/>
                </p:nvSpPr>
                <p:spPr>
                  <a:xfrm>
                    <a:off x="3324002" y="1532746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80" name="テキスト ボックス 179">
                    <a:extLst>
                      <a:ext uri="{FF2B5EF4-FFF2-40B4-BE49-F238E27FC236}">
                        <a16:creationId xmlns:a16="http://schemas.microsoft.com/office/drawing/2014/main" xmlns="" id="{5A88029A-A966-405E-8A44-3112D118546C}"/>
                      </a:ext>
                    </a:extLst>
                  </p:cNvPr>
                  <p:cNvSpPr txBox="1"/>
                  <p:nvPr/>
                </p:nvSpPr>
                <p:spPr>
                  <a:xfrm>
                    <a:off x="2896789" y="1439401"/>
                    <a:ext cx="571295" cy="33189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50</a:t>
                    </a:r>
                  </a:p>
                </p:txBody>
              </p:sp>
              <p:sp>
                <p:nvSpPr>
                  <p:cNvPr id="181" name="テキスト ボックス 180">
                    <a:extLst>
                      <a:ext uri="{FF2B5EF4-FFF2-40B4-BE49-F238E27FC236}">
                        <a16:creationId xmlns:a16="http://schemas.microsoft.com/office/drawing/2014/main" xmlns="" id="{9D64D6B5-6045-4044-A908-D6E11BA9F13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375951" y="3299114"/>
                    <a:ext cx="862461" cy="27846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ＭＳ Ｐゴシック"/>
                        <a:cs typeface="Arial" panose="020B0604020202020204" pitchFamily="34" charset="0"/>
                        <a:sym typeface="ＭＳ Ｐゴシック"/>
                        <a:rtl val="0"/>
                      </a:rPr>
                      <a:t>Density</a:t>
                    </a:r>
                  </a:p>
                </p:txBody>
              </p:sp>
            </p:grpSp>
          </p:grpSp>
        </p:grpSp>
        <p:grpSp>
          <p:nvGrpSpPr>
            <p:cNvPr id="188" name="グラフィックス 236">
              <a:extLst>
                <a:ext uri="{FF2B5EF4-FFF2-40B4-BE49-F238E27FC236}">
                  <a16:creationId xmlns:a16="http://schemas.microsoft.com/office/drawing/2014/main" xmlns="" id="{57857BD7-4E30-467A-905D-E3430A74028A}"/>
                </a:ext>
              </a:extLst>
            </p:cNvPr>
            <p:cNvGrpSpPr/>
            <p:nvPr/>
          </p:nvGrpSpPr>
          <p:grpSpPr>
            <a:xfrm>
              <a:off x="3052762" y="4762653"/>
              <a:ext cx="6130028" cy="4594274"/>
              <a:chOff x="3043237" y="1138237"/>
              <a:chExt cx="6130028" cy="4594274"/>
            </a:xfrm>
          </p:grpSpPr>
          <p:sp>
            <p:nvSpPr>
              <p:cNvPr id="189" name="フリーフォーム: 図形 188">
                <a:extLst>
                  <a:ext uri="{FF2B5EF4-FFF2-40B4-BE49-F238E27FC236}">
                    <a16:creationId xmlns:a16="http://schemas.microsoft.com/office/drawing/2014/main" xmlns="" id="{13A3D7C8-8D6C-4DF3-84F7-A7585B3DE924}"/>
                  </a:ext>
                </a:extLst>
              </p:cNvPr>
              <p:cNvSpPr/>
              <p:nvPr/>
            </p:nvSpPr>
            <p:spPr>
              <a:xfrm>
                <a:off x="3043237" y="1138237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90" name="フリーフォーム: 図形 189">
                <a:extLst>
                  <a:ext uri="{FF2B5EF4-FFF2-40B4-BE49-F238E27FC236}">
                    <a16:creationId xmlns:a16="http://schemas.microsoft.com/office/drawing/2014/main" xmlns="" id="{3664BB65-CA95-4C4D-B9A9-ECEEDB27AE5A}"/>
                  </a:ext>
                </a:extLst>
              </p:cNvPr>
              <p:cNvSpPr/>
              <p:nvPr/>
            </p:nvSpPr>
            <p:spPr>
              <a:xfrm>
                <a:off x="3043237" y="1138237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91" name="フリーフォーム: 図形 190">
                <a:extLst>
                  <a:ext uri="{FF2B5EF4-FFF2-40B4-BE49-F238E27FC236}">
                    <a16:creationId xmlns:a16="http://schemas.microsoft.com/office/drawing/2014/main" xmlns="" id="{292A9B76-9583-4BEC-ACD2-DF49561C483E}"/>
                  </a:ext>
                </a:extLst>
              </p:cNvPr>
              <p:cNvSpPr/>
              <p:nvPr/>
            </p:nvSpPr>
            <p:spPr>
              <a:xfrm>
                <a:off x="3043237" y="1138237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noFill/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grpSp>
            <p:nvGrpSpPr>
              <p:cNvPr id="192" name="グラフィックス 236">
                <a:extLst>
                  <a:ext uri="{FF2B5EF4-FFF2-40B4-BE49-F238E27FC236}">
                    <a16:creationId xmlns:a16="http://schemas.microsoft.com/office/drawing/2014/main" xmlns="" id="{E999BDF2-B15E-4EA2-BD2B-CEEE380C2A12}"/>
                  </a:ext>
                </a:extLst>
              </p:cNvPr>
              <p:cNvGrpSpPr/>
              <p:nvPr/>
            </p:nvGrpSpPr>
            <p:grpSpPr>
              <a:xfrm>
                <a:off x="3089055" y="1206692"/>
                <a:ext cx="6084210" cy="4525819"/>
                <a:chOff x="3089055" y="1206692"/>
                <a:chExt cx="6084210" cy="4525819"/>
              </a:xfrm>
            </p:grpSpPr>
            <p:sp>
              <p:nvSpPr>
                <p:cNvPr id="193" name="フリーフォーム: 図形 192">
                  <a:extLst>
                    <a:ext uri="{FF2B5EF4-FFF2-40B4-BE49-F238E27FC236}">
                      <a16:creationId xmlns:a16="http://schemas.microsoft.com/office/drawing/2014/main" xmlns="" id="{8C0420AC-5476-49CD-8E0C-A33F51B50203}"/>
                    </a:ext>
                  </a:extLst>
                </p:cNvPr>
                <p:cNvSpPr/>
                <p:nvPr/>
              </p:nvSpPr>
              <p:spPr>
                <a:xfrm>
                  <a:off x="3794665" y="1257268"/>
                  <a:ext cx="5192248" cy="3896744"/>
                </a:xfrm>
                <a:custGeom>
                  <a:avLst/>
                  <a:gdLst>
                    <a:gd name="connsiteX0" fmla="*/ 11 w 5192248"/>
                    <a:gd name="connsiteY0" fmla="*/ 11 h 3896744"/>
                    <a:gd name="connsiteX1" fmla="*/ 5192260 w 5192248"/>
                    <a:gd name="connsiteY1" fmla="*/ 11 h 3896744"/>
                    <a:gd name="connsiteX2" fmla="*/ 5192260 w 5192248"/>
                    <a:gd name="connsiteY2" fmla="*/ 3896755 h 3896744"/>
                    <a:gd name="connsiteX3" fmla="*/ 11 w 5192248"/>
                    <a:gd name="connsiteY3" fmla="*/ 3896755 h 389674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5192248" h="3896744">
                      <a:moveTo>
                        <a:pt x="11" y="11"/>
                      </a:moveTo>
                      <a:lnTo>
                        <a:pt x="5192260" y="11"/>
                      </a:lnTo>
                      <a:lnTo>
                        <a:pt x="5192260" y="3896755"/>
                      </a:lnTo>
                      <a:lnTo>
                        <a:pt x="11" y="3896755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/>
                </a:p>
              </p:txBody>
            </p:sp>
            <p:grpSp>
              <p:nvGrpSpPr>
                <p:cNvPr id="194" name="グラフィックス 236">
                  <a:extLst>
                    <a:ext uri="{FF2B5EF4-FFF2-40B4-BE49-F238E27FC236}">
                      <a16:creationId xmlns:a16="http://schemas.microsoft.com/office/drawing/2014/main" xmlns="" id="{13CDD30F-EA59-488C-B34D-294D97965F8F}"/>
                    </a:ext>
                  </a:extLst>
                </p:cNvPr>
                <p:cNvGrpSpPr/>
                <p:nvPr/>
              </p:nvGrpSpPr>
              <p:grpSpPr>
                <a:xfrm>
                  <a:off x="3558854" y="1252516"/>
                  <a:ext cx="4061706" cy="3906242"/>
                  <a:chOff x="3558854" y="1252516"/>
                  <a:chExt cx="4061706" cy="3906242"/>
                </a:xfrm>
                <a:noFill/>
              </p:grpSpPr>
              <p:sp>
                <p:nvSpPr>
                  <p:cNvPr id="241" name="フリーフォーム: 図形 240">
                    <a:extLst>
                      <a:ext uri="{FF2B5EF4-FFF2-40B4-BE49-F238E27FC236}">
                        <a16:creationId xmlns:a16="http://schemas.microsoft.com/office/drawing/2014/main" xmlns="" id="{27D9D11F-22E7-4120-B42D-E1379CD5CED2}"/>
                      </a:ext>
                    </a:extLst>
                  </p:cNvPr>
                  <p:cNvSpPr/>
                  <p:nvPr/>
                </p:nvSpPr>
                <p:spPr>
                  <a:xfrm>
                    <a:off x="3558854" y="1565390"/>
                    <a:ext cx="4061706" cy="3589796"/>
                  </a:xfrm>
                  <a:custGeom>
                    <a:avLst/>
                    <a:gdLst>
                      <a:gd name="connsiteX0" fmla="*/ 11 w 4061706"/>
                      <a:gd name="connsiteY0" fmla="*/ 3589807 h 3589796"/>
                      <a:gd name="connsiteX1" fmla="*/ 24479 w 4061706"/>
                      <a:gd name="connsiteY1" fmla="*/ 3588179 h 3589796"/>
                      <a:gd name="connsiteX2" fmla="*/ 48947 w 4061706"/>
                      <a:gd name="connsiteY2" fmla="*/ 3585931 h 3589796"/>
                      <a:gd name="connsiteX3" fmla="*/ 73415 w 4061706"/>
                      <a:gd name="connsiteY3" fmla="*/ 3582873 h 3589796"/>
                      <a:gd name="connsiteX4" fmla="*/ 97883 w 4061706"/>
                      <a:gd name="connsiteY4" fmla="*/ 3578787 h 3589796"/>
                      <a:gd name="connsiteX5" fmla="*/ 122351 w 4061706"/>
                      <a:gd name="connsiteY5" fmla="*/ 3573434 h 3589796"/>
                      <a:gd name="connsiteX6" fmla="*/ 146820 w 4061706"/>
                      <a:gd name="connsiteY6" fmla="*/ 3566519 h 3589796"/>
                      <a:gd name="connsiteX7" fmla="*/ 171288 w 4061706"/>
                      <a:gd name="connsiteY7" fmla="*/ 3557765 h 3589796"/>
                      <a:gd name="connsiteX8" fmla="*/ 195755 w 4061706"/>
                      <a:gd name="connsiteY8" fmla="*/ 3546840 h 3589796"/>
                      <a:gd name="connsiteX9" fmla="*/ 220223 w 4061706"/>
                      <a:gd name="connsiteY9" fmla="*/ 3533458 h 3589796"/>
                      <a:gd name="connsiteX10" fmla="*/ 244692 w 4061706"/>
                      <a:gd name="connsiteY10" fmla="*/ 3517313 h 3589796"/>
                      <a:gd name="connsiteX11" fmla="*/ 269160 w 4061706"/>
                      <a:gd name="connsiteY11" fmla="*/ 3498148 h 3589796"/>
                      <a:gd name="connsiteX12" fmla="*/ 293628 w 4061706"/>
                      <a:gd name="connsiteY12" fmla="*/ 3475746 h 3589796"/>
                      <a:gd name="connsiteX13" fmla="*/ 318096 w 4061706"/>
                      <a:gd name="connsiteY13" fmla="*/ 3449961 h 3589796"/>
                      <a:gd name="connsiteX14" fmla="*/ 342564 w 4061706"/>
                      <a:gd name="connsiteY14" fmla="*/ 3420682 h 3589796"/>
                      <a:gd name="connsiteX15" fmla="*/ 367032 w 4061706"/>
                      <a:gd name="connsiteY15" fmla="*/ 3387877 h 3589796"/>
                      <a:gd name="connsiteX16" fmla="*/ 391500 w 4061706"/>
                      <a:gd name="connsiteY16" fmla="*/ 3351578 h 3589796"/>
                      <a:gd name="connsiteX17" fmla="*/ 415969 w 4061706"/>
                      <a:gd name="connsiteY17" fmla="*/ 3311849 h 3589796"/>
                      <a:gd name="connsiteX18" fmla="*/ 440437 w 4061706"/>
                      <a:gd name="connsiteY18" fmla="*/ 3268767 h 3589796"/>
                      <a:gd name="connsiteX19" fmla="*/ 464904 w 4061706"/>
                      <a:gd name="connsiteY19" fmla="*/ 3222447 h 3589796"/>
                      <a:gd name="connsiteX20" fmla="*/ 489373 w 4061706"/>
                      <a:gd name="connsiteY20" fmla="*/ 3172955 h 3589796"/>
                      <a:gd name="connsiteX21" fmla="*/ 513841 w 4061706"/>
                      <a:gd name="connsiteY21" fmla="*/ 3120339 h 3589796"/>
                      <a:gd name="connsiteX22" fmla="*/ 538309 w 4061706"/>
                      <a:gd name="connsiteY22" fmla="*/ 3064589 h 3589796"/>
                      <a:gd name="connsiteX23" fmla="*/ 562776 w 4061706"/>
                      <a:gd name="connsiteY23" fmla="*/ 3005649 h 3589796"/>
                      <a:gd name="connsiteX24" fmla="*/ 587245 w 4061706"/>
                      <a:gd name="connsiteY24" fmla="*/ 2943422 h 3589796"/>
                      <a:gd name="connsiteX25" fmla="*/ 611715 w 4061706"/>
                      <a:gd name="connsiteY25" fmla="*/ 2877757 h 3589796"/>
                      <a:gd name="connsiteX26" fmla="*/ 636185 w 4061706"/>
                      <a:gd name="connsiteY26" fmla="*/ 2808500 h 3589796"/>
                      <a:gd name="connsiteX27" fmla="*/ 660645 w 4061706"/>
                      <a:gd name="connsiteY27" fmla="*/ 2735539 h 3589796"/>
                      <a:gd name="connsiteX28" fmla="*/ 685115 w 4061706"/>
                      <a:gd name="connsiteY28" fmla="*/ 2658786 h 3589796"/>
                      <a:gd name="connsiteX29" fmla="*/ 709584 w 4061706"/>
                      <a:gd name="connsiteY29" fmla="*/ 2578224 h 3589796"/>
                      <a:gd name="connsiteX30" fmla="*/ 734054 w 4061706"/>
                      <a:gd name="connsiteY30" fmla="*/ 2493947 h 3589796"/>
                      <a:gd name="connsiteX31" fmla="*/ 758524 w 4061706"/>
                      <a:gd name="connsiteY31" fmla="*/ 2406136 h 3589796"/>
                      <a:gd name="connsiteX32" fmla="*/ 782994 w 4061706"/>
                      <a:gd name="connsiteY32" fmla="*/ 2315096 h 3589796"/>
                      <a:gd name="connsiteX33" fmla="*/ 831924 w 4061706"/>
                      <a:gd name="connsiteY33" fmla="*/ 2124920 h 3589796"/>
                      <a:gd name="connsiteX34" fmla="*/ 905333 w 4061706"/>
                      <a:gd name="connsiteY34" fmla="*/ 1826539 h 3589796"/>
                      <a:gd name="connsiteX35" fmla="*/ 1150011 w 4061706"/>
                      <a:gd name="connsiteY35" fmla="*/ 828415 h 3589796"/>
                      <a:gd name="connsiteX36" fmla="*/ 1198950 w 4061706"/>
                      <a:gd name="connsiteY36" fmla="*/ 642420 h 3589796"/>
                      <a:gd name="connsiteX37" fmla="*/ 1223411 w 4061706"/>
                      <a:gd name="connsiteY37" fmla="*/ 553976 h 3589796"/>
                      <a:gd name="connsiteX38" fmla="*/ 1247880 w 4061706"/>
                      <a:gd name="connsiteY38" fmla="*/ 469560 h 3589796"/>
                      <a:gd name="connsiteX39" fmla="*/ 1272350 w 4061706"/>
                      <a:gd name="connsiteY39" fmla="*/ 389972 h 3589796"/>
                      <a:gd name="connsiteX40" fmla="*/ 1296820 w 4061706"/>
                      <a:gd name="connsiteY40" fmla="*/ 316004 h 3589796"/>
                      <a:gd name="connsiteX41" fmla="*/ 1321290 w 4061706"/>
                      <a:gd name="connsiteY41" fmla="*/ 248408 h 3589796"/>
                      <a:gd name="connsiteX42" fmla="*/ 1345759 w 4061706"/>
                      <a:gd name="connsiteY42" fmla="*/ 187870 h 3589796"/>
                      <a:gd name="connsiteX43" fmla="*/ 1370219 w 4061706"/>
                      <a:gd name="connsiteY43" fmla="*/ 134994 h 3589796"/>
                      <a:gd name="connsiteX44" fmla="*/ 1394689 w 4061706"/>
                      <a:gd name="connsiteY44" fmla="*/ 90288 h 3589796"/>
                      <a:gd name="connsiteX45" fmla="*/ 1419159 w 4061706"/>
                      <a:gd name="connsiteY45" fmla="*/ 54164 h 3589796"/>
                      <a:gd name="connsiteX46" fmla="*/ 1443629 w 4061706"/>
                      <a:gd name="connsiteY46" fmla="*/ 26942 h 3589796"/>
                      <a:gd name="connsiteX47" fmla="*/ 1468098 w 4061706"/>
                      <a:gd name="connsiteY47" fmla="*/ 8847 h 3589796"/>
                      <a:gd name="connsiteX48" fmla="*/ 1492568 w 4061706"/>
                      <a:gd name="connsiteY48" fmla="*/ 11 h 3589796"/>
                      <a:gd name="connsiteX49" fmla="*/ 1517028 w 4061706"/>
                      <a:gd name="connsiteY49" fmla="*/ 458 h 3589796"/>
                      <a:gd name="connsiteX50" fmla="*/ 1541498 w 4061706"/>
                      <a:gd name="connsiteY50" fmla="*/ 10088 h 3589796"/>
                      <a:gd name="connsiteX51" fmla="*/ 1565968 w 4061706"/>
                      <a:gd name="connsiteY51" fmla="*/ 28659 h 3589796"/>
                      <a:gd name="connsiteX52" fmla="*/ 1590437 w 4061706"/>
                      <a:gd name="connsiteY52" fmla="*/ 55752 h 3589796"/>
                      <a:gd name="connsiteX53" fmla="*/ 1614907 w 4061706"/>
                      <a:gd name="connsiteY53" fmla="*/ 90758 h 3589796"/>
                      <a:gd name="connsiteX54" fmla="*/ 1639377 w 4061706"/>
                      <a:gd name="connsiteY54" fmla="*/ 132861 h 3589796"/>
                      <a:gd name="connsiteX55" fmla="*/ 1663837 w 4061706"/>
                      <a:gd name="connsiteY55" fmla="*/ 181047 h 3589796"/>
                      <a:gd name="connsiteX56" fmla="*/ 1688307 w 4061706"/>
                      <a:gd name="connsiteY56" fmla="*/ 234129 h 3589796"/>
                      <a:gd name="connsiteX57" fmla="*/ 1712777 w 4061706"/>
                      <a:gd name="connsiteY57" fmla="*/ 290786 h 3589796"/>
                      <a:gd name="connsiteX58" fmla="*/ 1835116 w 4061706"/>
                      <a:gd name="connsiteY58" fmla="*/ 581784 h 3589796"/>
                      <a:gd name="connsiteX59" fmla="*/ 1859585 w 4061706"/>
                      <a:gd name="connsiteY59" fmla="*/ 634400 h 3589796"/>
                      <a:gd name="connsiteX60" fmla="*/ 1884055 w 4061706"/>
                      <a:gd name="connsiteY60" fmla="*/ 684025 h 3589796"/>
                      <a:gd name="connsiteX61" fmla="*/ 1908525 w 4061706"/>
                      <a:gd name="connsiteY61" fmla="*/ 730812 h 3589796"/>
                      <a:gd name="connsiteX62" fmla="*/ 1932995 w 4061706"/>
                      <a:gd name="connsiteY62" fmla="*/ 775217 h 3589796"/>
                      <a:gd name="connsiteX63" fmla="*/ 2055334 w 4061706"/>
                      <a:gd name="connsiteY63" fmla="*/ 990187 h 3589796"/>
                      <a:gd name="connsiteX64" fmla="*/ 2079794 w 4061706"/>
                      <a:gd name="connsiteY64" fmla="*/ 1038107 h 3589796"/>
                      <a:gd name="connsiteX65" fmla="*/ 2104264 w 4061706"/>
                      <a:gd name="connsiteY65" fmla="*/ 1089428 h 3589796"/>
                      <a:gd name="connsiteX66" fmla="*/ 2128733 w 4061706"/>
                      <a:gd name="connsiteY66" fmla="*/ 1144606 h 3589796"/>
                      <a:gd name="connsiteX67" fmla="*/ 2153203 w 4061706"/>
                      <a:gd name="connsiteY67" fmla="*/ 1203900 h 3589796"/>
                      <a:gd name="connsiteX68" fmla="*/ 2177673 w 4061706"/>
                      <a:gd name="connsiteY68" fmla="*/ 1267422 h 3589796"/>
                      <a:gd name="connsiteX69" fmla="*/ 2202143 w 4061706"/>
                      <a:gd name="connsiteY69" fmla="*/ 1335135 h 3589796"/>
                      <a:gd name="connsiteX70" fmla="*/ 2226603 w 4061706"/>
                      <a:gd name="connsiteY70" fmla="*/ 1406896 h 3589796"/>
                      <a:gd name="connsiteX71" fmla="*/ 2251072 w 4061706"/>
                      <a:gd name="connsiteY71" fmla="*/ 1482477 h 3589796"/>
                      <a:gd name="connsiteX72" fmla="*/ 2275542 w 4061706"/>
                      <a:gd name="connsiteY72" fmla="*/ 1561563 h 3589796"/>
                      <a:gd name="connsiteX73" fmla="*/ 2300012 w 4061706"/>
                      <a:gd name="connsiteY73" fmla="*/ 1643793 h 3589796"/>
                      <a:gd name="connsiteX74" fmla="*/ 2348951 w 4061706"/>
                      <a:gd name="connsiteY74" fmla="*/ 1816062 h 3589796"/>
                      <a:gd name="connsiteX75" fmla="*/ 2422351 w 4061706"/>
                      <a:gd name="connsiteY75" fmla="*/ 2086648 h 3589796"/>
                      <a:gd name="connsiteX76" fmla="*/ 2495760 w 4061706"/>
                      <a:gd name="connsiteY76" fmla="*/ 2357653 h 3589796"/>
                      <a:gd name="connsiteX77" fmla="*/ 2520220 w 4061706"/>
                      <a:gd name="connsiteY77" fmla="*/ 2444874 h 3589796"/>
                      <a:gd name="connsiteX78" fmla="*/ 2544690 w 4061706"/>
                      <a:gd name="connsiteY78" fmla="*/ 2529303 h 3589796"/>
                      <a:gd name="connsiteX79" fmla="*/ 2569160 w 4061706"/>
                      <a:gd name="connsiteY79" fmla="*/ 2610228 h 3589796"/>
                      <a:gd name="connsiteX80" fmla="*/ 2593629 w 4061706"/>
                      <a:gd name="connsiteY80" fmla="*/ 2686971 h 3589796"/>
                      <a:gd name="connsiteX81" fmla="*/ 2618099 w 4061706"/>
                      <a:gd name="connsiteY81" fmla="*/ 2758923 h 3589796"/>
                      <a:gd name="connsiteX82" fmla="*/ 2642569 w 4061706"/>
                      <a:gd name="connsiteY82" fmla="*/ 2825617 h 3589796"/>
                      <a:gd name="connsiteX83" fmla="*/ 2667029 w 4061706"/>
                      <a:gd name="connsiteY83" fmla="*/ 2886681 h 3589796"/>
                      <a:gd name="connsiteX84" fmla="*/ 2691499 w 4061706"/>
                      <a:gd name="connsiteY84" fmla="*/ 2941936 h 3589796"/>
                      <a:gd name="connsiteX85" fmla="*/ 2715969 w 4061706"/>
                      <a:gd name="connsiteY85" fmla="*/ 2991361 h 3589796"/>
                      <a:gd name="connsiteX86" fmla="*/ 2740439 w 4061706"/>
                      <a:gd name="connsiteY86" fmla="*/ 3035138 h 3589796"/>
                      <a:gd name="connsiteX87" fmla="*/ 2764908 w 4061706"/>
                      <a:gd name="connsiteY87" fmla="*/ 3073591 h 3589796"/>
                      <a:gd name="connsiteX88" fmla="*/ 2789378 w 4061706"/>
                      <a:gd name="connsiteY88" fmla="*/ 3107233 h 3589796"/>
                      <a:gd name="connsiteX89" fmla="*/ 2813838 w 4061706"/>
                      <a:gd name="connsiteY89" fmla="*/ 3136684 h 3589796"/>
                      <a:gd name="connsiteX90" fmla="*/ 2838308 w 4061706"/>
                      <a:gd name="connsiteY90" fmla="*/ 3162640 h 3589796"/>
                      <a:gd name="connsiteX91" fmla="*/ 2862778 w 4061706"/>
                      <a:gd name="connsiteY91" fmla="*/ 3185824 h 3589796"/>
                      <a:gd name="connsiteX92" fmla="*/ 2887247 w 4061706"/>
                      <a:gd name="connsiteY92" fmla="*/ 3206969 h 3589796"/>
                      <a:gd name="connsiteX93" fmla="*/ 2911717 w 4061706"/>
                      <a:gd name="connsiteY93" fmla="*/ 3226695 h 3589796"/>
                      <a:gd name="connsiteX94" fmla="*/ 2960647 w 4061706"/>
                      <a:gd name="connsiteY94" fmla="*/ 3263938 h 3589796"/>
                      <a:gd name="connsiteX95" fmla="*/ 3034056 w 4061706"/>
                      <a:gd name="connsiteY95" fmla="*/ 3317888 h 3589796"/>
                      <a:gd name="connsiteX96" fmla="*/ 3058526 w 4061706"/>
                      <a:gd name="connsiteY96" fmla="*/ 3335347 h 3589796"/>
                      <a:gd name="connsiteX97" fmla="*/ 3082986 w 4061706"/>
                      <a:gd name="connsiteY97" fmla="*/ 3352206 h 3589796"/>
                      <a:gd name="connsiteX98" fmla="*/ 3107456 w 4061706"/>
                      <a:gd name="connsiteY98" fmla="*/ 3368189 h 3589796"/>
                      <a:gd name="connsiteX99" fmla="*/ 3131925 w 4061706"/>
                      <a:gd name="connsiteY99" fmla="*/ 3383020 h 3589796"/>
                      <a:gd name="connsiteX100" fmla="*/ 3156395 w 4061706"/>
                      <a:gd name="connsiteY100" fmla="*/ 3396421 h 3589796"/>
                      <a:gd name="connsiteX101" fmla="*/ 3180865 w 4061706"/>
                      <a:gd name="connsiteY101" fmla="*/ 3408194 h 3589796"/>
                      <a:gd name="connsiteX102" fmla="*/ 3205335 w 4061706"/>
                      <a:gd name="connsiteY102" fmla="*/ 3418195 h 3589796"/>
                      <a:gd name="connsiteX103" fmla="*/ 3229795 w 4061706"/>
                      <a:gd name="connsiteY103" fmla="*/ 3426349 h 3589796"/>
                      <a:gd name="connsiteX104" fmla="*/ 3254264 w 4061706"/>
                      <a:gd name="connsiteY104" fmla="*/ 3432692 h 3589796"/>
                      <a:gd name="connsiteX105" fmla="*/ 3278734 w 4061706"/>
                      <a:gd name="connsiteY105" fmla="*/ 3437293 h 3589796"/>
                      <a:gd name="connsiteX106" fmla="*/ 3303204 w 4061706"/>
                      <a:gd name="connsiteY106" fmla="*/ 3440332 h 3589796"/>
                      <a:gd name="connsiteX107" fmla="*/ 3327674 w 4061706"/>
                      <a:gd name="connsiteY107" fmla="*/ 3442008 h 3589796"/>
                      <a:gd name="connsiteX108" fmla="*/ 3352143 w 4061706"/>
                      <a:gd name="connsiteY108" fmla="*/ 3442608 h 3589796"/>
                      <a:gd name="connsiteX109" fmla="*/ 3376604 w 4061706"/>
                      <a:gd name="connsiteY109" fmla="*/ 3442427 h 3589796"/>
                      <a:gd name="connsiteX110" fmla="*/ 3401073 w 4061706"/>
                      <a:gd name="connsiteY110" fmla="*/ 3441808 h 3589796"/>
                      <a:gd name="connsiteX111" fmla="*/ 3425543 w 4061706"/>
                      <a:gd name="connsiteY111" fmla="*/ 3441075 h 3589796"/>
                      <a:gd name="connsiteX112" fmla="*/ 3450013 w 4061706"/>
                      <a:gd name="connsiteY112" fmla="*/ 3440589 h 3589796"/>
                      <a:gd name="connsiteX113" fmla="*/ 3474483 w 4061706"/>
                      <a:gd name="connsiteY113" fmla="*/ 3440646 h 3589796"/>
                      <a:gd name="connsiteX114" fmla="*/ 3498952 w 4061706"/>
                      <a:gd name="connsiteY114" fmla="*/ 3441560 h 3589796"/>
                      <a:gd name="connsiteX115" fmla="*/ 3523413 w 4061706"/>
                      <a:gd name="connsiteY115" fmla="*/ 3443551 h 3589796"/>
                      <a:gd name="connsiteX116" fmla="*/ 3547882 w 4061706"/>
                      <a:gd name="connsiteY116" fmla="*/ 3446808 h 3589796"/>
                      <a:gd name="connsiteX117" fmla="*/ 3572352 w 4061706"/>
                      <a:gd name="connsiteY117" fmla="*/ 3451409 h 3589796"/>
                      <a:gd name="connsiteX118" fmla="*/ 3596822 w 4061706"/>
                      <a:gd name="connsiteY118" fmla="*/ 3457381 h 3589796"/>
                      <a:gd name="connsiteX119" fmla="*/ 3621291 w 4061706"/>
                      <a:gd name="connsiteY119" fmla="*/ 3464659 h 3589796"/>
                      <a:gd name="connsiteX120" fmla="*/ 3645761 w 4061706"/>
                      <a:gd name="connsiteY120" fmla="*/ 3473098 h 3589796"/>
                      <a:gd name="connsiteX121" fmla="*/ 3670221 w 4061706"/>
                      <a:gd name="connsiteY121" fmla="*/ 3482489 h 3589796"/>
                      <a:gd name="connsiteX122" fmla="*/ 3694691 w 4061706"/>
                      <a:gd name="connsiteY122" fmla="*/ 3492567 h 3589796"/>
                      <a:gd name="connsiteX123" fmla="*/ 3792560 w 4061706"/>
                      <a:gd name="connsiteY123" fmla="*/ 3534067 h 3589796"/>
                      <a:gd name="connsiteX124" fmla="*/ 3817030 w 4061706"/>
                      <a:gd name="connsiteY124" fmla="*/ 3543421 h 3589796"/>
                      <a:gd name="connsiteX125" fmla="*/ 3841500 w 4061706"/>
                      <a:gd name="connsiteY125" fmla="*/ 3551974 h 3589796"/>
                      <a:gd name="connsiteX126" fmla="*/ 3865970 w 4061706"/>
                      <a:gd name="connsiteY126" fmla="*/ 3559613 h 3589796"/>
                      <a:gd name="connsiteX127" fmla="*/ 3890439 w 4061706"/>
                      <a:gd name="connsiteY127" fmla="*/ 3566290 h 3589796"/>
                      <a:gd name="connsiteX128" fmla="*/ 3914909 w 4061706"/>
                      <a:gd name="connsiteY128" fmla="*/ 3572005 h 3589796"/>
                      <a:gd name="connsiteX129" fmla="*/ 3939369 w 4061706"/>
                      <a:gd name="connsiteY129" fmla="*/ 3576796 h 3589796"/>
                      <a:gd name="connsiteX130" fmla="*/ 3963839 w 4061706"/>
                      <a:gd name="connsiteY130" fmla="*/ 3580730 h 3589796"/>
                      <a:gd name="connsiteX131" fmla="*/ 3988309 w 4061706"/>
                      <a:gd name="connsiteY131" fmla="*/ 3583892 h 3589796"/>
                      <a:gd name="connsiteX132" fmla="*/ 4012778 w 4061706"/>
                      <a:gd name="connsiteY132" fmla="*/ 3586378 h 3589796"/>
                      <a:gd name="connsiteX133" fmla="*/ 4037248 w 4061706"/>
                      <a:gd name="connsiteY133" fmla="*/ 3588302 h 3589796"/>
                      <a:gd name="connsiteX134" fmla="*/ 4061718 w 4061706"/>
                      <a:gd name="connsiteY134" fmla="*/ 3589769 h 358979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  <a:cxn ang="0">
                        <a:pos x="connsiteX101" y="connsiteY101"/>
                      </a:cxn>
                      <a:cxn ang="0">
                        <a:pos x="connsiteX102" y="connsiteY102"/>
                      </a:cxn>
                      <a:cxn ang="0">
                        <a:pos x="connsiteX103" y="connsiteY103"/>
                      </a:cxn>
                      <a:cxn ang="0">
                        <a:pos x="connsiteX104" y="connsiteY104"/>
                      </a:cxn>
                      <a:cxn ang="0">
                        <a:pos x="connsiteX105" y="connsiteY105"/>
                      </a:cxn>
                      <a:cxn ang="0">
                        <a:pos x="connsiteX106" y="connsiteY106"/>
                      </a:cxn>
                      <a:cxn ang="0">
                        <a:pos x="connsiteX107" y="connsiteY107"/>
                      </a:cxn>
                      <a:cxn ang="0">
                        <a:pos x="connsiteX108" y="connsiteY108"/>
                      </a:cxn>
                      <a:cxn ang="0">
                        <a:pos x="connsiteX109" y="connsiteY109"/>
                      </a:cxn>
                      <a:cxn ang="0">
                        <a:pos x="connsiteX110" y="connsiteY110"/>
                      </a:cxn>
                      <a:cxn ang="0">
                        <a:pos x="connsiteX111" y="connsiteY111"/>
                      </a:cxn>
                      <a:cxn ang="0">
                        <a:pos x="connsiteX112" y="connsiteY112"/>
                      </a:cxn>
                      <a:cxn ang="0">
                        <a:pos x="connsiteX113" y="connsiteY113"/>
                      </a:cxn>
                      <a:cxn ang="0">
                        <a:pos x="connsiteX114" y="connsiteY114"/>
                      </a:cxn>
                      <a:cxn ang="0">
                        <a:pos x="connsiteX115" y="connsiteY115"/>
                      </a:cxn>
                      <a:cxn ang="0">
                        <a:pos x="connsiteX116" y="connsiteY116"/>
                      </a:cxn>
                      <a:cxn ang="0">
                        <a:pos x="connsiteX117" y="connsiteY117"/>
                      </a:cxn>
                      <a:cxn ang="0">
                        <a:pos x="connsiteX118" y="connsiteY118"/>
                      </a:cxn>
                      <a:cxn ang="0">
                        <a:pos x="connsiteX119" y="connsiteY119"/>
                      </a:cxn>
                      <a:cxn ang="0">
                        <a:pos x="connsiteX120" y="connsiteY120"/>
                      </a:cxn>
                      <a:cxn ang="0">
                        <a:pos x="connsiteX121" y="connsiteY121"/>
                      </a:cxn>
                      <a:cxn ang="0">
                        <a:pos x="connsiteX122" y="connsiteY122"/>
                      </a:cxn>
                      <a:cxn ang="0">
                        <a:pos x="connsiteX123" y="connsiteY123"/>
                      </a:cxn>
                      <a:cxn ang="0">
                        <a:pos x="connsiteX124" y="connsiteY124"/>
                      </a:cxn>
                      <a:cxn ang="0">
                        <a:pos x="connsiteX125" y="connsiteY125"/>
                      </a:cxn>
                      <a:cxn ang="0">
                        <a:pos x="connsiteX126" y="connsiteY126"/>
                      </a:cxn>
                      <a:cxn ang="0">
                        <a:pos x="connsiteX127" y="connsiteY127"/>
                      </a:cxn>
                      <a:cxn ang="0">
                        <a:pos x="connsiteX128" y="connsiteY128"/>
                      </a:cxn>
                      <a:cxn ang="0">
                        <a:pos x="connsiteX129" y="connsiteY129"/>
                      </a:cxn>
                      <a:cxn ang="0">
                        <a:pos x="connsiteX130" y="connsiteY130"/>
                      </a:cxn>
                      <a:cxn ang="0">
                        <a:pos x="connsiteX131" y="connsiteY131"/>
                      </a:cxn>
                      <a:cxn ang="0">
                        <a:pos x="connsiteX132" y="connsiteY132"/>
                      </a:cxn>
                      <a:cxn ang="0">
                        <a:pos x="connsiteX133" y="connsiteY133"/>
                      </a:cxn>
                      <a:cxn ang="0">
                        <a:pos x="connsiteX134" y="connsiteY134"/>
                      </a:cxn>
                    </a:cxnLst>
                    <a:rect l="l" t="t" r="r" b="b"/>
                    <a:pathLst>
                      <a:path w="4061706" h="3589796">
                        <a:moveTo>
                          <a:pt x="11" y="3589807"/>
                        </a:moveTo>
                        <a:lnTo>
                          <a:pt x="24479" y="3588179"/>
                        </a:lnTo>
                        <a:lnTo>
                          <a:pt x="48947" y="3585931"/>
                        </a:lnTo>
                        <a:lnTo>
                          <a:pt x="73415" y="3582873"/>
                        </a:lnTo>
                        <a:lnTo>
                          <a:pt x="97883" y="3578787"/>
                        </a:lnTo>
                        <a:lnTo>
                          <a:pt x="122351" y="3573434"/>
                        </a:lnTo>
                        <a:lnTo>
                          <a:pt x="146820" y="3566519"/>
                        </a:lnTo>
                        <a:lnTo>
                          <a:pt x="171288" y="3557765"/>
                        </a:lnTo>
                        <a:lnTo>
                          <a:pt x="195755" y="3546840"/>
                        </a:lnTo>
                        <a:lnTo>
                          <a:pt x="220223" y="3533458"/>
                        </a:lnTo>
                        <a:lnTo>
                          <a:pt x="244692" y="3517313"/>
                        </a:lnTo>
                        <a:lnTo>
                          <a:pt x="269160" y="3498148"/>
                        </a:lnTo>
                        <a:lnTo>
                          <a:pt x="293628" y="3475746"/>
                        </a:lnTo>
                        <a:lnTo>
                          <a:pt x="318096" y="3449961"/>
                        </a:lnTo>
                        <a:lnTo>
                          <a:pt x="342564" y="3420682"/>
                        </a:lnTo>
                        <a:lnTo>
                          <a:pt x="367032" y="3387877"/>
                        </a:lnTo>
                        <a:lnTo>
                          <a:pt x="391500" y="3351578"/>
                        </a:lnTo>
                        <a:lnTo>
                          <a:pt x="415969" y="3311849"/>
                        </a:lnTo>
                        <a:lnTo>
                          <a:pt x="440437" y="3268767"/>
                        </a:lnTo>
                        <a:lnTo>
                          <a:pt x="464904" y="3222447"/>
                        </a:lnTo>
                        <a:lnTo>
                          <a:pt x="489373" y="3172955"/>
                        </a:lnTo>
                        <a:lnTo>
                          <a:pt x="513841" y="3120339"/>
                        </a:lnTo>
                        <a:lnTo>
                          <a:pt x="538309" y="3064589"/>
                        </a:lnTo>
                        <a:lnTo>
                          <a:pt x="562776" y="3005649"/>
                        </a:lnTo>
                        <a:lnTo>
                          <a:pt x="587245" y="2943422"/>
                        </a:lnTo>
                        <a:lnTo>
                          <a:pt x="611715" y="2877757"/>
                        </a:lnTo>
                        <a:lnTo>
                          <a:pt x="636185" y="2808500"/>
                        </a:lnTo>
                        <a:lnTo>
                          <a:pt x="660645" y="2735539"/>
                        </a:lnTo>
                        <a:lnTo>
                          <a:pt x="685115" y="2658786"/>
                        </a:lnTo>
                        <a:lnTo>
                          <a:pt x="709584" y="2578224"/>
                        </a:lnTo>
                        <a:lnTo>
                          <a:pt x="734054" y="2493947"/>
                        </a:lnTo>
                        <a:lnTo>
                          <a:pt x="758524" y="2406136"/>
                        </a:lnTo>
                        <a:lnTo>
                          <a:pt x="782994" y="2315096"/>
                        </a:lnTo>
                        <a:lnTo>
                          <a:pt x="831924" y="2124920"/>
                        </a:lnTo>
                        <a:lnTo>
                          <a:pt x="905333" y="1826539"/>
                        </a:lnTo>
                        <a:lnTo>
                          <a:pt x="1150011" y="828415"/>
                        </a:lnTo>
                        <a:lnTo>
                          <a:pt x="1198950" y="642420"/>
                        </a:lnTo>
                        <a:lnTo>
                          <a:pt x="1223411" y="553976"/>
                        </a:lnTo>
                        <a:lnTo>
                          <a:pt x="1247880" y="469560"/>
                        </a:lnTo>
                        <a:lnTo>
                          <a:pt x="1272350" y="389972"/>
                        </a:lnTo>
                        <a:lnTo>
                          <a:pt x="1296820" y="316004"/>
                        </a:lnTo>
                        <a:lnTo>
                          <a:pt x="1321290" y="248408"/>
                        </a:lnTo>
                        <a:lnTo>
                          <a:pt x="1345759" y="187870"/>
                        </a:lnTo>
                        <a:lnTo>
                          <a:pt x="1370219" y="134994"/>
                        </a:lnTo>
                        <a:lnTo>
                          <a:pt x="1394689" y="90288"/>
                        </a:lnTo>
                        <a:lnTo>
                          <a:pt x="1419159" y="54164"/>
                        </a:lnTo>
                        <a:lnTo>
                          <a:pt x="1443629" y="26942"/>
                        </a:lnTo>
                        <a:lnTo>
                          <a:pt x="1468098" y="8847"/>
                        </a:lnTo>
                        <a:lnTo>
                          <a:pt x="1492568" y="11"/>
                        </a:lnTo>
                        <a:lnTo>
                          <a:pt x="1517028" y="458"/>
                        </a:lnTo>
                        <a:lnTo>
                          <a:pt x="1541498" y="10088"/>
                        </a:lnTo>
                        <a:lnTo>
                          <a:pt x="1565968" y="28659"/>
                        </a:lnTo>
                        <a:lnTo>
                          <a:pt x="1590437" y="55752"/>
                        </a:lnTo>
                        <a:lnTo>
                          <a:pt x="1614907" y="90758"/>
                        </a:lnTo>
                        <a:lnTo>
                          <a:pt x="1639377" y="132861"/>
                        </a:lnTo>
                        <a:lnTo>
                          <a:pt x="1663837" y="181047"/>
                        </a:lnTo>
                        <a:lnTo>
                          <a:pt x="1688307" y="234129"/>
                        </a:lnTo>
                        <a:lnTo>
                          <a:pt x="1712777" y="290786"/>
                        </a:lnTo>
                        <a:lnTo>
                          <a:pt x="1835116" y="581784"/>
                        </a:lnTo>
                        <a:lnTo>
                          <a:pt x="1859585" y="634400"/>
                        </a:lnTo>
                        <a:lnTo>
                          <a:pt x="1884055" y="684025"/>
                        </a:lnTo>
                        <a:lnTo>
                          <a:pt x="1908525" y="730812"/>
                        </a:lnTo>
                        <a:lnTo>
                          <a:pt x="1932995" y="775217"/>
                        </a:lnTo>
                        <a:lnTo>
                          <a:pt x="2055334" y="990187"/>
                        </a:lnTo>
                        <a:lnTo>
                          <a:pt x="2079794" y="1038107"/>
                        </a:lnTo>
                        <a:lnTo>
                          <a:pt x="2104264" y="1089428"/>
                        </a:lnTo>
                        <a:lnTo>
                          <a:pt x="2128733" y="1144606"/>
                        </a:lnTo>
                        <a:lnTo>
                          <a:pt x="2153203" y="1203900"/>
                        </a:lnTo>
                        <a:lnTo>
                          <a:pt x="2177673" y="1267422"/>
                        </a:lnTo>
                        <a:lnTo>
                          <a:pt x="2202143" y="1335135"/>
                        </a:lnTo>
                        <a:lnTo>
                          <a:pt x="2226603" y="1406896"/>
                        </a:lnTo>
                        <a:lnTo>
                          <a:pt x="2251072" y="1482477"/>
                        </a:lnTo>
                        <a:lnTo>
                          <a:pt x="2275542" y="1561563"/>
                        </a:lnTo>
                        <a:lnTo>
                          <a:pt x="2300012" y="1643793"/>
                        </a:lnTo>
                        <a:lnTo>
                          <a:pt x="2348951" y="1816062"/>
                        </a:lnTo>
                        <a:lnTo>
                          <a:pt x="2422351" y="2086648"/>
                        </a:lnTo>
                        <a:lnTo>
                          <a:pt x="2495760" y="2357653"/>
                        </a:lnTo>
                        <a:lnTo>
                          <a:pt x="2520220" y="2444874"/>
                        </a:lnTo>
                        <a:lnTo>
                          <a:pt x="2544690" y="2529303"/>
                        </a:lnTo>
                        <a:lnTo>
                          <a:pt x="2569160" y="2610228"/>
                        </a:lnTo>
                        <a:lnTo>
                          <a:pt x="2593629" y="2686971"/>
                        </a:lnTo>
                        <a:lnTo>
                          <a:pt x="2618099" y="2758923"/>
                        </a:lnTo>
                        <a:lnTo>
                          <a:pt x="2642569" y="2825617"/>
                        </a:lnTo>
                        <a:lnTo>
                          <a:pt x="2667029" y="2886681"/>
                        </a:lnTo>
                        <a:lnTo>
                          <a:pt x="2691499" y="2941936"/>
                        </a:lnTo>
                        <a:lnTo>
                          <a:pt x="2715969" y="2991361"/>
                        </a:lnTo>
                        <a:lnTo>
                          <a:pt x="2740439" y="3035138"/>
                        </a:lnTo>
                        <a:lnTo>
                          <a:pt x="2764908" y="3073591"/>
                        </a:lnTo>
                        <a:lnTo>
                          <a:pt x="2789378" y="3107233"/>
                        </a:lnTo>
                        <a:lnTo>
                          <a:pt x="2813838" y="3136684"/>
                        </a:lnTo>
                        <a:lnTo>
                          <a:pt x="2838308" y="3162640"/>
                        </a:lnTo>
                        <a:lnTo>
                          <a:pt x="2862778" y="3185824"/>
                        </a:lnTo>
                        <a:lnTo>
                          <a:pt x="2887247" y="3206969"/>
                        </a:lnTo>
                        <a:lnTo>
                          <a:pt x="2911717" y="3226695"/>
                        </a:lnTo>
                        <a:lnTo>
                          <a:pt x="2960647" y="3263938"/>
                        </a:lnTo>
                        <a:lnTo>
                          <a:pt x="3034056" y="3317888"/>
                        </a:lnTo>
                        <a:lnTo>
                          <a:pt x="3058526" y="3335347"/>
                        </a:lnTo>
                        <a:lnTo>
                          <a:pt x="3082986" y="3352206"/>
                        </a:lnTo>
                        <a:lnTo>
                          <a:pt x="3107456" y="3368189"/>
                        </a:lnTo>
                        <a:lnTo>
                          <a:pt x="3131925" y="3383020"/>
                        </a:lnTo>
                        <a:lnTo>
                          <a:pt x="3156395" y="3396421"/>
                        </a:lnTo>
                        <a:lnTo>
                          <a:pt x="3180865" y="3408194"/>
                        </a:lnTo>
                        <a:lnTo>
                          <a:pt x="3205335" y="3418195"/>
                        </a:lnTo>
                        <a:lnTo>
                          <a:pt x="3229795" y="3426349"/>
                        </a:lnTo>
                        <a:lnTo>
                          <a:pt x="3254264" y="3432692"/>
                        </a:lnTo>
                        <a:lnTo>
                          <a:pt x="3278734" y="3437293"/>
                        </a:lnTo>
                        <a:lnTo>
                          <a:pt x="3303204" y="3440332"/>
                        </a:lnTo>
                        <a:lnTo>
                          <a:pt x="3327674" y="3442008"/>
                        </a:lnTo>
                        <a:lnTo>
                          <a:pt x="3352143" y="3442608"/>
                        </a:lnTo>
                        <a:lnTo>
                          <a:pt x="3376604" y="3442427"/>
                        </a:lnTo>
                        <a:lnTo>
                          <a:pt x="3401073" y="3441808"/>
                        </a:lnTo>
                        <a:lnTo>
                          <a:pt x="3425543" y="3441075"/>
                        </a:lnTo>
                        <a:lnTo>
                          <a:pt x="3450013" y="3440589"/>
                        </a:lnTo>
                        <a:lnTo>
                          <a:pt x="3474483" y="3440646"/>
                        </a:lnTo>
                        <a:lnTo>
                          <a:pt x="3498952" y="3441560"/>
                        </a:lnTo>
                        <a:lnTo>
                          <a:pt x="3523413" y="3443551"/>
                        </a:lnTo>
                        <a:lnTo>
                          <a:pt x="3547882" y="3446808"/>
                        </a:lnTo>
                        <a:lnTo>
                          <a:pt x="3572352" y="3451409"/>
                        </a:lnTo>
                        <a:lnTo>
                          <a:pt x="3596822" y="3457381"/>
                        </a:lnTo>
                        <a:lnTo>
                          <a:pt x="3621291" y="3464659"/>
                        </a:lnTo>
                        <a:lnTo>
                          <a:pt x="3645761" y="3473098"/>
                        </a:lnTo>
                        <a:lnTo>
                          <a:pt x="3670221" y="3482489"/>
                        </a:lnTo>
                        <a:lnTo>
                          <a:pt x="3694691" y="3492567"/>
                        </a:lnTo>
                        <a:lnTo>
                          <a:pt x="3792560" y="3534067"/>
                        </a:lnTo>
                        <a:lnTo>
                          <a:pt x="3817030" y="3543421"/>
                        </a:lnTo>
                        <a:lnTo>
                          <a:pt x="3841500" y="3551974"/>
                        </a:lnTo>
                        <a:lnTo>
                          <a:pt x="3865970" y="3559613"/>
                        </a:lnTo>
                        <a:lnTo>
                          <a:pt x="3890439" y="3566290"/>
                        </a:lnTo>
                        <a:lnTo>
                          <a:pt x="3914909" y="3572005"/>
                        </a:lnTo>
                        <a:lnTo>
                          <a:pt x="3939369" y="3576796"/>
                        </a:lnTo>
                        <a:lnTo>
                          <a:pt x="3963839" y="3580730"/>
                        </a:lnTo>
                        <a:lnTo>
                          <a:pt x="3988309" y="3583892"/>
                        </a:lnTo>
                        <a:lnTo>
                          <a:pt x="4012778" y="3586378"/>
                        </a:lnTo>
                        <a:lnTo>
                          <a:pt x="4037248" y="3588302"/>
                        </a:lnTo>
                        <a:lnTo>
                          <a:pt x="4061718" y="3589769"/>
                        </a:lnTo>
                      </a:path>
                    </a:pathLst>
                  </a:custGeom>
                  <a:noFill/>
                  <a:ln w="19050" cap="flat">
                    <a:solidFill>
                      <a:srgbClr val="003178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2" name="フリーフォーム: 図形 241">
                    <a:extLst>
                      <a:ext uri="{FF2B5EF4-FFF2-40B4-BE49-F238E27FC236}">
                        <a16:creationId xmlns:a16="http://schemas.microsoft.com/office/drawing/2014/main" xmlns="" id="{46FCDEE0-3722-47B9-9E78-02A6DD0AC2C8}"/>
                      </a:ext>
                    </a:extLst>
                  </p:cNvPr>
                  <p:cNvSpPr/>
                  <p:nvPr/>
                </p:nvSpPr>
                <p:spPr>
                  <a:xfrm>
                    <a:off x="4370317" y="1252516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custDash>
                      <a:ds d="75000" sp="225000"/>
                    </a:custDash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3" name="フリーフォーム: 図形 242">
                    <a:extLst>
                      <a:ext uri="{FF2B5EF4-FFF2-40B4-BE49-F238E27FC236}">
                        <a16:creationId xmlns:a16="http://schemas.microsoft.com/office/drawing/2014/main" xmlns="" id="{78B867C2-E6E3-438A-B908-A75BDBFB85EC}"/>
                      </a:ext>
                    </a:extLst>
                  </p:cNvPr>
                  <p:cNvSpPr/>
                  <p:nvPr/>
                </p:nvSpPr>
                <p:spPr>
                  <a:xfrm>
                    <a:off x="4367212" y="1252516"/>
                    <a:ext cx="3105" cy="9545"/>
                  </a:xfrm>
                  <a:custGeom>
                    <a:avLst/>
                    <a:gdLst>
                      <a:gd name="connsiteX0" fmla="*/ 11 w 3105"/>
                      <a:gd name="connsiteY0" fmla="*/ 9557 h 9545"/>
                      <a:gd name="connsiteX1" fmla="*/ 3116 w 3105"/>
                      <a:gd name="connsiteY1" fmla="*/ 11 h 954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3105" h="9545">
                        <a:moveTo>
                          <a:pt x="11" y="9557"/>
                        </a:moveTo>
                        <a:lnTo>
                          <a:pt x="3116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</p:grpSp>
            <p:grpSp>
              <p:nvGrpSpPr>
                <p:cNvPr id="195" name="グラフィックス 236">
                  <a:extLst>
                    <a:ext uri="{FF2B5EF4-FFF2-40B4-BE49-F238E27FC236}">
                      <a16:creationId xmlns:a16="http://schemas.microsoft.com/office/drawing/2014/main" xmlns="" id="{46BCE72D-1CF0-4BF4-B817-021AA395C44F}"/>
                    </a:ext>
                  </a:extLst>
                </p:cNvPr>
                <p:cNvGrpSpPr/>
                <p:nvPr/>
              </p:nvGrpSpPr>
              <p:grpSpPr>
                <a:xfrm>
                  <a:off x="3089055" y="1206692"/>
                  <a:ext cx="6084210" cy="4525819"/>
                  <a:chOff x="3089055" y="1206692"/>
                  <a:chExt cx="6084210" cy="4525819"/>
                </a:xfrm>
              </p:grpSpPr>
              <p:sp>
                <p:nvSpPr>
                  <p:cNvPr id="196" name="フリーフォーム: 図形 195">
                    <a:extLst>
                      <a:ext uri="{FF2B5EF4-FFF2-40B4-BE49-F238E27FC236}">
                        <a16:creationId xmlns:a16="http://schemas.microsoft.com/office/drawing/2014/main" xmlns="" id="{ECAADC10-A895-4A72-B877-5D22D1FFCC5C}"/>
                      </a:ext>
                    </a:extLst>
                  </p:cNvPr>
                  <p:cNvSpPr/>
                  <p:nvPr/>
                </p:nvSpPr>
                <p:spPr>
                  <a:xfrm>
                    <a:off x="3794665" y="5158758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97" name="フリーフォーム: 図形 196">
                    <a:extLst>
                      <a:ext uri="{FF2B5EF4-FFF2-40B4-BE49-F238E27FC236}">
                        <a16:creationId xmlns:a16="http://schemas.microsoft.com/office/drawing/2014/main" xmlns="" id="{4CA4C48E-5DA2-47AE-882E-F45B9F7FECBC}"/>
                      </a:ext>
                    </a:extLst>
                  </p:cNvPr>
                  <p:cNvSpPr/>
                  <p:nvPr/>
                </p:nvSpPr>
                <p:spPr>
                  <a:xfrm>
                    <a:off x="8986913" y="1252516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98" name="フリーフォーム: 図形 197">
                    <a:extLst>
                      <a:ext uri="{FF2B5EF4-FFF2-40B4-BE49-F238E27FC236}">
                        <a16:creationId xmlns:a16="http://schemas.microsoft.com/office/drawing/2014/main" xmlns="" id="{A99A8830-1552-4ED6-832B-2B04B1E8F0DD}"/>
                      </a:ext>
                    </a:extLst>
                  </p:cNvPr>
                  <p:cNvSpPr/>
                  <p:nvPr/>
                </p:nvSpPr>
                <p:spPr>
                  <a:xfrm>
                    <a:off x="3794665" y="1252516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99" name="フリーフォーム: 図形 198">
                    <a:extLst>
                      <a:ext uri="{FF2B5EF4-FFF2-40B4-BE49-F238E27FC236}">
                        <a16:creationId xmlns:a16="http://schemas.microsoft.com/office/drawing/2014/main" xmlns="" id="{91341D40-D548-4414-AF9A-CAB64D04FD16}"/>
                      </a:ext>
                    </a:extLst>
                  </p:cNvPr>
                  <p:cNvSpPr/>
                  <p:nvPr/>
                </p:nvSpPr>
                <p:spPr>
                  <a:xfrm>
                    <a:off x="3794665" y="1252516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0" name="フリーフォーム: 図形 199">
                    <a:extLst>
                      <a:ext uri="{FF2B5EF4-FFF2-40B4-BE49-F238E27FC236}">
                        <a16:creationId xmlns:a16="http://schemas.microsoft.com/office/drawing/2014/main" xmlns="" id="{07BC5C06-C183-44B1-85BA-A36FC2BFE9FB}"/>
                      </a:ext>
                    </a:extLst>
                  </p:cNvPr>
                  <p:cNvSpPr/>
                  <p:nvPr/>
                </p:nvSpPr>
                <p:spPr>
                  <a:xfrm>
                    <a:off x="3794665" y="5158758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1" name="フリーフォーム: 図形 200">
                    <a:extLst>
                      <a:ext uri="{FF2B5EF4-FFF2-40B4-BE49-F238E27FC236}">
                        <a16:creationId xmlns:a16="http://schemas.microsoft.com/office/drawing/2014/main" xmlns="" id="{C437E2CA-528C-483C-8102-BF6583FEF818}"/>
                      </a:ext>
                    </a:extLst>
                  </p:cNvPr>
                  <p:cNvSpPr/>
                  <p:nvPr/>
                </p:nvSpPr>
                <p:spPr>
                  <a:xfrm>
                    <a:off x="4334807" y="5158758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2" name="フリーフォーム: 図形 201">
                    <a:extLst>
                      <a:ext uri="{FF2B5EF4-FFF2-40B4-BE49-F238E27FC236}">
                        <a16:creationId xmlns:a16="http://schemas.microsoft.com/office/drawing/2014/main" xmlns="" id="{35645ED0-F96E-4E2C-A97C-2A420E5BF34E}"/>
                      </a:ext>
                    </a:extLst>
                  </p:cNvPr>
                  <p:cNvSpPr/>
                  <p:nvPr/>
                </p:nvSpPr>
                <p:spPr>
                  <a:xfrm>
                    <a:off x="5358050" y="5158758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3" name="フリーフォーム: 図形 202">
                    <a:extLst>
                      <a:ext uri="{FF2B5EF4-FFF2-40B4-BE49-F238E27FC236}">
                        <a16:creationId xmlns:a16="http://schemas.microsoft.com/office/drawing/2014/main" xmlns="" id="{C953BC39-5D88-487D-9C6B-4FBEF6101DD2}"/>
                      </a:ext>
                    </a:extLst>
                  </p:cNvPr>
                  <p:cNvSpPr/>
                  <p:nvPr/>
                </p:nvSpPr>
                <p:spPr>
                  <a:xfrm>
                    <a:off x="6381282" y="5158758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4" name="フリーフォーム: 図形 203">
                    <a:extLst>
                      <a:ext uri="{FF2B5EF4-FFF2-40B4-BE49-F238E27FC236}">
                        <a16:creationId xmlns:a16="http://schemas.microsoft.com/office/drawing/2014/main" xmlns="" id="{951EC86F-2BA3-4EF9-9168-540645A5E8F1}"/>
                      </a:ext>
                    </a:extLst>
                  </p:cNvPr>
                  <p:cNvSpPr/>
                  <p:nvPr/>
                </p:nvSpPr>
                <p:spPr>
                  <a:xfrm>
                    <a:off x="7404515" y="5158758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5" name="フリーフォーム: 図形 204">
                    <a:extLst>
                      <a:ext uri="{FF2B5EF4-FFF2-40B4-BE49-F238E27FC236}">
                        <a16:creationId xmlns:a16="http://schemas.microsoft.com/office/drawing/2014/main" xmlns="" id="{75126976-35BD-4A01-A329-F48F0929CA8B}"/>
                      </a:ext>
                    </a:extLst>
                  </p:cNvPr>
                  <p:cNvSpPr/>
                  <p:nvPr/>
                </p:nvSpPr>
                <p:spPr>
                  <a:xfrm>
                    <a:off x="8427747" y="5158758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6" name="フリーフォーム: 図形 205">
                    <a:extLst>
                      <a:ext uri="{FF2B5EF4-FFF2-40B4-BE49-F238E27FC236}">
                        <a16:creationId xmlns:a16="http://schemas.microsoft.com/office/drawing/2014/main" xmlns="" id="{EBF4F67D-C9F8-4354-BF4A-907A1B801995}"/>
                      </a:ext>
                    </a:extLst>
                  </p:cNvPr>
                  <p:cNvSpPr/>
                  <p:nvPr/>
                </p:nvSpPr>
                <p:spPr>
                  <a:xfrm>
                    <a:off x="3823194" y="5158758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7" name="テキスト ボックス 206">
                    <a:extLst>
                      <a:ext uri="{FF2B5EF4-FFF2-40B4-BE49-F238E27FC236}">
                        <a16:creationId xmlns:a16="http://schemas.microsoft.com/office/drawing/2014/main" xmlns="" id="{63DD7335-63FB-4D4F-84D6-21494390C99F}"/>
                      </a:ext>
                    </a:extLst>
                  </p:cNvPr>
                  <p:cNvSpPr txBox="1"/>
                  <p:nvPr/>
                </p:nvSpPr>
                <p:spPr>
                  <a:xfrm>
                    <a:off x="3703180" y="5207812"/>
                    <a:ext cx="278464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</a:t>
                    </a:r>
                  </a:p>
                </p:txBody>
              </p:sp>
              <p:sp>
                <p:nvSpPr>
                  <p:cNvPr id="208" name="フリーフォーム: 図形 207">
                    <a:extLst>
                      <a:ext uri="{FF2B5EF4-FFF2-40B4-BE49-F238E27FC236}">
                        <a16:creationId xmlns:a16="http://schemas.microsoft.com/office/drawing/2014/main" xmlns="" id="{5F5FD9CE-262E-47B2-9B7B-31D26F1EC8F6}"/>
                      </a:ext>
                    </a:extLst>
                  </p:cNvPr>
                  <p:cNvSpPr/>
                  <p:nvPr/>
                </p:nvSpPr>
                <p:spPr>
                  <a:xfrm>
                    <a:off x="4846424" y="5158758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9" name="テキスト ボックス 208">
                    <a:extLst>
                      <a:ext uri="{FF2B5EF4-FFF2-40B4-BE49-F238E27FC236}">
                        <a16:creationId xmlns:a16="http://schemas.microsoft.com/office/drawing/2014/main" xmlns="" id="{4E3A63C6-D0F4-4BD9-92EA-68E5C20F1584}"/>
                      </a:ext>
                    </a:extLst>
                  </p:cNvPr>
                  <p:cNvSpPr txBox="1"/>
                  <p:nvPr/>
                </p:nvSpPr>
                <p:spPr>
                  <a:xfrm>
                    <a:off x="4697834" y="5207812"/>
                    <a:ext cx="344765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 dirty="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50</a:t>
                    </a:r>
                  </a:p>
                </p:txBody>
              </p:sp>
              <p:sp>
                <p:nvSpPr>
                  <p:cNvPr id="210" name="フリーフォーム: 図形 209">
                    <a:extLst>
                      <a:ext uri="{FF2B5EF4-FFF2-40B4-BE49-F238E27FC236}">
                        <a16:creationId xmlns:a16="http://schemas.microsoft.com/office/drawing/2014/main" xmlns="" id="{5EBE0B1D-3A32-40E4-A1A1-C172D1BD6259}"/>
                      </a:ext>
                    </a:extLst>
                  </p:cNvPr>
                  <p:cNvSpPr/>
                  <p:nvPr/>
                </p:nvSpPr>
                <p:spPr>
                  <a:xfrm>
                    <a:off x="5869666" y="5158758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11" name="テキスト ボックス 210">
                    <a:extLst>
                      <a:ext uri="{FF2B5EF4-FFF2-40B4-BE49-F238E27FC236}">
                        <a16:creationId xmlns:a16="http://schemas.microsoft.com/office/drawing/2014/main" xmlns="" id="{77C265AE-1A9E-47B1-BDEC-CDB9A2B4936C}"/>
                      </a:ext>
                    </a:extLst>
                  </p:cNvPr>
                  <p:cNvSpPr txBox="1"/>
                  <p:nvPr/>
                </p:nvSpPr>
                <p:spPr>
                  <a:xfrm>
                    <a:off x="5692501" y="5207812"/>
                    <a:ext cx="411066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100</a:t>
                    </a:r>
                  </a:p>
                </p:txBody>
              </p:sp>
              <p:sp>
                <p:nvSpPr>
                  <p:cNvPr id="212" name="フリーフォーム: 図形 211">
                    <a:extLst>
                      <a:ext uri="{FF2B5EF4-FFF2-40B4-BE49-F238E27FC236}">
                        <a16:creationId xmlns:a16="http://schemas.microsoft.com/office/drawing/2014/main" xmlns="" id="{388FA3C3-F38A-455F-A2B1-C6DE22C2F3D1}"/>
                      </a:ext>
                    </a:extLst>
                  </p:cNvPr>
                  <p:cNvSpPr/>
                  <p:nvPr/>
                </p:nvSpPr>
                <p:spPr>
                  <a:xfrm>
                    <a:off x="6892899" y="5158758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13" name="テキスト ボックス 212">
                    <a:extLst>
                      <a:ext uri="{FF2B5EF4-FFF2-40B4-BE49-F238E27FC236}">
                        <a16:creationId xmlns:a16="http://schemas.microsoft.com/office/drawing/2014/main" xmlns="" id="{DD5A8D5F-419F-438C-AE50-FFE15998D7CE}"/>
                      </a:ext>
                    </a:extLst>
                  </p:cNvPr>
                  <p:cNvSpPr txBox="1"/>
                  <p:nvPr/>
                </p:nvSpPr>
                <p:spPr>
                  <a:xfrm>
                    <a:off x="6715734" y="5207812"/>
                    <a:ext cx="411066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150</a:t>
                    </a:r>
                  </a:p>
                </p:txBody>
              </p:sp>
              <p:sp>
                <p:nvSpPr>
                  <p:cNvPr id="214" name="フリーフォーム: 図形 213">
                    <a:extLst>
                      <a:ext uri="{FF2B5EF4-FFF2-40B4-BE49-F238E27FC236}">
                        <a16:creationId xmlns:a16="http://schemas.microsoft.com/office/drawing/2014/main" xmlns="" id="{544150B2-2627-4D28-8FC3-5E97206A8AE3}"/>
                      </a:ext>
                    </a:extLst>
                  </p:cNvPr>
                  <p:cNvSpPr/>
                  <p:nvPr/>
                </p:nvSpPr>
                <p:spPr>
                  <a:xfrm>
                    <a:off x="7916131" y="5158758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15" name="テキスト ボックス 214">
                    <a:extLst>
                      <a:ext uri="{FF2B5EF4-FFF2-40B4-BE49-F238E27FC236}">
                        <a16:creationId xmlns:a16="http://schemas.microsoft.com/office/drawing/2014/main" xmlns="" id="{2919635B-EED3-4EFD-AA23-24E56F387AAC}"/>
                      </a:ext>
                    </a:extLst>
                  </p:cNvPr>
                  <p:cNvSpPr txBox="1"/>
                  <p:nvPr/>
                </p:nvSpPr>
                <p:spPr>
                  <a:xfrm>
                    <a:off x="7738965" y="5207812"/>
                    <a:ext cx="411066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200</a:t>
                    </a:r>
                  </a:p>
                </p:txBody>
              </p:sp>
              <p:sp>
                <p:nvSpPr>
                  <p:cNvPr id="216" name="フリーフォーム: 図形 215">
                    <a:extLst>
                      <a:ext uri="{FF2B5EF4-FFF2-40B4-BE49-F238E27FC236}">
                        <a16:creationId xmlns:a16="http://schemas.microsoft.com/office/drawing/2014/main" xmlns="" id="{A1E613A6-B7FF-41D3-A354-254A0B24A8B1}"/>
                      </a:ext>
                    </a:extLst>
                  </p:cNvPr>
                  <p:cNvSpPr/>
                  <p:nvPr/>
                </p:nvSpPr>
                <p:spPr>
                  <a:xfrm>
                    <a:off x="8939364" y="5158758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17" name="テキスト ボックス 216">
                    <a:extLst>
                      <a:ext uri="{FF2B5EF4-FFF2-40B4-BE49-F238E27FC236}">
                        <a16:creationId xmlns:a16="http://schemas.microsoft.com/office/drawing/2014/main" xmlns="" id="{F3496F4C-A744-4FF2-9646-AF39365F7497}"/>
                      </a:ext>
                    </a:extLst>
                  </p:cNvPr>
                  <p:cNvSpPr txBox="1"/>
                  <p:nvPr/>
                </p:nvSpPr>
                <p:spPr>
                  <a:xfrm>
                    <a:off x="8762199" y="5207812"/>
                    <a:ext cx="411066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250</a:t>
                    </a:r>
                  </a:p>
                </p:txBody>
              </p:sp>
              <p:sp>
                <p:nvSpPr>
                  <p:cNvPr id="218" name="テキスト ボックス 217">
                    <a:extLst>
                      <a:ext uri="{FF2B5EF4-FFF2-40B4-BE49-F238E27FC236}">
                        <a16:creationId xmlns:a16="http://schemas.microsoft.com/office/drawing/2014/main" xmlns="" id="{AFBECB7A-0F6F-4BEC-851F-2AABFA1C13F7}"/>
                      </a:ext>
                    </a:extLst>
                  </p:cNvPr>
                  <p:cNvSpPr txBox="1"/>
                  <p:nvPr/>
                </p:nvSpPr>
                <p:spPr>
                  <a:xfrm>
                    <a:off x="5761186" y="5384023"/>
                    <a:ext cx="1460834" cy="3484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 Unicode MS"/>
                        <a:cs typeface="Arial" panose="020B0604020202020204" pitchFamily="34" charset="0"/>
                        <a:sym typeface="Arial Unicode MS"/>
                        <a:rtl val="0"/>
                      </a:rPr>
                      <a:t>APOA2-AT (µg/mL)</a:t>
                    </a:r>
                  </a:p>
                </p:txBody>
              </p:sp>
              <p:sp>
                <p:nvSpPr>
                  <p:cNvPr id="219" name="フリーフォーム: 図形 218">
                    <a:extLst>
                      <a:ext uri="{FF2B5EF4-FFF2-40B4-BE49-F238E27FC236}">
                        <a16:creationId xmlns:a16="http://schemas.microsoft.com/office/drawing/2014/main" xmlns="" id="{FD493AB6-5B2E-41D5-9404-B25069E1A764}"/>
                      </a:ext>
                    </a:extLst>
                  </p:cNvPr>
                  <p:cNvSpPr/>
                  <p:nvPr/>
                </p:nvSpPr>
                <p:spPr>
                  <a:xfrm>
                    <a:off x="3794665" y="1252516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0" name="フリーフォーム: 図形 219">
                    <a:extLst>
                      <a:ext uri="{FF2B5EF4-FFF2-40B4-BE49-F238E27FC236}">
                        <a16:creationId xmlns:a16="http://schemas.microsoft.com/office/drawing/2014/main" xmlns="" id="{76E42DC1-238D-40F7-B51C-6A7F8FA47FEE}"/>
                      </a:ext>
                    </a:extLst>
                  </p:cNvPr>
                  <p:cNvSpPr/>
                  <p:nvPr/>
                </p:nvSpPr>
                <p:spPr>
                  <a:xfrm>
                    <a:off x="3769886" y="4837203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1" name="フリーフォーム: 図形 220">
                    <a:extLst>
                      <a:ext uri="{FF2B5EF4-FFF2-40B4-BE49-F238E27FC236}">
                        <a16:creationId xmlns:a16="http://schemas.microsoft.com/office/drawing/2014/main" xmlns="" id="{026B9E18-4FFA-49C9-90E1-84DBD3915558}"/>
                      </a:ext>
                    </a:extLst>
                  </p:cNvPr>
                  <p:cNvSpPr/>
                  <p:nvPr/>
                </p:nvSpPr>
                <p:spPr>
                  <a:xfrm>
                    <a:off x="3769886" y="4194085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2" name="フリーフォーム: 図形 221">
                    <a:extLst>
                      <a:ext uri="{FF2B5EF4-FFF2-40B4-BE49-F238E27FC236}">
                        <a16:creationId xmlns:a16="http://schemas.microsoft.com/office/drawing/2014/main" xmlns="" id="{5076AB8E-6692-40B1-8636-70F35F374B5A}"/>
                      </a:ext>
                    </a:extLst>
                  </p:cNvPr>
                  <p:cNvSpPr/>
                  <p:nvPr/>
                </p:nvSpPr>
                <p:spPr>
                  <a:xfrm>
                    <a:off x="3769886" y="3550957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3" name="フリーフォーム: 図形 222">
                    <a:extLst>
                      <a:ext uri="{FF2B5EF4-FFF2-40B4-BE49-F238E27FC236}">
                        <a16:creationId xmlns:a16="http://schemas.microsoft.com/office/drawing/2014/main" xmlns="" id="{DA6985D3-02E4-4582-85E5-86D0B7A5E926}"/>
                      </a:ext>
                    </a:extLst>
                  </p:cNvPr>
                  <p:cNvSpPr/>
                  <p:nvPr/>
                </p:nvSpPr>
                <p:spPr>
                  <a:xfrm>
                    <a:off x="3769886" y="2907839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4" name="フリーフォーム: 図形 223">
                    <a:extLst>
                      <a:ext uri="{FF2B5EF4-FFF2-40B4-BE49-F238E27FC236}">
                        <a16:creationId xmlns:a16="http://schemas.microsoft.com/office/drawing/2014/main" xmlns="" id="{1D3E9348-3160-4903-9976-6D96A6C87BE1}"/>
                      </a:ext>
                    </a:extLst>
                  </p:cNvPr>
                  <p:cNvSpPr/>
                  <p:nvPr/>
                </p:nvSpPr>
                <p:spPr>
                  <a:xfrm>
                    <a:off x="3769886" y="2264720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5" name="フリーフォーム: 図形 224">
                    <a:extLst>
                      <a:ext uri="{FF2B5EF4-FFF2-40B4-BE49-F238E27FC236}">
                        <a16:creationId xmlns:a16="http://schemas.microsoft.com/office/drawing/2014/main" xmlns="" id="{5E26C17F-F500-42C8-8B25-975D2C256213}"/>
                      </a:ext>
                    </a:extLst>
                  </p:cNvPr>
                  <p:cNvSpPr/>
                  <p:nvPr/>
                </p:nvSpPr>
                <p:spPr>
                  <a:xfrm>
                    <a:off x="3769886" y="1621598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6" name="フリーフォーム: 図形 225">
                    <a:extLst>
                      <a:ext uri="{FF2B5EF4-FFF2-40B4-BE49-F238E27FC236}">
                        <a16:creationId xmlns:a16="http://schemas.microsoft.com/office/drawing/2014/main" xmlns="" id="{1F3195E0-A9BC-4F91-9B9E-C1236A6C6708}"/>
                      </a:ext>
                    </a:extLst>
                  </p:cNvPr>
                  <p:cNvSpPr/>
                  <p:nvPr/>
                </p:nvSpPr>
                <p:spPr>
                  <a:xfrm>
                    <a:off x="3745107" y="5158758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7" name="テキスト ボックス 226">
                    <a:extLst>
                      <a:ext uri="{FF2B5EF4-FFF2-40B4-BE49-F238E27FC236}">
                        <a16:creationId xmlns:a16="http://schemas.microsoft.com/office/drawing/2014/main" xmlns="" id="{EF55DFB6-6C5F-4DED-B758-533E80916350}"/>
                      </a:ext>
                    </a:extLst>
                  </p:cNvPr>
                  <p:cNvSpPr txBox="1"/>
                  <p:nvPr/>
                </p:nvSpPr>
                <p:spPr>
                  <a:xfrm>
                    <a:off x="3317894" y="5065413"/>
                    <a:ext cx="571295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00</a:t>
                    </a:r>
                  </a:p>
                </p:txBody>
              </p:sp>
              <p:sp>
                <p:nvSpPr>
                  <p:cNvPr id="228" name="フリーフォーム: 図形 227">
                    <a:extLst>
                      <a:ext uri="{FF2B5EF4-FFF2-40B4-BE49-F238E27FC236}">
                        <a16:creationId xmlns:a16="http://schemas.microsoft.com/office/drawing/2014/main" xmlns="" id="{33DD1FAA-D22C-42A8-8579-444A2146243B}"/>
                      </a:ext>
                    </a:extLst>
                  </p:cNvPr>
                  <p:cNvSpPr/>
                  <p:nvPr/>
                </p:nvSpPr>
                <p:spPr>
                  <a:xfrm>
                    <a:off x="3745107" y="4515640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9" name="テキスト ボックス 228">
                    <a:extLst>
                      <a:ext uri="{FF2B5EF4-FFF2-40B4-BE49-F238E27FC236}">
                        <a16:creationId xmlns:a16="http://schemas.microsoft.com/office/drawing/2014/main" xmlns="" id="{118B1BC2-58A9-47D6-9C6E-7F8293235358}"/>
                      </a:ext>
                    </a:extLst>
                  </p:cNvPr>
                  <p:cNvSpPr txBox="1"/>
                  <p:nvPr/>
                </p:nvSpPr>
                <p:spPr>
                  <a:xfrm>
                    <a:off x="3317894" y="4422297"/>
                    <a:ext cx="571295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25</a:t>
                    </a:r>
                  </a:p>
                </p:txBody>
              </p:sp>
              <p:sp>
                <p:nvSpPr>
                  <p:cNvPr id="230" name="フリーフォーム: 図形 229">
                    <a:extLst>
                      <a:ext uri="{FF2B5EF4-FFF2-40B4-BE49-F238E27FC236}">
                        <a16:creationId xmlns:a16="http://schemas.microsoft.com/office/drawing/2014/main" xmlns="" id="{F29296FA-BDF0-436B-94AD-F586F07E7203}"/>
                      </a:ext>
                    </a:extLst>
                  </p:cNvPr>
                  <p:cNvSpPr/>
                  <p:nvPr/>
                </p:nvSpPr>
                <p:spPr>
                  <a:xfrm>
                    <a:off x="3745107" y="3872521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31" name="テキスト ボックス 230">
                    <a:extLst>
                      <a:ext uri="{FF2B5EF4-FFF2-40B4-BE49-F238E27FC236}">
                        <a16:creationId xmlns:a16="http://schemas.microsoft.com/office/drawing/2014/main" xmlns="" id="{1278AB7F-A950-4BD8-9D7B-F8CA8A9D1417}"/>
                      </a:ext>
                    </a:extLst>
                  </p:cNvPr>
                  <p:cNvSpPr txBox="1"/>
                  <p:nvPr/>
                </p:nvSpPr>
                <p:spPr>
                  <a:xfrm>
                    <a:off x="3317894" y="3779176"/>
                    <a:ext cx="571295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 dirty="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50</a:t>
                    </a:r>
                  </a:p>
                </p:txBody>
              </p:sp>
              <p:sp>
                <p:nvSpPr>
                  <p:cNvPr id="232" name="フリーフォーム: 図形 231">
                    <a:extLst>
                      <a:ext uri="{FF2B5EF4-FFF2-40B4-BE49-F238E27FC236}">
                        <a16:creationId xmlns:a16="http://schemas.microsoft.com/office/drawing/2014/main" xmlns="" id="{CF075897-3D53-4EC2-B869-4A3B91F4F890}"/>
                      </a:ext>
                    </a:extLst>
                  </p:cNvPr>
                  <p:cNvSpPr/>
                  <p:nvPr/>
                </p:nvSpPr>
                <p:spPr>
                  <a:xfrm>
                    <a:off x="3745107" y="3229403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33" name="テキスト ボックス 232">
                    <a:extLst>
                      <a:ext uri="{FF2B5EF4-FFF2-40B4-BE49-F238E27FC236}">
                        <a16:creationId xmlns:a16="http://schemas.microsoft.com/office/drawing/2014/main" xmlns="" id="{E6C17A36-14B1-45C7-9F37-A4234AA084E2}"/>
                      </a:ext>
                    </a:extLst>
                  </p:cNvPr>
                  <p:cNvSpPr txBox="1"/>
                  <p:nvPr/>
                </p:nvSpPr>
                <p:spPr>
                  <a:xfrm>
                    <a:off x="3317894" y="3136058"/>
                    <a:ext cx="571295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 dirty="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75</a:t>
                    </a:r>
                  </a:p>
                </p:txBody>
              </p:sp>
              <p:sp>
                <p:nvSpPr>
                  <p:cNvPr id="234" name="フリーフォーム: 図形 233">
                    <a:extLst>
                      <a:ext uri="{FF2B5EF4-FFF2-40B4-BE49-F238E27FC236}">
                        <a16:creationId xmlns:a16="http://schemas.microsoft.com/office/drawing/2014/main" xmlns="" id="{211B014A-29A3-45DD-994E-EBF9D281653C}"/>
                      </a:ext>
                    </a:extLst>
                  </p:cNvPr>
                  <p:cNvSpPr/>
                  <p:nvPr/>
                </p:nvSpPr>
                <p:spPr>
                  <a:xfrm>
                    <a:off x="3745107" y="2586275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35" name="テキスト ボックス 234">
                    <a:extLst>
                      <a:ext uri="{FF2B5EF4-FFF2-40B4-BE49-F238E27FC236}">
                        <a16:creationId xmlns:a16="http://schemas.microsoft.com/office/drawing/2014/main" xmlns="" id="{DABA85D4-B2B1-49B4-A433-772AA01811E1}"/>
                      </a:ext>
                    </a:extLst>
                  </p:cNvPr>
                  <p:cNvSpPr txBox="1"/>
                  <p:nvPr/>
                </p:nvSpPr>
                <p:spPr>
                  <a:xfrm>
                    <a:off x="3317894" y="2492930"/>
                    <a:ext cx="571295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00</a:t>
                    </a:r>
                  </a:p>
                </p:txBody>
              </p:sp>
              <p:sp>
                <p:nvSpPr>
                  <p:cNvPr id="236" name="フリーフォーム: 図形 235">
                    <a:extLst>
                      <a:ext uri="{FF2B5EF4-FFF2-40B4-BE49-F238E27FC236}">
                        <a16:creationId xmlns:a16="http://schemas.microsoft.com/office/drawing/2014/main" xmlns="" id="{CCDA9C93-A67A-4160-96C5-B11B55AAA90F}"/>
                      </a:ext>
                    </a:extLst>
                  </p:cNvPr>
                  <p:cNvSpPr/>
                  <p:nvPr/>
                </p:nvSpPr>
                <p:spPr>
                  <a:xfrm>
                    <a:off x="3745107" y="1943158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37" name="テキスト ボックス 236">
                    <a:extLst>
                      <a:ext uri="{FF2B5EF4-FFF2-40B4-BE49-F238E27FC236}">
                        <a16:creationId xmlns:a16="http://schemas.microsoft.com/office/drawing/2014/main" xmlns="" id="{12135CFD-7669-4393-A029-13054FB855B5}"/>
                      </a:ext>
                    </a:extLst>
                  </p:cNvPr>
                  <p:cNvSpPr txBox="1"/>
                  <p:nvPr/>
                </p:nvSpPr>
                <p:spPr>
                  <a:xfrm>
                    <a:off x="3317894" y="1849813"/>
                    <a:ext cx="571295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25</a:t>
                    </a:r>
                  </a:p>
                </p:txBody>
              </p:sp>
              <p:sp>
                <p:nvSpPr>
                  <p:cNvPr id="238" name="フリーフォーム: 図形 237">
                    <a:extLst>
                      <a:ext uri="{FF2B5EF4-FFF2-40B4-BE49-F238E27FC236}">
                        <a16:creationId xmlns:a16="http://schemas.microsoft.com/office/drawing/2014/main" xmlns="" id="{5C9904E7-1340-458A-98D7-B8C1497B4B9F}"/>
                      </a:ext>
                    </a:extLst>
                  </p:cNvPr>
                  <p:cNvSpPr/>
                  <p:nvPr/>
                </p:nvSpPr>
                <p:spPr>
                  <a:xfrm>
                    <a:off x="3745107" y="1300037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39" name="テキスト ボックス 238">
                    <a:extLst>
                      <a:ext uri="{FF2B5EF4-FFF2-40B4-BE49-F238E27FC236}">
                        <a16:creationId xmlns:a16="http://schemas.microsoft.com/office/drawing/2014/main" xmlns="" id="{4BC319BD-75CE-4D14-A7BF-7770A867065E}"/>
                      </a:ext>
                    </a:extLst>
                  </p:cNvPr>
                  <p:cNvSpPr txBox="1"/>
                  <p:nvPr/>
                </p:nvSpPr>
                <p:spPr>
                  <a:xfrm>
                    <a:off x="3317894" y="1206692"/>
                    <a:ext cx="571295" cy="3318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50</a:t>
                    </a:r>
                  </a:p>
                </p:txBody>
              </p:sp>
              <p:sp>
                <p:nvSpPr>
                  <p:cNvPr id="240" name="テキスト ボックス 239">
                    <a:extLst>
                      <a:ext uri="{FF2B5EF4-FFF2-40B4-BE49-F238E27FC236}">
                        <a16:creationId xmlns:a16="http://schemas.microsoft.com/office/drawing/2014/main" xmlns="" id="{36610C71-8B78-45AD-845E-54DFCC25A104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797056" y="3066405"/>
                    <a:ext cx="862462" cy="27846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ＭＳ Ｐゴシック"/>
                        <a:cs typeface="Arial" panose="020B0604020202020204" pitchFamily="34" charset="0"/>
                        <a:sym typeface="ＭＳ Ｐゴシック"/>
                        <a:rtl val="0"/>
                      </a:rPr>
                      <a:t>Density</a:t>
                    </a:r>
                  </a:p>
                </p:txBody>
              </p:sp>
            </p:grpSp>
          </p:grpSp>
        </p:grpSp>
      </p:grp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xmlns="" id="{336C3EB3-5F90-47C6-8C77-A0C69A897987}"/>
              </a:ext>
            </a:extLst>
          </p:cNvPr>
          <p:cNvSpPr txBox="1"/>
          <p:nvPr/>
        </p:nvSpPr>
        <p:spPr>
          <a:xfrm>
            <a:off x="4841014" y="702853"/>
            <a:ext cx="992579" cy="369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725"/>
            <a:r>
              <a:rPr kumimoji="1" lang="en-US" altLang="ja-JP" sz="1802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:</a:t>
            </a:r>
            <a:r>
              <a:rPr kumimoji="1" lang="ja-JP" altLang="en-US" sz="1802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802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000</a:t>
            </a:r>
            <a:endParaRPr kumimoji="1" lang="ja-JP" altLang="en-US" sz="1802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45" name="テキスト ボックス 244">
            <a:extLst>
              <a:ext uri="{FF2B5EF4-FFF2-40B4-BE49-F238E27FC236}">
                <a16:creationId xmlns:a16="http://schemas.microsoft.com/office/drawing/2014/main" xmlns="" id="{F98B8830-DB27-4476-BB42-028197155826}"/>
              </a:ext>
            </a:extLst>
          </p:cNvPr>
          <p:cNvSpPr txBox="1"/>
          <p:nvPr/>
        </p:nvSpPr>
        <p:spPr>
          <a:xfrm>
            <a:off x="4905396" y="4026766"/>
            <a:ext cx="864339" cy="369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725"/>
            <a:r>
              <a:rPr kumimoji="1" lang="en-US" altLang="ja-JP" sz="1802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: 400</a:t>
            </a:r>
            <a:endParaRPr kumimoji="1" lang="ja-JP" altLang="en-US" sz="1802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27691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タイトル 1">
            <a:extLst>
              <a:ext uri="{FF2B5EF4-FFF2-40B4-BE49-F238E27FC236}">
                <a16:creationId xmlns:a16="http://schemas.microsoft.com/office/drawing/2014/main" xmlns="" id="{B62ADC04-7504-AF26-CDD6-B8ABEDFE7DE1}"/>
              </a:ext>
            </a:extLst>
          </p:cNvPr>
          <p:cNvSpPr txBox="1">
            <a:spLocks/>
          </p:cNvSpPr>
          <p:nvPr/>
        </p:nvSpPr>
        <p:spPr>
          <a:xfrm rot="10800000" flipV="1">
            <a:off x="145512" y="38370"/>
            <a:ext cx="2661757" cy="366965"/>
          </a:xfrm>
          <a:prstGeom prst="rect">
            <a:avLst/>
          </a:prstGeom>
        </p:spPr>
        <p:txBody>
          <a:bodyPr vert="horz" lIns="91551" tIns="45776" rIns="91551" bIns="45776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2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ja-JP" altLang="en-US" sz="180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xmlns="" id="{19B34B0B-A6B1-3310-09B5-23822CDBEAFE}"/>
              </a:ext>
            </a:extLst>
          </p:cNvPr>
          <p:cNvSpPr txBox="1">
            <a:spLocks/>
          </p:cNvSpPr>
          <p:nvPr/>
        </p:nvSpPr>
        <p:spPr>
          <a:xfrm rot="10800000" flipV="1">
            <a:off x="64301" y="7476986"/>
            <a:ext cx="6891323" cy="1008903"/>
          </a:xfrm>
          <a:prstGeom prst="rect">
            <a:avLst/>
          </a:prstGeom>
        </p:spPr>
        <p:txBody>
          <a:bodyPr vert="horz" lIns="91551" tIns="45776" rIns="91551" bIns="45776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86586"/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3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(A) Kernel density estimation of apoA2-ATQ in the cut-off setting test. The 5th percentile of apoA2-ATQ is 68.95</a:t>
            </a:r>
            <a:r>
              <a:rPr lang="en-US" altLang="ja-JP" sz="1200" dirty="0">
                <a:solidFill>
                  <a:srgbClr val="FF0000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μg/mL (dashed line: 95% specificity). (B) Kernel density estimation of apoA2-ATQ in the cut-off evaluation test. The specificity of 68.95 μg/mL of apoA2-ATQ is 95.5% (dashed line: apoA2-ATQ 68.95 μg/mL).</a:t>
            </a:r>
          </a:p>
          <a:p>
            <a:pPr defTabSz="686586"/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xmlns="" id="{6643D123-C11E-497A-A318-66449DA14BA7}"/>
              </a:ext>
            </a:extLst>
          </p:cNvPr>
          <p:cNvSpPr txBox="1"/>
          <p:nvPr/>
        </p:nvSpPr>
        <p:spPr>
          <a:xfrm>
            <a:off x="244047" y="48268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xmlns="" id="{00F1D354-0469-4CD1-B381-398301A7264C}"/>
              </a:ext>
            </a:extLst>
          </p:cNvPr>
          <p:cNvSpPr txBox="1"/>
          <p:nvPr/>
        </p:nvSpPr>
        <p:spPr>
          <a:xfrm>
            <a:off x="213916" y="399188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xmlns="" id="{5802081B-C2A6-4C23-A407-94E4EFC383BC}"/>
              </a:ext>
            </a:extLst>
          </p:cNvPr>
          <p:cNvGrpSpPr/>
          <p:nvPr/>
        </p:nvGrpSpPr>
        <p:grpSpPr>
          <a:xfrm>
            <a:off x="838956" y="482684"/>
            <a:ext cx="5371373" cy="6700997"/>
            <a:chOff x="3052762" y="260200"/>
            <a:chExt cx="6175373" cy="9246042"/>
          </a:xfrm>
        </p:grpSpPr>
        <p:grpSp>
          <p:nvGrpSpPr>
            <p:cNvPr id="108" name="グラフィックス 64">
              <a:extLst>
                <a:ext uri="{FF2B5EF4-FFF2-40B4-BE49-F238E27FC236}">
                  <a16:creationId xmlns:a16="http://schemas.microsoft.com/office/drawing/2014/main" xmlns="" id="{84EC451C-5978-4BE8-B4AD-2E7DE1821DDD}"/>
                </a:ext>
              </a:extLst>
            </p:cNvPr>
            <p:cNvGrpSpPr/>
            <p:nvPr/>
          </p:nvGrpSpPr>
          <p:grpSpPr>
            <a:xfrm>
              <a:off x="3052762" y="260200"/>
              <a:ext cx="6130307" cy="4580215"/>
              <a:chOff x="2792182" y="1445312"/>
              <a:chExt cx="6130307" cy="4580215"/>
            </a:xfrm>
          </p:grpSpPr>
          <p:sp>
            <p:nvSpPr>
              <p:cNvPr id="110" name="フリーフォーム: 図形 109">
                <a:extLst>
                  <a:ext uri="{FF2B5EF4-FFF2-40B4-BE49-F238E27FC236}">
                    <a16:creationId xmlns:a16="http://schemas.microsoft.com/office/drawing/2014/main" xmlns="" id="{A5BFF9C3-1994-43D8-B13D-BB2563A06FCA}"/>
                  </a:ext>
                </a:extLst>
              </p:cNvPr>
              <p:cNvSpPr/>
              <p:nvPr/>
            </p:nvSpPr>
            <p:spPr>
              <a:xfrm>
                <a:off x="2792182" y="1445312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1" name="フリーフォーム: 図形 110">
                <a:extLst>
                  <a:ext uri="{FF2B5EF4-FFF2-40B4-BE49-F238E27FC236}">
                    <a16:creationId xmlns:a16="http://schemas.microsoft.com/office/drawing/2014/main" xmlns="" id="{71B7033E-87A3-4CE1-ADF1-E66B46CC58B4}"/>
                  </a:ext>
                </a:extLst>
              </p:cNvPr>
              <p:cNvSpPr/>
              <p:nvPr/>
            </p:nvSpPr>
            <p:spPr>
              <a:xfrm>
                <a:off x="2792182" y="1445312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112" name="フリーフォーム: 図形 111">
                <a:extLst>
                  <a:ext uri="{FF2B5EF4-FFF2-40B4-BE49-F238E27FC236}">
                    <a16:creationId xmlns:a16="http://schemas.microsoft.com/office/drawing/2014/main" xmlns="" id="{5751C838-D02B-44B5-B1AD-C999D96D0F9B}"/>
                  </a:ext>
                </a:extLst>
              </p:cNvPr>
              <p:cNvSpPr/>
              <p:nvPr/>
            </p:nvSpPr>
            <p:spPr>
              <a:xfrm>
                <a:off x="2792182" y="1445312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noFill/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grpSp>
            <p:nvGrpSpPr>
              <p:cNvPr id="129" name="グラフィックス 64">
                <a:extLst>
                  <a:ext uri="{FF2B5EF4-FFF2-40B4-BE49-F238E27FC236}">
                    <a16:creationId xmlns:a16="http://schemas.microsoft.com/office/drawing/2014/main" xmlns="" id="{04D019A4-418B-41BB-813C-E34B32AC4104}"/>
                  </a:ext>
                </a:extLst>
              </p:cNvPr>
              <p:cNvGrpSpPr/>
              <p:nvPr/>
            </p:nvGrpSpPr>
            <p:grpSpPr>
              <a:xfrm>
                <a:off x="2837908" y="1513767"/>
                <a:ext cx="6084581" cy="4511760"/>
                <a:chOff x="2837908" y="1513767"/>
                <a:chExt cx="6084581" cy="4511760"/>
              </a:xfrm>
            </p:grpSpPr>
            <p:sp>
              <p:nvSpPr>
                <p:cNvPr id="131" name="フリーフォーム: 図形 130">
                  <a:extLst>
                    <a:ext uri="{FF2B5EF4-FFF2-40B4-BE49-F238E27FC236}">
                      <a16:creationId xmlns:a16="http://schemas.microsoft.com/office/drawing/2014/main" xmlns="" id="{BF53F373-328E-47CE-8DFD-9477FF61CDB8}"/>
                    </a:ext>
                  </a:extLst>
                </p:cNvPr>
                <p:cNvSpPr/>
                <p:nvPr/>
              </p:nvSpPr>
              <p:spPr>
                <a:xfrm>
                  <a:off x="3543610" y="1564343"/>
                  <a:ext cx="5192248" cy="3896744"/>
                </a:xfrm>
                <a:custGeom>
                  <a:avLst/>
                  <a:gdLst>
                    <a:gd name="connsiteX0" fmla="*/ 11 w 5192248"/>
                    <a:gd name="connsiteY0" fmla="*/ 11 h 3896744"/>
                    <a:gd name="connsiteX1" fmla="*/ 5192260 w 5192248"/>
                    <a:gd name="connsiteY1" fmla="*/ 11 h 3896744"/>
                    <a:gd name="connsiteX2" fmla="*/ 5192260 w 5192248"/>
                    <a:gd name="connsiteY2" fmla="*/ 3896755 h 3896744"/>
                    <a:gd name="connsiteX3" fmla="*/ 11 w 5192248"/>
                    <a:gd name="connsiteY3" fmla="*/ 3896755 h 389674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5192248" h="3896744">
                      <a:moveTo>
                        <a:pt x="11" y="11"/>
                      </a:moveTo>
                      <a:lnTo>
                        <a:pt x="5192260" y="11"/>
                      </a:lnTo>
                      <a:lnTo>
                        <a:pt x="5192260" y="3896755"/>
                      </a:lnTo>
                      <a:lnTo>
                        <a:pt x="11" y="3896755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/>
                </a:p>
              </p:txBody>
            </p:sp>
            <p:grpSp>
              <p:nvGrpSpPr>
                <p:cNvPr id="132" name="グラフィックス 64">
                  <a:extLst>
                    <a:ext uri="{FF2B5EF4-FFF2-40B4-BE49-F238E27FC236}">
                      <a16:creationId xmlns:a16="http://schemas.microsoft.com/office/drawing/2014/main" xmlns="" id="{5F2359EE-BF7B-4F40-8CCB-B95642DA8A07}"/>
                    </a:ext>
                  </a:extLst>
                </p:cNvPr>
                <p:cNvGrpSpPr/>
                <p:nvPr/>
              </p:nvGrpSpPr>
              <p:grpSpPr>
                <a:xfrm>
                  <a:off x="3505321" y="1559591"/>
                  <a:ext cx="3953748" cy="3906242"/>
                  <a:chOff x="3505321" y="1559591"/>
                  <a:chExt cx="3953748" cy="3906242"/>
                </a:xfrm>
                <a:noFill/>
              </p:grpSpPr>
              <p:sp>
                <p:nvSpPr>
                  <p:cNvPr id="224" name="フリーフォーム: 図形 223">
                    <a:extLst>
                      <a:ext uri="{FF2B5EF4-FFF2-40B4-BE49-F238E27FC236}">
                        <a16:creationId xmlns:a16="http://schemas.microsoft.com/office/drawing/2014/main" xmlns="" id="{F3FCA1B2-6644-4EBB-8E17-5CFEC83E1811}"/>
                      </a:ext>
                    </a:extLst>
                  </p:cNvPr>
                  <p:cNvSpPr/>
                  <p:nvPr/>
                </p:nvSpPr>
                <p:spPr>
                  <a:xfrm>
                    <a:off x="3505321" y="2769829"/>
                    <a:ext cx="3953748" cy="2695860"/>
                  </a:xfrm>
                  <a:custGeom>
                    <a:avLst/>
                    <a:gdLst>
                      <a:gd name="connsiteX0" fmla="*/ 11 w 3953748"/>
                      <a:gd name="connsiteY0" fmla="*/ 2695872 h 2695860"/>
                      <a:gd name="connsiteX1" fmla="*/ 26023 w 3953748"/>
                      <a:gd name="connsiteY1" fmla="*/ 2695738 h 2695860"/>
                      <a:gd name="connsiteX2" fmla="*/ 52034 w 3953748"/>
                      <a:gd name="connsiteY2" fmla="*/ 2695519 h 2695860"/>
                      <a:gd name="connsiteX3" fmla="*/ 78045 w 3953748"/>
                      <a:gd name="connsiteY3" fmla="*/ 2695177 h 2695860"/>
                      <a:gd name="connsiteX4" fmla="*/ 104057 w 3953748"/>
                      <a:gd name="connsiteY4" fmla="*/ 2694643 h 2695860"/>
                      <a:gd name="connsiteX5" fmla="*/ 130068 w 3953748"/>
                      <a:gd name="connsiteY5" fmla="*/ 2693853 h 2695860"/>
                      <a:gd name="connsiteX6" fmla="*/ 156080 w 3953748"/>
                      <a:gd name="connsiteY6" fmla="*/ 2692710 h 2695860"/>
                      <a:gd name="connsiteX7" fmla="*/ 182092 w 3953748"/>
                      <a:gd name="connsiteY7" fmla="*/ 2691100 h 2695860"/>
                      <a:gd name="connsiteX8" fmla="*/ 208103 w 3953748"/>
                      <a:gd name="connsiteY8" fmla="*/ 2688862 h 2695860"/>
                      <a:gd name="connsiteX9" fmla="*/ 234115 w 3953748"/>
                      <a:gd name="connsiteY9" fmla="*/ 2685794 h 2695860"/>
                      <a:gd name="connsiteX10" fmla="*/ 260126 w 3953748"/>
                      <a:gd name="connsiteY10" fmla="*/ 2681651 h 2695860"/>
                      <a:gd name="connsiteX11" fmla="*/ 286138 w 3953748"/>
                      <a:gd name="connsiteY11" fmla="*/ 2676127 h 2695860"/>
                      <a:gd name="connsiteX12" fmla="*/ 312149 w 3953748"/>
                      <a:gd name="connsiteY12" fmla="*/ 2668907 h 2695860"/>
                      <a:gd name="connsiteX13" fmla="*/ 338161 w 3953748"/>
                      <a:gd name="connsiteY13" fmla="*/ 2659686 h 2695860"/>
                      <a:gd name="connsiteX14" fmla="*/ 364168 w 3953748"/>
                      <a:gd name="connsiteY14" fmla="*/ 2648237 h 2695860"/>
                      <a:gd name="connsiteX15" fmla="*/ 390181 w 3953748"/>
                      <a:gd name="connsiteY15" fmla="*/ 2634435 h 2695860"/>
                      <a:gd name="connsiteX16" fmla="*/ 416194 w 3953748"/>
                      <a:gd name="connsiteY16" fmla="*/ 2618329 h 2695860"/>
                      <a:gd name="connsiteX17" fmla="*/ 442206 w 3953748"/>
                      <a:gd name="connsiteY17" fmla="*/ 2600098 h 2695860"/>
                      <a:gd name="connsiteX18" fmla="*/ 468219 w 3953748"/>
                      <a:gd name="connsiteY18" fmla="*/ 2580029 h 2695860"/>
                      <a:gd name="connsiteX19" fmla="*/ 494232 w 3953748"/>
                      <a:gd name="connsiteY19" fmla="*/ 2558435 h 2695860"/>
                      <a:gd name="connsiteX20" fmla="*/ 520245 w 3953748"/>
                      <a:gd name="connsiteY20" fmla="*/ 2535604 h 2695860"/>
                      <a:gd name="connsiteX21" fmla="*/ 546257 w 3953748"/>
                      <a:gd name="connsiteY21" fmla="*/ 2511735 h 2695860"/>
                      <a:gd name="connsiteX22" fmla="*/ 572261 w 3953748"/>
                      <a:gd name="connsiteY22" fmla="*/ 2486979 h 2695860"/>
                      <a:gd name="connsiteX23" fmla="*/ 624286 w 3953748"/>
                      <a:gd name="connsiteY23" fmla="*/ 2435153 h 2695860"/>
                      <a:gd name="connsiteX24" fmla="*/ 650299 w 3953748"/>
                      <a:gd name="connsiteY24" fmla="*/ 2408160 h 2695860"/>
                      <a:gd name="connsiteX25" fmla="*/ 676312 w 3953748"/>
                      <a:gd name="connsiteY25" fmla="*/ 2380347 h 2695860"/>
                      <a:gd name="connsiteX26" fmla="*/ 702325 w 3953748"/>
                      <a:gd name="connsiteY26" fmla="*/ 2351381 h 2695860"/>
                      <a:gd name="connsiteX27" fmla="*/ 728337 w 3953748"/>
                      <a:gd name="connsiteY27" fmla="*/ 2320568 h 2695860"/>
                      <a:gd name="connsiteX28" fmla="*/ 754350 w 3953748"/>
                      <a:gd name="connsiteY28" fmla="*/ 2286821 h 2695860"/>
                      <a:gd name="connsiteX29" fmla="*/ 780353 w 3953748"/>
                      <a:gd name="connsiteY29" fmla="*/ 2248721 h 2695860"/>
                      <a:gd name="connsiteX30" fmla="*/ 806366 w 3953748"/>
                      <a:gd name="connsiteY30" fmla="*/ 2204706 h 2695860"/>
                      <a:gd name="connsiteX31" fmla="*/ 832379 w 3953748"/>
                      <a:gd name="connsiteY31" fmla="*/ 2153290 h 2695860"/>
                      <a:gd name="connsiteX32" fmla="*/ 858392 w 3953748"/>
                      <a:gd name="connsiteY32" fmla="*/ 2093434 h 2695860"/>
                      <a:gd name="connsiteX33" fmla="*/ 884404 w 3953748"/>
                      <a:gd name="connsiteY33" fmla="*/ 2024702 h 2695860"/>
                      <a:gd name="connsiteX34" fmla="*/ 910417 w 3953748"/>
                      <a:gd name="connsiteY34" fmla="*/ 1947464 h 2695860"/>
                      <a:gd name="connsiteX35" fmla="*/ 936430 w 3953748"/>
                      <a:gd name="connsiteY35" fmla="*/ 1862777 h 2695860"/>
                      <a:gd name="connsiteX36" fmla="*/ 962433 w 3953748"/>
                      <a:gd name="connsiteY36" fmla="*/ 1772242 h 2695860"/>
                      <a:gd name="connsiteX37" fmla="*/ 1014459 w 3953748"/>
                      <a:gd name="connsiteY37" fmla="*/ 1580990 h 2695860"/>
                      <a:gd name="connsiteX38" fmla="*/ 1118510 w 3953748"/>
                      <a:gd name="connsiteY38" fmla="*/ 1196770 h 2695860"/>
                      <a:gd name="connsiteX39" fmla="*/ 1170526 w 3953748"/>
                      <a:gd name="connsiteY39" fmla="*/ 1013833 h 2695860"/>
                      <a:gd name="connsiteX40" fmla="*/ 1222551 w 3953748"/>
                      <a:gd name="connsiteY40" fmla="*/ 839602 h 2695860"/>
                      <a:gd name="connsiteX41" fmla="*/ 1248564 w 3953748"/>
                      <a:gd name="connsiteY41" fmla="*/ 756782 h 2695860"/>
                      <a:gd name="connsiteX42" fmla="*/ 1274577 w 3953748"/>
                      <a:gd name="connsiteY42" fmla="*/ 677553 h 2695860"/>
                      <a:gd name="connsiteX43" fmla="*/ 1300590 w 3953748"/>
                      <a:gd name="connsiteY43" fmla="*/ 602334 h 2695860"/>
                      <a:gd name="connsiteX44" fmla="*/ 1326603 w 3953748"/>
                      <a:gd name="connsiteY44" fmla="*/ 531163 h 2695860"/>
                      <a:gd name="connsiteX45" fmla="*/ 1352615 w 3953748"/>
                      <a:gd name="connsiteY45" fmla="*/ 463583 h 2695860"/>
                      <a:gd name="connsiteX46" fmla="*/ 1404631 w 3953748"/>
                      <a:gd name="connsiteY46" fmla="*/ 335319 h 2695860"/>
                      <a:gd name="connsiteX47" fmla="*/ 1456657 w 3953748"/>
                      <a:gd name="connsiteY47" fmla="*/ 211056 h 2695860"/>
                      <a:gd name="connsiteX48" fmla="*/ 1482670 w 3953748"/>
                      <a:gd name="connsiteY48" fmla="*/ 151563 h 2695860"/>
                      <a:gd name="connsiteX49" fmla="*/ 1508682 w 3953748"/>
                      <a:gd name="connsiteY49" fmla="*/ 96956 h 2695860"/>
                      <a:gd name="connsiteX50" fmla="*/ 1534695 w 3953748"/>
                      <a:gd name="connsiteY50" fmla="*/ 50941 h 2695860"/>
                      <a:gd name="connsiteX51" fmla="*/ 1560699 w 3953748"/>
                      <a:gd name="connsiteY51" fmla="*/ 17499 h 2695860"/>
                      <a:gd name="connsiteX52" fmla="*/ 1586711 w 3953748"/>
                      <a:gd name="connsiteY52" fmla="*/ 11 h 2695860"/>
                      <a:gd name="connsiteX53" fmla="*/ 1612724 w 3953748"/>
                      <a:gd name="connsiteY53" fmla="*/ 411 h 2695860"/>
                      <a:gd name="connsiteX54" fmla="*/ 1638737 w 3953748"/>
                      <a:gd name="connsiteY54" fmla="*/ 18613 h 2695860"/>
                      <a:gd name="connsiteX55" fmla="*/ 1664750 w 3953748"/>
                      <a:gd name="connsiteY55" fmla="*/ 52456 h 2695860"/>
                      <a:gd name="connsiteX56" fmla="*/ 1690762 w 3953748"/>
                      <a:gd name="connsiteY56" fmla="*/ 98042 h 2695860"/>
                      <a:gd name="connsiteX57" fmla="*/ 1716775 w 3953748"/>
                      <a:gd name="connsiteY57" fmla="*/ 150601 h 2695860"/>
                      <a:gd name="connsiteX58" fmla="*/ 1768791 w 3953748"/>
                      <a:gd name="connsiteY58" fmla="*/ 258510 h 2695860"/>
                      <a:gd name="connsiteX59" fmla="*/ 1794804 w 3953748"/>
                      <a:gd name="connsiteY59" fmla="*/ 307754 h 2695860"/>
                      <a:gd name="connsiteX60" fmla="*/ 1820817 w 3953748"/>
                      <a:gd name="connsiteY60" fmla="*/ 352579 h 2695860"/>
                      <a:gd name="connsiteX61" fmla="*/ 1846829 w 3953748"/>
                      <a:gd name="connsiteY61" fmla="*/ 394003 h 2695860"/>
                      <a:gd name="connsiteX62" fmla="*/ 1898855 w 3953748"/>
                      <a:gd name="connsiteY62" fmla="*/ 475080 h 2695860"/>
                      <a:gd name="connsiteX63" fmla="*/ 1924868 w 3953748"/>
                      <a:gd name="connsiteY63" fmla="*/ 519152 h 2695860"/>
                      <a:gd name="connsiteX64" fmla="*/ 1950881 w 3953748"/>
                      <a:gd name="connsiteY64" fmla="*/ 567663 h 2695860"/>
                      <a:gd name="connsiteX65" fmla="*/ 1976884 w 3953748"/>
                      <a:gd name="connsiteY65" fmla="*/ 621260 h 2695860"/>
                      <a:gd name="connsiteX66" fmla="*/ 2002897 w 3953748"/>
                      <a:gd name="connsiteY66" fmla="*/ 680077 h 2695860"/>
                      <a:gd name="connsiteX67" fmla="*/ 2028909 w 3953748"/>
                      <a:gd name="connsiteY67" fmla="*/ 744037 h 2695860"/>
                      <a:gd name="connsiteX68" fmla="*/ 2054922 w 3953748"/>
                      <a:gd name="connsiteY68" fmla="*/ 813179 h 2695860"/>
                      <a:gd name="connsiteX69" fmla="*/ 2080935 w 3953748"/>
                      <a:gd name="connsiteY69" fmla="*/ 887750 h 2695860"/>
                      <a:gd name="connsiteX70" fmla="*/ 2106948 w 3953748"/>
                      <a:gd name="connsiteY70" fmla="*/ 968103 h 2695860"/>
                      <a:gd name="connsiteX71" fmla="*/ 2132961 w 3953748"/>
                      <a:gd name="connsiteY71" fmla="*/ 1054295 h 2695860"/>
                      <a:gd name="connsiteX72" fmla="*/ 2158964 w 3953748"/>
                      <a:gd name="connsiteY72" fmla="*/ 1145735 h 2695860"/>
                      <a:gd name="connsiteX73" fmla="*/ 2237002 w 3953748"/>
                      <a:gd name="connsiteY73" fmla="*/ 1431390 h 2695860"/>
                      <a:gd name="connsiteX74" fmla="*/ 2263015 w 3953748"/>
                      <a:gd name="connsiteY74" fmla="*/ 1520134 h 2695860"/>
                      <a:gd name="connsiteX75" fmla="*/ 2289028 w 3953748"/>
                      <a:gd name="connsiteY75" fmla="*/ 1600506 h 2695860"/>
                      <a:gd name="connsiteX76" fmla="*/ 2315040 w 3953748"/>
                      <a:gd name="connsiteY76" fmla="*/ 1670639 h 2695860"/>
                      <a:gd name="connsiteX77" fmla="*/ 2341053 w 3953748"/>
                      <a:gd name="connsiteY77" fmla="*/ 1730103 h 2695860"/>
                      <a:gd name="connsiteX78" fmla="*/ 2367056 w 3953748"/>
                      <a:gd name="connsiteY78" fmla="*/ 1779843 h 2695860"/>
                      <a:gd name="connsiteX79" fmla="*/ 2393069 w 3953748"/>
                      <a:gd name="connsiteY79" fmla="*/ 1821982 h 2695860"/>
                      <a:gd name="connsiteX80" fmla="*/ 2419082 w 3953748"/>
                      <a:gd name="connsiteY80" fmla="*/ 1859272 h 2695860"/>
                      <a:gd name="connsiteX81" fmla="*/ 2471108 w 3953748"/>
                      <a:gd name="connsiteY81" fmla="*/ 1929995 h 2695860"/>
                      <a:gd name="connsiteX82" fmla="*/ 2497120 w 3953748"/>
                      <a:gd name="connsiteY82" fmla="*/ 1967124 h 2695860"/>
                      <a:gd name="connsiteX83" fmla="*/ 2523133 w 3953748"/>
                      <a:gd name="connsiteY83" fmla="*/ 2006309 h 2695860"/>
                      <a:gd name="connsiteX84" fmla="*/ 2653188 w 3953748"/>
                      <a:gd name="connsiteY84" fmla="*/ 2207411 h 2695860"/>
                      <a:gd name="connsiteX85" fmla="*/ 2705213 w 3953748"/>
                      <a:gd name="connsiteY85" fmla="*/ 2279867 h 2695860"/>
                      <a:gd name="connsiteX86" fmla="*/ 2757229 w 3953748"/>
                      <a:gd name="connsiteY86" fmla="*/ 2349438 h 2695860"/>
                      <a:gd name="connsiteX87" fmla="*/ 2783242 w 3953748"/>
                      <a:gd name="connsiteY87" fmla="*/ 2383233 h 2695860"/>
                      <a:gd name="connsiteX88" fmla="*/ 2809254 w 3953748"/>
                      <a:gd name="connsiteY88" fmla="*/ 2415742 h 2695860"/>
                      <a:gd name="connsiteX89" fmla="*/ 2835267 w 3953748"/>
                      <a:gd name="connsiteY89" fmla="*/ 2446212 h 2695860"/>
                      <a:gd name="connsiteX90" fmla="*/ 2861280 w 3953748"/>
                      <a:gd name="connsiteY90" fmla="*/ 2473949 h 2695860"/>
                      <a:gd name="connsiteX91" fmla="*/ 2887293 w 3953748"/>
                      <a:gd name="connsiteY91" fmla="*/ 2498466 h 2695860"/>
                      <a:gd name="connsiteX92" fmla="*/ 2913306 w 3953748"/>
                      <a:gd name="connsiteY92" fmla="*/ 2519583 h 2695860"/>
                      <a:gd name="connsiteX93" fmla="*/ 2939319 w 3953748"/>
                      <a:gd name="connsiteY93" fmla="*/ 2537452 h 2695860"/>
                      <a:gd name="connsiteX94" fmla="*/ 2965322 w 3953748"/>
                      <a:gd name="connsiteY94" fmla="*/ 2552473 h 2695860"/>
                      <a:gd name="connsiteX95" fmla="*/ 2991335 w 3953748"/>
                      <a:gd name="connsiteY95" fmla="*/ 2565198 h 2695860"/>
                      <a:gd name="connsiteX96" fmla="*/ 3017347 w 3953748"/>
                      <a:gd name="connsiteY96" fmla="*/ 2576200 h 2695860"/>
                      <a:gd name="connsiteX97" fmla="*/ 3043360 w 3953748"/>
                      <a:gd name="connsiteY97" fmla="*/ 2585963 h 2695860"/>
                      <a:gd name="connsiteX98" fmla="*/ 3069373 w 3953748"/>
                      <a:gd name="connsiteY98" fmla="*/ 2594869 h 2695860"/>
                      <a:gd name="connsiteX99" fmla="*/ 3095386 w 3953748"/>
                      <a:gd name="connsiteY99" fmla="*/ 2603175 h 2695860"/>
                      <a:gd name="connsiteX100" fmla="*/ 3121399 w 3953748"/>
                      <a:gd name="connsiteY100" fmla="*/ 2611004 h 2695860"/>
                      <a:gd name="connsiteX101" fmla="*/ 3147411 w 3953748"/>
                      <a:gd name="connsiteY101" fmla="*/ 2618424 h 2695860"/>
                      <a:gd name="connsiteX102" fmla="*/ 3173415 w 3953748"/>
                      <a:gd name="connsiteY102" fmla="*/ 2625453 h 2695860"/>
                      <a:gd name="connsiteX103" fmla="*/ 3199427 w 3953748"/>
                      <a:gd name="connsiteY103" fmla="*/ 2632073 h 2695860"/>
                      <a:gd name="connsiteX104" fmla="*/ 3225440 w 3953748"/>
                      <a:gd name="connsiteY104" fmla="*/ 2638274 h 2695860"/>
                      <a:gd name="connsiteX105" fmla="*/ 3251453 w 3953748"/>
                      <a:gd name="connsiteY105" fmla="*/ 2644046 h 2695860"/>
                      <a:gd name="connsiteX106" fmla="*/ 3277465 w 3953748"/>
                      <a:gd name="connsiteY106" fmla="*/ 2649352 h 2695860"/>
                      <a:gd name="connsiteX107" fmla="*/ 3303478 w 3953748"/>
                      <a:gd name="connsiteY107" fmla="*/ 2654143 h 2695860"/>
                      <a:gd name="connsiteX108" fmla="*/ 3329491 w 3953748"/>
                      <a:gd name="connsiteY108" fmla="*/ 2658362 h 2695860"/>
                      <a:gd name="connsiteX109" fmla="*/ 3355494 w 3953748"/>
                      <a:gd name="connsiteY109" fmla="*/ 2661963 h 2695860"/>
                      <a:gd name="connsiteX110" fmla="*/ 3381507 w 3953748"/>
                      <a:gd name="connsiteY110" fmla="*/ 2664896 h 2695860"/>
                      <a:gd name="connsiteX111" fmla="*/ 3407520 w 3953748"/>
                      <a:gd name="connsiteY111" fmla="*/ 2667183 h 2695860"/>
                      <a:gd name="connsiteX112" fmla="*/ 3433533 w 3953748"/>
                      <a:gd name="connsiteY112" fmla="*/ 2668878 h 2695860"/>
                      <a:gd name="connsiteX113" fmla="*/ 3459545 w 3953748"/>
                      <a:gd name="connsiteY113" fmla="*/ 2670097 h 2695860"/>
                      <a:gd name="connsiteX114" fmla="*/ 3485558 w 3953748"/>
                      <a:gd name="connsiteY114" fmla="*/ 2670993 h 2695860"/>
                      <a:gd name="connsiteX115" fmla="*/ 3537584 w 3953748"/>
                      <a:gd name="connsiteY115" fmla="*/ 2672469 h 2695860"/>
                      <a:gd name="connsiteX116" fmla="*/ 3563587 w 3953748"/>
                      <a:gd name="connsiteY116" fmla="*/ 2673393 h 2695860"/>
                      <a:gd name="connsiteX117" fmla="*/ 3589600 w 3953748"/>
                      <a:gd name="connsiteY117" fmla="*/ 2674621 h 2695860"/>
                      <a:gd name="connsiteX118" fmla="*/ 3615613 w 3953748"/>
                      <a:gd name="connsiteY118" fmla="*/ 2676231 h 2695860"/>
                      <a:gd name="connsiteX119" fmla="*/ 3641625 w 3953748"/>
                      <a:gd name="connsiteY119" fmla="*/ 2678203 h 2695860"/>
                      <a:gd name="connsiteX120" fmla="*/ 3667638 w 3953748"/>
                      <a:gd name="connsiteY120" fmla="*/ 2680489 h 2695860"/>
                      <a:gd name="connsiteX121" fmla="*/ 3745676 w 3953748"/>
                      <a:gd name="connsiteY121" fmla="*/ 2687785 h 2695860"/>
                      <a:gd name="connsiteX122" fmla="*/ 3771680 w 3953748"/>
                      <a:gd name="connsiteY122" fmla="*/ 2689890 h 2695860"/>
                      <a:gd name="connsiteX123" fmla="*/ 3797692 w 3953748"/>
                      <a:gd name="connsiteY123" fmla="*/ 2691652 h 2695860"/>
                      <a:gd name="connsiteX124" fmla="*/ 3823705 w 3953748"/>
                      <a:gd name="connsiteY124" fmla="*/ 2693043 h 2695860"/>
                      <a:gd name="connsiteX125" fmla="*/ 3849718 w 3953748"/>
                      <a:gd name="connsiteY125" fmla="*/ 2694081 h 2695860"/>
                      <a:gd name="connsiteX126" fmla="*/ 3875731 w 3953748"/>
                      <a:gd name="connsiteY126" fmla="*/ 2694815 h 2695860"/>
                      <a:gd name="connsiteX127" fmla="*/ 3901744 w 3953748"/>
                      <a:gd name="connsiteY127" fmla="*/ 2695310 h 2695860"/>
                      <a:gd name="connsiteX128" fmla="*/ 3927756 w 3953748"/>
                      <a:gd name="connsiteY128" fmla="*/ 2695615 h 2695860"/>
                      <a:gd name="connsiteX129" fmla="*/ 3953760 w 3953748"/>
                      <a:gd name="connsiteY129" fmla="*/ 2695805 h 269586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  <a:cxn ang="0">
                        <a:pos x="connsiteX101" y="connsiteY101"/>
                      </a:cxn>
                      <a:cxn ang="0">
                        <a:pos x="connsiteX102" y="connsiteY102"/>
                      </a:cxn>
                      <a:cxn ang="0">
                        <a:pos x="connsiteX103" y="connsiteY103"/>
                      </a:cxn>
                      <a:cxn ang="0">
                        <a:pos x="connsiteX104" y="connsiteY104"/>
                      </a:cxn>
                      <a:cxn ang="0">
                        <a:pos x="connsiteX105" y="connsiteY105"/>
                      </a:cxn>
                      <a:cxn ang="0">
                        <a:pos x="connsiteX106" y="connsiteY106"/>
                      </a:cxn>
                      <a:cxn ang="0">
                        <a:pos x="connsiteX107" y="connsiteY107"/>
                      </a:cxn>
                      <a:cxn ang="0">
                        <a:pos x="connsiteX108" y="connsiteY108"/>
                      </a:cxn>
                      <a:cxn ang="0">
                        <a:pos x="connsiteX109" y="connsiteY109"/>
                      </a:cxn>
                      <a:cxn ang="0">
                        <a:pos x="connsiteX110" y="connsiteY110"/>
                      </a:cxn>
                      <a:cxn ang="0">
                        <a:pos x="connsiteX111" y="connsiteY111"/>
                      </a:cxn>
                      <a:cxn ang="0">
                        <a:pos x="connsiteX112" y="connsiteY112"/>
                      </a:cxn>
                      <a:cxn ang="0">
                        <a:pos x="connsiteX113" y="connsiteY113"/>
                      </a:cxn>
                      <a:cxn ang="0">
                        <a:pos x="connsiteX114" y="connsiteY114"/>
                      </a:cxn>
                      <a:cxn ang="0">
                        <a:pos x="connsiteX115" y="connsiteY115"/>
                      </a:cxn>
                      <a:cxn ang="0">
                        <a:pos x="connsiteX116" y="connsiteY116"/>
                      </a:cxn>
                      <a:cxn ang="0">
                        <a:pos x="connsiteX117" y="connsiteY117"/>
                      </a:cxn>
                      <a:cxn ang="0">
                        <a:pos x="connsiteX118" y="connsiteY118"/>
                      </a:cxn>
                      <a:cxn ang="0">
                        <a:pos x="connsiteX119" y="connsiteY119"/>
                      </a:cxn>
                      <a:cxn ang="0">
                        <a:pos x="connsiteX120" y="connsiteY120"/>
                      </a:cxn>
                      <a:cxn ang="0">
                        <a:pos x="connsiteX121" y="connsiteY121"/>
                      </a:cxn>
                      <a:cxn ang="0">
                        <a:pos x="connsiteX122" y="connsiteY122"/>
                      </a:cxn>
                      <a:cxn ang="0">
                        <a:pos x="connsiteX123" y="connsiteY123"/>
                      </a:cxn>
                      <a:cxn ang="0">
                        <a:pos x="connsiteX124" y="connsiteY124"/>
                      </a:cxn>
                      <a:cxn ang="0">
                        <a:pos x="connsiteX125" y="connsiteY125"/>
                      </a:cxn>
                      <a:cxn ang="0">
                        <a:pos x="connsiteX126" y="connsiteY126"/>
                      </a:cxn>
                      <a:cxn ang="0">
                        <a:pos x="connsiteX127" y="connsiteY127"/>
                      </a:cxn>
                      <a:cxn ang="0">
                        <a:pos x="connsiteX128" y="connsiteY128"/>
                      </a:cxn>
                      <a:cxn ang="0">
                        <a:pos x="connsiteX129" y="connsiteY129"/>
                      </a:cxn>
                    </a:cxnLst>
                    <a:rect l="l" t="t" r="r" b="b"/>
                    <a:pathLst>
                      <a:path w="3953748" h="2695860">
                        <a:moveTo>
                          <a:pt x="11" y="2695872"/>
                        </a:moveTo>
                        <a:lnTo>
                          <a:pt x="26023" y="2695738"/>
                        </a:lnTo>
                        <a:lnTo>
                          <a:pt x="52034" y="2695519"/>
                        </a:lnTo>
                        <a:lnTo>
                          <a:pt x="78045" y="2695177"/>
                        </a:lnTo>
                        <a:lnTo>
                          <a:pt x="104057" y="2694643"/>
                        </a:lnTo>
                        <a:lnTo>
                          <a:pt x="130068" y="2693853"/>
                        </a:lnTo>
                        <a:lnTo>
                          <a:pt x="156080" y="2692710"/>
                        </a:lnTo>
                        <a:lnTo>
                          <a:pt x="182092" y="2691100"/>
                        </a:lnTo>
                        <a:lnTo>
                          <a:pt x="208103" y="2688862"/>
                        </a:lnTo>
                        <a:lnTo>
                          <a:pt x="234115" y="2685794"/>
                        </a:lnTo>
                        <a:lnTo>
                          <a:pt x="260126" y="2681651"/>
                        </a:lnTo>
                        <a:lnTo>
                          <a:pt x="286138" y="2676127"/>
                        </a:lnTo>
                        <a:lnTo>
                          <a:pt x="312149" y="2668907"/>
                        </a:lnTo>
                        <a:lnTo>
                          <a:pt x="338161" y="2659686"/>
                        </a:lnTo>
                        <a:lnTo>
                          <a:pt x="364168" y="2648237"/>
                        </a:lnTo>
                        <a:lnTo>
                          <a:pt x="390181" y="2634435"/>
                        </a:lnTo>
                        <a:lnTo>
                          <a:pt x="416194" y="2618329"/>
                        </a:lnTo>
                        <a:lnTo>
                          <a:pt x="442206" y="2600098"/>
                        </a:lnTo>
                        <a:lnTo>
                          <a:pt x="468219" y="2580029"/>
                        </a:lnTo>
                        <a:lnTo>
                          <a:pt x="494232" y="2558435"/>
                        </a:lnTo>
                        <a:lnTo>
                          <a:pt x="520245" y="2535604"/>
                        </a:lnTo>
                        <a:lnTo>
                          <a:pt x="546257" y="2511735"/>
                        </a:lnTo>
                        <a:lnTo>
                          <a:pt x="572261" y="2486979"/>
                        </a:lnTo>
                        <a:lnTo>
                          <a:pt x="624286" y="2435153"/>
                        </a:lnTo>
                        <a:lnTo>
                          <a:pt x="650299" y="2408160"/>
                        </a:lnTo>
                        <a:lnTo>
                          <a:pt x="676312" y="2380347"/>
                        </a:lnTo>
                        <a:lnTo>
                          <a:pt x="702325" y="2351381"/>
                        </a:lnTo>
                        <a:lnTo>
                          <a:pt x="728337" y="2320568"/>
                        </a:lnTo>
                        <a:lnTo>
                          <a:pt x="754350" y="2286821"/>
                        </a:lnTo>
                        <a:lnTo>
                          <a:pt x="780353" y="2248721"/>
                        </a:lnTo>
                        <a:lnTo>
                          <a:pt x="806366" y="2204706"/>
                        </a:lnTo>
                        <a:lnTo>
                          <a:pt x="832379" y="2153290"/>
                        </a:lnTo>
                        <a:lnTo>
                          <a:pt x="858392" y="2093434"/>
                        </a:lnTo>
                        <a:lnTo>
                          <a:pt x="884404" y="2024702"/>
                        </a:lnTo>
                        <a:lnTo>
                          <a:pt x="910417" y="1947464"/>
                        </a:lnTo>
                        <a:lnTo>
                          <a:pt x="936430" y="1862777"/>
                        </a:lnTo>
                        <a:lnTo>
                          <a:pt x="962433" y="1772242"/>
                        </a:lnTo>
                        <a:lnTo>
                          <a:pt x="1014459" y="1580990"/>
                        </a:lnTo>
                        <a:lnTo>
                          <a:pt x="1118510" y="1196770"/>
                        </a:lnTo>
                        <a:lnTo>
                          <a:pt x="1170526" y="1013833"/>
                        </a:lnTo>
                        <a:lnTo>
                          <a:pt x="1222551" y="839602"/>
                        </a:lnTo>
                        <a:lnTo>
                          <a:pt x="1248564" y="756782"/>
                        </a:lnTo>
                        <a:lnTo>
                          <a:pt x="1274577" y="677553"/>
                        </a:lnTo>
                        <a:lnTo>
                          <a:pt x="1300590" y="602334"/>
                        </a:lnTo>
                        <a:lnTo>
                          <a:pt x="1326603" y="531163"/>
                        </a:lnTo>
                        <a:lnTo>
                          <a:pt x="1352615" y="463583"/>
                        </a:lnTo>
                        <a:lnTo>
                          <a:pt x="1404631" y="335319"/>
                        </a:lnTo>
                        <a:lnTo>
                          <a:pt x="1456657" y="211056"/>
                        </a:lnTo>
                        <a:lnTo>
                          <a:pt x="1482670" y="151563"/>
                        </a:lnTo>
                        <a:lnTo>
                          <a:pt x="1508682" y="96956"/>
                        </a:lnTo>
                        <a:lnTo>
                          <a:pt x="1534695" y="50941"/>
                        </a:lnTo>
                        <a:lnTo>
                          <a:pt x="1560699" y="17499"/>
                        </a:lnTo>
                        <a:lnTo>
                          <a:pt x="1586711" y="11"/>
                        </a:lnTo>
                        <a:lnTo>
                          <a:pt x="1612724" y="411"/>
                        </a:lnTo>
                        <a:lnTo>
                          <a:pt x="1638737" y="18613"/>
                        </a:lnTo>
                        <a:lnTo>
                          <a:pt x="1664750" y="52456"/>
                        </a:lnTo>
                        <a:lnTo>
                          <a:pt x="1690762" y="98042"/>
                        </a:lnTo>
                        <a:lnTo>
                          <a:pt x="1716775" y="150601"/>
                        </a:lnTo>
                        <a:lnTo>
                          <a:pt x="1768791" y="258510"/>
                        </a:lnTo>
                        <a:lnTo>
                          <a:pt x="1794804" y="307754"/>
                        </a:lnTo>
                        <a:lnTo>
                          <a:pt x="1820817" y="352579"/>
                        </a:lnTo>
                        <a:lnTo>
                          <a:pt x="1846829" y="394003"/>
                        </a:lnTo>
                        <a:lnTo>
                          <a:pt x="1898855" y="475080"/>
                        </a:lnTo>
                        <a:lnTo>
                          <a:pt x="1924868" y="519152"/>
                        </a:lnTo>
                        <a:lnTo>
                          <a:pt x="1950881" y="567663"/>
                        </a:lnTo>
                        <a:lnTo>
                          <a:pt x="1976884" y="621260"/>
                        </a:lnTo>
                        <a:lnTo>
                          <a:pt x="2002897" y="680077"/>
                        </a:lnTo>
                        <a:lnTo>
                          <a:pt x="2028909" y="744037"/>
                        </a:lnTo>
                        <a:lnTo>
                          <a:pt x="2054922" y="813179"/>
                        </a:lnTo>
                        <a:lnTo>
                          <a:pt x="2080935" y="887750"/>
                        </a:lnTo>
                        <a:lnTo>
                          <a:pt x="2106948" y="968103"/>
                        </a:lnTo>
                        <a:lnTo>
                          <a:pt x="2132961" y="1054295"/>
                        </a:lnTo>
                        <a:lnTo>
                          <a:pt x="2158964" y="1145735"/>
                        </a:lnTo>
                        <a:lnTo>
                          <a:pt x="2237002" y="1431390"/>
                        </a:lnTo>
                        <a:lnTo>
                          <a:pt x="2263015" y="1520134"/>
                        </a:lnTo>
                        <a:lnTo>
                          <a:pt x="2289028" y="1600506"/>
                        </a:lnTo>
                        <a:lnTo>
                          <a:pt x="2315040" y="1670639"/>
                        </a:lnTo>
                        <a:lnTo>
                          <a:pt x="2341053" y="1730103"/>
                        </a:lnTo>
                        <a:lnTo>
                          <a:pt x="2367056" y="1779843"/>
                        </a:lnTo>
                        <a:lnTo>
                          <a:pt x="2393069" y="1821982"/>
                        </a:lnTo>
                        <a:lnTo>
                          <a:pt x="2419082" y="1859272"/>
                        </a:lnTo>
                        <a:lnTo>
                          <a:pt x="2471108" y="1929995"/>
                        </a:lnTo>
                        <a:lnTo>
                          <a:pt x="2497120" y="1967124"/>
                        </a:lnTo>
                        <a:lnTo>
                          <a:pt x="2523133" y="2006309"/>
                        </a:lnTo>
                        <a:lnTo>
                          <a:pt x="2653188" y="2207411"/>
                        </a:lnTo>
                        <a:lnTo>
                          <a:pt x="2705213" y="2279867"/>
                        </a:lnTo>
                        <a:lnTo>
                          <a:pt x="2757229" y="2349438"/>
                        </a:lnTo>
                        <a:lnTo>
                          <a:pt x="2783242" y="2383233"/>
                        </a:lnTo>
                        <a:lnTo>
                          <a:pt x="2809254" y="2415742"/>
                        </a:lnTo>
                        <a:lnTo>
                          <a:pt x="2835267" y="2446212"/>
                        </a:lnTo>
                        <a:lnTo>
                          <a:pt x="2861280" y="2473949"/>
                        </a:lnTo>
                        <a:lnTo>
                          <a:pt x="2887293" y="2498466"/>
                        </a:lnTo>
                        <a:lnTo>
                          <a:pt x="2913306" y="2519583"/>
                        </a:lnTo>
                        <a:lnTo>
                          <a:pt x="2939319" y="2537452"/>
                        </a:lnTo>
                        <a:lnTo>
                          <a:pt x="2965322" y="2552473"/>
                        </a:lnTo>
                        <a:lnTo>
                          <a:pt x="2991335" y="2565198"/>
                        </a:lnTo>
                        <a:lnTo>
                          <a:pt x="3017347" y="2576200"/>
                        </a:lnTo>
                        <a:lnTo>
                          <a:pt x="3043360" y="2585963"/>
                        </a:lnTo>
                        <a:lnTo>
                          <a:pt x="3069373" y="2594869"/>
                        </a:lnTo>
                        <a:lnTo>
                          <a:pt x="3095386" y="2603175"/>
                        </a:lnTo>
                        <a:lnTo>
                          <a:pt x="3121399" y="2611004"/>
                        </a:lnTo>
                        <a:lnTo>
                          <a:pt x="3147411" y="2618424"/>
                        </a:lnTo>
                        <a:lnTo>
                          <a:pt x="3173415" y="2625453"/>
                        </a:lnTo>
                        <a:lnTo>
                          <a:pt x="3199427" y="2632073"/>
                        </a:lnTo>
                        <a:lnTo>
                          <a:pt x="3225440" y="2638274"/>
                        </a:lnTo>
                        <a:lnTo>
                          <a:pt x="3251453" y="2644046"/>
                        </a:lnTo>
                        <a:lnTo>
                          <a:pt x="3277465" y="2649352"/>
                        </a:lnTo>
                        <a:lnTo>
                          <a:pt x="3303478" y="2654143"/>
                        </a:lnTo>
                        <a:lnTo>
                          <a:pt x="3329491" y="2658362"/>
                        </a:lnTo>
                        <a:lnTo>
                          <a:pt x="3355494" y="2661963"/>
                        </a:lnTo>
                        <a:lnTo>
                          <a:pt x="3381507" y="2664896"/>
                        </a:lnTo>
                        <a:lnTo>
                          <a:pt x="3407520" y="2667183"/>
                        </a:lnTo>
                        <a:lnTo>
                          <a:pt x="3433533" y="2668878"/>
                        </a:lnTo>
                        <a:lnTo>
                          <a:pt x="3459545" y="2670097"/>
                        </a:lnTo>
                        <a:lnTo>
                          <a:pt x="3485558" y="2670993"/>
                        </a:lnTo>
                        <a:lnTo>
                          <a:pt x="3537584" y="2672469"/>
                        </a:lnTo>
                        <a:lnTo>
                          <a:pt x="3563587" y="2673393"/>
                        </a:lnTo>
                        <a:lnTo>
                          <a:pt x="3589600" y="2674621"/>
                        </a:lnTo>
                        <a:lnTo>
                          <a:pt x="3615613" y="2676231"/>
                        </a:lnTo>
                        <a:lnTo>
                          <a:pt x="3641625" y="2678203"/>
                        </a:lnTo>
                        <a:lnTo>
                          <a:pt x="3667638" y="2680489"/>
                        </a:lnTo>
                        <a:lnTo>
                          <a:pt x="3745676" y="2687785"/>
                        </a:lnTo>
                        <a:lnTo>
                          <a:pt x="3771680" y="2689890"/>
                        </a:lnTo>
                        <a:lnTo>
                          <a:pt x="3797692" y="2691652"/>
                        </a:lnTo>
                        <a:lnTo>
                          <a:pt x="3823705" y="2693043"/>
                        </a:lnTo>
                        <a:lnTo>
                          <a:pt x="3849718" y="2694081"/>
                        </a:lnTo>
                        <a:lnTo>
                          <a:pt x="3875731" y="2694815"/>
                        </a:lnTo>
                        <a:lnTo>
                          <a:pt x="3901744" y="2695310"/>
                        </a:lnTo>
                        <a:lnTo>
                          <a:pt x="3927756" y="2695615"/>
                        </a:lnTo>
                        <a:lnTo>
                          <a:pt x="3953760" y="2695805"/>
                        </a:lnTo>
                      </a:path>
                    </a:pathLst>
                  </a:custGeom>
                  <a:noFill/>
                  <a:ln w="19050" cap="flat">
                    <a:solidFill>
                      <a:srgbClr val="003178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5" name="フリーフォーム: 図形 224">
                    <a:extLst>
                      <a:ext uri="{FF2B5EF4-FFF2-40B4-BE49-F238E27FC236}">
                        <a16:creationId xmlns:a16="http://schemas.microsoft.com/office/drawing/2014/main" xmlns="" id="{F86F85A0-C35D-4896-B4C7-198F1CC8EEB3}"/>
                      </a:ext>
                    </a:extLst>
                  </p:cNvPr>
                  <p:cNvSpPr/>
                  <p:nvPr/>
                </p:nvSpPr>
                <p:spPr>
                  <a:xfrm>
                    <a:off x="4454037" y="1559591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custDash>
                      <a:ds d="75000" sp="225000"/>
                    </a:custDash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6" name="フリーフォーム: 図形 225">
                    <a:extLst>
                      <a:ext uri="{FF2B5EF4-FFF2-40B4-BE49-F238E27FC236}">
                        <a16:creationId xmlns:a16="http://schemas.microsoft.com/office/drawing/2014/main" xmlns="" id="{87D5065E-1086-4014-BF8A-146560A1D4B5}"/>
                      </a:ext>
                    </a:extLst>
                  </p:cNvPr>
                  <p:cNvSpPr/>
                  <p:nvPr/>
                </p:nvSpPr>
                <p:spPr>
                  <a:xfrm>
                    <a:off x="4449532" y="1559591"/>
                    <a:ext cx="4505" cy="9545"/>
                  </a:xfrm>
                  <a:custGeom>
                    <a:avLst/>
                    <a:gdLst>
                      <a:gd name="connsiteX0" fmla="*/ 11 w 4505"/>
                      <a:gd name="connsiteY0" fmla="*/ 9557 h 9545"/>
                      <a:gd name="connsiteX1" fmla="*/ 4516 w 4505"/>
                      <a:gd name="connsiteY1" fmla="*/ 11 h 954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505" h="9545">
                        <a:moveTo>
                          <a:pt x="11" y="9557"/>
                        </a:moveTo>
                        <a:lnTo>
                          <a:pt x="4516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</p:grpSp>
            <p:grpSp>
              <p:nvGrpSpPr>
                <p:cNvPr id="133" name="グラフィックス 64">
                  <a:extLst>
                    <a:ext uri="{FF2B5EF4-FFF2-40B4-BE49-F238E27FC236}">
                      <a16:creationId xmlns:a16="http://schemas.microsoft.com/office/drawing/2014/main" xmlns="" id="{5CAD50FD-E204-4651-A91F-CA74D5E23148}"/>
                    </a:ext>
                  </a:extLst>
                </p:cNvPr>
                <p:cNvGrpSpPr/>
                <p:nvPr/>
              </p:nvGrpSpPr>
              <p:grpSpPr>
                <a:xfrm>
                  <a:off x="2837908" y="1513767"/>
                  <a:ext cx="6084581" cy="4511760"/>
                  <a:chOff x="2837908" y="1513767"/>
                  <a:chExt cx="6084581" cy="4511760"/>
                </a:xfrm>
              </p:grpSpPr>
              <p:sp>
                <p:nvSpPr>
                  <p:cNvPr id="134" name="フリーフォーム: 図形 133">
                    <a:extLst>
                      <a:ext uri="{FF2B5EF4-FFF2-40B4-BE49-F238E27FC236}">
                        <a16:creationId xmlns:a16="http://schemas.microsoft.com/office/drawing/2014/main" xmlns="" id="{3CFE78CD-58D3-4776-94C6-7FB476719419}"/>
                      </a:ext>
                    </a:extLst>
                  </p:cNvPr>
                  <p:cNvSpPr/>
                  <p:nvPr/>
                </p:nvSpPr>
                <p:spPr>
                  <a:xfrm>
                    <a:off x="3543610" y="5465833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47" name="フリーフォーム: 図形 146">
                    <a:extLst>
                      <a:ext uri="{FF2B5EF4-FFF2-40B4-BE49-F238E27FC236}">
                        <a16:creationId xmlns:a16="http://schemas.microsoft.com/office/drawing/2014/main" xmlns="" id="{5CF2AD91-C2E7-46D6-836E-FC91B8568569}"/>
                      </a:ext>
                    </a:extLst>
                  </p:cNvPr>
                  <p:cNvSpPr/>
                  <p:nvPr/>
                </p:nvSpPr>
                <p:spPr>
                  <a:xfrm>
                    <a:off x="8735858" y="1559591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49" name="フリーフォーム: 図形 148">
                    <a:extLst>
                      <a:ext uri="{FF2B5EF4-FFF2-40B4-BE49-F238E27FC236}">
                        <a16:creationId xmlns:a16="http://schemas.microsoft.com/office/drawing/2014/main" xmlns="" id="{D995D2B1-08D2-40A9-BC30-7AD433612352}"/>
                      </a:ext>
                    </a:extLst>
                  </p:cNvPr>
                  <p:cNvSpPr/>
                  <p:nvPr/>
                </p:nvSpPr>
                <p:spPr>
                  <a:xfrm>
                    <a:off x="3543610" y="1559591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1" name="フリーフォーム: 図形 150">
                    <a:extLst>
                      <a:ext uri="{FF2B5EF4-FFF2-40B4-BE49-F238E27FC236}">
                        <a16:creationId xmlns:a16="http://schemas.microsoft.com/office/drawing/2014/main" xmlns="" id="{56AA833C-6002-4695-8FAC-B053F01D33B5}"/>
                      </a:ext>
                    </a:extLst>
                  </p:cNvPr>
                  <p:cNvSpPr/>
                  <p:nvPr/>
                </p:nvSpPr>
                <p:spPr>
                  <a:xfrm>
                    <a:off x="3543610" y="1559591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3" name="フリーフォーム: 図形 152">
                    <a:extLst>
                      <a:ext uri="{FF2B5EF4-FFF2-40B4-BE49-F238E27FC236}">
                        <a16:creationId xmlns:a16="http://schemas.microsoft.com/office/drawing/2014/main" xmlns="" id="{953745B8-497E-4BBE-A382-981BB8928127}"/>
                      </a:ext>
                    </a:extLst>
                  </p:cNvPr>
                  <p:cNvSpPr/>
                  <p:nvPr/>
                </p:nvSpPr>
                <p:spPr>
                  <a:xfrm>
                    <a:off x="3543610" y="5465833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5" name="フリーフォーム: 図形 154">
                    <a:extLst>
                      <a:ext uri="{FF2B5EF4-FFF2-40B4-BE49-F238E27FC236}">
                        <a16:creationId xmlns:a16="http://schemas.microsoft.com/office/drawing/2014/main" xmlns="" id="{94242346-DEA6-4AA9-AAE3-09D4ADA3001B}"/>
                      </a:ext>
                    </a:extLst>
                  </p:cNvPr>
                  <p:cNvSpPr/>
                  <p:nvPr/>
                </p:nvSpPr>
                <p:spPr>
                  <a:xfrm>
                    <a:off x="4211664" y="5465833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6" name="フリーフォーム: 図形 155">
                    <a:extLst>
                      <a:ext uri="{FF2B5EF4-FFF2-40B4-BE49-F238E27FC236}">
                        <a16:creationId xmlns:a16="http://schemas.microsoft.com/office/drawing/2014/main" xmlns="" id="{10A69230-87EF-410F-9469-28E59175FD5C}"/>
                      </a:ext>
                    </a:extLst>
                  </p:cNvPr>
                  <p:cNvSpPr/>
                  <p:nvPr/>
                </p:nvSpPr>
                <p:spPr>
                  <a:xfrm>
                    <a:off x="5490700" y="5465833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5" name="フリーフォーム: 図形 164">
                    <a:extLst>
                      <a:ext uri="{FF2B5EF4-FFF2-40B4-BE49-F238E27FC236}">
                        <a16:creationId xmlns:a16="http://schemas.microsoft.com/office/drawing/2014/main" xmlns="" id="{B615ED59-91D8-4C23-AE8D-433DA867A94D}"/>
                      </a:ext>
                    </a:extLst>
                  </p:cNvPr>
                  <p:cNvSpPr/>
                  <p:nvPr/>
                </p:nvSpPr>
                <p:spPr>
                  <a:xfrm>
                    <a:off x="6769745" y="5465833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7" name="フリーフォーム: 図形 166">
                    <a:extLst>
                      <a:ext uri="{FF2B5EF4-FFF2-40B4-BE49-F238E27FC236}">
                        <a16:creationId xmlns:a16="http://schemas.microsoft.com/office/drawing/2014/main" xmlns="" id="{3230296A-1D57-4F28-A9A6-536A8553C076}"/>
                      </a:ext>
                    </a:extLst>
                  </p:cNvPr>
                  <p:cNvSpPr/>
                  <p:nvPr/>
                </p:nvSpPr>
                <p:spPr>
                  <a:xfrm>
                    <a:off x="8048791" y="5465833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9" name="フリーフォーム: 図形 168">
                    <a:extLst>
                      <a:ext uri="{FF2B5EF4-FFF2-40B4-BE49-F238E27FC236}">
                        <a16:creationId xmlns:a16="http://schemas.microsoft.com/office/drawing/2014/main" xmlns="" id="{09FB4995-458C-4426-A30B-544718804FBC}"/>
                      </a:ext>
                    </a:extLst>
                  </p:cNvPr>
                  <p:cNvSpPr/>
                  <p:nvPr/>
                </p:nvSpPr>
                <p:spPr>
                  <a:xfrm>
                    <a:off x="3572139" y="5465833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71" name="テキスト ボックス 170">
                    <a:extLst>
                      <a:ext uri="{FF2B5EF4-FFF2-40B4-BE49-F238E27FC236}">
                        <a16:creationId xmlns:a16="http://schemas.microsoft.com/office/drawing/2014/main" xmlns="" id="{B2B6841C-3F80-4377-A53D-D7EE1882DCE0}"/>
                      </a:ext>
                    </a:extLst>
                  </p:cNvPr>
                  <p:cNvSpPr txBox="1"/>
                  <p:nvPr/>
                </p:nvSpPr>
                <p:spPr>
                  <a:xfrm>
                    <a:off x="3452124" y="5514890"/>
                    <a:ext cx="278653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</a:t>
                    </a:r>
                  </a:p>
                </p:txBody>
              </p:sp>
              <p:sp>
                <p:nvSpPr>
                  <p:cNvPr id="173" name="フリーフォーム: 図形 172">
                    <a:extLst>
                      <a:ext uri="{FF2B5EF4-FFF2-40B4-BE49-F238E27FC236}">
                        <a16:creationId xmlns:a16="http://schemas.microsoft.com/office/drawing/2014/main" xmlns="" id="{71733C43-729C-47BB-BB71-3DD7511ACFBE}"/>
                      </a:ext>
                    </a:extLst>
                  </p:cNvPr>
                  <p:cNvSpPr/>
                  <p:nvPr/>
                </p:nvSpPr>
                <p:spPr>
                  <a:xfrm>
                    <a:off x="4851182" y="5465833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75" name="テキスト ボックス 174">
                    <a:extLst>
                      <a:ext uri="{FF2B5EF4-FFF2-40B4-BE49-F238E27FC236}">
                        <a16:creationId xmlns:a16="http://schemas.microsoft.com/office/drawing/2014/main" xmlns="" id="{3F78E955-51D3-45AA-BB1F-726606DB82AD}"/>
                      </a:ext>
                    </a:extLst>
                  </p:cNvPr>
                  <p:cNvSpPr txBox="1"/>
                  <p:nvPr/>
                </p:nvSpPr>
                <p:spPr>
                  <a:xfrm>
                    <a:off x="4674017" y="5514890"/>
                    <a:ext cx="411345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100</a:t>
                    </a:r>
                  </a:p>
                </p:txBody>
              </p:sp>
              <p:sp>
                <p:nvSpPr>
                  <p:cNvPr id="177" name="フリーフォーム: 図形 176">
                    <a:extLst>
                      <a:ext uri="{FF2B5EF4-FFF2-40B4-BE49-F238E27FC236}">
                        <a16:creationId xmlns:a16="http://schemas.microsoft.com/office/drawing/2014/main" xmlns="" id="{DBEA838C-2B73-4845-99A0-B6365F5273C0}"/>
                      </a:ext>
                    </a:extLst>
                  </p:cNvPr>
                  <p:cNvSpPr/>
                  <p:nvPr/>
                </p:nvSpPr>
                <p:spPr>
                  <a:xfrm>
                    <a:off x="6130227" y="5465833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78" name="テキスト ボックス 177">
                    <a:extLst>
                      <a:ext uri="{FF2B5EF4-FFF2-40B4-BE49-F238E27FC236}">
                        <a16:creationId xmlns:a16="http://schemas.microsoft.com/office/drawing/2014/main" xmlns="" id="{8CF24520-0806-490F-B942-2C3052110261}"/>
                      </a:ext>
                    </a:extLst>
                  </p:cNvPr>
                  <p:cNvSpPr txBox="1"/>
                  <p:nvPr/>
                </p:nvSpPr>
                <p:spPr>
                  <a:xfrm>
                    <a:off x="5953062" y="5514890"/>
                    <a:ext cx="411345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200</a:t>
                    </a:r>
                  </a:p>
                </p:txBody>
              </p:sp>
              <p:sp>
                <p:nvSpPr>
                  <p:cNvPr id="197" name="フリーフォーム: 図形 196">
                    <a:extLst>
                      <a:ext uri="{FF2B5EF4-FFF2-40B4-BE49-F238E27FC236}">
                        <a16:creationId xmlns:a16="http://schemas.microsoft.com/office/drawing/2014/main" xmlns="" id="{797FD586-C879-4C06-998E-E308DA103340}"/>
                      </a:ext>
                    </a:extLst>
                  </p:cNvPr>
                  <p:cNvSpPr/>
                  <p:nvPr/>
                </p:nvSpPr>
                <p:spPr>
                  <a:xfrm>
                    <a:off x="7409263" y="5465833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98" name="テキスト ボックス 197">
                    <a:extLst>
                      <a:ext uri="{FF2B5EF4-FFF2-40B4-BE49-F238E27FC236}">
                        <a16:creationId xmlns:a16="http://schemas.microsoft.com/office/drawing/2014/main" xmlns="" id="{43BE7DA9-FAC9-46B0-8080-5F56A04D37F3}"/>
                      </a:ext>
                    </a:extLst>
                  </p:cNvPr>
                  <p:cNvSpPr txBox="1"/>
                  <p:nvPr/>
                </p:nvSpPr>
                <p:spPr>
                  <a:xfrm>
                    <a:off x="7232098" y="5514890"/>
                    <a:ext cx="411345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300</a:t>
                    </a:r>
                  </a:p>
                </p:txBody>
              </p:sp>
              <p:sp>
                <p:nvSpPr>
                  <p:cNvPr id="199" name="フリーフォーム: 図形 198">
                    <a:extLst>
                      <a:ext uri="{FF2B5EF4-FFF2-40B4-BE49-F238E27FC236}">
                        <a16:creationId xmlns:a16="http://schemas.microsoft.com/office/drawing/2014/main" xmlns="" id="{C10AFB87-4195-46BE-86BB-60EBFD541EEF}"/>
                      </a:ext>
                    </a:extLst>
                  </p:cNvPr>
                  <p:cNvSpPr/>
                  <p:nvPr/>
                </p:nvSpPr>
                <p:spPr>
                  <a:xfrm>
                    <a:off x="8688309" y="5465833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0" name="テキスト ボックス 199">
                    <a:extLst>
                      <a:ext uri="{FF2B5EF4-FFF2-40B4-BE49-F238E27FC236}">
                        <a16:creationId xmlns:a16="http://schemas.microsoft.com/office/drawing/2014/main" xmlns="" id="{0151A0A1-A37A-4D87-85B0-2F134C5089C5}"/>
                      </a:ext>
                    </a:extLst>
                  </p:cNvPr>
                  <p:cNvSpPr txBox="1"/>
                  <p:nvPr/>
                </p:nvSpPr>
                <p:spPr>
                  <a:xfrm>
                    <a:off x="8511144" y="5514890"/>
                    <a:ext cx="411345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400</a:t>
                    </a:r>
                  </a:p>
                </p:txBody>
              </p:sp>
              <p:sp>
                <p:nvSpPr>
                  <p:cNvPr id="201" name="テキスト ボックス 200">
                    <a:extLst>
                      <a:ext uri="{FF2B5EF4-FFF2-40B4-BE49-F238E27FC236}">
                        <a16:creationId xmlns:a16="http://schemas.microsoft.com/office/drawing/2014/main" xmlns="" id="{9A6145FA-2FA6-4952-B69A-DECBBCE17CEA}"/>
                      </a:ext>
                    </a:extLst>
                  </p:cNvPr>
                  <p:cNvSpPr txBox="1"/>
                  <p:nvPr/>
                </p:nvSpPr>
                <p:spPr>
                  <a:xfrm>
                    <a:off x="5505367" y="5691099"/>
                    <a:ext cx="1574244" cy="33442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 Unicode MS"/>
                        <a:cs typeface="Arial" panose="020B0604020202020204" pitchFamily="34" charset="0"/>
                        <a:sym typeface="Arial Unicode MS"/>
                        <a:rtl val="0"/>
                      </a:rPr>
                      <a:t>APOA2-</a:t>
                    </a:r>
                    <a:r>
                      <a:rPr lang="en-US" altLang="ja-JP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 Unicode MS"/>
                        <a:cs typeface="Arial" panose="020B0604020202020204" pitchFamily="34" charset="0"/>
                        <a:sym typeface="Arial Unicode MS"/>
                        <a:rtl val="0"/>
                      </a:rPr>
                      <a:t>A</a:t>
                    </a:r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 Unicode MS"/>
                        <a:cs typeface="Arial" panose="020B0604020202020204" pitchFamily="34" charset="0"/>
                        <a:sym typeface="Arial Unicode MS"/>
                        <a:rtl val="0"/>
                      </a:rPr>
                      <a:t>TQ (µg/mL)</a:t>
                    </a:r>
                  </a:p>
                </p:txBody>
              </p:sp>
              <p:sp>
                <p:nvSpPr>
                  <p:cNvPr id="202" name="フリーフォーム: 図形 201">
                    <a:extLst>
                      <a:ext uri="{FF2B5EF4-FFF2-40B4-BE49-F238E27FC236}">
                        <a16:creationId xmlns:a16="http://schemas.microsoft.com/office/drawing/2014/main" xmlns="" id="{F198E486-D865-4AD5-96DD-F0BEF693BF62}"/>
                      </a:ext>
                    </a:extLst>
                  </p:cNvPr>
                  <p:cNvSpPr/>
                  <p:nvPr/>
                </p:nvSpPr>
                <p:spPr>
                  <a:xfrm>
                    <a:off x="3543610" y="1559591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3" name="フリーフォーム: 図形 202">
                    <a:extLst>
                      <a:ext uri="{FF2B5EF4-FFF2-40B4-BE49-F238E27FC236}">
                        <a16:creationId xmlns:a16="http://schemas.microsoft.com/office/drawing/2014/main" xmlns="" id="{868B0A4E-EF0B-4204-AEA2-84B93CB6C911}"/>
                      </a:ext>
                    </a:extLst>
                  </p:cNvPr>
                  <p:cNvSpPr/>
                  <p:nvPr/>
                </p:nvSpPr>
                <p:spPr>
                  <a:xfrm>
                    <a:off x="3518831" y="5144278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4" name="フリーフォーム: 図形 203">
                    <a:extLst>
                      <a:ext uri="{FF2B5EF4-FFF2-40B4-BE49-F238E27FC236}">
                        <a16:creationId xmlns:a16="http://schemas.microsoft.com/office/drawing/2014/main" xmlns="" id="{76AE63B7-9F91-4C38-898D-C145254047DE}"/>
                      </a:ext>
                    </a:extLst>
                  </p:cNvPr>
                  <p:cNvSpPr/>
                  <p:nvPr/>
                </p:nvSpPr>
                <p:spPr>
                  <a:xfrm>
                    <a:off x="3518831" y="4501160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5" name="フリーフォーム: 図形 204">
                    <a:extLst>
                      <a:ext uri="{FF2B5EF4-FFF2-40B4-BE49-F238E27FC236}">
                        <a16:creationId xmlns:a16="http://schemas.microsoft.com/office/drawing/2014/main" xmlns="" id="{26D39768-7C38-40FE-B1EE-AC06E07A1246}"/>
                      </a:ext>
                    </a:extLst>
                  </p:cNvPr>
                  <p:cNvSpPr/>
                  <p:nvPr/>
                </p:nvSpPr>
                <p:spPr>
                  <a:xfrm>
                    <a:off x="3518831" y="3858032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6" name="フリーフォーム: 図形 205">
                    <a:extLst>
                      <a:ext uri="{FF2B5EF4-FFF2-40B4-BE49-F238E27FC236}">
                        <a16:creationId xmlns:a16="http://schemas.microsoft.com/office/drawing/2014/main" xmlns="" id="{FB26ED9F-9DB3-44EB-8FFE-6DE1D42AB514}"/>
                      </a:ext>
                    </a:extLst>
                  </p:cNvPr>
                  <p:cNvSpPr/>
                  <p:nvPr/>
                </p:nvSpPr>
                <p:spPr>
                  <a:xfrm>
                    <a:off x="3518831" y="3214914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7" name="フリーフォーム: 図形 206">
                    <a:extLst>
                      <a:ext uri="{FF2B5EF4-FFF2-40B4-BE49-F238E27FC236}">
                        <a16:creationId xmlns:a16="http://schemas.microsoft.com/office/drawing/2014/main" xmlns="" id="{5F777F0F-9797-4AED-97AA-0E04F56915B0}"/>
                      </a:ext>
                    </a:extLst>
                  </p:cNvPr>
                  <p:cNvSpPr/>
                  <p:nvPr/>
                </p:nvSpPr>
                <p:spPr>
                  <a:xfrm>
                    <a:off x="3518831" y="2571795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8" name="フリーフォーム: 図形 207">
                    <a:extLst>
                      <a:ext uri="{FF2B5EF4-FFF2-40B4-BE49-F238E27FC236}">
                        <a16:creationId xmlns:a16="http://schemas.microsoft.com/office/drawing/2014/main" xmlns="" id="{43AAB42E-591C-4F8E-BB11-6AE8BB7150AF}"/>
                      </a:ext>
                    </a:extLst>
                  </p:cNvPr>
                  <p:cNvSpPr/>
                  <p:nvPr/>
                </p:nvSpPr>
                <p:spPr>
                  <a:xfrm>
                    <a:off x="3518831" y="1928673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09" name="フリーフォーム: 図形 208">
                    <a:extLst>
                      <a:ext uri="{FF2B5EF4-FFF2-40B4-BE49-F238E27FC236}">
                        <a16:creationId xmlns:a16="http://schemas.microsoft.com/office/drawing/2014/main" xmlns="" id="{610C7589-19D8-4855-B2FE-70738CCC0AC0}"/>
                      </a:ext>
                    </a:extLst>
                  </p:cNvPr>
                  <p:cNvSpPr/>
                  <p:nvPr/>
                </p:nvSpPr>
                <p:spPr>
                  <a:xfrm>
                    <a:off x="3494052" y="5465833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10" name="テキスト ボックス 209">
                    <a:extLst>
                      <a:ext uri="{FF2B5EF4-FFF2-40B4-BE49-F238E27FC236}">
                        <a16:creationId xmlns:a16="http://schemas.microsoft.com/office/drawing/2014/main" xmlns="" id="{BF4793E6-7804-4463-9CA4-B47FBF496C89}"/>
                      </a:ext>
                    </a:extLst>
                  </p:cNvPr>
                  <p:cNvSpPr txBox="1"/>
                  <p:nvPr/>
                </p:nvSpPr>
                <p:spPr>
                  <a:xfrm>
                    <a:off x="3066839" y="5372489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00</a:t>
                    </a:r>
                  </a:p>
                </p:txBody>
              </p:sp>
              <p:sp>
                <p:nvSpPr>
                  <p:cNvPr id="211" name="フリーフォーム: 図形 210">
                    <a:extLst>
                      <a:ext uri="{FF2B5EF4-FFF2-40B4-BE49-F238E27FC236}">
                        <a16:creationId xmlns:a16="http://schemas.microsoft.com/office/drawing/2014/main" xmlns="" id="{309E3D6B-49EA-465F-85B5-1C9F79AFA255}"/>
                      </a:ext>
                    </a:extLst>
                  </p:cNvPr>
                  <p:cNvSpPr/>
                  <p:nvPr/>
                </p:nvSpPr>
                <p:spPr>
                  <a:xfrm>
                    <a:off x="3494052" y="4822715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12" name="テキスト ボックス 211">
                    <a:extLst>
                      <a:ext uri="{FF2B5EF4-FFF2-40B4-BE49-F238E27FC236}">
                        <a16:creationId xmlns:a16="http://schemas.microsoft.com/office/drawing/2014/main" xmlns="" id="{713D6C69-D5F0-47F4-9FC9-F06B68A7F6C0}"/>
                      </a:ext>
                    </a:extLst>
                  </p:cNvPr>
                  <p:cNvSpPr txBox="1"/>
                  <p:nvPr/>
                </p:nvSpPr>
                <p:spPr>
                  <a:xfrm>
                    <a:off x="3066839" y="4729370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25</a:t>
                    </a:r>
                  </a:p>
                </p:txBody>
              </p:sp>
              <p:sp>
                <p:nvSpPr>
                  <p:cNvPr id="213" name="フリーフォーム: 図形 212">
                    <a:extLst>
                      <a:ext uri="{FF2B5EF4-FFF2-40B4-BE49-F238E27FC236}">
                        <a16:creationId xmlns:a16="http://schemas.microsoft.com/office/drawing/2014/main" xmlns="" id="{1A2BEC1B-B894-4EA9-A64E-EC94A0E74500}"/>
                      </a:ext>
                    </a:extLst>
                  </p:cNvPr>
                  <p:cNvSpPr/>
                  <p:nvPr/>
                </p:nvSpPr>
                <p:spPr>
                  <a:xfrm>
                    <a:off x="3494052" y="4179596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14" name="テキスト ボックス 213">
                    <a:extLst>
                      <a:ext uri="{FF2B5EF4-FFF2-40B4-BE49-F238E27FC236}">
                        <a16:creationId xmlns:a16="http://schemas.microsoft.com/office/drawing/2014/main" xmlns="" id="{C98E02BD-2466-421E-86C7-35495B9B20F0}"/>
                      </a:ext>
                    </a:extLst>
                  </p:cNvPr>
                  <p:cNvSpPr txBox="1"/>
                  <p:nvPr/>
                </p:nvSpPr>
                <p:spPr>
                  <a:xfrm>
                    <a:off x="3066839" y="4086250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50</a:t>
                    </a:r>
                  </a:p>
                </p:txBody>
              </p:sp>
              <p:sp>
                <p:nvSpPr>
                  <p:cNvPr id="215" name="フリーフォーム: 図形 214">
                    <a:extLst>
                      <a:ext uri="{FF2B5EF4-FFF2-40B4-BE49-F238E27FC236}">
                        <a16:creationId xmlns:a16="http://schemas.microsoft.com/office/drawing/2014/main" xmlns="" id="{84458FCB-A8EC-4743-B1CD-172C409A1FAC}"/>
                      </a:ext>
                    </a:extLst>
                  </p:cNvPr>
                  <p:cNvSpPr/>
                  <p:nvPr/>
                </p:nvSpPr>
                <p:spPr>
                  <a:xfrm>
                    <a:off x="3494052" y="3536478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16" name="テキスト ボックス 215">
                    <a:extLst>
                      <a:ext uri="{FF2B5EF4-FFF2-40B4-BE49-F238E27FC236}">
                        <a16:creationId xmlns:a16="http://schemas.microsoft.com/office/drawing/2014/main" xmlns="" id="{2B323BA0-0713-4349-BFE2-3913A20CCB47}"/>
                      </a:ext>
                    </a:extLst>
                  </p:cNvPr>
                  <p:cNvSpPr txBox="1"/>
                  <p:nvPr/>
                </p:nvSpPr>
                <p:spPr>
                  <a:xfrm>
                    <a:off x="3066839" y="3443133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75</a:t>
                    </a:r>
                  </a:p>
                </p:txBody>
              </p:sp>
              <p:sp>
                <p:nvSpPr>
                  <p:cNvPr id="217" name="フリーフォーム: 図形 216">
                    <a:extLst>
                      <a:ext uri="{FF2B5EF4-FFF2-40B4-BE49-F238E27FC236}">
                        <a16:creationId xmlns:a16="http://schemas.microsoft.com/office/drawing/2014/main" xmlns="" id="{7C994123-0214-4CC9-AC90-4972A2464633}"/>
                      </a:ext>
                    </a:extLst>
                  </p:cNvPr>
                  <p:cNvSpPr/>
                  <p:nvPr/>
                </p:nvSpPr>
                <p:spPr>
                  <a:xfrm>
                    <a:off x="3494052" y="2893350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18" name="テキスト ボックス 217">
                    <a:extLst>
                      <a:ext uri="{FF2B5EF4-FFF2-40B4-BE49-F238E27FC236}">
                        <a16:creationId xmlns:a16="http://schemas.microsoft.com/office/drawing/2014/main" xmlns="" id="{E060A769-2D09-4D27-921D-FF5160861692}"/>
                      </a:ext>
                    </a:extLst>
                  </p:cNvPr>
                  <p:cNvSpPr txBox="1"/>
                  <p:nvPr/>
                </p:nvSpPr>
                <p:spPr>
                  <a:xfrm>
                    <a:off x="3066839" y="2800005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00</a:t>
                    </a:r>
                  </a:p>
                </p:txBody>
              </p:sp>
              <p:sp>
                <p:nvSpPr>
                  <p:cNvPr id="219" name="フリーフォーム: 図形 218">
                    <a:extLst>
                      <a:ext uri="{FF2B5EF4-FFF2-40B4-BE49-F238E27FC236}">
                        <a16:creationId xmlns:a16="http://schemas.microsoft.com/office/drawing/2014/main" xmlns="" id="{E4A998B5-054F-4213-B779-762C7C5924F4}"/>
                      </a:ext>
                    </a:extLst>
                  </p:cNvPr>
                  <p:cNvSpPr/>
                  <p:nvPr/>
                </p:nvSpPr>
                <p:spPr>
                  <a:xfrm>
                    <a:off x="3494052" y="2250233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0" name="テキスト ボックス 219">
                    <a:extLst>
                      <a:ext uri="{FF2B5EF4-FFF2-40B4-BE49-F238E27FC236}">
                        <a16:creationId xmlns:a16="http://schemas.microsoft.com/office/drawing/2014/main" xmlns="" id="{F3B86DE5-3A3A-43BA-80F1-F1AFDF89AD77}"/>
                      </a:ext>
                    </a:extLst>
                  </p:cNvPr>
                  <p:cNvSpPr txBox="1"/>
                  <p:nvPr/>
                </p:nvSpPr>
                <p:spPr>
                  <a:xfrm>
                    <a:off x="3066839" y="2156888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25</a:t>
                    </a:r>
                  </a:p>
                </p:txBody>
              </p:sp>
              <p:sp>
                <p:nvSpPr>
                  <p:cNvPr id="221" name="フリーフォーム: 図形 220">
                    <a:extLst>
                      <a:ext uri="{FF2B5EF4-FFF2-40B4-BE49-F238E27FC236}">
                        <a16:creationId xmlns:a16="http://schemas.microsoft.com/office/drawing/2014/main" xmlns="" id="{5BDA53D1-2927-43B6-A30C-9195A30DE7D7}"/>
                      </a:ext>
                    </a:extLst>
                  </p:cNvPr>
                  <p:cNvSpPr/>
                  <p:nvPr/>
                </p:nvSpPr>
                <p:spPr>
                  <a:xfrm>
                    <a:off x="3494052" y="1607112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22" name="テキスト ボックス 221">
                    <a:extLst>
                      <a:ext uri="{FF2B5EF4-FFF2-40B4-BE49-F238E27FC236}">
                        <a16:creationId xmlns:a16="http://schemas.microsoft.com/office/drawing/2014/main" xmlns="" id="{729B2C6D-19EC-4D0E-A020-E9CBE9FCE97F}"/>
                      </a:ext>
                    </a:extLst>
                  </p:cNvPr>
                  <p:cNvSpPr txBox="1"/>
                  <p:nvPr/>
                </p:nvSpPr>
                <p:spPr>
                  <a:xfrm>
                    <a:off x="3066839" y="1513767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50</a:t>
                    </a:r>
                  </a:p>
                </p:txBody>
              </p:sp>
              <p:sp>
                <p:nvSpPr>
                  <p:cNvPr id="223" name="テキスト ボックス 222">
                    <a:extLst>
                      <a:ext uri="{FF2B5EF4-FFF2-40B4-BE49-F238E27FC236}">
                        <a16:creationId xmlns:a16="http://schemas.microsoft.com/office/drawing/2014/main" xmlns="" id="{3A1A7B7F-4914-4B15-9CA7-06A495620DBB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563402" y="3373384"/>
                    <a:ext cx="827665" cy="2786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ＭＳ Ｐゴシック"/>
                        <a:cs typeface="Arial" panose="020B0604020202020204" pitchFamily="34" charset="0"/>
                        <a:sym typeface="ＭＳ Ｐゴシック"/>
                        <a:rtl val="0"/>
                      </a:rPr>
                      <a:t>Density</a:t>
                    </a:r>
                  </a:p>
                </p:txBody>
              </p:sp>
            </p:grpSp>
          </p:grpSp>
        </p:grpSp>
        <p:grpSp>
          <p:nvGrpSpPr>
            <p:cNvPr id="227" name="グラフィックス 65">
              <a:extLst>
                <a:ext uri="{FF2B5EF4-FFF2-40B4-BE49-F238E27FC236}">
                  <a16:creationId xmlns:a16="http://schemas.microsoft.com/office/drawing/2014/main" xmlns="" id="{D9F11448-1E04-4993-9C0B-FA043943712F}"/>
                </a:ext>
              </a:extLst>
            </p:cNvPr>
            <p:cNvGrpSpPr/>
            <p:nvPr/>
          </p:nvGrpSpPr>
          <p:grpSpPr>
            <a:xfrm>
              <a:off x="3083995" y="4926027"/>
              <a:ext cx="6144140" cy="4580215"/>
              <a:chOff x="3083995" y="1424840"/>
              <a:chExt cx="6144140" cy="4580215"/>
            </a:xfrm>
          </p:grpSpPr>
          <p:sp>
            <p:nvSpPr>
              <p:cNvPr id="228" name="フリーフォーム: 図形 227">
                <a:extLst>
                  <a:ext uri="{FF2B5EF4-FFF2-40B4-BE49-F238E27FC236}">
                    <a16:creationId xmlns:a16="http://schemas.microsoft.com/office/drawing/2014/main" xmlns="" id="{8A3F1F0B-EFFF-4F16-BB16-DDBA145F518A}"/>
                  </a:ext>
                </a:extLst>
              </p:cNvPr>
              <p:cNvSpPr/>
              <p:nvPr/>
            </p:nvSpPr>
            <p:spPr>
              <a:xfrm>
                <a:off x="3097828" y="1424840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229" name="フリーフォーム: 図形 228">
                <a:extLst>
                  <a:ext uri="{FF2B5EF4-FFF2-40B4-BE49-F238E27FC236}">
                    <a16:creationId xmlns:a16="http://schemas.microsoft.com/office/drawing/2014/main" xmlns="" id="{2C53B8A4-6F20-4398-B20D-70DBC5ABB643}"/>
                  </a:ext>
                </a:extLst>
              </p:cNvPr>
              <p:cNvSpPr/>
              <p:nvPr/>
            </p:nvSpPr>
            <p:spPr>
              <a:xfrm>
                <a:off x="3083995" y="1424840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solidFill>
                <a:srgbClr val="FFFFFF"/>
              </a:solidFill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sp>
            <p:nvSpPr>
              <p:cNvPr id="230" name="フリーフォーム: 図形 229">
                <a:extLst>
                  <a:ext uri="{FF2B5EF4-FFF2-40B4-BE49-F238E27FC236}">
                    <a16:creationId xmlns:a16="http://schemas.microsoft.com/office/drawing/2014/main" xmlns="" id="{154EF2FC-E4CD-4634-AEE4-3B541D97EB5F}"/>
                  </a:ext>
                </a:extLst>
              </p:cNvPr>
              <p:cNvSpPr/>
              <p:nvPr/>
            </p:nvSpPr>
            <p:spPr>
              <a:xfrm>
                <a:off x="3097828" y="1424840"/>
                <a:ext cx="6086475" cy="4562475"/>
              </a:xfrm>
              <a:custGeom>
                <a:avLst/>
                <a:gdLst>
                  <a:gd name="connsiteX0" fmla="*/ 0 w 6086475"/>
                  <a:gd name="connsiteY0" fmla="*/ 0 h 4562475"/>
                  <a:gd name="connsiteX1" fmla="*/ 6086475 w 6086475"/>
                  <a:gd name="connsiteY1" fmla="*/ 0 h 4562475"/>
                  <a:gd name="connsiteX2" fmla="*/ 6086475 w 6086475"/>
                  <a:gd name="connsiteY2" fmla="*/ 4562475 h 4562475"/>
                  <a:gd name="connsiteX3" fmla="*/ 0 w 6086475"/>
                  <a:gd name="connsiteY3" fmla="*/ 4562475 h 45624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86475" h="4562475">
                    <a:moveTo>
                      <a:pt x="0" y="0"/>
                    </a:moveTo>
                    <a:lnTo>
                      <a:pt x="6086475" y="0"/>
                    </a:lnTo>
                    <a:lnTo>
                      <a:pt x="6086475" y="4562475"/>
                    </a:lnTo>
                    <a:lnTo>
                      <a:pt x="0" y="4562475"/>
                    </a:lnTo>
                    <a:close/>
                  </a:path>
                </a:pathLst>
              </a:custGeom>
              <a:noFill/>
              <a:ln w="952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/>
              </a:p>
            </p:txBody>
          </p:sp>
          <p:grpSp>
            <p:nvGrpSpPr>
              <p:cNvPr id="231" name="グラフィックス 65">
                <a:extLst>
                  <a:ext uri="{FF2B5EF4-FFF2-40B4-BE49-F238E27FC236}">
                    <a16:creationId xmlns:a16="http://schemas.microsoft.com/office/drawing/2014/main" xmlns="" id="{E379CE19-2EF7-41B8-BBB9-6964E8E4B393}"/>
                  </a:ext>
                </a:extLst>
              </p:cNvPr>
              <p:cNvGrpSpPr/>
              <p:nvPr/>
            </p:nvGrpSpPr>
            <p:grpSpPr>
              <a:xfrm>
                <a:off x="3143554" y="1493295"/>
                <a:ext cx="6084581" cy="4511760"/>
                <a:chOff x="3143554" y="1493295"/>
                <a:chExt cx="6084581" cy="4511760"/>
              </a:xfrm>
            </p:grpSpPr>
            <p:sp>
              <p:nvSpPr>
                <p:cNvPr id="232" name="フリーフォーム: 図形 231">
                  <a:extLst>
                    <a:ext uri="{FF2B5EF4-FFF2-40B4-BE49-F238E27FC236}">
                      <a16:creationId xmlns:a16="http://schemas.microsoft.com/office/drawing/2014/main" xmlns="" id="{6E2ADB3F-2DDE-4A6A-A18A-86D8BEFB6A10}"/>
                    </a:ext>
                  </a:extLst>
                </p:cNvPr>
                <p:cNvSpPr/>
                <p:nvPr/>
              </p:nvSpPr>
              <p:spPr>
                <a:xfrm>
                  <a:off x="3849256" y="1543871"/>
                  <a:ext cx="5192248" cy="3896744"/>
                </a:xfrm>
                <a:custGeom>
                  <a:avLst/>
                  <a:gdLst>
                    <a:gd name="connsiteX0" fmla="*/ 11 w 5192248"/>
                    <a:gd name="connsiteY0" fmla="*/ 11 h 3896744"/>
                    <a:gd name="connsiteX1" fmla="*/ 5192260 w 5192248"/>
                    <a:gd name="connsiteY1" fmla="*/ 11 h 3896744"/>
                    <a:gd name="connsiteX2" fmla="*/ 5192260 w 5192248"/>
                    <a:gd name="connsiteY2" fmla="*/ 3896755 h 3896744"/>
                    <a:gd name="connsiteX3" fmla="*/ 11 w 5192248"/>
                    <a:gd name="connsiteY3" fmla="*/ 3896755 h 389674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5192248" h="3896744">
                      <a:moveTo>
                        <a:pt x="11" y="11"/>
                      </a:moveTo>
                      <a:lnTo>
                        <a:pt x="5192260" y="11"/>
                      </a:lnTo>
                      <a:lnTo>
                        <a:pt x="5192260" y="3896755"/>
                      </a:lnTo>
                      <a:lnTo>
                        <a:pt x="11" y="3896755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52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ja-JP" altLang="en-US"/>
                </a:p>
              </p:txBody>
            </p:sp>
            <p:grpSp>
              <p:nvGrpSpPr>
                <p:cNvPr id="233" name="グラフィックス 65">
                  <a:extLst>
                    <a:ext uri="{FF2B5EF4-FFF2-40B4-BE49-F238E27FC236}">
                      <a16:creationId xmlns:a16="http://schemas.microsoft.com/office/drawing/2014/main" xmlns="" id="{C4752FB2-0824-4D42-A5EB-9626989CEA87}"/>
                    </a:ext>
                  </a:extLst>
                </p:cNvPr>
                <p:cNvGrpSpPr/>
                <p:nvPr/>
              </p:nvGrpSpPr>
              <p:grpSpPr>
                <a:xfrm>
                  <a:off x="3955922" y="1539119"/>
                  <a:ext cx="5039709" cy="3906242"/>
                  <a:chOff x="3955922" y="1539119"/>
                  <a:chExt cx="5039709" cy="3906242"/>
                </a:xfrm>
                <a:noFill/>
              </p:grpSpPr>
              <p:sp>
                <p:nvSpPr>
                  <p:cNvPr id="277" name="フリーフォーム: 図形 276">
                    <a:extLst>
                      <a:ext uri="{FF2B5EF4-FFF2-40B4-BE49-F238E27FC236}">
                        <a16:creationId xmlns:a16="http://schemas.microsoft.com/office/drawing/2014/main" xmlns="" id="{77BFBEB5-2A74-4ED6-BFD1-07A592E49E06}"/>
                      </a:ext>
                    </a:extLst>
                  </p:cNvPr>
                  <p:cNvSpPr/>
                  <p:nvPr/>
                </p:nvSpPr>
                <p:spPr>
                  <a:xfrm>
                    <a:off x="3955922" y="2920026"/>
                    <a:ext cx="5039709" cy="2525277"/>
                  </a:xfrm>
                  <a:custGeom>
                    <a:avLst/>
                    <a:gdLst>
                      <a:gd name="connsiteX0" fmla="*/ 11 w 5039709"/>
                      <a:gd name="connsiteY0" fmla="*/ 2524003 h 2525277"/>
                      <a:gd name="connsiteX1" fmla="*/ 32317 w 5039709"/>
                      <a:gd name="connsiteY1" fmla="*/ 2523107 h 2525277"/>
                      <a:gd name="connsiteX2" fmla="*/ 64623 w 5039709"/>
                      <a:gd name="connsiteY2" fmla="*/ 2521717 h 2525277"/>
                      <a:gd name="connsiteX3" fmla="*/ 96929 w 5039709"/>
                      <a:gd name="connsiteY3" fmla="*/ 2519640 h 2525277"/>
                      <a:gd name="connsiteX4" fmla="*/ 129235 w 5039709"/>
                      <a:gd name="connsiteY4" fmla="*/ 2516630 h 2525277"/>
                      <a:gd name="connsiteX5" fmla="*/ 161540 w 5039709"/>
                      <a:gd name="connsiteY5" fmla="*/ 2512411 h 2525277"/>
                      <a:gd name="connsiteX6" fmla="*/ 193846 w 5039709"/>
                      <a:gd name="connsiteY6" fmla="*/ 2506629 h 2525277"/>
                      <a:gd name="connsiteX7" fmla="*/ 226156 w 5039709"/>
                      <a:gd name="connsiteY7" fmla="*/ 2498961 h 2525277"/>
                      <a:gd name="connsiteX8" fmla="*/ 258456 w 5039709"/>
                      <a:gd name="connsiteY8" fmla="*/ 2488998 h 2525277"/>
                      <a:gd name="connsiteX9" fmla="*/ 290764 w 5039709"/>
                      <a:gd name="connsiteY9" fmla="*/ 2476378 h 2525277"/>
                      <a:gd name="connsiteX10" fmla="*/ 323073 w 5039709"/>
                      <a:gd name="connsiteY10" fmla="*/ 2460671 h 2525277"/>
                      <a:gd name="connsiteX11" fmla="*/ 355373 w 5039709"/>
                      <a:gd name="connsiteY11" fmla="*/ 2441450 h 2525277"/>
                      <a:gd name="connsiteX12" fmla="*/ 387681 w 5039709"/>
                      <a:gd name="connsiteY12" fmla="*/ 2418275 h 2525277"/>
                      <a:gd name="connsiteX13" fmla="*/ 419990 w 5039709"/>
                      <a:gd name="connsiteY13" fmla="*/ 2390662 h 2525277"/>
                      <a:gd name="connsiteX14" fmla="*/ 452289 w 5039709"/>
                      <a:gd name="connsiteY14" fmla="*/ 2358068 h 2525277"/>
                      <a:gd name="connsiteX15" fmla="*/ 484598 w 5039709"/>
                      <a:gd name="connsiteY15" fmla="*/ 2319977 h 2525277"/>
                      <a:gd name="connsiteX16" fmla="*/ 516907 w 5039709"/>
                      <a:gd name="connsiteY16" fmla="*/ 2275857 h 2525277"/>
                      <a:gd name="connsiteX17" fmla="*/ 549206 w 5039709"/>
                      <a:gd name="connsiteY17" fmla="*/ 2225203 h 2525277"/>
                      <a:gd name="connsiteX18" fmla="*/ 581515 w 5039709"/>
                      <a:gd name="connsiteY18" fmla="*/ 2167634 h 2525277"/>
                      <a:gd name="connsiteX19" fmla="*/ 613824 w 5039709"/>
                      <a:gd name="connsiteY19" fmla="*/ 2102874 h 2525277"/>
                      <a:gd name="connsiteX20" fmla="*/ 646123 w 5039709"/>
                      <a:gd name="connsiteY20" fmla="*/ 2030846 h 2525277"/>
                      <a:gd name="connsiteX21" fmla="*/ 678432 w 5039709"/>
                      <a:gd name="connsiteY21" fmla="*/ 1951636 h 2525277"/>
                      <a:gd name="connsiteX22" fmla="*/ 710741 w 5039709"/>
                      <a:gd name="connsiteY22" fmla="*/ 1865549 h 2525277"/>
                      <a:gd name="connsiteX23" fmla="*/ 743050 w 5039709"/>
                      <a:gd name="connsiteY23" fmla="*/ 1773090 h 2525277"/>
                      <a:gd name="connsiteX24" fmla="*/ 775349 w 5039709"/>
                      <a:gd name="connsiteY24" fmla="*/ 1674935 h 2525277"/>
                      <a:gd name="connsiteX25" fmla="*/ 807658 w 5039709"/>
                      <a:gd name="connsiteY25" fmla="*/ 1571931 h 2525277"/>
                      <a:gd name="connsiteX26" fmla="*/ 872266 w 5039709"/>
                      <a:gd name="connsiteY26" fmla="*/ 1355504 h 2525277"/>
                      <a:gd name="connsiteX27" fmla="*/ 1001491 w 5039709"/>
                      <a:gd name="connsiteY27" fmla="*/ 916173 h 2525277"/>
                      <a:gd name="connsiteX28" fmla="*/ 1033800 w 5039709"/>
                      <a:gd name="connsiteY28" fmla="*/ 812836 h 2525277"/>
                      <a:gd name="connsiteX29" fmla="*/ 1066100 w 5039709"/>
                      <a:gd name="connsiteY29" fmla="*/ 714491 h 2525277"/>
                      <a:gd name="connsiteX30" fmla="*/ 1098408 w 5039709"/>
                      <a:gd name="connsiteY30" fmla="*/ 621879 h 2525277"/>
                      <a:gd name="connsiteX31" fmla="*/ 1130717 w 5039709"/>
                      <a:gd name="connsiteY31" fmla="*/ 535392 h 2525277"/>
                      <a:gd name="connsiteX32" fmla="*/ 1163016 w 5039709"/>
                      <a:gd name="connsiteY32" fmla="*/ 455011 h 2525277"/>
                      <a:gd name="connsiteX33" fmla="*/ 1195325 w 5039709"/>
                      <a:gd name="connsiteY33" fmla="*/ 380401 h 2525277"/>
                      <a:gd name="connsiteX34" fmla="*/ 1227634 w 5039709"/>
                      <a:gd name="connsiteY34" fmla="*/ 311059 h 2525277"/>
                      <a:gd name="connsiteX35" fmla="*/ 1259943 w 5039709"/>
                      <a:gd name="connsiteY35" fmla="*/ 246566 h 2525277"/>
                      <a:gd name="connsiteX36" fmla="*/ 1292242 w 5039709"/>
                      <a:gd name="connsiteY36" fmla="*/ 186844 h 2525277"/>
                      <a:gd name="connsiteX37" fmla="*/ 1324551 w 5039709"/>
                      <a:gd name="connsiteY37" fmla="*/ 132389 h 2525277"/>
                      <a:gd name="connsiteX38" fmla="*/ 1356860 w 5039709"/>
                      <a:gd name="connsiteY38" fmla="*/ 84403 h 2525277"/>
                      <a:gd name="connsiteX39" fmla="*/ 1389159 w 5039709"/>
                      <a:gd name="connsiteY39" fmla="*/ 44788 h 2525277"/>
                      <a:gd name="connsiteX40" fmla="*/ 1421468 w 5039709"/>
                      <a:gd name="connsiteY40" fmla="*/ 15899 h 2525277"/>
                      <a:gd name="connsiteX41" fmla="*/ 1453777 w 5039709"/>
                      <a:gd name="connsiteY41" fmla="*/ 249 h 2525277"/>
                      <a:gd name="connsiteX42" fmla="*/ 1486076 w 5039709"/>
                      <a:gd name="connsiteY42" fmla="*/ 11 h 2525277"/>
                      <a:gd name="connsiteX43" fmla="*/ 1518385 w 5039709"/>
                      <a:gd name="connsiteY43" fmla="*/ 16565 h 2525277"/>
                      <a:gd name="connsiteX44" fmla="*/ 1550693 w 5039709"/>
                      <a:gd name="connsiteY44" fmla="*/ 50151 h 2525277"/>
                      <a:gd name="connsiteX45" fmla="*/ 1582993 w 5039709"/>
                      <a:gd name="connsiteY45" fmla="*/ 99671 h 2525277"/>
                      <a:gd name="connsiteX46" fmla="*/ 1615302 w 5039709"/>
                      <a:gd name="connsiteY46" fmla="*/ 162688 h 2525277"/>
                      <a:gd name="connsiteX47" fmla="*/ 1647610 w 5039709"/>
                      <a:gd name="connsiteY47" fmla="*/ 235736 h 2525277"/>
                      <a:gd name="connsiteX48" fmla="*/ 1776836 w 5039709"/>
                      <a:gd name="connsiteY48" fmla="*/ 547413 h 2525277"/>
                      <a:gd name="connsiteX49" fmla="*/ 1809135 w 5039709"/>
                      <a:gd name="connsiteY49" fmla="*/ 614440 h 2525277"/>
                      <a:gd name="connsiteX50" fmla="*/ 1841444 w 5039709"/>
                      <a:gd name="connsiteY50" fmla="*/ 674514 h 2525277"/>
                      <a:gd name="connsiteX51" fmla="*/ 1873753 w 5039709"/>
                      <a:gd name="connsiteY51" fmla="*/ 728378 h 2525277"/>
                      <a:gd name="connsiteX52" fmla="*/ 1906052 w 5039709"/>
                      <a:gd name="connsiteY52" fmla="*/ 777632 h 2525277"/>
                      <a:gd name="connsiteX53" fmla="*/ 2002969 w 5039709"/>
                      <a:gd name="connsiteY53" fmla="*/ 917669 h 2525277"/>
                      <a:gd name="connsiteX54" fmla="*/ 2035278 w 5039709"/>
                      <a:gd name="connsiteY54" fmla="*/ 967437 h 2525277"/>
                      <a:gd name="connsiteX55" fmla="*/ 2067587 w 5039709"/>
                      <a:gd name="connsiteY55" fmla="*/ 1020415 h 2525277"/>
                      <a:gd name="connsiteX56" fmla="*/ 2099886 w 5039709"/>
                      <a:gd name="connsiteY56" fmla="*/ 1076812 h 2525277"/>
                      <a:gd name="connsiteX57" fmla="*/ 2132195 w 5039709"/>
                      <a:gd name="connsiteY57" fmla="*/ 1136553 h 2525277"/>
                      <a:gd name="connsiteX58" fmla="*/ 2164504 w 5039709"/>
                      <a:gd name="connsiteY58" fmla="*/ 1199390 h 2525277"/>
                      <a:gd name="connsiteX59" fmla="*/ 2196803 w 5039709"/>
                      <a:gd name="connsiteY59" fmla="*/ 1265102 h 2525277"/>
                      <a:gd name="connsiteX60" fmla="*/ 2229112 w 5039709"/>
                      <a:gd name="connsiteY60" fmla="*/ 1333578 h 2525277"/>
                      <a:gd name="connsiteX61" fmla="*/ 2261420 w 5039709"/>
                      <a:gd name="connsiteY61" fmla="*/ 1404787 h 2525277"/>
                      <a:gd name="connsiteX62" fmla="*/ 2293729 w 5039709"/>
                      <a:gd name="connsiteY62" fmla="*/ 1478805 h 2525277"/>
                      <a:gd name="connsiteX63" fmla="*/ 2326029 w 5039709"/>
                      <a:gd name="connsiteY63" fmla="*/ 1555596 h 2525277"/>
                      <a:gd name="connsiteX64" fmla="*/ 2390646 w 5039709"/>
                      <a:gd name="connsiteY64" fmla="*/ 1716264 h 2525277"/>
                      <a:gd name="connsiteX65" fmla="*/ 2487563 w 5039709"/>
                      <a:gd name="connsiteY65" fmla="*/ 1960789 h 2525277"/>
                      <a:gd name="connsiteX66" fmla="*/ 2519862 w 5039709"/>
                      <a:gd name="connsiteY66" fmla="*/ 2037142 h 2525277"/>
                      <a:gd name="connsiteX67" fmla="*/ 2552171 w 5039709"/>
                      <a:gd name="connsiteY67" fmla="*/ 2107970 h 2525277"/>
                      <a:gd name="connsiteX68" fmla="*/ 2584480 w 5039709"/>
                      <a:gd name="connsiteY68" fmla="*/ 2171682 h 2525277"/>
                      <a:gd name="connsiteX69" fmla="*/ 2616779 w 5039709"/>
                      <a:gd name="connsiteY69" fmla="*/ 2227108 h 2525277"/>
                      <a:gd name="connsiteX70" fmla="*/ 2649088 w 5039709"/>
                      <a:gd name="connsiteY70" fmla="*/ 2273524 h 2525277"/>
                      <a:gd name="connsiteX71" fmla="*/ 2681397 w 5039709"/>
                      <a:gd name="connsiteY71" fmla="*/ 2310776 h 2525277"/>
                      <a:gd name="connsiteX72" fmla="*/ 2713696 w 5039709"/>
                      <a:gd name="connsiteY72" fmla="*/ 2339218 h 2525277"/>
                      <a:gd name="connsiteX73" fmla="*/ 2746005 w 5039709"/>
                      <a:gd name="connsiteY73" fmla="*/ 2359696 h 2525277"/>
                      <a:gd name="connsiteX74" fmla="*/ 2778313 w 5039709"/>
                      <a:gd name="connsiteY74" fmla="*/ 2373403 h 2525277"/>
                      <a:gd name="connsiteX75" fmla="*/ 2810622 w 5039709"/>
                      <a:gd name="connsiteY75" fmla="*/ 2381756 h 2525277"/>
                      <a:gd name="connsiteX76" fmla="*/ 2842922 w 5039709"/>
                      <a:gd name="connsiteY76" fmla="*/ 2386281 h 2525277"/>
                      <a:gd name="connsiteX77" fmla="*/ 2875231 w 5039709"/>
                      <a:gd name="connsiteY77" fmla="*/ 2388471 h 2525277"/>
                      <a:gd name="connsiteX78" fmla="*/ 2907539 w 5039709"/>
                      <a:gd name="connsiteY78" fmla="*/ 2389652 h 2525277"/>
                      <a:gd name="connsiteX79" fmla="*/ 2939839 w 5039709"/>
                      <a:gd name="connsiteY79" fmla="*/ 2390920 h 2525277"/>
                      <a:gd name="connsiteX80" fmla="*/ 2972147 w 5039709"/>
                      <a:gd name="connsiteY80" fmla="*/ 2393082 h 2525277"/>
                      <a:gd name="connsiteX81" fmla="*/ 3004456 w 5039709"/>
                      <a:gd name="connsiteY81" fmla="*/ 2396625 h 2525277"/>
                      <a:gd name="connsiteX82" fmla="*/ 3036756 w 5039709"/>
                      <a:gd name="connsiteY82" fmla="*/ 2401740 h 2525277"/>
                      <a:gd name="connsiteX83" fmla="*/ 3069064 w 5039709"/>
                      <a:gd name="connsiteY83" fmla="*/ 2408360 h 2525277"/>
                      <a:gd name="connsiteX84" fmla="*/ 3101373 w 5039709"/>
                      <a:gd name="connsiteY84" fmla="*/ 2416237 h 2525277"/>
                      <a:gd name="connsiteX85" fmla="*/ 3133672 w 5039709"/>
                      <a:gd name="connsiteY85" fmla="*/ 2424990 h 2525277"/>
                      <a:gd name="connsiteX86" fmla="*/ 3262898 w 5039709"/>
                      <a:gd name="connsiteY86" fmla="*/ 2461385 h 2525277"/>
                      <a:gd name="connsiteX87" fmla="*/ 3295207 w 5039709"/>
                      <a:gd name="connsiteY87" fmla="*/ 2469539 h 2525277"/>
                      <a:gd name="connsiteX88" fmla="*/ 3327516 w 5039709"/>
                      <a:gd name="connsiteY88" fmla="*/ 2477092 h 2525277"/>
                      <a:gd name="connsiteX89" fmla="*/ 3359815 w 5039709"/>
                      <a:gd name="connsiteY89" fmla="*/ 2484055 h 2525277"/>
                      <a:gd name="connsiteX90" fmla="*/ 3392124 w 5039709"/>
                      <a:gd name="connsiteY90" fmla="*/ 2490418 h 2525277"/>
                      <a:gd name="connsiteX91" fmla="*/ 3424432 w 5039709"/>
                      <a:gd name="connsiteY91" fmla="*/ 2496218 h 2525277"/>
                      <a:gd name="connsiteX92" fmla="*/ 3456732 w 5039709"/>
                      <a:gd name="connsiteY92" fmla="*/ 2501438 h 2525277"/>
                      <a:gd name="connsiteX93" fmla="*/ 3489040 w 5039709"/>
                      <a:gd name="connsiteY93" fmla="*/ 2506096 h 2525277"/>
                      <a:gd name="connsiteX94" fmla="*/ 3521349 w 5039709"/>
                      <a:gd name="connsiteY94" fmla="*/ 2510172 h 2525277"/>
                      <a:gd name="connsiteX95" fmla="*/ 3553649 w 5039709"/>
                      <a:gd name="connsiteY95" fmla="*/ 2513659 h 2525277"/>
                      <a:gd name="connsiteX96" fmla="*/ 3585958 w 5039709"/>
                      <a:gd name="connsiteY96" fmla="*/ 2516573 h 2525277"/>
                      <a:gd name="connsiteX97" fmla="*/ 3618266 w 5039709"/>
                      <a:gd name="connsiteY97" fmla="*/ 2518935 h 2525277"/>
                      <a:gd name="connsiteX98" fmla="*/ 3650565 w 5039709"/>
                      <a:gd name="connsiteY98" fmla="*/ 2520793 h 2525277"/>
                      <a:gd name="connsiteX99" fmla="*/ 3682874 w 5039709"/>
                      <a:gd name="connsiteY99" fmla="*/ 2522203 h 2525277"/>
                      <a:gd name="connsiteX100" fmla="*/ 3715183 w 5039709"/>
                      <a:gd name="connsiteY100" fmla="*/ 2523241 h 2525277"/>
                      <a:gd name="connsiteX101" fmla="*/ 3747482 w 5039709"/>
                      <a:gd name="connsiteY101" fmla="*/ 2523984 h 2525277"/>
                      <a:gd name="connsiteX102" fmla="*/ 3779791 w 5039709"/>
                      <a:gd name="connsiteY102" fmla="*/ 2524488 h 2525277"/>
                      <a:gd name="connsiteX103" fmla="*/ 3812100 w 5039709"/>
                      <a:gd name="connsiteY103" fmla="*/ 2524822 h 2525277"/>
                      <a:gd name="connsiteX104" fmla="*/ 3844409 w 5039709"/>
                      <a:gd name="connsiteY104" fmla="*/ 2525041 h 2525277"/>
                      <a:gd name="connsiteX105" fmla="*/ 3876708 w 5039709"/>
                      <a:gd name="connsiteY105" fmla="*/ 2525165 h 2525277"/>
                      <a:gd name="connsiteX106" fmla="*/ 3909017 w 5039709"/>
                      <a:gd name="connsiteY106" fmla="*/ 2525241 h 2525277"/>
                      <a:gd name="connsiteX107" fmla="*/ 3941326 w 5039709"/>
                      <a:gd name="connsiteY107" fmla="*/ 2525279 h 2525277"/>
                      <a:gd name="connsiteX108" fmla="*/ 3973625 w 5039709"/>
                      <a:gd name="connsiteY108" fmla="*/ 2525289 h 2525277"/>
                      <a:gd name="connsiteX109" fmla="*/ 4005934 w 5039709"/>
                      <a:gd name="connsiteY109" fmla="*/ 2525269 h 2525277"/>
                      <a:gd name="connsiteX110" fmla="*/ 4038242 w 5039709"/>
                      <a:gd name="connsiteY110" fmla="*/ 2525222 h 2525277"/>
                      <a:gd name="connsiteX111" fmla="*/ 4070542 w 5039709"/>
                      <a:gd name="connsiteY111" fmla="*/ 2525127 h 2525277"/>
                      <a:gd name="connsiteX112" fmla="*/ 4102851 w 5039709"/>
                      <a:gd name="connsiteY112" fmla="*/ 2524974 h 2525277"/>
                      <a:gd name="connsiteX113" fmla="*/ 4135159 w 5039709"/>
                      <a:gd name="connsiteY113" fmla="*/ 2524726 h 2525277"/>
                      <a:gd name="connsiteX114" fmla="*/ 4167459 w 5039709"/>
                      <a:gd name="connsiteY114" fmla="*/ 2524355 h 2525277"/>
                      <a:gd name="connsiteX115" fmla="*/ 4199768 w 5039709"/>
                      <a:gd name="connsiteY115" fmla="*/ 2523803 h 2525277"/>
                      <a:gd name="connsiteX116" fmla="*/ 4232077 w 5039709"/>
                      <a:gd name="connsiteY116" fmla="*/ 2523050 h 2525277"/>
                      <a:gd name="connsiteX117" fmla="*/ 4264385 w 5039709"/>
                      <a:gd name="connsiteY117" fmla="*/ 2522031 h 2525277"/>
                      <a:gd name="connsiteX118" fmla="*/ 4296684 w 5039709"/>
                      <a:gd name="connsiteY118" fmla="*/ 2520726 h 2525277"/>
                      <a:gd name="connsiteX119" fmla="*/ 4328993 w 5039709"/>
                      <a:gd name="connsiteY119" fmla="*/ 2519136 h 2525277"/>
                      <a:gd name="connsiteX120" fmla="*/ 4361302 w 5039709"/>
                      <a:gd name="connsiteY120" fmla="*/ 2517278 h 2525277"/>
                      <a:gd name="connsiteX121" fmla="*/ 4393601 w 5039709"/>
                      <a:gd name="connsiteY121" fmla="*/ 2515221 h 2525277"/>
                      <a:gd name="connsiteX122" fmla="*/ 4458219 w 5039709"/>
                      <a:gd name="connsiteY122" fmla="*/ 2511001 h 2525277"/>
                      <a:gd name="connsiteX123" fmla="*/ 4490518 w 5039709"/>
                      <a:gd name="connsiteY123" fmla="*/ 2509134 h 2525277"/>
                      <a:gd name="connsiteX124" fmla="*/ 4522827 w 5039709"/>
                      <a:gd name="connsiteY124" fmla="*/ 2507667 h 2525277"/>
                      <a:gd name="connsiteX125" fmla="*/ 4555136 w 5039709"/>
                      <a:gd name="connsiteY125" fmla="*/ 2506715 h 2525277"/>
                      <a:gd name="connsiteX126" fmla="*/ 4587435 w 5039709"/>
                      <a:gd name="connsiteY126" fmla="*/ 2506381 h 2525277"/>
                      <a:gd name="connsiteX127" fmla="*/ 4619744 w 5039709"/>
                      <a:gd name="connsiteY127" fmla="*/ 2506715 h 2525277"/>
                      <a:gd name="connsiteX128" fmla="*/ 4652053 w 5039709"/>
                      <a:gd name="connsiteY128" fmla="*/ 2507667 h 2525277"/>
                      <a:gd name="connsiteX129" fmla="*/ 4684352 w 5039709"/>
                      <a:gd name="connsiteY129" fmla="*/ 2509134 h 2525277"/>
                      <a:gd name="connsiteX130" fmla="*/ 4716661 w 5039709"/>
                      <a:gd name="connsiteY130" fmla="*/ 2511001 h 2525277"/>
                      <a:gd name="connsiteX131" fmla="*/ 4813578 w 5039709"/>
                      <a:gd name="connsiteY131" fmla="*/ 2517278 h 2525277"/>
                      <a:gd name="connsiteX132" fmla="*/ 4845886 w 5039709"/>
                      <a:gd name="connsiteY132" fmla="*/ 2519136 h 2525277"/>
                      <a:gd name="connsiteX133" fmla="*/ 4878195 w 5039709"/>
                      <a:gd name="connsiteY133" fmla="*/ 2520726 h 2525277"/>
                      <a:gd name="connsiteX134" fmla="*/ 4910495 w 5039709"/>
                      <a:gd name="connsiteY134" fmla="*/ 2522031 h 2525277"/>
                      <a:gd name="connsiteX135" fmla="*/ 4942804 w 5039709"/>
                      <a:gd name="connsiteY135" fmla="*/ 2523050 h 2525277"/>
                      <a:gd name="connsiteX136" fmla="*/ 4975112 w 5039709"/>
                      <a:gd name="connsiteY136" fmla="*/ 2523803 h 2525277"/>
                      <a:gd name="connsiteX137" fmla="*/ 5007411 w 5039709"/>
                      <a:gd name="connsiteY137" fmla="*/ 2524355 h 2525277"/>
                      <a:gd name="connsiteX138" fmla="*/ 5039720 w 5039709"/>
                      <a:gd name="connsiteY138" fmla="*/ 2524726 h 252527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  <a:cxn ang="0">
                        <a:pos x="connsiteX101" y="connsiteY101"/>
                      </a:cxn>
                      <a:cxn ang="0">
                        <a:pos x="connsiteX102" y="connsiteY102"/>
                      </a:cxn>
                      <a:cxn ang="0">
                        <a:pos x="connsiteX103" y="connsiteY103"/>
                      </a:cxn>
                      <a:cxn ang="0">
                        <a:pos x="connsiteX104" y="connsiteY104"/>
                      </a:cxn>
                      <a:cxn ang="0">
                        <a:pos x="connsiteX105" y="connsiteY105"/>
                      </a:cxn>
                      <a:cxn ang="0">
                        <a:pos x="connsiteX106" y="connsiteY106"/>
                      </a:cxn>
                      <a:cxn ang="0">
                        <a:pos x="connsiteX107" y="connsiteY107"/>
                      </a:cxn>
                      <a:cxn ang="0">
                        <a:pos x="connsiteX108" y="connsiteY108"/>
                      </a:cxn>
                      <a:cxn ang="0">
                        <a:pos x="connsiteX109" y="connsiteY109"/>
                      </a:cxn>
                      <a:cxn ang="0">
                        <a:pos x="connsiteX110" y="connsiteY110"/>
                      </a:cxn>
                      <a:cxn ang="0">
                        <a:pos x="connsiteX111" y="connsiteY111"/>
                      </a:cxn>
                      <a:cxn ang="0">
                        <a:pos x="connsiteX112" y="connsiteY112"/>
                      </a:cxn>
                      <a:cxn ang="0">
                        <a:pos x="connsiteX113" y="connsiteY113"/>
                      </a:cxn>
                      <a:cxn ang="0">
                        <a:pos x="connsiteX114" y="connsiteY114"/>
                      </a:cxn>
                      <a:cxn ang="0">
                        <a:pos x="connsiteX115" y="connsiteY115"/>
                      </a:cxn>
                      <a:cxn ang="0">
                        <a:pos x="connsiteX116" y="connsiteY116"/>
                      </a:cxn>
                      <a:cxn ang="0">
                        <a:pos x="connsiteX117" y="connsiteY117"/>
                      </a:cxn>
                      <a:cxn ang="0">
                        <a:pos x="connsiteX118" y="connsiteY118"/>
                      </a:cxn>
                      <a:cxn ang="0">
                        <a:pos x="connsiteX119" y="connsiteY119"/>
                      </a:cxn>
                      <a:cxn ang="0">
                        <a:pos x="connsiteX120" y="connsiteY120"/>
                      </a:cxn>
                      <a:cxn ang="0">
                        <a:pos x="connsiteX121" y="connsiteY121"/>
                      </a:cxn>
                      <a:cxn ang="0">
                        <a:pos x="connsiteX122" y="connsiteY122"/>
                      </a:cxn>
                      <a:cxn ang="0">
                        <a:pos x="connsiteX123" y="connsiteY123"/>
                      </a:cxn>
                      <a:cxn ang="0">
                        <a:pos x="connsiteX124" y="connsiteY124"/>
                      </a:cxn>
                      <a:cxn ang="0">
                        <a:pos x="connsiteX125" y="connsiteY125"/>
                      </a:cxn>
                      <a:cxn ang="0">
                        <a:pos x="connsiteX126" y="connsiteY126"/>
                      </a:cxn>
                      <a:cxn ang="0">
                        <a:pos x="connsiteX127" y="connsiteY127"/>
                      </a:cxn>
                      <a:cxn ang="0">
                        <a:pos x="connsiteX128" y="connsiteY128"/>
                      </a:cxn>
                      <a:cxn ang="0">
                        <a:pos x="connsiteX129" y="connsiteY129"/>
                      </a:cxn>
                      <a:cxn ang="0">
                        <a:pos x="connsiteX130" y="connsiteY130"/>
                      </a:cxn>
                      <a:cxn ang="0">
                        <a:pos x="connsiteX131" y="connsiteY131"/>
                      </a:cxn>
                      <a:cxn ang="0">
                        <a:pos x="connsiteX132" y="connsiteY132"/>
                      </a:cxn>
                      <a:cxn ang="0">
                        <a:pos x="connsiteX133" y="connsiteY133"/>
                      </a:cxn>
                      <a:cxn ang="0">
                        <a:pos x="connsiteX134" y="connsiteY134"/>
                      </a:cxn>
                      <a:cxn ang="0">
                        <a:pos x="connsiteX135" y="connsiteY135"/>
                      </a:cxn>
                      <a:cxn ang="0">
                        <a:pos x="connsiteX136" y="connsiteY136"/>
                      </a:cxn>
                      <a:cxn ang="0">
                        <a:pos x="connsiteX137" y="connsiteY137"/>
                      </a:cxn>
                      <a:cxn ang="0">
                        <a:pos x="connsiteX138" y="connsiteY138"/>
                      </a:cxn>
                    </a:cxnLst>
                    <a:rect l="l" t="t" r="r" b="b"/>
                    <a:pathLst>
                      <a:path w="5039709" h="2525277">
                        <a:moveTo>
                          <a:pt x="11" y="2524003"/>
                        </a:moveTo>
                        <a:lnTo>
                          <a:pt x="32317" y="2523107"/>
                        </a:lnTo>
                        <a:lnTo>
                          <a:pt x="64623" y="2521717"/>
                        </a:lnTo>
                        <a:lnTo>
                          <a:pt x="96929" y="2519640"/>
                        </a:lnTo>
                        <a:lnTo>
                          <a:pt x="129235" y="2516630"/>
                        </a:lnTo>
                        <a:lnTo>
                          <a:pt x="161540" y="2512411"/>
                        </a:lnTo>
                        <a:lnTo>
                          <a:pt x="193846" y="2506629"/>
                        </a:lnTo>
                        <a:lnTo>
                          <a:pt x="226156" y="2498961"/>
                        </a:lnTo>
                        <a:lnTo>
                          <a:pt x="258456" y="2488998"/>
                        </a:lnTo>
                        <a:lnTo>
                          <a:pt x="290764" y="2476378"/>
                        </a:lnTo>
                        <a:lnTo>
                          <a:pt x="323073" y="2460671"/>
                        </a:lnTo>
                        <a:lnTo>
                          <a:pt x="355373" y="2441450"/>
                        </a:lnTo>
                        <a:lnTo>
                          <a:pt x="387681" y="2418275"/>
                        </a:lnTo>
                        <a:lnTo>
                          <a:pt x="419990" y="2390662"/>
                        </a:lnTo>
                        <a:lnTo>
                          <a:pt x="452289" y="2358068"/>
                        </a:lnTo>
                        <a:lnTo>
                          <a:pt x="484598" y="2319977"/>
                        </a:lnTo>
                        <a:lnTo>
                          <a:pt x="516907" y="2275857"/>
                        </a:lnTo>
                        <a:lnTo>
                          <a:pt x="549206" y="2225203"/>
                        </a:lnTo>
                        <a:lnTo>
                          <a:pt x="581515" y="2167634"/>
                        </a:lnTo>
                        <a:lnTo>
                          <a:pt x="613824" y="2102874"/>
                        </a:lnTo>
                        <a:lnTo>
                          <a:pt x="646123" y="2030846"/>
                        </a:lnTo>
                        <a:lnTo>
                          <a:pt x="678432" y="1951636"/>
                        </a:lnTo>
                        <a:lnTo>
                          <a:pt x="710741" y="1865549"/>
                        </a:lnTo>
                        <a:lnTo>
                          <a:pt x="743050" y="1773090"/>
                        </a:lnTo>
                        <a:lnTo>
                          <a:pt x="775349" y="1674935"/>
                        </a:lnTo>
                        <a:lnTo>
                          <a:pt x="807658" y="1571931"/>
                        </a:lnTo>
                        <a:lnTo>
                          <a:pt x="872266" y="1355504"/>
                        </a:lnTo>
                        <a:lnTo>
                          <a:pt x="1001491" y="916173"/>
                        </a:lnTo>
                        <a:lnTo>
                          <a:pt x="1033800" y="812836"/>
                        </a:lnTo>
                        <a:lnTo>
                          <a:pt x="1066100" y="714491"/>
                        </a:lnTo>
                        <a:lnTo>
                          <a:pt x="1098408" y="621879"/>
                        </a:lnTo>
                        <a:lnTo>
                          <a:pt x="1130717" y="535392"/>
                        </a:lnTo>
                        <a:lnTo>
                          <a:pt x="1163016" y="455011"/>
                        </a:lnTo>
                        <a:lnTo>
                          <a:pt x="1195325" y="380401"/>
                        </a:lnTo>
                        <a:lnTo>
                          <a:pt x="1227634" y="311059"/>
                        </a:lnTo>
                        <a:lnTo>
                          <a:pt x="1259943" y="246566"/>
                        </a:lnTo>
                        <a:lnTo>
                          <a:pt x="1292242" y="186844"/>
                        </a:lnTo>
                        <a:lnTo>
                          <a:pt x="1324551" y="132389"/>
                        </a:lnTo>
                        <a:lnTo>
                          <a:pt x="1356860" y="84403"/>
                        </a:lnTo>
                        <a:lnTo>
                          <a:pt x="1389159" y="44788"/>
                        </a:lnTo>
                        <a:lnTo>
                          <a:pt x="1421468" y="15899"/>
                        </a:lnTo>
                        <a:lnTo>
                          <a:pt x="1453777" y="249"/>
                        </a:lnTo>
                        <a:lnTo>
                          <a:pt x="1486076" y="11"/>
                        </a:lnTo>
                        <a:lnTo>
                          <a:pt x="1518385" y="16565"/>
                        </a:lnTo>
                        <a:lnTo>
                          <a:pt x="1550693" y="50151"/>
                        </a:lnTo>
                        <a:lnTo>
                          <a:pt x="1582993" y="99671"/>
                        </a:lnTo>
                        <a:lnTo>
                          <a:pt x="1615302" y="162688"/>
                        </a:lnTo>
                        <a:lnTo>
                          <a:pt x="1647610" y="235736"/>
                        </a:lnTo>
                        <a:lnTo>
                          <a:pt x="1776836" y="547413"/>
                        </a:lnTo>
                        <a:lnTo>
                          <a:pt x="1809135" y="614440"/>
                        </a:lnTo>
                        <a:lnTo>
                          <a:pt x="1841444" y="674514"/>
                        </a:lnTo>
                        <a:lnTo>
                          <a:pt x="1873753" y="728378"/>
                        </a:lnTo>
                        <a:lnTo>
                          <a:pt x="1906052" y="777632"/>
                        </a:lnTo>
                        <a:lnTo>
                          <a:pt x="2002969" y="917669"/>
                        </a:lnTo>
                        <a:lnTo>
                          <a:pt x="2035278" y="967437"/>
                        </a:lnTo>
                        <a:lnTo>
                          <a:pt x="2067587" y="1020415"/>
                        </a:lnTo>
                        <a:lnTo>
                          <a:pt x="2099886" y="1076812"/>
                        </a:lnTo>
                        <a:lnTo>
                          <a:pt x="2132195" y="1136553"/>
                        </a:lnTo>
                        <a:lnTo>
                          <a:pt x="2164504" y="1199390"/>
                        </a:lnTo>
                        <a:lnTo>
                          <a:pt x="2196803" y="1265102"/>
                        </a:lnTo>
                        <a:lnTo>
                          <a:pt x="2229112" y="1333578"/>
                        </a:lnTo>
                        <a:lnTo>
                          <a:pt x="2261420" y="1404787"/>
                        </a:lnTo>
                        <a:lnTo>
                          <a:pt x="2293729" y="1478805"/>
                        </a:lnTo>
                        <a:lnTo>
                          <a:pt x="2326029" y="1555596"/>
                        </a:lnTo>
                        <a:lnTo>
                          <a:pt x="2390646" y="1716264"/>
                        </a:lnTo>
                        <a:lnTo>
                          <a:pt x="2487563" y="1960789"/>
                        </a:lnTo>
                        <a:lnTo>
                          <a:pt x="2519862" y="2037142"/>
                        </a:lnTo>
                        <a:lnTo>
                          <a:pt x="2552171" y="2107970"/>
                        </a:lnTo>
                        <a:lnTo>
                          <a:pt x="2584480" y="2171682"/>
                        </a:lnTo>
                        <a:lnTo>
                          <a:pt x="2616779" y="2227108"/>
                        </a:lnTo>
                        <a:lnTo>
                          <a:pt x="2649088" y="2273524"/>
                        </a:lnTo>
                        <a:lnTo>
                          <a:pt x="2681397" y="2310776"/>
                        </a:lnTo>
                        <a:lnTo>
                          <a:pt x="2713696" y="2339218"/>
                        </a:lnTo>
                        <a:lnTo>
                          <a:pt x="2746005" y="2359696"/>
                        </a:lnTo>
                        <a:lnTo>
                          <a:pt x="2778313" y="2373403"/>
                        </a:lnTo>
                        <a:lnTo>
                          <a:pt x="2810622" y="2381756"/>
                        </a:lnTo>
                        <a:lnTo>
                          <a:pt x="2842922" y="2386281"/>
                        </a:lnTo>
                        <a:lnTo>
                          <a:pt x="2875231" y="2388471"/>
                        </a:lnTo>
                        <a:lnTo>
                          <a:pt x="2907539" y="2389652"/>
                        </a:lnTo>
                        <a:lnTo>
                          <a:pt x="2939839" y="2390920"/>
                        </a:lnTo>
                        <a:lnTo>
                          <a:pt x="2972147" y="2393082"/>
                        </a:lnTo>
                        <a:lnTo>
                          <a:pt x="3004456" y="2396625"/>
                        </a:lnTo>
                        <a:lnTo>
                          <a:pt x="3036756" y="2401740"/>
                        </a:lnTo>
                        <a:lnTo>
                          <a:pt x="3069064" y="2408360"/>
                        </a:lnTo>
                        <a:lnTo>
                          <a:pt x="3101373" y="2416237"/>
                        </a:lnTo>
                        <a:lnTo>
                          <a:pt x="3133672" y="2424990"/>
                        </a:lnTo>
                        <a:lnTo>
                          <a:pt x="3262898" y="2461385"/>
                        </a:lnTo>
                        <a:lnTo>
                          <a:pt x="3295207" y="2469539"/>
                        </a:lnTo>
                        <a:lnTo>
                          <a:pt x="3327516" y="2477092"/>
                        </a:lnTo>
                        <a:lnTo>
                          <a:pt x="3359815" y="2484055"/>
                        </a:lnTo>
                        <a:lnTo>
                          <a:pt x="3392124" y="2490418"/>
                        </a:lnTo>
                        <a:lnTo>
                          <a:pt x="3424432" y="2496218"/>
                        </a:lnTo>
                        <a:lnTo>
                          <a:pt x="3456732" y="2501438"/>
                        </a:lnTo>
                        <a:lnTo>
                          <a:pt x="3489040" y="2506096"/>
                        </a:lnTo>
                        <a:lnTo>
                          <a:pt x="3521349" y="2510172"/>
                        </a:lnTo>
                        <a:lnTo>
                          <a:pt x="3553649" y="2513659"/>
                        </a:lnTo>
                        <a:lnTo>
                          <a:pt x="3585958" y="2516573"/>
                        </a:lnTo>
                        <a:lnTo>
                          <a:pt x="3618266" y="2518935"/>
                        </a:lnTo>
                        <a:lnTo>
                          <a:pt x="3650565" y="2520793"/>
                        </a:lnTo>
                        <a:lnTo>
                          <a:pt x="3682874" y="2522203"/>
                        </a:lnTo>
                        <a:lnTo>
                          <a:pt x="3715183" y="2523241"/>
                        </a:lnTo>
                        <a:lnTo>
                          <a:pt x="3747482" y="2523984"/>
                        </a:lnTo>
                        <a:lnTo>
                          <a:pt x="3779791" y="2524488"/>
                        </a:lnTo>
                        <a:lnTo>
                          <a:pt x="3812100" y="2524822"/>
                        </a:lnTo>
                        <a:lnTo>
                          <a:pt x="3844409" y="2525041"/>
                        </a:lnTo>
                        <a:lnTo>
                          <a:pt x="3876708" y="2525165"/>
                        </a:lnTo>
                        <a:lnTo>
                          <a:pt x="3909017" y="2525241"/>
                        </a:lnTo>
                        <a:lnTo>
                          <a:pt x="3941326" y="2525279"/>
                        </a:lnTo>
                        <a:lnTo>
                          <a:pt x="3973625" y="2525289"/>
                        </a:lnTo>
                        <a:lnTo>
                          <a:pt x="4005934" y="2525269"/>
                        </a:lnTo>
                        <a:lnTo>
                          <a:pt x="4038242" y="2525222"/>
                        </a:lnTo>
                        <a:lnTo>
                          <a:pt x="4070542" y="2525127"/>
                        </a:lnTo>
                        <a:lnTo>
                          <a:pt x="4102851" y="2524974"/>
                        </a:lnTo>
                        <a:lnTo>
                          <a:pt x="4135159" y="2524726"/>
                        </a:lnTo>
                        <a:lnTo>
                          <a:pt x="4167459" y="2524355"/>
                        </a:lnTo>
                        <a:lnTo>
                          <a:pt x="4199768" y="2523803"/>
                        </a:lnTo>
                        <a:lnTo>
                          <a:pt x="4232077" y="2523050"/>
                        </a:lnTo>
                        <a:lnTo>
                          <a:pt x="4264385" y="2522031"/>
                        </a:lnTo>
                        <a:lnTo>
                          <a:pt x="4296684" y="2520726"/>
                        </a:lnTo>
                        <a:lnTo>
                          <a:pt x="4328993" y="2519136"/>
                        </a:lnTo>
                        <a:lnTo>
                          <a:pt x="4361302" y="2517278"/>
                        </a:lnTo>
                        <a:lnTo>
                          <a:pt x="4393601" y="2515221"/>
                        </a:lnTo>
                        <a:lnTo>
                          <a:pt x="4458219" y="2511001"/>
                        </a:lnTo>
                        <a:lnTo>
                          <a:pt x="4490518" y="2509134"/>
                        </a:lnTo>
                        <a:lnTo>
                          <a:pt x="4522827" y="2507667"/>
                        </a:lnTo>
                        <a:lnTo>
                          <a:pt x="4555136" y="2506715"/>
                        </a:lnTo>
                        <a:lnTo>
                          <a:pt x="4587435" y="2506381"/>
                        </a:lnTo>
                        <a:lnTo>
                          <a:pt x="4619744" y="2506715"/>
                        </a:lnTo>
                        <a:lnTo>
                          <a:pt x="4652053" y="2507667"/>
                        </a:lnTo>
                        <a:lnTo>
                          <a:pt x="4684352" y="2509134"/>
                        </a:lnTo>
                        <a:lnTo>
                          <a:pt x="4716661" y="2511001"/>
                        </a:lnTo>
                        <a:lnTo>
                          <a:pt x="4813578" y="2517278"/>
                        </a:lnTo>
                        <a:lnTo>
                          <a:pt x="4845886" y="2519136"/>
                        </a:lnTo>
                        <a:lnTo>
                          <a:pt x="4878195" y="2520726"/>
                        </a:lnTo>
                        <a:lnTo>
                          <a:pt x="4910495" y="2522031"/>
                        </a:lnTo>
                        <a:lnTo>
                          <a:pt x="4942804" y="2523050"/>
                        </a:lnTo>
                        <a:lnTo>
                          <a:pt x="4975112" y="2523803"/>
                        </a:lnTo>
                        <a:lnTo>
                          <a:pt x="5007411" y="2524355"/>
                        </a:lnTo>
                        <a:lnTo>
                          <a:pt x="5039720" y="2524726"/>
                        </a:lnTo>
                      </a:path>
                    </a:pathLst>
                  </a:custGeom>
                  <a:noFill/>
                  <a:ln w="19050" cap="flat">
                    <a:solidFill>
                      <a:srgbClr val="003178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78" name="フリーフォーム: 図形 277">
                    <a:extLst>
                      <a:ext uri="{FF2B5EF4-FFF2-40B4-BE49-F238E27FC236}">
                        <a16:creationId xmlns:a16="http://schemas.microsoft.com/office/drawing/2014/main" xmlns="" id="{501285D6-F88D-4D69-A39E-CEF172833412}"/>
                      </a:ext>
                    </a:extLst>
                  </p:cNvPr>
                  <p:cNvSpPr/>
                  <p:nvPr/>
                </p:nvSpPr>
                <p:spPr>
                  <a:xfrm>
                    <a:off x="4759683" y="1539119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custDash>
                      <a:ds d="75000" sp="225000"/>
                    </a:custDash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79" name="フリーフォーム: 図形 278">
                    <a:extLst>
                      <a:ext uri="{FF2B5EF4-FFF2-40B4-BE49-F238E27FC236}">
                        <a16:creationId xmlns:a16="http://schemas.microsoft.com/office/drawing/2014/main" xmlns="" id="{7418CC67-44C5-4BD9-8031-A222E5A1A588}"/>
                      </a:ext>
                    </a:extLst>
                  </p:cNvPr>
                  <p:cNvSpPr/>
                  <p:nvPr/>
                </p:nvSpPr>
                <p:spPr>
                  <a:xfrm>
                    <a:off x="4755178" y="1539119"/>
                    <a:ext cx="4505" cy="9545"/>
                  </a:xfrm>
                  <a:custGeom>
                    <a:avLst/>
                    <a:gdLst>
                      <a:gd name="connsiteX0" fmla="*/ 11 w 4505"/>
                      <a:gd name="connsiteY0" fmla="*/ 9557 h 9545"/>
                      <a:gd name="connsiteX1" fmla="*/ 4516 w 4505"/>
                      <a:gd name="connsiteY1" fmla="*/ 11 h 954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505" h="9545">
                        <a:moveTo>
                          <a:pt x="11" y="9557"/>
                        </a:moveTo>
                        <a:lnTo>
                          <a:pt x="4516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</p:grpSp>
            <p:grpSp>
              <p:nvGrpSpPr>
                <p:cNvPr id="234" name="グラフィックス 65">
                  <a:extLst>
                    <a:ext uri="{FF2B5EF4-FFF2-40B4-BE49-F238E27FC236}">
                      <a16:creationId xmlns:a16="http://schemas.microsoft.com/office/drawing/2014/main" xmlns="" id="{F5011ADF-C78A-4AFF-8BBC-4B43EF766C20}"/>
                    </a:ext>
                  </a:extLst>
                </p:cNvPr>
                <p:cNvGrpSpPr/>
                <p:nvPr/>
              </p:nvGrpSpPr>
              <p:grpSpPr>
                <a:xfrm>
                  <a:off x="3143554" y="1493295"/>
                  <a:ext cx="6084581" cy="4511760"/>
                  <a:chOff x="3143554" y="1493295"/>
                  <a:chExt cx="6084581" cy="4511760"/>
                </a:xfrm>
              </p:grpSpPr>
              <p:sp>
                <p:nvSpPr>
                  <p:cNvPr id="235" name="フリーフォーム: 図形 234">
                    <a:extLst>
                      <a:ext uri="{FF2B5EF4-FFF2-40B4-BE49-F238E27FC236}">
                        <a16:creationId xmlns:a16="http://schemas.microsoft.com/office/drawing/2014/main" xmlns="" id="{8438925F-CC70-410A-BA98-535F0987361F}"/>
                      </a:ext>
                    </a:extLst>
                  </p:cNvPr>
                  <p:cNvSpPr/>
                  <p:nvPr/>
                </p:nvSpPr>
                <p:spPr>
                  <a:xfrm>
                    <a:off x="3849256" y="5445361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36" name="フリーフォーム: 図形 235">
                    <a:extLst>
                      <a:ext uri="{FF2B5EF4-FFF2-40B4-BE49-F238E27FC236}">
                        <a16:creationId xmlns:a16="http://schemas.microsoft.com/office/drawing/2014/main" xmlns="" id="{BF23BABD-857C-4778-86BD-FE4976CB1D93}"/>
                      </a:ext>
                    </a:extLst>
                  </p:cNvPr>
                  <p:cNvSpPr/>
                  <p:nvPr/>
                </p:nvSpPr>
                <p:spPr>
                  <a:xfrm>
                    <a:off x="9041504" y="1539119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37" name="フリーフォーム: 図形 236">
                    <a:extLst>
                      <a:ext uri="{FF2B5EF4-FFF2-40B4-BE49-F238E27FC236}">
                        <a16:creationId xmlns:a16="http://schemas.microsoft.com/office/drawing/2014/main" xmlns="" id="{BCE893B6-0C6F-4842-922A-246EB50E9516}"/>
                      </a:ext>
                    </a:extLst>
                  </p:cNvPr>
                  <p:cNvSpPr/>
                  <p:nvPr/>
                </p:nvSpPr>
                <p:spPr>
                  <a:xfrm>
                    <a:off x="3849256" y="1539119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38" name="フリーフォーム: 図形 237">
                    <a:extLst>
                      <a:ext uri="{FF2B5EF4-FFF2-40B4-BE49-F238E27FC236}">
                        <a16:creationId xmlns:a16="http://schemas.microsoft.com/office/drawing/2014/main" xmlns="" id="{DF81F39A-793D-47E3-9DE9-9F0F1D558010}"/>
                      </a:ext>
                    </a:extLst>
                  </p:cNvPr>
                  <p:cNvSpPr/>
                  <p:nvPr/>
                </p:nvSpPr>
                <p:spPr>
                  <a:xfrm>
                    <a:off x="3849256" y="1539119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39" name="フリーフォーム: 図形 238">
                    <a:extLst>
                      <a:ext uri="{FF2B5EF4-FFF2-40B4-BE49-F238E27FC236}">
                        <a16:creationId xmlns:a16="http://schemas.microsoft.com/office/drawing/2014/main" xmlns="" id="{41BF3912-3D30-4B5D-85CC-73BD89518B3C}"/>
                      </a:ext>
                    </a:extLst>
                  </p:cNvPr>
                  <p:cNvSpPr/>
                  <p:nvPr/>
                </p:nvSpPr>
                <p:spPr>
                  <a:xfrm>
                    <a:off x="3849256" y="5445361"/>
                    <a:ext cx="5192247" cy="9525"/>
                  </a:xfrm>
                  <a:custGeom>
                    <a:avLst/>
                    <a:gdLst>
                      <a:gd name="connsiteX0" fmla="*/ 11 w 5192247"/>
                      <a:gd name="connsiteY0" fmla="*/ 11 h 9525"/>
                      <a:gd name="connsiteX1" fmla="*/ 5192259 w 519224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5192247" h="9525">
                        <a:moveTo>
                          <a:pt x="11" y="11"/>
                        </a:moveTo>
                        <a:lnTo>
                          <a:pt x="5192259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0" name="フリーフォーム: 図形 239">
                    <a:extLst>
                      <a:ext uri="{FF2B5EF4-FFF2-40B4-BE49-F238E27FC236}">
                        <a16:creationId xmlns:a16="http://schemas.microsoft.com/office/drawing/2014/main" xmlns="" id="{4F05F2E4-EAC4-4174-A1A8-BB572A329F41}"/>
                      </a:ext>
                    </a:extLst>
                  </p:cNvPr>
                  <p:cNvSpPr/>
                  <p:nvPr/>
                </p:nvSpPr>
                <p:spPr>
                  <a:xfrm>
                    <a:off x="4517310" y="5445361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1" name="フリーフォーム: 図形 240">
                    <a:extLst>
                      <a:ext uri="{FF2B5EF4-FFF2-40B4-BE49-F238E27FC236}">
                        <a16:creationId xmlns:a16="http://schemas.microsoft.com/office/drawing/2014/main" xmlns="" id="{BA5BCC65-F99E-4223-80F8-4CC06057219F}"/>
                      </a:ext>
                    </a:extLst>
                  </p:cNvPr>
                  <p:cNvSpPr/>
                  <p:nvPr/>
                </p:nvSpPr>
                <p:spPr>
                  <a:xfrm>
                    <a:off x="5796346" y="5445361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2" name="フリーフォーム: 図形 241">
                    <a:extLst>
                      <a:ext uri="{FF2B5EF4-FFF2-40B4-BE49-F238E27FC236}">
                        <a16:creationId xmlns:a16="http://schemas.microsoft.com/office/drawing/2014/main" xmlns="" id="{1A694670-F832-4748-AA17-D8286EF88E7F}"/>
                      </a:ext>
                    </a:extLst>
                  </p:cNvPr>
                  <p:cNvSpPr/>
                  <p:nvPr/>
                </p:nvSpPr>
                <p:spPr>
                  <a:xfrm>
                    <a:off x="7075391" y="5445361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3" name="フリーフォーム: 図形 242">
                    <a:extLst>
                      <a:ext uri="{FF2B5EF4-FFF2-40B4-BE49-F238E27FC236}">
                        <a16:creationId xmlns:a16="http://schemas.microsoft.com/office/drawing/2014/main" xmlns="" id="{F5E2CEEE-0567-43B4-B1EE-90065B580C65}"/>
                      </a:ext>
                    </a:extLst>
                  </p:cNvPr>
                  <p:cNvSpPr/>
                  <p:nvPr/>
                </p:nvSpPr>
                <p:spPr>
                  <a:xfrm>
                    <a:off x="8354437" y="5445361"/>
                    <a:ext cx="9525" cy="24765"/>
                  </a:xfrm>
                  <a:custGeom>
                    <a:avLst/>
                    <a:gdLst>
                      <a:gd name="connsiteX0" fmla="*/ 11 w 9525"/>
                      <a:gd name="connsiteY0" fmla="*/ 11 h 24765"/>
                      <a:gd name="connsiteX1" fmla="*/ 11 w 9525"/>
                      <a:gd name="connsiteY1" fmla="*/ 24776 h 2476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24765">
                        <a:moveTo>
                          <a:pt x="11" y="11"/>
                        </a:moveTo>
                        <a:lnTo>
                          <a:pt x="11" y="24776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4" name="フリーフォーム: 図形 243">
                    <a:extLst>
                      <a:ext uri="{FF2B5EF4-FFF2-40B4-BE49-F238E27FC236}">
                        <a16:creationId xmlns:a16="http://schemas.microsoft.com/office/drawing/2014/main" xmlns="" id="{EBBDAE6B-31DA-4E9A-9DD4-F1B76C101421}"/>
                      </a:ext>
                    </a:extLst>
                  </p:cNvPr>
                  <p:cNvSpPr/>
                  <p:nvPr/>
                </p:nvSpPr>
                <p:spPr>
                  <a:xfrm>
                    <a:off x="3877785" y="5445361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5" name="テキスト ボックス 244">
                    <a:extLst>
                      <a:ext uri="{FF2B5EF4-FFF2-40B4-BE49-F238E27FC236}">
                        <a16:creationId xmlns:a16="http://schemas.microsoft.com/office/drawing/2014/main" xmlns="" id="{E2F0DBA7-1C65-4812-BC46-7DEDFC0820CA}"/>
                      </a:ext>
                    </a:extLst>
                  </p:cNvPr>
                  <p:cNvSpPr txBox="1"/>
                  <p:nvPr/>
                </p:nvSpPr>
                <p:spPr>
                  <a:xfrm>
                    <a:off x="3757770" y="5494418"/>
                    <a:ext cx="278653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</a:t>
                    </a:r>
                  </a:p>
                </p:txBody>
              </p:sp>
              <p:sp>
                <p:nvSpPr>
                  <p:cNvPr id="246" name="フリーフォーム: 図形 245">
                    <a:extLst>
                      <a:ext uri="{FF2B5EF4-FFF2-40B4-BE49-F238E27FC236}">
                        <a16:creationId xmlns:a16="http://schemas.microsoft.com/office/drawing/2014/main" xmlns="" id="{1FCC914F-B850-419C-BBE2-1908F6FC8ACB}"/>
                      </a:ext>
                    </a:extLst>
                  </p:cNvPr>
                  <p:cNvSpPr/>
                  <p:nvPr/>
                </p:nvSpPr>
                <p:spPr>
                  <a:xfrm>
                    <a:off x="5156828" y="5445361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7" name="テキスト ボックス 246">
                    <a:extLst>
                      <a:ext uri="{FF2B5EF4-FFF2-40B4-BE49-F238E27FC236}">
                        <a16:creationId xmlns:a16="http://schemas.microsoft.com/office/drawing/2014/main" xmlns="" id="{BFE4915A-DEA6-4926-8E59-14B1130A7BE7}"/>
                      </a:ext>
                    </a:extLst>
                  </p:cNvPr>
                  <p:cNvSpPr txBox="1"/>
                  <p:nvPr/>
                </p:nvSpPr>
                <p:spPr>
                  <a:xfrm>
                    <a:off x="4979663" y="5494418"/>
                    <a:ext cx="411345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100</a:t>
                    </a:r>
                  </a:p>
                </p:txBody>
              </p:sp>
              <p:sp>
                <p:nvSpPr>
                  <p:cNvPr id="248" name="フリーフォーム: 図形 247">
                    <a:extLst>
                      <a:ext uri="{FF2B5EF4-FFF2-40B4-BE49-F238E27FC236}">
                        <a16:creationId xmlns:a16="http://schemas.microsoft.com/office/drawing/2014/main" xmlns="" id="{100FD28A-A137-4336-9F62-DB86D45AF78C}"/>
                      </a:ext>
                    </a:extLst>
                  </p:cNvPr>
                  <p:cNvSpPr/>
                  <p:nvPr/>
                </p:nvSpPr>
                <p:spPr>
                  <a:xfrm>
                    <a:off x="6435873" y="5445361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49" name="テキスト ボックス 248">
                    <a:extLst>
                      <a:ext uri="{FF2B5EF4-FFF2-40B4-BE49-F238E27FC236}">
                        <a16:creationId xmlns:a16="http://schemas.microsoft.com/office/drawing/2014/main" xmlns="" id="{5C5B52B7-2EB0-4F24-AF19-528A8F4D09D6}"/>
                      </a:ext>
                    </a:extLst>
                  </p:cNvPr>
                  <p:cNvSpPr txBox="1"/>
                  <p:nvPr/>
                </p:nvSpPr>
                <p:spPr>
                  <a:xfrm>
                    <a:off x="6258708" y="5494418"/>
                    <a:ext cx="411345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200</a:t>
                    </a:r>
                  </a:p>
                </p:txBody>
              </p:sp>
              <p:sp>
                <p:nvSpPr>
                  <p:cNvPr id="250" name="フリーフォーム: 図形 249">
                    <a:extLst>
                      <a:ext uri="{FF2B5EF4-FFF2-40B4-BE49-F238E27FC236}">
                        <a16:creationId xmlns:a16="http://schemas.microsoft.com/office/drawing/2014/main" xmlns="" id="{0395A69B-4EBF-4681-BC75-4A81B2389F23}"/>
                      </a:ext>
                    </a:extLst>
                  </p:cNvPr>
                  <p:cNvSpPr/>
                  <p:nvPr/>
                </p:nvSpPr>
                <p:spPr>
                  <a:xfrm>
                    <a:off x="7714909" y="5445361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51" name="テキスト ボックス 250">
                    <a:extLst>
                      <a:ext uri="{FF2B5EF4-FFF2-40B4-BE49-F238E27FC236}">
                        <a16:creationId xmlns:a16="http://schemas.microsoft.com/office/drawing/2014/main" xmlns="" id="{AC430959-83E2-4EE3-A0E4-A87A1D952F80}"/>
                      </a:ext>
                    </a:extLst>
                  </p:cNvPr>
                  <p:cNvSpPr txBox="1"/>
                  <p:nvPr/>
                </p:nvSpPr>
                <p:spPr>
                  <a:xfrm>
                    <a:off x="7537744" y="5494418"/>
                    <a:ext cx="411345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300</a:t>
                    </a:r>
                  </a:p>
                </p:txBody>
              </p:sp>
              <p:sp>
                <p:nvSpPr>
                  <p:cNvPr id="252" name="フリーフォーム: 図形 251">
                    <a:extLst>
                      <a:ext uri="{FF2B5EF4-FFF2-40B4-BE49-F238E27FC236}">
                        <a16:creationId xmlns:a16="http://schemas.microsoft.com/office/drawing/2014/main" xmlns="" id="{6F019C56-B169-4553-AB4F-F64E4EBDC865}"/>
                      </a:ext>
                    </a:extLst>
                  </p:cNvPr>
                  <p:cNvSpPr/>
                  <p:nvPr/>
                </p:nvSpPr>
                <p:spPr>
                  <a:xfrm>
                    <a:off x="8993955" y="5445361"/>
                    <a:ext cx="9525" cy="49530"/>
                  </a:xfrm>
                  <a:custGeom>
                    <a:avLst/>
                    <a:gdLst>
                      <a:gd name="connsiteX0" fmla="*/ 11 w 9525"/>
                      <a:gd name="connsiteY0" fmla="*/ 11 h 49530"/>
                      <a:gd name="connsiteX1" fmla="*/ 11 w 9525"/>
                      <a:gd name="connsiteY1" fmla="*/ 49541 h 4953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49530">
                        <a:moveTo>
                          <a:pt x="11" y="11"/>
                        </a:moveTo>
                        <a:lnTo>
                          <a:pt x="11" y="4954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53" name="テキスト ボックス 252">
                    <a:extLst>
                      <a:ext uri="{FF2B5EF4-FFF2-40B4-BE49-F238E27FC236}">
                        <a16:creationId xmlns:a16="http://schemas.microsoft.com/office/drawing/2014/main" xmlns="" id="{F6A4B60D-C8BC-4943-AA15-773E738AE70A}"/>
                      </a:ext>
                    </a:extLst>
                  </p:cNvPr>
                  <p:cNvSpPr txBox="1"/>
                  <p:nvPr/>
                </p:nvSpPr>
                <p:spPr>
                  <a:xfrm>
                    <a:off x="8816790" y="5494418"/>
                    <a:ext cx="411345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400</a:t>
                    </a:r>
                  </a:p>
                </p:txBody>
              </p:sp>
              <p:sp>
                <p:nvSpPr>
                  <p:cNvPr id="254" name="テキスト ボックス 253">
                    <a:extLst>
                      <a:ext uri="{FF2B5EF4-FFF2-40B4-BE49-F238E27FC236}">
                        <a16:creationId xmlns:a16="http://schemas.microsoft.com/office/drawing/2014/main" xmlns="" id="{65ADEAE6-0FE8-4189-988A-F4B7223CC6EC}"/>
                      </a:ext>
                    </a:extLst>
                  </p:cNvPr>
                  <p:cNvSpPr txBox="1"/>
                  <p:nvPr/>
                </p:nvSpPr>
                <p:spPr>
                  <a:xfrm>
                    <a:off x="5811014" y="5670627"/>
                    <a:ext cx="1574244" cy="33442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 Unicode MS"/>
                        <a:cs typeface="Arial" panose="020B0604020202020204" pitchFamily="34" charset="0"/>
                        <a:sym typeface="Arial Unicode MS"/>
                        <a:rtl val="0"/>
                      </a:rPr>
                      <a:t>APOA2-</a:t>
                    </a:r>
                    <a:r>
                      <a:rPr lang="en-US" altLang="ja-JP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 Unicode MS"/>
                        <a:cs typeface="Arial" panose="020B0604020202020204" pitchFamily="34" charset="0"/>
                        <a:sym typeface="Arial Unicode MS"/>
                        <a:rtl val="0"/>
                      </a:rPr>
                      <a:t>A</a:t>
                    </a:r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Arial Unicode MS"/>
                        <a:cs typeface="Arial" panose="020B0604020202020204" pitchFamily="34" charset="0"/>
                        <a:sym typeface="Arial Unicode MS"/>
                        <a:rtl val="0"/>
                      </a:rPr>
                      <a:t>TQ (µg/mL)</a:t>
                    </a:r>
                  </a:p>
                </p:txBody>
              </p:sp>
              <p:sp>
                <p:nvSpPr>
                  <p:cNvPr id="255" name="フリーフォーム: 図形 254">
                    <a:extLst>
                      <a:ext uri="{FF2B5EF4-FFF2-40B4-BE49-F238E27FC236}">
                        <a16:creationId xmlns:a16="http://schemas.microsoft.com/office/drawing/2014/main" xmlns="" id="{9C4EB656-7DE6-4EE0-80A5-5D30C561F593}"/>
                      </a:ext>
                    </a:extLst>
                  </p:cNvPr>
                  <p:cNvSpPr/>
                  <p:nvPr/>
                </p:nvSpPr>
                <p:spPr>
                  <a:xfrm>
                    <a:off x="3849256" y="1539119"/>
                    <a:ext cx="9525" cy="3906242"/>
                  </a:xfrm>
                  <a:custGeom>
                    <a:avLst/>
                    <a:gdLst>
                      <a:gd name="connsiteX0" fmla="*/ 11 w 9525"/>
                      <a:gd name="connsiteY0" fmla="*/ 3906253 h 3906242"/>
                      <a:gd name="connsiteX1" fmla="*/ 11 w 9525"/>
                      <a:gd name="connsiteY1" fmla="*/ 11 h 390624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9525" h="3906242">
                        <a:moveTo>
                          <a:pt x="11" y="3906253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56" name="フリーフォーム: 図形 255">
                    <a:extLst>
                      <a:ext uri="{FF2B5EF4-FFF2-40B4-BE49-F238E27FC236}">
                        <a16:creationId xmlns:a16="http://schemas.microsoft.com/office/drawing/2014/main" xmlns="" id="{C3D5835A-053C-4471-AA92-DC4F95D93CC3}"/>
                      </a:ext>
                    </a:extLst>
                  </p:cNvPr>
                  <p:cNvSpPr/>
                  <p:nvPr/>
                </p:nvSpPr>
                <p:spPr>
                  <a:xfrm>
                    <a:off x="3824477" y="5123806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57" name="フリーフォーム: 図形 256">
                    <a:extLst>
                      <a:ext uri="{FF2B5EF4-FFF2-40B4-BE49-F238E27FC236}">
                        <a16:creationId xmlns:a16="http://schemas.microsoft.com/office/drawing/2014/main" xmlns="" id="{3DA9AFAC-AA1F-444F-B002-7242FAC91428}"/>
                      </a:ext>
                    </a:extLst>
                  </p:cNvPr>
                  <p:cNvSpPr/>
                  <p:nvPr/>
                </p:nvSpPr>
                <p:spPr>
                  <a:xfrm>
                    <a:off x="3824477" y="4480688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58" name="フリーフォーム: 図形 257">
                    <a:extLst>
                      <a:ext uri="{FF2B5EF4-FFF2-40B4-BE49-F238E27FC236}">
                        <a16:creationId xmlns:a16="http://schemas.microsoft.com/office/drawing/2014/main" xmlns="" id="{0E7AB078-2C9F-4951-ADD8-B71767510B0A}"/>
                      </a:ext>
                    </a:extLst>
                  </p:cNvPr>
                  <p:cNvSpPr/>
                  <p:nvPr/>
                </p:nvSpPr>
                <p:spPr>
                  <a:xfrm>
                    <a:off x="3824477" y="3837560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59" name="フリーフォーム: 図形 258">
                    <a:extLst>
                      <a:ext uri="{FF2B5EF4-FFF2-40B4-BE49-F238E27FC236}">
                        <a16:creationId xmlns:a16="http://schemas.microsoft.com/office/drawing/2014/main" xmlns="" id="{4390E7CC-1A71-4901-80CC-B727A6A6BCBC}"/>
                      </a:ext>
                    </a:extLst>
                  </p:cNvPr>
                  <p:cNvSpPr/>
                  <p:nvPr/>
                </p:nvSpPr>
                <p:spPr>
                  <a:xfrm>
                    <a:off x="3824477" y="3194442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60" name="フリーフォーム: 図形 259">
                    <a:extLst>
                      <a:ext uri="{FF2B5EF4-FFF2-40B4-BE49-F238E27FC236}">
                        <a16:creationId xmlns:a16="http://schemas.microsoft.com/office/drawing/2014/main" xmlns="" id="{21DFAB59-FB70-4294-954B-1621A0558782}"/>
                      </a:ext>
                    </a:extLst>
                  </p:cNvPr>
                  <p:cNvSpPr/>
                  <p:nvPr/>
                </p:nvSpPr>
                <p:spPr>
                  <a:xfrm>
                    <a:off x="3824477" y="2551323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61" name="フリーフォーム: 図形 260">
                    <a:extLst>
                      <a:ext uri="{FF2B5EF4-FFF2-40B4-BE49-F238E27FC236}">
                        <a16:creationId xmlns:a16="http://schemas.microsoft.com/office/drawing/2014/main" xmlns="" id="{C12300B4-7B60-4087-B9C7-8DFEF2092B6F}"/>
                      </a:ext>
                    </a:extLst>
                  </p:cNvPr>
                  <p:cNvSpPr/>
                  <p:nvPr/>
                </p:nvSpPr>
                <p:spPr>
                  <a:xfrm>
                    <a:off x="3824477" y="1908201"/>
                    <a:ext cx="24778" cy="9525"/>
                  </a:xfrm>
                  <a:custGeom>
                    <a:avLst/>
                    <a:gdLst>
                      <a:gd name="connsiteX0" fmla="*/ 24789 w 24778"/>
                      <a:gd name="connsiteY0" fmla="*/ 11 h 9525"/>
                      <a:gd name="connsiteX1" fmla="*/ 11 w 24778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24778" h="9525">
                        <a:moveTo>
                          <a:pt x="2478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62" name="フリーフォーム: 図形 261">
                    <a:extLst>
                      <a:ext uri="{FF2B5EF4-FFF2-40B4-BE49-F238E27FC236}">
                        <a16:creationId xmlns:a16="http://schemas.microsoft.com/office/drawing/2014/main" xmlns="" id="{97005194-8C51-4F0C-BFC0-A0EF93B598C8}"/>
                      </a:ext>
                    </a:extLst>
                  </p:cNvPr>
                  <p:cNvSpPr/>
                  <p:nvPr/>
                </p:nvSpPr>
                <p:spPr>
                  <a:xfrm>
                    <a:off x="3799698" y="5445361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63" name="テキスト ボックス 262">
                    <a:extLst>
                      <a:ext uri="{FF2B5EF4-FFF2-40B4-BE49-F238E27FC236}">
                        <a16:creationId xmlns:a16="http://schemas.microsoft.com/office/drawing/2014/main" xmlns="" id="{BD96E6F4-5D98-419E-A596-14DE7BEB87B0}"/>
                      </a:ext>
                    </a:extLst>
                  </p:cNvPr>
                  <p:cNvSpPr txBox="1"/>
                  <p:nvPr/>
                </p:nvSpPr>
                <p:spPr>
                  <a:xfrm>
                    <a:off x="3372485" y="5352017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00</a:t>
                    </a:r>
                  </a:p>
                </p:txBody>
              </p:sp>
              <p:sp>
                <p:nvSpPr>
                  <p:cNvPr id="264" name="フリーフォーム: 図形 263">
                    <a:extLst>
                      <a:ext uri="{FF2B5EF4-FFF2-40B4-BE49-F238E27FC236}">
                        <a16:creationId xmlns:a16="http://schemas.microsoft.com/office/drawing/2014/main" xmlns="" id="{D5C3DB9E-2FEC-4F45-8026-891AD822D187}"/>
                      </a:ext>
                    </a:extLst>
                  </p:cNvPr>
                  <p:cNvSpPr/>
                  <p:nvPr/>
                </p:nvSpPr>
                <p:spPr>
                  <a:xfrm>
                    <a:off x="3799698" y="4802243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65" name="テキスト ボックス 264">
                    <a:extLst>
                      <a:ext uri="{FF2B5EF4-FFF2-40B4-BE49-F238E27FC236}">
                        <a16:creationId xmlns:a16="http://schemas.microsoft.com/office/drawing/2014/main" xmlns="" id="{89733B81-22B7-4C4A-9BB7-5D05D7824FCA}"/>
                      </a:ext>
                    </a:extLst>
                  </p:cNvPr>
                  <p:cNvSpPr txBox="1"/>
                  <p:nvPr/>
                </p:nvSpPr>
                <p:spPr>
                  <a:xfrm>
                    <a:off x="3372485" y="4708898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25</a:t>
                    </a:r>
                  </a:p>
                </p:txBody>
              </p:sp>
              <p:sp>
                <p:nvSpPr>
                  <p:cNvPr id="266" name="フリーフォーム: 図形 265">
                    <a:extLst>
                      <a:ext uri="{FF2B5EF4-FFF2-40B4-BE49-F238E27FC236}">
                        <a16:creationId xmlns:a16="http://schemas.microsoft.com/office/drawing/2014/main" xmlns="" id="{7817380A-4AAF-4297-9CB2-A039BC1432DA}"/>
                      </a:ext>
                    </a:extLst>
                  </p:cNvPr>
                  <p:cNvSpPr/>
                  <p:nvPr/>
                </p:nvSpPr>
                <p:spPr>
                  <a:xfrm>
                    <a:off x="3799698" y="4159124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67" name="テキスト ボックス 266">
                    <a:extLst>
                      <a:ext uri="{FF2B5EF4-FFF2-40B4-BE49-F238E27FC236}">
                        <a16:creationId xmlns:a16="http://schemas.microsoft.com/office/drawing/2014/main" xmlns="" id="{4C62E56E-4BDD-4A03-8D85-D7FAE5060587}"/>
                      </a:ext>
                    </a:extLst>
                  </p:cNvPr>
                  <p:cNvSpPr txBox="1"/>
                  <p:nvPr/>
                </p:nvSpPr>
                <p:spPr>
                  <a:xfrm>
                    <a:off x="3372485" y="4065778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50</a:t>
                    </a:r>
                  </a:p>
                </p:txBody>
              </p:sp>
              <p:sp>
                <p:nvSpPr>
                  <p:cNvPr id="268" name="フリーフォーム: 図形 267">
                    <a:extLst>
                      <a:ext uri="{FF2B5EF4-FFF2-40B4-BE49-F238E27FC236}">
                        <a16:creationId xmlns:a16="http://schemas.microsoft.com/office/drawing/2014/main" xmlns="" id="{D436D6B0-9E19-4859-B937-9E67BA543081}"/>
                      </a:ext>
                    </a:extLst>
                  </p:cNvPr>
                  <p:cNvSpPr/>
                  <p:nvPr/>
                </p:nvSpPr>
                <p:spPr>
                  <a:xfrm>
                    <a:off x="3799698" y="3516006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69" name="テキスト ボックス 268">
                    <a:extLst>
                      <a:ext uri="{FF2B5EF4-FFF2-40B4-BE49-F238E27FC236}">
                        <a16:creationId xmlns:a16="http://schemas.microsoft.com/office/drawing/2014/main" xmlns="" id="{A752E5FE-C1C1-438C-909C-986B0C593610}"/>
                      </a:ext>
                    </a:extLst>
                  </p:cNvPr>
                  <p:cNvSpPr txBox="1"/>
                  <p:nvPr/>
                </p:nvSpPr>
                <p:spPr>
                  <a:xfrm>
                    <a:off x="3372485" y="3422661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075</a:t>
                    </a:r>
                  </a:p>
                </p:txBody>
              </p:sp>
              <p:sp>
                <p:nvSpPr>
                  <p:cNvPr id="270" name="フリーフォーム: 図形 269">
                    <a:extLst>
                      <a:ext uri="{FF2B5EF4-FFF2-40B4-BE49-F238E27FC236}">
                        <a16:creationId xmlns:a16="http://schemas.microsoft.com/office/drawing/2014/main" xmlns="" id="{1B23F55E-58D8-401C-80A0-2FCEBAF6FFC1}"/>
                      </a:ext>
                    </a:extLst>
                  </p:cNvPr>
                  <p:cNvSpPr/>
                  <p:nvPr/>
                </p:nvSpPr>
                <p:spPr>
                  <a:xfrm>
                    <a:off x="3799698" y="2872878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71" name="テキスト ボックス 270">
                    <a:extLst>
                      <a:ext uri="{FF2B5EF4-FFF2-40B4-BE49-F238E27FC236}">
                        <a16:creationId xmlns:a16="http://schemas.microsoft.com/office/drawing/2014/main" xmlns="" id="{546B1B3E-67C5-46DA-A865-BADFCE3E84C7}"/>
                      </a:ext>
                    </a:extLst>
                  </p:cNvPr>
                  <p:cNvSpPr txBox="1"/>
                  <p:nvPr/>
                </p:nvSpPr>
                <p:spPr>
                  <a:xfrm>
                    <a:off x="3372485" y="2779533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00</a:t>
                    </a:r>
                  </a:p>
                </p:txBody>
              </p:sp>
              <p:sp>
                <p:nvSpPr>
                  <p:cNvPr id="272" name="フリーフォーム: 図形 271">
                    <a:extLst>
                      <a:ext uri="{FF2B5EF4-FFF2-40B4-BE49-F238E27FC236}">
                        <a16:creationId xmlns:a16="http://schemas.microsoft.com/office/drawing/2014/main" xmlns="" id="{74A150ED-C693-4336-ACDD-3749F32A6263}"/>
                      </a:ext>
                    </a:extLst>
                  </p:cNvPr>
                  <p:cNvSpPr/>
                  <p:nvPr/>
                </p:nvSpPr>
                <p:spPr>
                  <a:xfrm>
                    <a:off x="3799698" y="2229761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73" name="テキスト ボックス 272">
                    <a:extLst>
                      <a:ext uri="{FF2B5EF4-FFF2-40B4-BE49-F238E27FC236}">
                        <a16:creationId xmlns:a16="http://schemas.microsoft.com/office/drawing/2014/main" xmlns="" id="{8A5EC776-8C9F-4561-B336-54A906FB65F0}"/>
                      </a:ext>
                    </a:extLst>
                  </p:cNvPr>
                  <p:cNvSpPr txBox="1"/>
                  <p:nvPr/>
                </p:nvSpPr>
                <p:spPr>
                  <a:xfrm>
                    <a:off x="3372485" y="2136416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25</a:t>
                    </a:r>
                  </a:p>
                </p:txBody>
              </p:sp>
              <p:sp>
                <p:nvSpPr>
                  <p:cNvPr id="274" name="フリーフォーム: 図形 273">
                    <a:extLst>
                      <a:ext uri="{FF2B5EF4-FFF2-40B4-BE49-F238E27FC236}">
                        <a16:creationId xmlns:a16="http://schemas.microsoft.com/office/drawing/2014/main" xmlns="" id="{EF7BA833-3E39-4468-96B6-EC1DE28A6017}"/>
                      </a:ext>
                    </a:extLst>
                  </p:cNvPr>
                  <p:cNvSpPr/>
                  <p:nvPr/>
                </p:nvSpPr>
                <p:spPr>
                  <a:xfrm>
                    <a:off x="3799698" y="1586640"/>
                    <a:ext cx="49557" cy="9525"/>
                  </a:xfrm>
                  <a:custGeom>
                    <a:avLst/>
                    <a:gdLst>
                      <a:gd name="connsiteX0" fmla="*/ 49569 w 49557"/>
                      <a:gd name="connsiteY0" fmla="*/ 11 h 9525"/>
                      <a:gd name="connsiteX1" fmla="*/ 11 w 49557"/>
                      <a:gd name="connsiteY1" fmla="*/ 11 h 95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49557" h="9525">
                        <a:moveTo>
                          <a:pt x="49569" y="11"/>
                        </a:moveTo>
                        <a:lnTo>
                          <a:pt x="11" y="11"/>
                        </a:lnTo>
                      </a:path>
                    </a:pathLst>
                  </a:custGeom>
                  <a:noFill/>
                  <a:ln w="9525" cap="flat">
                    <a:solidFill>
                      <a:srgbClr val="000000"/>
                    </a:solidFill>
                    <a:prstDash val="solid"/>
                    <a:miter/>
                  </a:ln>
                </p:spPr>
                <p:txBody>
                  <a:bodyPr rtlCol="0" anchor="ctr"/>
                  <a:lstStyle/>
                  <a:p>
                    <a:endParaRPr lang="ja-JP" altLang="en-US"/>
                  </a:p>
                </p:txBody>
              </p:sp>
              <p:sp>
                <p:nvSpPr>
                  <p:cNvPr id="275" name="テキスト ボックス 274">
                    <a:extLst>
                      <a:ext uri="{FF2B5EF4-FFF2-40B4-BE49-F238E27FC236}">
                        <a16:creationId xmlns:a16="http://schemas.microsoft.com/office/drawing/2014/main" xmlns="" id="{1AF2354B-80C3-4997-A031-3E4C51B1AC59}"/>
                      </a:ext>
                    </a:extLst>
                  </p:cNvPr>
                  <p:cNvSpPr txBox="1"/>
                  <p:nvPr/>
                </p:nvSpPr>
                <p:spPr>
                  <a:xfrm>
                    <a:off x="3372485" y="1493295"/>
                    <a:ext cx="571682" cy="3185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00">
                        <a:solidFill>
                          <a:srgbClr val="000000"/>
                        </a:solidFill>
                        <a:latin typeface="ＭＳ Ｐゴシック"/>
                        <a:ea typeface="ＭＳ Ｐゴシック"/>
                        <a:sym typeface="ＭＳ Ｐゴシック"/>
                        <a:rtl val="0"/>
                      </a:rPr>
                      <a:t>0.0150</a:t>
                    </a:r>
                  </a:p>
                </p:txBody>
              </p:sp>
              <p:sp>
                <p:nvSpPr>
                  <p:cNvPr id="276" name="テキスト ボックス 275">
                    <a:extLst>
                      <a:ext uri="{FF2B5EF4-FFF2-40B4-BE49-F238E27FC236}">
                        <a16:creationId xmlns:a16="http://schemas.microsoft.com/office/drawing/2014/main" xmlns="" id="{2FBEC5D2-C66A-4F66-BE73-6539D310C90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869048" y="3352912"/>
                    <a:ext cx="827665" cy="2786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l"/>
                    <a:r>
                      <a:rPr lang="ja-JP" altLang="en-US" sz="975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ＭＳ Ｐゴシック"/>
                        <a:cs typeface="Arial" panose="020B0604020202020204" pitchFamily="34" charset="0"/>
                        <a:sym typeface="ＭＳ Ｐゴシック"/>
                        <a:rtl val="0"/>
                      </a:rPr>
                      <a:t>Density</a:t>
                    </a:r>
                  </a:p>
                </p:txBody>
              </p:sp>
            </p:grpSp>
          </p:grpSp>
        </p:grpSp>
      </p:grp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xmlns="" id="{E14F5FF2-0885-4D65-9806-DF292C9D3858}"/>
              </a:ext>
            </a:extLst>
          </p:cNvPr>
          <p:cNvSpPr txBox="1"/>
          <p:nvPr/>
        </p:nvSpPr>
        <p:spPr>
          <a:xfrm>
            <a:off x="4841014" y="702853"/>
            <a:ext cx="992579" cy="369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725"/>
            <a:r>
              <a:rPr kumimoji="1" lang="en-US" altLang="ja-JP" sz="1802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: 2000</a:t>
            </a:r>
            <a:endParaRPr kumimoji="1" lang="ja-JP" altLang="en-US" sz="1802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xmlns="" id="{9114794D-EC1D-45B2-AE12-1B4678820389}"/>
              </a:ext>
            </a:extLst>
          </p:cNvPr>
          <p:cNvSpPr txBox="1"/>
          <p:nvPr/>
        </p:nvSpPr>
        <p:spPr>
          <a:xfrm>
            <a:off x="4905396" y="4026766"/>
            <a:ext cx="864339" cy="369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725"/>
            <a:r>
              <a:rPr kumimoji="1" lang="en-US" altLang="ja-JP" sz="1802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: 400</a:t>
            </a:r>
            <a:endParaRPr kumimoji="1" lang="ja-JP" altLang="en-US" sz="1802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28032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>
            <a:extLst>
              <a:ext uri="{FF2B5EF4-FFF2-40B4-BE49-F238E27FC236}">
                <a16:creationId xmlns:a16="http://schemas.microsoft.com/office/drawing/2014/main" xmlns="" id="{43EEE33D-DE70-A916-24BE-9A3D4352EC77}"/>
              </a:ext>
            </a:extLst>
          </p:cNvPr>
          <p:cNvSpPr txBox="1">
            <a:spLocks/>
          </p:cNvSpPr>
          <p:nvPr/>
        </p:nvSpPr>
        <p:spPr>
          <a:xfrm rot="10800000" flipV="1">
            <a:off x="145512" y="38370"/>
            <a:ext cx="2661757" cy="366965"/>
          </a:xfrm>
          <a:prstGeom prst="rect">
            <a:avLst/>
          </a:prstGeom>
        </p:spPr>
        <p:txBody>
          <a:bodyPr vert="horz" lIns="91551" tIns="45776" rIns="91551" bIns="45776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86586"/>
            <a:r>
              <a:rPr lang="en-US" altLang="ja-JP" sz="1802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4</a:t>
            </a:r>
            <a:endParaRPr lang="ja-JP" altLang="en-US" sz="1802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198B90DF-E32C-86FD-DD46-38BFC2DF004E}"/>
              </a:ext>
            </a:extLst>
          </p:cNvPr>
          <p:cNvSpPr txBox="1"/>
          <p:nvPr/>
        </p:nvSpPr>
        <p:spPr>
          <a:xfrm rot="16200000">
            <a:off x="-737046" y="2587868"/>
            <a:ext cx="22402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DUPAN2 (U/mL)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xmlns="" id="{DA60FB63-BE1F-D85B-932B-F92DFF0516C3}"/>
              </a:ext>
            </a:extLst>
          </p:cNvPr>
          <p:cNvGrpSpPr/>
          <p:nvPr/>
        </p:nvGrpSpPr>
        <p:grpSpPr>
          <a:xfrm>
            <a:off x="1086097" y="4909413"/>
            <a:ext cx="4553821" cy="702124"/>
            <a:chOff x="925462" y="4032082"/>
            <a:chExt cx="3535328" cy="702124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xmlns="" id="{813AA805-DC3C-C3DB-F78C-5533498854F1}"/>
                </a:ext>
              </a:extLst>
            </p:cNvPr>
            <p:cNvSpPr txBox="1"/>
            <p:nvPr/>
          </p:nvSpPr>
          <p:spPr>
            <a:xfrm flipV="1">
              <a:off x="3175660" y="4037135"/>
              <a:ext cx="6798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xmlns="" id="{9C1BFAC3-A329-ABD4-9B0F-23A1D94C22DE}"/>
                </a:ext>
              </a:extLst>
            </p:cNvPr>
            <p:cNvCxnSpPr>
              <a:cxnSpLocks/>
            </p:cNvCxnSpPr>
            <p:nvPr/>
          </p:nvCxnSpPr>
          <p:spPr>
            <a:xfrm>
              <a:off x="2458995" y="4419067"/>
              <a:ext cx="192765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xmlns="" id="{DD367781-3F84-D9DE-C874-9C06D4294C2D}"/>
                </a:ext>
              </a:extLst>
            </p:cNvPr>
            <p:cNvGrpSpPr/>
            <p:nvPr/>
          </p:nvGrpSpPr>
          <p:grpSpPr>
            <a:xfrm>
              <a:off x="925462" y="4032082"/>
              <a:ext cx="3535328" cy="702124"/>
              <a:chOff x="838965" y="3611952"/>
              <a:chExt cx="3535328" cy="702124"/>
            </a:xfrm>
          </p:grpSpPr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xmlns="" id="{089CDE67-88B2-0ABF-E76B-475B0AF32C2B}"/>
                  </a:ext>
                </a:extLst>
              </p:cNvPr>
              <p:cNvSpPr txBox="1"/>
              <p:nvPr/>
            </p:nvSpPr>
            <p:spPr>
              <a:xfrm rot="10800000" flipV="1">
                <a:off x="1406342" y="3669338"/>
                <a:ext cx="91389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ll stages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xmlns="" id="{FB403DB8-9A9A-6459-7499-5F4A90445999}"/>
                  </a:ext>
                </a:extLst>
              </p:cNvPr>
              <p:cNvSpPr txBox="1"/>
              <p:nvPr/>
            </p:nvSpPr>
            <p:spPr>
              <a:xfrm flipH="1">
                <a:off x="2039940" y="3629744"/>
                <a:ext cx="67463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xmlns="" id="{7684AE68-2BA0-F3E7-34BE-8CE4B6EA1C04}"/>
                  </a:ext>
                </a:extLst>
              </p:cNvPr>
              <p:cNvSpPr txBox="1"/>
              <p:nvPr/>
            </p:nvSpPr>
            <p:spPr>
              <a:xfrm flipV="1">
                <a:off x="2614455" y="3611952"/>
                <a:ext cx="5971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II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xmlns="" id="{A3E4411F-4D43-D497-D3E8-618ADA38EA39}"/>
                  </a:ext>
                </a:extLst>
              </p:cNvPr>
              <p:cNvSpPr txBox="1"/>
              <p:nvPr/>
            </p:nvSpPr>
            <p:spPr>
              <a:xfrm rot="10800000" flipV="1">
                <a:off x="3663961" y="3628895"/>
                <a:ext cx="6007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IV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xmlns="" id="{D74DF4CF-F1B8-91A1-7324-D1E14407AACE}"/>
                  </a:ext>
                </a:extLst>
              </p:cNvPr>
              <p:cNvSpPr txBox="1"/>
              <p:nvPr/>
            </p:nvSpPr>
            <p:spPr>
              <a:xfrm>
                <a:off x="838965" y="3645668"/>
                <a:ext cx="763702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ealthy controls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xmlns="" id="{8925EF99-A62F-2F97-A05D-E1F97F56680D}"/>
                  </a:ext>
                </a:extLst>
              </p:cNvPr>
              <p:cNvSpPr txBox="1"/>
              <p:nvPr/>
            </p:nvSpPr>
            <p:spPr>
              <a:xfrm>
                <a:off x="2453297" y="4006299"/>
                <a:ext cx="19209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ancreatic cancer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61C333F8-C80A-D369-6117-E5DDACAD651D}"/>
              </a:ext>
            </a:extLst>
          </p:cNvPr>
          <p:cNvSpPr txBox="1"/>
          <p:nvPr/>
        </p:nvSpPr>
        <p:spPr>
          <a:xfrm>
            <a:off x="383061" y="5701031"/>
            <a:ext cx="637993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86586"/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4: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Distribution of the plasma concentration of DUPAN2 in healthy controls and pancreatic cancer. </a:t>
            </a:r>
          </a:p>
          <a:p>
            <a:pPr defTabSz="686586"/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ignificance was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calculated by the Wilcoxon rank sum test  (***p &lt;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0.001). Clinical stages are classified according to UICC 8</a:t>
            </a:r>
            <a:r>
              <a:rPr lang="en-US" altLang="ja-JP" sz="1200" baseline="300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th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 edition.</a:t>
            </a:r>
          </a:p>
          <a:p>
            <a:pPr defTabSz="686586"/>
            <a:endParaRPr lang="en-US" altLang="ja-JP" sz="1200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xmlns="" id="{3738B2AE-5128-F81A-93CE-46743A13A2DA}"/>
              </a:ext>
            </a:extLst>
          </p:cNvPr>
          <p:cNvGrpSpPr/>
          <p:nvPr/>
        </p:nvGrpSpPr>
        <p:grpSpPr>
          <a:xfrm>
            <a:off x="1977081" y="881447"/>
            <a:ext cx="3385751" cy="366585"/>
            <a:chOff x="1668162" y="955589"/>
            <a:chExt cx="2533135" cy="366585"/>
          </a:xfrm>
        </p:grpSpPr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xmlns="" id="{C3D0755C-CDBC-A173-D80E-CE0D798670DC}"/>
                </a:ext>
              </a:extLst>
            </p:cNvPr>
            <p:cNvSpPr txBox="1"/>
            <p:nvPr/>
          </p:nvSpPr>
          <p:spPr>
            <a:xfrm>
              <a:off x="3805881" y="963828"/>
              <a:ext cx="395416" cy="358346"/>
            </a:xfrm>
            <a:prstGeom prst="rect">
              <a:avLst/>
            </a:prstGeom>
          </p:spPr>
          <p:txBody>
            <a:bodyPr vert="horz" wrap="none" lIns="91551" tIns="45776" rIns="91551" bIns="45776" rtlCol="0" anchor="ctr">
              <a:noAutofit/>
            </a:bodyPr>
            <a:lstStyle/>
            <a:p>
              <a:pPr algn="l" defTabSz="686586"/>
              <a:r>
                <a:rPr kumimoji="1" lang="en-US" altLang="ja-JP" b="1" dirty="0">
                  <a:solidFill>
                    <a:prstClr val="black"/>
                  </a:solidFill>
                  <a:latin typeface="Arial" panose="020B0604020202020204" pitchFamily="34" charset="0"/>
                  <a:ea typeface="游ゴシック Light" panose="020B0300000000000000" pitchFamily="50" charset="-128"/>
                  <a:cs typeface="Arial" panose="020B0604020202020204" pitchFamily="34" charset="0"/>
                </a:rPr>
                <a:t>***</a:t>
              </a:r>
              <a:endParaRPr kumimoji="1" lang="ja-JP" altLang="en-US" b="1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xmlns="" id="{62E7AF13-23DA-FDC2-C523-68940C4808C6}"/>
                </a:ext>
              </a:extLst>
            </p:cNvPr>
            <p:cNvGrpSpPr/>
            <p:nvPr/>
          </p:nvGrpSpPr>
          <p:grpSpPr>
            <a:xfrm>
              <a:off x="1668162" y="955589"/>
              <a:ext cx="2034745" cy="366584"/>
              <a:chOff x="1668162" y="955589"/>
              <a:chExt cx="2034745" cy="366584"/>
            </a:xfrm>
          </p:grpSpPr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xmlns="" id="{B027267B-2847-A682-D52E-CCC17DE17390}"/>
                  </a:ext>
                </a:extLst>
              </p:cNvPr>
              <p:cNvSpPr txBox="1"/>
              <p:nvPr/>
            </p:nvSpPr>
            <p:spPr>
              <a:xfrm>
                <a:off x="2796745" y="955590"/>
                <a:ext cx="395416" cy="358346"/>
              </a:xfrm>
              <a:prstGeom prst="rect">
                <a:avLst/>
              </a:prstGeom>
            </p:spPr>
            <p:txBody>
              <a:bodyPr vert="horz" wrap="none" lIns="91551" tIns="45776" rIns="91551" bIns="45776" rtlCol="0" anchor="ctr">
                <a:noAutofit/>
              </a:bodyPr>
              <a:lstStyle/>
              <a:p>
                <a:pPr algn="l" defTabSz="686586"/>
                <a:r>
                  <a:rPr kumimoji="1" lang="en-US" altLang="ja-JP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 Light" panose="020B0300000000000000" pitchFamily="50" charset="-128"/>
                    <a:cs typeface="Arial" panose="020B0604020202020204" pitchFamily="34" charset="0"/>
                  </a:rPr>
                  <a:t>***</a:t>
                </a:r>
                <a:endParaRPr kumimoji="1" lang="ja-JP" altLang="en-US" b="1" dirty="0">
                  <a:solidFill>
                    <a:prstClr val="black"/>
                  </a:solidFill>
                  <a:latin typeface="Arial" panose="020B0604020202020204" pitchFamily="34" charset="0"/>
                  <a:ea typeface="游ゴシック Light" panose="020B03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xmlns="" id="{8AFF5ACA-06D9-FC2A-EB22-01C42A7B71C3}"/>
                  </a:ext>
                </a:extLst>
              </p:cNvPr>
              <p:cNvSpPr txBox="1"/>
              <p:nvPr/>
            </p:nvSpPr>
            <p:spPr>
              <a:xfrm>
                <a:off x="3307491" y="959709"/>
                <a:ext cx="395416" cy="358346"/>
              </a:xfrm>
              <a:prstGeom prst="rect">
                <a:avLst/>
              </a:prstGeom>
            </p:spPr>
            <p:txBody>
              <a:bodyPr vert="horz" wrap="none" lIns="91551" tIns="45776" rIns="91551" bIns="45776" rtlCol="0" anchor="ctr">
                <a:noAutofit/>
              </a:bodyPr>
              <a:lstStyle/>
              <a:p>
                <a:pPr algn="l" defTabSz="686586"/>
                <a:r>
                  <a:rPr kumimoji="1" lang="en-US" altLang="ja-JP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 Light" panose="020B0300000000000000" pitchFamily="50" charset="-128"/>
                    <a:cs typeface="Arial" panose="020B0604020202020204" pitchFamily="34" charset="0"/>
                  </a:rPr>
                  <a:t>***</a:t>
                </a:r>
                <a:endParaRPr kumimoji="1" lang="ja-JP" altLang="en-US" b="1" dirty="0">
                  <a:solidFill>
                    <a:prstClr val="black"/>
                  </a:solidFill>
                  <a:latin typeface="Arial" panose="020B0604020202020204" pitchFamily="34" charset="0"/>
                  <a:ea typeface="游ゴシック Light" panose="020B0300000000000000" pitchFamily="50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48" name="グループ化 47">
                <a:extLst>
                  <a:ext uri="{FF2B5EF4-FFF2-40B4-BE49-F238E27FC236}">
                    <a16:creationId xmlns:a16="http://schemas.microsoft.com/office/drawing/2014/main" xmlns="" id="{967735AC-1289-5B40-6EE0-0F130C2A3B35}"/>
                  </a:ext>
                </a:extLst>
              </p:cNvPr>
              <p:cNvGrpSpPr/>
              <p:nvPr/>
            </p:nvGrpSpPr>
            <p:grpSpPr>
              <a:xfrm>
                <a:off x="1668162" y="955589"/>
                <a:ext cx="980301" cy="366584"/>
                <a:chOff x="1668162" y="955589"/>
                <a:chExt cx="980301" cy="366584"/>
              </a:xfrm>
            </p:grpSpPr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xmlns="" id="{0F12C9D0-966B-619C-4405-05DECCE8E7B0}"/>
                    </a:ext>
                  </a:extLst>
                </p:cNvPr>
                <p:cNvSpPr txBox="1"/>
                <p:nvPr/>
              </p:nvSpPr>
              <p:spPr>
                <a:xfrm>
                  <a:off x="1668162" y="963827"/>
                  <a:ext cx="395416" cy="358346"/>
                </a:xfrm>
                <a:prstGeom prst="rect">
                  <a:avLst/>
                </a:prstGeom>
              </p:spPr>
              <p:txBody>
                <a:bodyPr vert="horz" wrap="none" lIns="91551" tIns="45776" rIns="91551" bIns="45776" rtlCol="0" anchor="ctr">
                  <a:noAutofit/>
                </a:bodyPr>
                <a:lstStyle/>
                <a:p>
                  <a:pPr algn="l" defTabSz="686586"/>
                  <a:r>
                    <a:rPr kumimoji="1" lang="en-US" altLang="ja-JP" b="1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 Light" panose="020B0300000000000000" pitchFamily="50" charset="-128"/>
                      <a:cs typeface="Arial" panose="020B0604020202020204" pitchFamily="34" charset="0"/>
                    </a:rPr>
                    <a:t>***</a:t>
                  </a:r>
                  <a:endParaRPr kumimoji="1" lang="ja-JP" altLang="en-US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 Light" panose="020B0300000000000000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xmlns="" id="{6DB6BE80-127A-13FE-33BE-6B522609B7B9}"/>
                    </a:ext>
                  </a:extLst>
                </p:cNvPr>
                <p:cNvSpPr txBox="1"/>
                <p:nvPr/>
              </p:nvSpPr>
              <p:spPr>
                <a:xfrm>
                  <a:off x="2253047" y="955589"/>
                  <a:ext cx="395416" cy="358346"/>
                </a:xfrm>
                <a:prstGeom prst="rect">
                  <a:avLst/>
                </a:prstGeom>
              </p:spPr>
              <p:txBody>
                <a:bodyPr vert="horz" wrap="none" lIns="91551" tIns="45776" rIns="91551" bIns="45776" rtlCol="0" anchor="ctr">
                  <a:noAutofit/>
                </a:bodyPr>
                <a:lstStyle/>
                <a:p>
                  <a:pPr algn="l" defTabSz="686586"/>
                  <a:r>
                    <a:rPr kumimoji="1" lang="en-US" altLang="ja-JP" b="1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游ゴシック Light" panose="020B0300000000000000" pitchFamily="50" charset="-128"/>
                      <a:cs typeface="Arial" panose="020B0604020202020204" pitchFamily="34" charset="0"/>
                    </a:rPr>
                    <a:t>***</a:t>
                  </a:r>
                  <a:endParaRPr kumimoji="1" lang="ja-JP" altLang="en-US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 Light" panose="020B0300000000000000" pitchFamily="50" charset="-128"/>
                    <a:cs typeface="Arial" panose="020B0604020202020204" pitchFamily="34" charset="0"/>
                  </a:endParaRPr>
                </a:p>
              </p:txBody>
            </p:sp>
          </p:grpSp>
        </p:grpSp>
      </p:grpSp>
      <p:graphicFrame>
        <p:nvGraphicFramePr>
          <p:cNvPr id="45" name="オブジェクト 44">
            <a:extLst>
              <a:ext uri="{FF2B5EF4-FFF2-40B4-BE49-F238E27FC236}">
                <a16:creationId xmlns:a16="http://schemas.microsoft.com/office/drawing/2014/main" xmlns="" id="{CB67E82C-855F-DCBB-213F-89808D75C5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3033601"/>
              </p:ext>
            </p:extLst>
          </p:nvPr>
        </p:nvGraphicFramePr>
        <p:xfrm>
          <a:off x="976405" y="704336"/>
          <a:ext cx="4697236" cy="43001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3636290" imgH="2884474" progId="Prism9.Document">
                  <p:embed/>
                </p:oleObj>
              </mc:Choice>
              <mc:Fallback>
                <p:oleObj name="Prism 9" r:id="rId3" imgW="3636290" imgH="288447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76405" y="704336"/>
                        <a:ext cx="4697236" cy="43001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E4BFCF74-29FF-7DC1-E044-7DF5261A24E1}"/>
              </a:ext>
            </a:extLst>
          </p:cNvPr>
          <p:cNvSpPr txBox="1"/>
          <p:nvPr/>
        </p:nvSpPr>
        <p:spPr>
          <a:xfrm>
            <a:off x="586700" y="3576399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xmlns="" id="{E69B4AA3-9C4C-27AA-63EC-0613346C836D}"/>
              </a:ext>
            </a:extLst>
          </p:cNvPr>
          <p:cNvSpPr txBox="1"/>
          <p:nvPr/>
        </p:nvSpPr>
        <p:spPr>
          <a:xfrm>
            <a:off x="518955" y="2654964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xmlns="" id="{E8B6FFE1-95E0-542F-DB87-9799E51D89A9}"/>
              </a:ext>
            </a:extLst>
          </p:cNvPr>
          <p:cNvSpPr txBox="1"/>
          <p:nvPr/>
        </p:nvSpPr>
        <p:spPr>
          <a:xfrm>
            <a:off x="523409" y="1765427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D33E0FCD-1FE6-C26E-347F-0589791E055D}"/>
              </a:ext>
            </a:extLst>
          </p:cNvPr>
          <p:cNvSpPr txBox="1"/>
          <p:nvPr/>
        </p:nvSpPr>
        <p:spPr>
          <a:xfrm>
            <a:off x="554961" y="889768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xmlns="" id="{9927FE06-E616-D9C1-8680-F4D0CF4E9506}"/>
              </a:ext>
            </a:extLst>
          </p:cNvPr>
          <p:cNvSpPr txBox="1"/>
          <p:nvPr/>
        </p:nvSpPr>
        <p:spPr>
          <a:xfrm>
            <a:off x="747784" y="451155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31288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A6D125A-25F7-E89C-9A9D-87C5AED018EE}"/>
              </a:ext>
            </a:extLst>
          </p:cNvPr>
          <p:cNvSpPr txBox="1">
            <a:spLocks/>
          </p:cNvSpPr>
          <p:nvPr/>
        </p:nvSpPr>
        <p:spPr>
          <a:xfrm rot="10800000" flipV="1">
            <a:off x="219124" y="137685"/>
            <a:ext cx="2603520" cy="358936"/>
          </a:xfrm>
          <a:prstGeom prst="rect">
            <a:avLst/>
          </a:prstGeom>
        </p:spPr>
        <p:txBody>
          <a:bodyPr vert="horz" lIns="89548" tIns="44774" rIns="89548" bIns="44774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71595"/>
            <a:r>
              <a:rPr lang="en-US" altLang="ja-JP" sz="1763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5</a:t>
            </a:r>
            <a:endParaRPr lang="ja-JP" altLang="en-US" sz="1763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xmlns="" id="{EFF0F256-D4E2-8643-B766-3396D46D2BBE}"/>
              </a:ext>
            </a:extLst>
          </p:cNvPr>
          <p:cNvGrpSpPr/>
          <p:nvPr/>
        </p:nvGrpSpPr>
        <p:grpSpPr>
          <a:xfrm>
            <a:off x="327175" y="799472"/>
            <a:ext cx="5984979" cy="5478331"/>
            <a:chOff x="2707232" y="403225"/>
            <a:chExt cx="6748813" cy="6405154"/>
          </a:xfrm>
        </p:grpSpPr>
        <p:sp>
          <p:nvSpPr>
            <p:cNvPr id="3" name="Rectangle 5">
              <a:extLst>
                <a:ext uri="{FF2B5EF4-FFF2-40B4-BE49-F238E27FC236}">
                  <a16:creationId xmlns:a16="http://schemas.microsoft.com/office/drawing/2014/main" xmlns="" id="{621DBD94-6EC2-B5D8-C3E7-CA6ECB664E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9900" y="6524625"/>
              <a:ext cx="1189392" cy="2837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1577" dirty="0">
                  <a:solidFill>
                    <a:srgbClr val="000000"/>
                  </a:solidFill>
                  <a:cs typeface="Arial" panose="020B0604020202020204" pitchFamily="34" charset="0"/>
                </a:rPr>
                <a:t>1-specificity</a:t>
              </a:r>
              <a:endParaRPr lang="ja-JP" altLang="ja-JP" sz="1577" dirty="0">
                <a:cs typeface="Arial" panose="020B0604020202020204" pitchFamily="34" charset="0"/>
              </a:endParaRPr>
            </a:p>
          </p:txBody>
        </p:sp>
        <p:sp>
          <p:nvSpPr>
            <p:cNvPr id="4" name="Rectangle 6">
              <a:extLst>
                <a:ext uri="{FF2B5EF4-FFF2-40B4-BE49-F238E27FC236}">
                  <a16:creationId xmlns:a16="http://schemas.microsoft.com/office/drawing/2014/main" xmlns="" id="{7867658B-4330-0608-2A78-6AA368DD685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312731" y="3075315"/>
              <a:ext cx="1062671" cy="2736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1577" dirty="0">
                  <a:solidFill>
                    <a:srgbClr val="000000"/>
                  </a:solidFill>
                  <a:cs typeface="Arial" panose="020B0604020202020204" pitchFamily="34" charset="0"/>
                </a:rPr>
                <a:t>Sensitivity</a:t>
              </a:r>
              <a:endParaRPr lang="ja-JP" altLang="ja-JP" sz="1577" dirty="0">
                <a:cs typeface="Arial" panose="020B0604020202020204" pitchFamily="34" charset="0"/>
              </a:endParaRPr>
            </a:p>
          </p:txBody>
        </p:sp>
        <p:sp>
          <p:nvSpPr>
            <p:cNvPr id="5" name="Rectangle 7">
              <a:extLst>
                <a:ext uri="{FF2B5EF4-FFF2-40B4-BE49-F238E27FC236}">
                  <a16:creationId xmlns:a16="http://schemas.microsoft.com/office/drawing/2014/main" xmlns="" id="{B97B1129-7BFB-9AFE-C35B-690F53263C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4400" y="403225"/>
              <a:ext cx="5637213" cy="5637213"/>
            </a:xfrm>
            <a:prstGeom prst="rect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" name="Line 8">
              <a:extLst>
                <a:ext uri="{FF2B5EF4-FFF2-40B4-BE49-F238E27FC236}">
                  <a16:creationId xmlns:a16="http://schemas.microsoft.com/office/drawing/2014/main" xmlns="" id="{CE766D51-2A69-3C2E-0368-7AB7076EB9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662363" y="6040438"/>
              <a:ext cx="522128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" name="Line 9">
              <a:extLst>
                <a:ext uri="{FF2B5EF4-FFF2-40B4-BE49-F238E27FC236}">
                  <a16:creationId xmlns:a16="http://schemas.microsoft.com/office/drawing/2014/main" xmlns="" id="{A84C47B7-E9EA-90CF-96C9-673D9DEEFB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83650" y="6040438"/>
              <a:ext cx="0" cy="9683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" name="Line 10">
              <a:extLst>
                <a:ext uri="{FF2B5EF4-FFF2-40B4-BE49-F238E27FC236}">
                  <a16:creationId xmlns:a16="http://schemas.microsoft.com/office/drawing/2014/main" xmlns="" id="{858E5D1F-7701-688D-6D26-C9DBBAACE3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39075" y="6040438"/>
              <a:ext cx="0" cy="9683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9" name="Line 11">
              <a:extLst>
                <a:ext uri="{FF2B5EF4-FFF2-40B4-BE49-F238E27FC236}">
                  <a16:creationId xmlns:a16="http://schemas.microsoft.com/office/drawing/2014/main" xmlns="" id="{BE882B20-FFBC-6D3A-834A-671F9EF34B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96088" y="6040438"/>
              <a:ext cx="0" cy="9683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10" name="Line 12">
              <a:extLst>
                <a:ext uri="{FF2B5EF4-FFF2-40B4-BE49-F238E27FC236}">
                  <a16:creationId xmlns:a16="http://schemas.microsoft.com/office/drawing/2014/main" xmlns="" id="{B6FF5989-30D1-16DC-9479-CE4BFBE92F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48338" y="6040438"/>
              <a:ext cx="0" cy="9683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11" name="Line 13">
              <a:extLst>
                <a:ext uri="{FF2B5EF4-FFF2-40B4-BE49-F238E27FC236}">
                  <a16:creationId xmlns:a16="http://schemas.microsoft.com/office/drawing/2014/main" xmlns="" id="{9FD0FE60-B685-7792-CC3A-08056EBBA8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05350" y="6040438"/>
              <a:ext cx="0" cy="9683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12" name="Line 14">
              <a:extLst>
                <a:ext uri="{FF2B5EF4-FFF2-40B4-BE49-F238E27FC236}">
                  <a16:creationId xmlns:a16="http://schemas.microsoft.com/office/drawing/2014/main" xmlns="" id="{4F02CE0F-4B18-7204-10AA-9086ABF1BF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62363" y="6040438"/>
              <a:ext cx="0" cy="9683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13" name="Rectangle 15">
              <a:extLst>
                <a:ext uri="{FF2B5EF4-FFF2-40B4-BE49-F238E27FC236}">
                  <a16:creationId xmlns:a16="http://schemas.microsoft.com/office/drawing/2014/main" xmlns="" id="{2D75E0DA-429E-16D2-B20F-85C32A9357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3774" y="6238875"/>
              <a:ext cx="180758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  </a:t>
              </a:r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14" name="Rectangle 16">
              <a:extLst>
                <a:ext uri="{FF2B5EF4-FFF2-40B4-BE49-F238E27FC236}">
                  <a16:creationId xmlns:a16="http://schemas.microsoft.com/office/drawing/2014/main" xmlns="" id="{5E6A4245-ECC3-BD7E-A286-430E1572AC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4538" y="6238875"/>
              <a:ext cx="271137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.</a:t>
              </a:r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2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15" name="Rectangle 17">
              <a:extLst>
                <a:ext uri="{FF2B5EF4-FFF2-40B4-BE49-F238E27FC236}">
                  <a16:creationId xmlns:a16="http://schemas.microsoft.com/office/drawing/2014/main" xmlns="" id="{5FA7E4CE-7728-61CF-609E-420CE363D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7525" y="6238875"/>
              <a:ext cx="271137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.</a:t>
              </a:r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4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16" name="Rectangle 18">
              <a:extLst>
                <a:ext uri="{FF2B5EF4-FFF2-40B4-BE49-F238E27FC236}">
                  <a16:creationId xmlns:a16="http://schemas.microsoft.com/office/drawing/2014/main" xmlns="" id="{6BDADD48-AFC1-0B4E-8356-D4EAA6F46E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42100" y="6238875"/>
              <a:ext cx="271137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.</a:t>
              </a:r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6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17" name="Rectangle 19">
              <a:extLst>
                <a:ext uri="{FF2B5EF4-FFF2-40B4-BE49-F238E27FC236}">
                  <a16:creationId xmlns:a16="http://schemas.microsoft.com/office/drawing/2014/main" xmlns="" id="{9B2C29B4-64DD-98B6-688D-A610C09AE3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85088" y="6238875"/>
              <a:ext cx="271137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.</a:t>
              </a:r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8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18" name="Rectangle 20">
              <a:extLst>
                <a:ext uri="{FF2B5EF4-FFF2-40B4-BE49-F238E27FC236}">
                  <a16:creationId xmlns:a16="http://schemas.microsoft.com/office/drawing/2014/main" xmlns="" id="{DFEDE080-82A8-1592-97C4-A8E00A5B49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07438" y="6238875"/>
              <a:ext cx="225949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1</a:t>
              </a:r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.</a:t>
              </a:r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19" name="Line 21">
              <a:extLst>
                <a:ext uri="{FF2B5EF4-FFF2-40B4-BE49-F238E27FC236}">
                  <a16:creationId xmlns:a16="http://schemas.microsoft.com/office/drawing/2014/main" xmlns="" id="{0EE3933B-5E01-F4AE-FDC0-E59DE18393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54400" y="611188"/>
              <a:ext cx="0" cy="522128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0" name="Line 22">
              <a:extLst>
                <a:ext uri="{FF2B5EF4-FFF2-40B4-BE49-F238E27FC236}">
                  <a16:creationId xmlns:a16="http://schemas.microsoft.com/office/drawing/2014/main" xmlns="" id="{E82DB919-D42A-F025-8F62-A532E67CBF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355975" y="5832475"/>
              <a:ext cx="984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1" name="Line 23">
              <a:extLst>
                <a:ext uri="{FF2B5EF4-FFF2-40B4-BE49-F238E27FC236}">
                  <a16:creationId xmlns:a16="http://schemas.microsoft.com/office/drawing/2014/main" xmlns="" id="{E2297AAF-F895-B12B-BBBD-CFB25E9D55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355975" y="4789488"/>
              <a:ext cx="984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2" name="Line 24">
              <a:extLst>
                <a:ext uri="{FF2B5EF4-FFF2-40B4-BE49-F238E27FC236}">
                  <a16:creationId xmlns:a16="http://schemas.microsoft.com/office/drawing/2014/main" xmlns="" id="{BE8CB222-B3F4-4E4A-813E-C05000142C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355975" y="3744913"/>
              <a:ext cx="984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3" name="Line 25">
              <a:extLst>
                <a:ext uri="{FF2B5EF4-FFF2-40B4-BE49-F238E27FC236}">
                  <a16:creationId xmlns:a16="http://schemas.microsoft.com/office/drawing/2014/main" xmlns="" id="{A6EC956A-5634-B4B4-5BB0-1B8590A35E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355975" y="2698750"/>
              <a:ext cx="984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4" name="Line 26">
              <a:extLst>
                <a:ext uri="{FF2B5EF4-FFF2-40B4-BE49-F238E27FC236}">
                  <a16:creationId xmlns:a16="http://schemas.microsoft.com/office/drawing/2014/main" xmlns="" id="{A61FB643-352E-351E-E16C-1008A2F3C0C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355975" y="1654175"/>
              <a:ext cx="984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5" name="Line 27">
              <a:extLst>
                <a:ext uri="{FF2B5EF4-FFF2-40B4-BE49-F238E27FC236}">
                  <a16:creationId xmlns:a16="http://schemas.microsoft.com/office/drawing/2014/main" xmlns="" id="{BFC6D8B2-A63D-9339-E5A6-87847960B8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355975" y="611188"/>
              <a:ext cx="984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6" name="Rectangle 28">
              <a:extLst>
                <a:ext uri="{FF2B5EF4-FFF2-40B4-BE49-F238E27FC236}">
                  <a16:creationId xmlns:a16="http://schemas.microsoft.com/office/drawing/2014/main" xmlns="" id="{CC705003-9A92-4A43-3F61-4EFFBEED55E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28705">
              <a:off x="3098909" y="5727227"/>
              <a:ext cx="180758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  </a:t>
              </a:r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27" name="Rectangle 29">
              <a:extLst>
                <a:ext uri="{FF2B5EF4-FFF2-40B4-BE49-F238E27FC236}">
                  <a16:creationId xmlns:a16="http://schemas.microsoft.com/office/drawing/2014/main" xmlns="" id="{DE9B635F-E41D-E96B-DC0A-1B42623C5CC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94549">
              <a:off x="3076314" y="4682650"/>
              <a:ext cx="225949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.2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28" name="Rectangle 30">
              <a:extLst>
                <a:ext uri="{FF2B5EF4-FFF2-40B4-BE49-F238E27FC236}">
                  <a16:creationId xmlns:a16="http://schemas.microsoft.com/office/drawing/2014/main" xmlns="" id="{578F3006-CFA9-EF62-DA31-2F7C753FB7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664" y="3580986"/>
              <a:ext cx="225949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.</a:t>
              </a:r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4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29" name="Rectangle 31">
              <a:extLst>
                <a:ext uri="{FF2B5EF4-FFF2-40B4-BE49-F238E27FC236}">
                  <a16:creationId xmlns:a16="http://schemas.microsoft.com/office/drawing/2014/main" xmlns="" id="{71405F6E-C595-8DDA-9A34-F52C67EB9D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7543" y="2537998"/>
              <a:ext cx="271137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.</a:t>
              </a:r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6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30" name="Rectangle 32">
              <a:extLst>
                <a:ext uri="{FF2B5EF4-FFF2-40B4-BE49-F238E27FC236}">
                  <a16:creationId xmlns:a16="http://schemas.microsoft.com/office/drawing/2014/main" xmlns="" id="{6C563BB7-B3F9-7B49-C9FC-3AA6768EE4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664" y="1541315"/>
              <a:ext cx="225949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.8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31" name="Rectangle 33">
              <a:extLst>
                <a:ext uri="{FF2B5EF4-FFF2-40B4-BE49-F238E27FC236}">
                  <a16:creationId xmlns:a16="http://schemas.microsoft.com/office/drawing/2014/main" xmlns="" id="{28E6E8DD-CE13-FA42-6C9C-94565F6CC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664" y="452023"/>
              <a:ext cx="225949" cy="202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1</a:t>
              </a:r>
              <a:r>
                <a:rPr lang="en-US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.</a:t>
              </a:r>
              <a:r>
                <a:rPr lang="ja-JP" altLang="ja-JP" sz="1126" dirty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endParaRPr lang="ja-JP" altLang="ja-JP" sz="1126" dirty="0">
                <a:cs typeface="Arial" panose="020B0604020202020204" pitchFamily="34" charset="0"/>
              </a:endParaRPr>
            </a:p>
          </p:txBody>
        </p:sp>
        <p:sp>
          <p:nvSpPr>
            <p:cNvPr id="32" name="Line 34">
              <a:extLst>
                <a:ext uri="{FF2B5EF4-FFF2-40B4-BE49-F238E27FC236}">
                  <a16:creationId xmlns:a16="http://schemas.microsoft.com/office/drawing/2014/main" xmlns="" id="{7C429964-39A9-5E43-52FC-7879B4948D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54400" y="403225"/>
              <a:ext cx="5637213" cy="5637213"/>
            </a:xfrm>
            <a:prstGeom prst="line">
              <a:avLst/>
            </a:prstGeom>
            <a:noFill/>
            <a:ln w="9525" cap="rnd">
              <a:solidFill>
                <a:srgbClr val="A9A9A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3" name="Freeform 35">
              <a:extLst>
                <a:ext uri="{FF2B5EF4-FFF2-40B4-BE49-F238E27FC236}">
                  <a16:creationId xmlns:a16="http://schemas.microsoft.com/office/drawing/2014/main" xmlns="" id="{07FD350F-D7B4-632C-766F-A15F50C8A15F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363" y="611188"/>
              <a:ext cx="5221288" cy="5221288"/>
            </a:xfrm>
            <a:custGeom>
              <a:avLst/>
              <a:gdLst>
                <a:gd name="T0" fmla="*/ 3074 w 3289"/>
                <a:gd name="T1" fmla="*/ 68 h 3289"/>
                <a:gd name="T2" fmla="*/ 3074 w 3289"/>
                <a:gd name="T3" fmla="*/ 168 h 3289"/>
                <a:gd name="T4" fmla="*/ 3074 w 3289"/>
                <a:gd name="T5" fmla="*/ 268 h 3289"/>
                <a:gd name="T6" fmla="*/ 2965 w 3289"/>
                <a:gd name="T7" fmla="*/ 336 h 3289"/>
                <a:gd name="T8" fmla="*/ 2803 w 3289"/>
                <a:gd name="T9" fmla="*/ 369 h 3289"/>
                <a:gd name="T10" fmla="*/ 2695 w 3289"/>
                <a:gd name="T11" fmla="*/ 403 h 3289"/>
                <a:gd name="T12" fmla="*/ 2533 w 3289"/>
                <a:gd name="T13" fmla="*/ 403 h 3289"/>
                <a:gd name="T14" fmla="*/ 2426 w 3289"/>
                <a:gd name="T15" fmla="*/ 436 h 3289"/>
                <a:gd name="T16" fmla="*/ 2265 w 3289"/>
                <a:gd name="T17" fmla="*/ 436 h 3289"/>
                <a:gd name="T18" fmla="*/ 2156 w 3289"/>
                <a:gd name="T19" fmla="*/ 471 h 3289"/>
                <a:gd name="T20" fmla="*/ 2048 w 3289"/>
                <a:gd name="T21" fmla="*/ 504 h 3289"/>
                <a:gd name="T22" fmla="*/ 1941 w 3289"/>
                <a:gd name="T23" fmla="*/ 571 h 3289"/>
                <a:gd name="T24" fmla="*/ 1833 w 3289"/>
                <a:gd name="T25" fmla="*/ 604 h 3289"/>
                <a:gd name="T26" fmla="*/ 1833 w 3289"/>
                <a:gd name="T27" fmla="*/ 705 h 3289"/>
                <a:gd name="T28" fmla="*/ 1618 w 3289"/>
                <a:gd name="T29" fmla="*/ 705 h 3289"/>
                <a:gd name="T30" fmla="*/ 1456 w 3289"/>
                <a:gd name="T31" fmla="*/ 705 h 3289"/>
                <a:gd name="T32" fmla="*/ 1347 w 3289"/>
                <a:gd name="T33" fmla="*/ 739 h 3289"/>
                <a:gd name="T34" fmla="*/ 1294 w 3289"/>
                <a:gd name="T35" fmla="*/ 805 h 3289"/>
                <a:gd name="T36" fmla="*/ 1132 w 3289"/>
                <a:gd name="T37" fmla="*/ 805 h 3289"/>
                <a:gd name="T38" fmla="*/ 1024 w 3289"/>
                <a:gd name="T39" fmla="*/ 840 h 3289"/>
                <a:gd name="T40" fmla="*/ 862 w 3289"/>
                <a:gd name="T41" fmla="*/ 840 h 3289"/>
                <a:gd name="T42" fmla="*/ 809 w 3289"/>
                <a:gd name="T43" fmla="*/ 907 h 3289"/>
                <a:gd name="T44" fmla="*/ 700 w 3289"/>
                <a:gd name="T45" fmla="*/ 940 h 3289"/>
                <a:gd name="T46" fmla="*/ 594 w 3289"/>
                <a:gd name="T47" fmla="*/ 973 h 3289"/>
                <a:gd name="T48" fmla="*/ 538 w 3289"/>
                <a:gd name="T49" fmla="*/ 1040 h 3289"/>
                <a:gd name="T50" fmla="*/ 376 w 3289"/>
                <a:gd name="T51" fmla="*/ 1073 h 3289"/>
                <a:gd name="T52" fmla="*/ 323 w 3289"/>
                <a:gd name="T53" fmla="*/ 1141 h 3289"/>
                <a:gd name="T54" fmla="*/ 270 w 3289"/>
                <a:gd name="T55" fmla="*/ 1208 h 3289"/>
                <a:gd name="T56" fmla="*/ 215 w 3289"/>
                <a:gd name="T57" fmla="*/ 1276 h 3289"/>
                <a:gd name="T58" fmla="*/ 215 w 3289"/>
                <a:gd name="T59" fmla="*/ 1376 h 3289"/>
                <a:gd name="T60" fmla="*/ 215 w 3289"/>
                <a:gd name="T61" fmla="*/ 1477 h 3289"/>
                <a:gd name="T62" fmla="*/ 108 w 3289"/>
                <a:gd name="T63" fmla="*/ 1509 h 3289"/>
                <a:gd name="T64" fmla="*/ 108 w 3289"/>
                <a:gd name="T65" fmla="*/ 1612 h 3289"/>
                <a:gd name="T66" fmla="*/ 108 w 3289"/>
                <a:gd name="T67" fmla="*/ 1712 h 3289"/>
                <a:gd name="T68" fmla="*/ 53 w 3289"/>
                <a:gd name="T69" fmla="*/ 1780 h 3289"/>
                <a:gd name="T70" fmla="*/ 53 w 3289"/>
                <a:gd name="T71" fmla="*/ 1913 h 3289"/>
                <a:gd name="T72" fmla="*/ 53 w 3289"/>
                <a:gd name="T73" fmla="*/ 2013 h 3289"/>
                <a:gd name="T74" fmla="*/ 53 w 3289"/>
                <a:gd name="T75" fmla="*/ 2148 h 3289"/>
                <a:gd name="T76" fmla="*/ 53 w 3289"/>
                <a:gd name="T77" fmla="*/ 2249 h 3289"/>
                <a:gd name="T78" fmla="*/ 53 w 3289"/>
                <a:gd name="T79" fmla="*/ 2349 h 3289"/>
                <a:gd name="T80" fmla="*/ 53 w 3289"/>
                <a:gd name="T81" fmla="*/ 2449 h 3289"/>
                <a:gd name="T82" fmla="*/ 53 w 3289"/>
                <a:gd name="T83" fmla="*/ 2550 h 3289"/>
                <a:gd name="T84" fmla="*/ 53 w 3289"/>
                <a:gd name="T85" fmla="*/ 2652 h 3289"/>
                <a:gd name="T86" fmla="*/ 0 w 3289"/>
                <a:gd name="T87" fmla="*/ 2718 h 3289"/>
                <a:gd name="T88" fmla="*/ 0 w 3289"/>
                <a:gd name="T89" fmla="*/ 2818 h 3289"/>
                <a:gd name="T90" fmla="*/ 0 w 3289"/>
                <a:gd name="T91" fmla="*/ 2920 h 3289"/>
                <a:gd name="T92" fmla="*/ 0 w 3289"/>
                <a:gd name="T93" fmla="*/ 3021 h 3289"/>
                <a:gd name="T94" fmla="*/ 0 w 3289"/>
                <a:gd name="T95" fmla="*/ 3154 h 3289"/>
                <a:gd name="T96" fmla="*/ 0 w 3289"/>
                <a:gd name="T97" fmla="*/ 3254 h 32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3289" h="3289">
                  <a:moveTo>
                    <a:pt x="3289" y="0"/>
                  </a:moveTo>
                  <a:lnTo>
                    <a:pt x="3074" y="35"/>
                  </a:lnTo>
                  <a:lnTo>
                    <a:pt x="3074" y="68"/>
                  </a:lnTo>
                  <a:lnTo>
                    <a:pt x="3074" y="100"/>
                  </a:lnTo>
                  <a:lnTo>
                    <a:pt x="3074" y="135"/>
                  </a:lnTo>
                  <a:lnTo>
                    <a:pt x="3074" y="168"/>
                  </a:lnTo>
                  <a:lnTo>
                    <a:pt x="3074" y="201"/>
                  </a:lnTo>
                  <a:lnTo>
                    <a:pt x="3074" y="236"/>
                  </a:lnTo>
                  <a:lnTo>
                    <a:pt x="3074" y="268"/>
                  </a:lnTo>
                  <a:lnTo>
                    <a:pt x="3074" y="303"/>
                  </a:lnTo>
                  <a:lnTo>
                    <a:pt x="3074" y="336"/>
                  </a:lnTo>
                  <a:lnTo>
                    <a:pt x="2965" y="336"/>
                  </a:lnTo>
                  <a:lnTo>
                    <a:pt x="2912" y="369"/>
                  </a:lnTo>
                  <a:lnTo>
                    <a:pt x="2856" y="369"/>
                  </a:lnTo>
                  <a:lnTo>
                    <a:pt x="2803" y="369"/>
                  </a:lnTo>
                  <a:lnTo>
                    <a:pt x="2750" y="369"/>
                  </a:lnTo>
                  <a:lnTo>
                    <a:pt x="2750" y="403"/>
                  </a:lnTo>
                  <a:lnTo>
                    <a:pt x="2695" y="403"/>
                  </a:lnTo>
                  <a:lnTo>
                    <a:pt x="2641" y="403"/>
                  </a:lnTo>
                  <a:lnTo>
                    <a:pt x="2588" y="403"/>
                  </a:lnTo>
                  <a:lnTo>
                    <a:pt x="2533" y="403"/>
                  </a:lnTo>
                  <a:lnTo>
                    <a:pt x="2480" y="403"/>
                  </a:lnTo>
                  <a:lnTo>
                    <a:pt x="2480" y="436"/>
                  </a:lnTo>
                  <a:lnTo>
                    <a:pt x="2426" y="436"/>
                  </a:lnTo>
                  <a:lnTo>
                    <a:pt x="2371" y="436"/>
                  </a:lnTo>
                  <a:lnTo>
                    <a:pt x="2318" y="436"/>
                  </a:lnTo>
                  <a:lnTo>
                    <a:pt x="2265" y="436"/>
                  </a:lnTo>
                  <a:lnTo>
                    <a:pt x="2209" y="436"/>
                  </a:lnTo>
                  <a:lnTo>
                    <a:pt x="2156" y="436"/>
                  </a:lnTo>
                  <a:lnTo>
                    <a:pt x="2156" y="471"/>
                  </a:lnTo>
                  <a:lnTo>
                    <a:pt x="2103" y="471"/>
                  </a:lnTo>
                  <a:lnTo>
                    <a:pt x="2048" y="471"/>
                  </a:lnTo>
                  <a:lnTo>
                    <a:pt x="2048" y="504"/>
                  </a:lnTo>
                  <a:lnTo>
                    <a:pt x="1994" y="504"/>
                  </a:lnTo>
                  <a:lnTo>
                    <a:pt x="1994" y="537"/>
                  </a:lnTo>
                  <a:lnTo>
                    <a:pt x="1941" y="571"/>
                  </a:lnTo>
                  <a:lnTo>
                    <a:pt x="1941" y="604"/>
                  </a:lnTo>
                  <a:lnTo>
                    <a:pt x="1886" y="604"/>
                  </a:lnTo>
                  <a:lnTo>
                    <a:pt x="1833" y="604"/>
                  </a:lnTo>
                  <a:lnTo>
                    <a:pt x="1833" y="637"/>
                  </a:lnTo>
                  <a:lnTo>
                    <a:pt x="1833" y="672"/>
                  </a:lnTo>
                  <a:lnTo>
                    <a:pt x="1833" y="705"/>
                  </a:lnTo>
                  <a:lnTo>
                    <a:pt x="1779" y="705"/>
                  </a:lnTo>
                  <a:lnTo>
                    <a:pt x="1724" y="705"/>
                  </a:lnTo>
                  <a:lnTo>
                    <a:pt x="1618" y="705"/>
                  </a:lnTo>
                  <a:lnTo>
                    <a:pt x="1564" y="705"/>
                  </a:lnTo>
                  <a:lnTo>
                    <a:pt x="1509" y="705"/>
                  </a:lnTo>
                  <a:lnTo>
                    <a:pt x="1456" y="705"/>
                  </a:lnTo>
                  <a:lnTo>
                    <a:pt x="1402" y="705"/>
                  </a:lnTo>
                  <a:lnTo>
                    <a:pt x="1402" y="739"/>
                  </a:lnTo>
                  <a:lnTo>
                    <a:pt x="1347" y="739"/>
                  </a:lnTo>
                  <a:lnTo>
                    <a:pt x="1294" y="739"/>
                  </a:lnTo>
                  <a:lnTo>
                    <a:pt x="1294" y="772"/>
                  </a:lnTo>
                  <a:lnTo>
                    <a:pt x="1294" y="805"/>
                  </a:lnTo>
                  <a:lnTo>
                    <a:pt x="1241" y="805"/>
                  </a:lnTo>
                  <a:lnTo>
                    <a:pt x="1185" y="805"/>
                  </a:lnTo>
                  <a:lnTo>
                    <a:pt x="1132" y="805"/>
                  </a:lnTo>
                  <a:lnTo>
                    <a:pt x="1079" y="805"/>
                  </a:lnTo>
                  <a:lnTo>
                    <a:pt x="1079" y="840"/>
                  </a:lnTo>
                  <a:lnTo>
                    <a:pt x="1024" y="840"/>
                  </a:lnTo>
                  <a:lnTo>
                    <a:pt x="970" y="840"/>
                  </a:lnTo>
                  <a:lnTo>
                    <a:pt x="917" y="840"/>
                  </a:lnTo>
                  <a:lnTo>
                    <a:pt x="862" y="840"/>
                  </a:lnTo>
                  <a:lnTo>
                    <a:pt x="862" y="872"/>
                  </a:lnTo>
                  <a:lnTo>
                    <a:pt x="862" y="907"/>
                  </a:lnTo>
                  <a:lnTo>
                    <a:pt x="809" y="907"/>
                  </a:lnTo>
                  <a:lnTo>
                    <a:pt x="809" y="940"/>
                  </a:lnTo>
                  <a:lnTo>
                    <a:pt x="755" y="940"/>
                  </a:lnTo>
                  <a:lnTo>
                    <a:pt x="700" y="940"/>
                  </a:lnTo>
                  <a:lnTo>
                    <a:pt x="647" y="940"/>
                  </a:lnTo>
                  <a:lnTo>
                    <a:pt x="647" y="973"/>
                  </a:lnTo>
                  <a:lnTo>
                    <a:pt x="594" y="973"/>
                  </a:lnTo>
                  <a:lnTo>
                    <a:pt x="538" y="973"/>
                  </a:lnTo>
                  <a:lnTo>
                    <a:pt x="538" y="1008"/>
                  </a:lnTo>
                  <a:lnTo>
                    <a:pt x="538" y="1040"/>
                  </a:lnTo>
                  <a:lnTo>
                    <a:pt x="538" y="1073"/>
                  </a:lnTo>
                  <a:lnTo>
                    <a:pt x="432" y="1073"/>
                  </a:lnTo>
                  <a:lnTo>
                    <a:pt x="376" y="1073"/>
                  </a:lnTo>
                  <a:lnTo>
                    <a:pt x="376" y="1108"/>
                  </a:lnTo>
                  <a:lnTo>
                    <a:pt x="323" y="1108"/>
                  </a:lnTo>
                  <a:lnTo>
                    <a:pt x="323" y="1141"/>
                  </a:lnTo>
                  <a:lnTo>
                    <a:pt x="323" y="1176"/>
                  </a:lnTo>
                  <a:lnTo>
                    <a:pt x="323" y="1208"/>
                  </a:lnTo>
                  <a:lnTo>
                    <a:pt x="270" y="1208"/>
                  </a:lnTo>
                  <a:lnTo>
                    <a:pt x="270" y="1241"/>
                  </a:lnTo>
                  <a:lnTo>
                    <a:pt x="215" y="1241"/>
                  </a:lnTo>
                  <a:lnTo>
                    <a:pt x="215" y="1276"/>
                  </a:lnTo>
                  <a:lnTo>
                    <a:pt x="215" y="1309"/>
                  </a:lnTo>
                  <a:lnTo>
                    <a:pt x="215" y="1343"/>
                  </a:lnTo>
                  <a:lnTo>
                    <a:pt x="215" y="1376"/>
                  </a:lnTo>
                  <a:lnTo>
                    <a:pt x="215" y="1409"/>
                  </a:lnTo>
                  <a:lnTo>
                    <a:pt x="215" y="1444"/>
                  </a:lnTo>
                  <a:lnTo>
                    <a:pt x="215" y="1477"/>
                  </a:lnTo>
                  <a:lnTo>
                    <a:pt x="161" y="1477"/>
                  </a:lnTo>
                  <a:lnTo>
                    <a:pt x="161" y="1509"/>
                  </a:lnTo>
                  <a:lnTo>
                    <a:pt x="108" y="1509"/>
                  </a:lnTo>
                  <a:lnTo>
                    <a:pt x="108" y="1544"/>
                  </a:lnTo>
                  <a:lnTo>
                    <a:pt x="108" y="1577"/>
                  </a:lnTo>
                  <a:lnTo>
                    <a:pt x="108" y="1612"/>
                  </a:lnTo>
                  <a:lnTo>
                    <a:pt x="108" y="1644"/>
                  </a:lnTo>
                  <a:lnTo>
                    <a:pt x="108" y="1677"/>
                  </a:lnTo>
                  <a:lnTo>
                    <a:pt x="108" y="1712"/>
                  </a:lnTo>
                  <a:lnTo>
                    <a:pt x="108" y="1745"/>
                  </a:lnTo>
                  <a:lnTo>
                    <a:pt x="108" y="1780"/>
                  </a:lnTo>
                  <a:lnTo>
                    <a:pt x="53" y="1780"/>
                  </a:lnTo>
                  <a:lnTo>
                    <a:pt x="53" y="1812"/>
                  </a:lnTo>
                  <a:lnTo>
                    <a:pt x="53" y="1845"/>
                  </a:lnTo>
                  <a:lnTo>
                    <a:pt x="53" y="1913"/>
                  </a:lnTo>
                  <a:lnTo>
                    <a:pt x="53" y="1946"/>
                  </a:lnTo>
                  <a:lnTo>
                    <a:pt x="53" y="1980"/>
                  </a:lnTo>
                  <a:lnTo>
                    <a:pt x="53" y="2013"/>
                  </a:lnTo>
                  <a:lnTo>
                    <a:pt x="53" y="2048"/>
                  </a:lnTo>
                  <a:lnTo>
                    <a:pt x="53" y="2081"/>
                  </a:lnTo>
                  <a:lnTo>
                    <a:pt x="53" y="2148"/>
                  </a:lnTo>
                  <a:lnTo>
                    <a:pt x="53" y="2181"/>
                  </a:lnTo>
                  <a:lnTo>
                    <a:pt x="53" y="2216"/>
                  </a:lnTo>
                  <a:lnTo>
                    <a:pt x="53" y="2249"/>
                  </a:lnTo>
                  <a:lnTo>
                    <a:pt x="53" y="2281"/>
                  </a:lnTo>
                  <a:lnTo>
                    <a:pt x="53" y="2316"/>
                  </a:lnTo>
                  <a:lnTo>
                    <a:pt x="53" y="2349"/>
                  </a:lnTo>
                  <a:lnTo>
                    <a:pt x="53" y="2382"/>
                  </a:lnTo>
                  <a:lnTo>
                    <a:pt x="53" y="2417"/>
                  </a:lnTo>
                  <a:lnTo>
                    <a:pt x="53" y="2449"/>
                  </a:lnTo>
                  <a:lnTo>
                    <a:pt x="53" y="2484"/>
                  </a:lnTo>
                  <a:lnTo>
                    <a:pt x="53" y="2517"/>
                  </a:lnTo>
                  <a:lnTo>
                    <a:pt x="53" y="2550"/>
                  </a:lnTo>
                  <a:lnTo>
                    <a:pt x="53" y="2584"/>
                  </a:lnTo>
                  <a:lnTo>
                    <a:pt x="53" y="2617"/>
                  </a:lnTo>
                  <a:lnTo>
                    <a:pt x="53" y="2652"/>
                  </a:lnTo>
                  <a:lnTo>
                    <a:pt x="53" y="2685"/>
                  </a:lnTo>
                  <a:lnTo>
                    <a:pt x="0" y="2685"/>
                  </a:lnTo>
                  <a:lnTo>
                    <a:pt x="0" y="2718"/>
                  </a:lnTo>
                  <a:lnTo>
                    <a:pt x="0" y="2752"/>
                  </a:lnTo>
                  <a:lnTo>
                    <a:pt x="0" y="2785"/>
                  </a:lnTo>
                  <a:lnTo>
                    <a:pt x="0" y="2818"/>
                  </a:lnTo>
                  <a:lnTo>
                    <a:pt x="0" y="2853"/>
                  </a:lnTo>
                  <a:lnTo>
                    <a:pt x="0" y="2886"/>
                  </a:lnTo>
                  <a:lnTo>
                    <a:pt x="0" y="2920"/>
                  </a:lnTo>
                  <a:lnTo>
                    <a:pt x="0" y="2953"/>
                  </a:lnTo>
                  <a:lnTo>
                    <a:pt x="0" y="2986"/>
                  </a:lnTo>
                  <a:lnTo>
                    <a:pt x="0" y="3021"/>
                  </a:lnTo>
                  <a:lnTo>
                    <a:pt x="0" y="3053"/>
                  </a:lnTo>
                  <a:lnTo>
                    <a:pt x="0" y="3121"/>
                  </a:lnTo>
                  <a:lnTo>
                    <a:pt x="0" y="3154"/>
                  </a:lnTo>
                  <a:lnTo>
                    <a:pt x="0" y="3189"/>
                  </a:lnTo>
                  <a:lnTo>
                    <a:pt x="0" y="3221"/>
                  </a:lnTo>
                  <a:lnTo>
                    <a:pt x="0" y="3254"/>
                  </a:lnTo>
                  <a:lnTo>
                    <a:pt x="0" y="3289"/>
                  </a:lnTo>
                </a:path>
              </a:pathLst>
            </a:custGeom>
            <a:noFill/>
            <a:ln w="28575" cap="rnd">
              <a:solidFill>
                <a:schemeClr val="accent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 dirty="0"/>
            </a:p>
          </p:txBody>
        </p:sp>
        <p:sp>
          <p:nvSpPr>
            <p:cNvPr id="34" name="Freeform 38">
              <a:extLst>
                <a:ext uri="{FF2B5EF4-FFF2-40B4-BE49-F238E27FC236}">
                  <a16:creationId xmlns:a16="http://schemas.microsoft.com/office/drawing/2014/main" xmlns="" id="{F462F06A-1227-EDC2-0268-1A69E1A62723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363" y="611188"/>
              <a:ext cx="5221288" cy="5221288"/>
            </a:xfrm>
            <a:custGeom>
              <a:avLst/>
              <a:gdLst>
                <a:gd name="T0" fmla="*/ 3235 w 3289"/>
                <a:gd name="T1" fmla="*/ 0 h 3289"/>
                <a:gd name="T2" fmla="*/ 3127 w 3289"/>
                <a:gd name="T3" fmla="*/ 0 h 3289"/>
                <a:gd name="T4" fmla="*/ 3018 w 3289"/>
                <a:gd name="T5" fmla="*/ 0 h 3289"/>
                <a:gd name="T6" fmla="*/ 2912 w 3289"/>
                <a:gd name="T7" fmla="*/ 0 h 3289"/>
                <a:gd name="T8" fmla="*/ 2856 w 3289"/>
                <a:gd name="T9" fmla="*/ 35 h 3289"/>
                <a:gd name="T10" fmla="*/ 2750 w 3289"/>
                <a:gd name="T11" fmla="*/ 35 h 3289"/>
                <a:gd name="T12" fmla="*/ 2750 w 3289"/>
                <a:gd name="T13" fmla="*/ 100 h 3289"/>
                <a:gd name="T14" fmla="*/ 2641 w 3289"/>
                <a:gd name="T15" fmla="*/ 100 h 3289"/>
                <a:gd name="T16" fmla="*/ 2480 w 3289"/>
                <a:gd name="T17" fmla="*/ 100 h 3289"/>
                <a:gd name="T18" fmla="*/ 2480 w 3289"/>
                <a:gd name="T19" fmla="*/ 168 h 3289"/>
                <a:gd name="T20" fmla="*/ 2426 w 3289"/>
                <a:gd name="T21" fmla="*/ 201 h 3289"/>
                <a:gd name="T22" fmla="*/ 2371 w 3289"/>
                <a:gd name="T23" fmla="*/ 268 h 3289"/>
                <a:gd name="T24" fmla="*/ 2371 w 3289"/>
                <a:gd name="T25" fmla="*/ 336 h 3289"/>
                <a:gd name="T26" fmla="*/ 2265 w 3289"/>
                <a:gd name="T27" fmla="*/ 336 h 3289"/>
                <a:gd name="T28" fmla="*/ 2156 w 3289"/>
                <a:gd name="T29" fmla="*/ 336 h 3289"/>
                <a:gd name="T30" fmla="*/ 2048 w 3289"/>
                <a:gd name="T31" fmla="*/ 336 h 3289"/>
                <a:gd name="T32" fmla="*/ 1994 w 3289"/>
                <a:gd name="T33" fmla="*/ 369 h 3289"/>
                <a:gd name="T34" fmla="*/ 1941 w 3289"/>
                <a:gd name="T35" fmla="*/ 403 h 3289"/>
                <a:gd name="T36" fmla="*/ 1833 w 3289"/>
                <a:gd name="T37" fmla="*/ 403 h 3289"/>
                <a:gd name="T38" fmla="*/ 1779 w 3289"/>
                <a:gd name="T39" fmla="*/ 436 h 3289"/>
                <a:gd name="T40" fmla="*/ 1724 w 3289"/>
                <a:gd name="T41" fmla="*/ 471 h 3289"/>
                <a:gd name="T42" fmla="*/ 1618 w 3289"/>
                <a:gd name="T43" fmla="*/ 471 h 3289"/>
                <a:gd name="T44" fmla="*/ 1456 w 3289"/>
                <a:gd name="T45" fmla="*/ 471 h 3289"/>
                <a:gd name="T46" fmla="*/ 1402 w 3289"/>
                <a:gd name="T47" fmla="*/ 504 h 3289"/>
                <a:gd name="T48" fmla="*/ 1294 w 3289"/>
                <a:gd name="T49" fmla="*/ 504 h 3289"/>
                <a:gd name="T50" fmla="*/ 1294 w 3289"/>
                <a:gd name="T51" fmla="*/ 571 h 3289"/>
                <a:gd name="T52" fmla="*/ 1185 w 3289"/>
                <a:gd name="T53" fmla="*/ 571 h 3289"/>
                <a:gd name="T54" fmla="*/ 1185 w 3289"/>
                <a:gd name="T55" fmla="*/ 637 h 3289"/>
                <a:gd name="T56" fmla="*/ 1132 w 3289"/>
                <a:gd name="T57" fmla="*/ 672 h 3289"/>
                <a:gd name="T58" fmla="*/ 1024 w 3289"/>
                <a:gd name="T59" fmla="*/ 672 h 3289"/>
                <a:gd name="T60" fmla="*/ 970 w 3289"/>
                <a:gd name="T61" fmla="*/ 705 h 3289"/>
                <a:gd name="T62" fmla="*/ 862 w 3289"/>
                <a:gd name="T63" fmla="*/ 705 h 3289"/>
                <a:gd name="T64" fmla="*/ 755 w 3289"/>
                <a:gd name="T65" fmla="*/ 705 h 3289"/>
                <a:gd name="T66" fmla="*/ 647 w 3289"/>
                <a:gd name="T67" fmla="*/ 705 h 3289"/>
                <a:gd name="T68" fmla="*/ 647 w 3289"/>
                <a:gd name="T69" fmla="*/ 772 h 3289"/>
                <a:gd name="T70" fmla="*/ 594 w 3289"/>
                <a:gd name="T71" fmla="*/ 840 h 3289"/>
                <a:gd name="T72" fmla="*/ 594 w 3289"/>
                <a:gd name="T73" fmla="*/ 907 h 3289"/>
                <a:gd name="T74" fmla="*/ 594 w 3289"/>
                <a:gd name="T75" fmla="*/ 973 h 3289"/>
                <a:gd name="T76" fmla="*/ 538 w 3289"/>
                <a:gd name="T77" fmla="*/ 1008 h 3289"/>
                <a:gd name="T78" fmla="*/ 538 w 3289"/>
                <a:gd name="T79" fmla="*/ 1073 h 3289"/>
                <a:gd name="T80" fmla="*/ 485 w 3289"/>
                <a:gd name="T81" fmla="*/ 1108 h 3289"/>
                <a:gd name="T82" fmla="*/ 376 w 3289"/>
                <a:gd name="T83" fmla="*/ 1141 h 3289"/>
                <a:gd name="T84" fmla="*/ 323 w 3289"/>
                <a:gd name="T85" fmla="*/ 1176 h 3289"/>
                <a:gd name="T86" fmla="*/ 323 w 3289"/>
                <a:gd name="T87" fmla="*/ 1241 h 3289"/>
                <a:gd name="T88" fmla="*/ 215 w 3289"/>
                <a:gd name="T89" fmla="*/ 1241 h 3289"/>
                <a:gd name="T90" fmla="*/ 215 w 3289"/>
                <a:gd name="T91" fmla="*/ 1309 h 3289"/>
                <a:gd name="T92" fmla="*/ 108 w 3289"/>
                <a:gd name="T93" fmla="*/ 1309 h 3289"/>
                <a:gd name="T94" fmla="*/ 53 w 3289"/>
                <a:gd name="T95" fmla="*/ 1343 h 3289"/>
                <a:gd name="T96" fmla="*/ 53 w 3289"/>
                <a:gd name="T97" fmla="*/ 1409 h 3289"/>
                <a:gd name="T98" fmla="*/ 53 w 3289"/>
                <a:gd name="T99" fmla="*/ 1477 h 3289"/>
                <a:gd name="T100" fmla="*/ 53 w 3289"/>
                <a:gd name="T101" fmla="*/ 1544 h 3289"/>
                <a:gd name="T102" fmla="*/ 53 w 3289"/>
                <a:gd name="T103" fmla="*/ 1612 h 3289"/>
                <a:gd name="T104" fmla="*/ 53 w 3289"/>
                <a:gd name="T105" fmla="*/ 1677 h 3289"/>
                <a:gd name="T106" fmla="*/ 53 w 3289"/>
                <a:gd name="T107" fmla="*/ 1745 h 3289"/>
                <a:gd name="T108" fmla="*/ 53 w 3289"/>
                <a:gd name="T109" fmla="*/ 1812 h 3289"/>
                <a:gd name="T110" fmla="*/ 53 w 3289"/>
                <a:gd name="T111" fmla="*/ 1880 h 3289"/>
                <a:gd name="T112" fmla="*/ 53 w 3289"/>
                <a:gd name="T113" fmla="*/ 1946 h 3289"/>
                <a:gd name="T114" fmla="*/ 53 w 3289"/>
                <a:gd name="T115" fmla="*/ 2013 h 3289"/>
                <a:gd name="T116" fmla="*/ 53 w 3289"/>
                <a:gd name="T117" fmla="*/ 2081 h 3289"/>
                <a:gd name="T118" fmla="*/ 53 w 3289"/>
                <a:gd name="T119" fmla="*/ 2148 h 3289"/>
                <a:gd name="T120" fmla="*/ 53 w 3289"/>
                <a:gd name="T121" fmla="*/ 2216 h 3289"/>
                <a:gd name="T122" fmla="*/ 53 w 3289"/>
                <a:gd name="T123" fmla="*/ 2281 h 3289"/>
                <a:gd name="T124" fmla="*/ 53 w 3289"/>
                <a:gd name="T125" fmla="*/ 2349 h 32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289" h="3289">
                  <a:moveTo>
                    <a:pt x="3289" y="0"/>
                  </a:moveTo>
                  <a:lnTo>
                    <a:pt x="3235" y="0"/>
                  </a:lnTo>
                  <a:lnTo>
                    <a:pt x="3180" y="0"/>
                  </a:lnTo>
                  <a:lnTo>
                    <a:pt x="3127" y="0"/>
                  </a:lnTo>
                  <a:lnTo>
                    <a:pt x="3074" y="0"/>
                  </a:lnTo>
                  <a:lnTo>
                    <a:pt x="3018" y="0"/>
                  </a:lnTo>
                  <a:lnTo>
                    <a:pt x="2965" y="0"/>
                  </a:lnTo>
                  <a:lnTo>
                    <a:pt x="2912" y="0"/>
                  </a:lnTo>
                  <a:lnTo>
                    <a:pt x="2856" y="0"/>
                  </a:lnTo>
                  <a:lnTo>
                    <a:pt x="2856" y="35"/>
                  </a:lnTo>
                  <a:lnTo>
                    <a:pt x="2803" y="35"/>
                  </a:lnTo>
                  <a:lnTo>
                    <a:pt x="2750" y="35"/>
                  </a:lnTo>
                  <a:lnTo>
                    <a:pt x="2750" y="68"/>
                  </a:lnTo>
                  <a:lnTo>
                    <a:pt x="2750" y="100"/>
                  </a:lnTo>
                  <a:lnTo>
                    <a:pt x="2695" y="100"/>
                  </a:lnTo>
                  <a:lnTo>
                    <a:pt x="2641" y="100"/>
                  </a:lnTo>
                  <a:lnTo>
                    <a:pt x="2533" y="100"/>
                  </a:lnTo>
                  <a:lnTo>
                    <a:pt x="2480" y="100"/>
                  </a:lnTo>
                  <a:lnTo>
                    <a:pt x="2480" y="135"/>
                  </a:lnTo>
                  <a:lnTo>
                    <a:pt x="2480" y="168"/>
                  </a:lnTo>
                  <a:lnTo>
                    <a:pt x="2480" y="201"/>
                  </a:lnTo>
                  <a:lnTo>
                    <a:pt x="2426" y="201"/>
                  </a:lnTo>
                  <a:lnTo>
                    <a:pt x="2371" y="236"/>
                  </a:lnTo>
                  <a:lnTo>
                    <a:pt x="2371" y="268"/>
                  </a:lnTo>
                  <a:lnTo>
                    <a:pt x="2371" y="303"/>
                  </a:lnTo>
                  <a:lnTo>
                    <a:pt x="2371" y="336"/>
                  </a:lnTo>
                  <a:lnTo>
                    <a:pt x="2318" y="336"/>
                  </a:lnTo>
                  <a:lnTo>
                    <a:pt x="2265" y="336"/>
                  </a:lnTo>
                  <a:lnTo>
                    <a:pt x="2209" y="336"/>
                  </a:lnTo>
                  <a:lnTo>
                    <a:pt x="2156" y="336"/>
                  </a:lnTo>
                  <a:lnTo>
                    <a:pt x="2103" y="336"/>
                  </a:lnTo>
                  <a:lnTo>
                    <a:pt x="2048" y="336"/>
                  </a:lnTo>
                  <a:lnTo>
                    <a:pt x="1994" y="336"/>
                  </a:lnTo>
                  <a:lnTo>
                    <a:pt x="1994" y="369"/>
                  </a:lnTo>
                  <a:lnTo>
                    <a:pt x="1994" y="403"/>
                  </a:lnTo>
                  <a:lnTo>
                    <a:pt x="1941" y="403"/>
                  </a:lnTo>
                  <a:lnTo>
                    <a:pt x="1886" y="403"/>
                  </a:lnTo>
                  <a:lnTo>
                    <a:pt x="1833" y="403"/>
                  </a:lnTo>
                  <a:lnTo>
                    <a:pt x="1779" y="403"/>
                  </a:lnTo>
                  <a:lnTo>
                    <a:pt x="1779" y="436"/>
                  </a:lnTo>
                  <a:lnTo>
                    <a:pt x="1724" y="436"/>
                  </a:lnTo>
                  <a:lnTo>
                    <a:pt x="1724" y="471"/>
                  </a:lnTo>
                  <a:lnTo>
                    <a:pt x="1671" y="471"/>
                  </a:lnTo>
                  <a:lnTo>
                    <a:pt x="1618" y="471"/>
                  </a:lnTo>
                  <a:lnTo>
                    <a:pt x="1564" y="471"/>
                  </a:lnTo>
                  <a:lnTo>
                    <a:pt x="1456" y="471"/>
                  </a:lnTo>
                  <a:lnTo>
                    <a:pt x="1456" y="504"/>
                  </a:lnTo>
                  <a:lnTo>
                    <a:pt x="1402" y="504"/>
                  </a:lnTo>
                  <a:lnTo>
                    <a:pt x="1347" y="504"/>
                  </a:lnTo>
                  <a:lnTo>
                    <a:pt x="1294" y="504"/>
                  </a:lnTo>
                  <a:lnTo>
                    <a:pt x="1294" y="537"/>
                  </a:lnTo>
                  <a:lnTo>
                    <a:pt x="1294" y="571"/>
                  </a:lnTo>
                  <a:lnTo>
                    <a:pt x="1241" y="571"/>
                  </a:lnTo>
                  <a:lnTo>
                    <a:pt x="1185" y="571"/>
                  </a:lnTo>
                  <a:lnTo>
                    <a:pt x="1185" y="604"/>
                  </a:lnTo>
                  <a:lnTo>
                    <a:pt x="1185" y="637"/>
                  </a:lnTo>
                  <a:lnTo>
                    <a:pt x="1132" y="637"/>
                  </a:lnTo>
                  <a:lnTo>
                    <a:pt x="1132" y="672"/>
                  </a:lnTo>
                  <a:lnTo>
                    <a:pt x="1079" y="672"/>
                  </a:lnTo>
                  <a:lnTo>
                    <a:pt x="1024" y="672"/>
                  </a:lnTo>
                  <a:lnTo>
                    <a:pt x="970" y="672"/>
                  </a:lnTo>
                  <a:lnTo>
                    <a:pt x="970" y="705"/>
                  </a:lnTo>
                  <a:lnTo>
                    <a:pt x="917" y="705"/>
                  </a:lnTo>
                  <a:lnTo>
                    <a:pt x="862" y="705"/>
                  </a:lnTo>
                  <a:lnTo>
                    <a:pt x="809" y="705"/>
                  </a:lnTo>
                  <a:lnTo>
                    <a:pt x="755" y="705"/>
                  </a:lnTo>
                  <a:lnTo>
                    <a:pt x="700" y="705"/>
                  </a:lnTo>
                  <a:lnTo>
                    <a:pt x="647" y="705"/>
                  </a:lnTo>
                  <a:lnTo>
                    <a:pt x="647" y="739"/>
                  </a:lnTo>
                  <a:lnTo>
                    <a:pt x="647" y="772"/>
                  </a:lnTo>
                  <a:lnTo>
                    <a:pt x="647" y="805"/>
                  </a:lnTo>
                  <a:lnTo>
                    <a:pt x="594" y="840"/>
                  </a:lnTo>
                  <a:lnTo>
                    <a:pt x="594" y="872"/>
                  </a:lnTo>
                  <a:lnTo>
                    <a:pt x="594" y="907"/>
                  </a:lnTo>
                  <a:lnTo>
                    <a:pt x="594" y="940"/>
                  </a:lnTo>
                  <a:lnTo>
                    <a:pt x="594" y="973"/>
                  </a:lnTo>
                  <a:lnTo>
                    <a:pt x="538" y="973"/>
                  </a:lnTo>
                  <a:lnTo>
                    <a:pt x="538" y="1008"/>
                  </a:lnTo>
                  <a:lnTo>
                    <a:pt x="538" y="1040"/>
                  </a:lnTo>
                  <a:lnTo>
                    <a:pt x="538" y="1073"/>
                  </a:lnTo>
                  <a:lnTo>
                    <a:pt x="538" y="1108"/>
                  </a:lnTo>
                  <a:lnTo>
                    <a:pt x="485" y="1108"/>
                  </a:lnTo>
                  <a:lnTo>
                    <a:pt x="432" y="1141"/>
                  </a:lnTo>
                  <a:lnTo>
                    <a:pt x="376" y="1141"/>
                  </a:lnTo>
                  <a:lnTo>
                    <a:pt x="376" y="1176"/>
                  </a:lnTo>
                  <a:lnTo>
                    <a:pt x="323" y="1176"/>
                  </a:lnTo>
                  <a:lnTo>
                    <a:pt x="323" y="1208"/>
                  </a:lnTo>
                  <a:lnTo>
                    <a:pt x="323" y="1241"/>
                  </a:lnTo>
                  <a:lnTo>
                    <a:pt x="270" y="1241"/>
                  </a:lnTo>
                  <a:lnTo>
                    <a:pt x="215" y="1241"/>
                  </a:lnTo>
                  <a:lnTo>
                    <a:pt x="215" y="1276"/>
                  </a:lnTo>
                  <a:lnTo>
                    <a:pt x="215" y="1309"/>
                  </a:lnTo>
                  <a:lnTo>
                    <a:pt x="161" y="1309"/>
                  </a:lnTo>
                  <a:lnTo>
                    <a:pt x="108" y="1309"/>
                  </a:lnTo>
                  <a:lnTo>
                    <a:pt x="108" y="1343"/>
                  </a:lnTo>
                  <a:lnTo>
                    <a:pt x="53" y="1343"/>
                  </a:lnTo>
                  <a:lnTo>
                    <a:pt x="53" y="1376"/>
                  </a:lnTo>
                  <a:lnTo>
                    <a:pt x="53" y="1409"/>
                  </a:lnTo>
                  <a:lnTo>
                    <a:pt x="53" y="1444"/>
                  </a:lnTo>
                  <a:lnTo>
                    <a:pt x="53" y="1477"/>
                  </a:lnTo>
                  <a:lnTo>
                    <a:pt x="53" y="1509"/>
                  </a:lnTo>
                  <a:lnTo>
                    <a:pt x="53" y="1544"/>
                  </a:lnTo>
                  <a:lnTo>
                    <a:pt x="53" y="1577"/>
                  </a:lnTo>
                  <a:lnTo>
                    <a:pt x="53" y="1612"/>
                  </a:lnTo>
                  <a:lnTo>
                    <a:pt x="53" y="1644"/>
                  </a:lnTo>
                  <a:lnTo>
                    <a:pt x="53" y="1677"/>
                  </a:lnTo>
                  <a:lnTo>
                    <a:pt x="53" y="1712"/>
                  </a:lnTo>
                  <a:lnTo>
                    <a:pt x="53" y="1745"/>
                  </a:lnTo>
                  <a:lnTo>
                    <a:pt x="53" y="1780"/>
                  </a:lnTo>
                  <a:lnTo>
                    <a:pt x="53" y="1812"/>
                  </a:lnTo>
                  <a:lnTo>
                    <a:pt x="53" y="1845"/>
                  </a:lnTo>
                  <a:lnTo>
                    <a:pt x="53" y="1880"/>
                  </a:lnTo>
                  <a:lnTo>
                    <a:pt x="53" y="1913"/>
                  </a:lnTo>
                  <a:lnTo>
                    <a:pt x="53" y="1946"/>
                  </a:lnTo>
                  <a:lnTo>
                    <a:pt x="53" y="1980"/>
                  </a:lnTo>
                  <a:lnTo>
                    <a:pt x="53" y="2013"/>
                  </a:lnTo>
                  <a:lnTo>
                    <a:pt x="53" y="2048"/>
                  </a:lnTo>
                  <a:lnTo>
                    <a:pt x="53" y="2081"/>
                  </a:lnTo>
                  <a:lnTo>
                    <a:pt x="53" y="2113"/>
                  </a:lnTo>
                  <a:lnTo>
                    <a:pt x="53" y="2148"/>
                  </a:lnTo>
                  <a:lnTo>
                    <a:pt x="53" y="2181"/>
                  </a:lnTo>
                  <a:lnTo>
                    <a:pt x="53" y="2216"/>
                  </a:lnTo>
                  <a:lnTo>
                    <a:pt x="53" y="2249"/>
                  </a:lnTo>
                  <a:lnTo>
                    <a:pt x="53" y="2281"/>
                  </a:lnTo>
                  <a:lnTo>
                    <a:pt x="53" y="2316"/>
                  </a:lnTo>
                  <a:lnTo>
                    <a:pt x="53" y="2349"/>
                  </a:lnTo>
                  <a:lnTo>
                    <a:pt x="0" y="3289"/>
                  </a:lnTo>
                </a:path>
              </a:pathLst>
            </a:custGeom>
            <a:noFill/>
            <a:ln w="285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 dirty="0"/>
            </a:p>
          </p:txBody>
        </p:sp>
        <p:sp>
          <p:nvSpPr>
            <p:cNvPr id="35" name="AutoShape 3">
              <a:extLst>
                <a:ext uri="{FF2B5EF4-FFF2-40B4-BE49-F238E27FC236}">
                  <a16:creationId xmlns:a16="http://schemas.microsoft.com/office/drawing/2014/main" xmlns="" id="{896603CE-8A74-998F-D3F0-FB6EE9F78D9E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6392890" y="3786322"/>
              <a:ext cx="2686286" cy="9796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ja-JP" altLang="ja-JP" sz="1761" dirty="0">
                  <a:solidFill>
                    <a:srgbClr val="FF0000"/>
                  </a:solidFill>
                  <a:latin typeface="Helvetica" panose="020B0604020202020204" pitchFamily="34" charset="0"/>
                </a:rPr>
                <a:t>APOA2-</a:t>
              </a:r>
              <a:r>
                <a:rPr lang="en-US" altLang="ja-JP" sz="1761" dirty="0">
                  <a:solidFill>
                    <a:srgbClr val="FF0000"/>
                  </a:solidFill>
                  <a:latin typeface="Helvetica" panose="020B0604020202020204" pitchFamily="34" charset="0"/>
                </a:rPr>
                <a:t>ATQ/AT</a:t>
              </a:r>
              <a:endParaRPr lang="ja-JP" altLang="ja-JP" sz="1761" dirty="0">
                <a:solidFill>
                  <a:srgbClr val="FF0000"/>
                </a:solidFill>
                <a:latin typeface="Arial" panose="020B0604020202020204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761" dirty="0">
                  <a:solidFill>
                    <a:srgbClr val="FF0000"/>
                  </a:solidFill>
                  <a:latin typeface="Helvetica" panose="020B0604020202020204" pitchFamily="34" charset="0"/>
                </a:rPr>
                <a:t>AUC=0.836</a:t>
              </a:r>
              <a:endParaRPr lang="ja-JP" altLang="ja-JP" sz="2347" dirty="0">
                <a:solidFill>
                  <a:srgbClr val="FF0000"/>
                </a:solidFill>
              </a:endParaRP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1761" dirty="0">
                  <a:solidFill>
                    <a:srgbClr val="FF0000"/>
                  </a:solidFill>
                  <a:latin typeface="Helvetica" panose="020B0604020202020204" pitchFamily="34" charset="0"/>
                </a:rPr>
                <a:t>(95% CI, 0.774-0.898</a:t>
              </a:r>
              <a:r>
                <a:rPr lang="ja-JP" altLang="ja-JP" sz="1761" dirty="0">
                  <a:solidFill>
                    <a:srgbClr val="FF0000"/>
                  </a:solidFill>
                  <a:latin typeface="Helvetica" panose="020B0604020202020204" pitchFamily="34" charset="0"/>
                </a:rPr>
                <a:t>)</a:t>
              </a:r>
              <a:endParaRPr lang="ja-JP" altLang="ja-JP" sz="2347" dirty="0">
                <a:solidFill>
                  <a:srgbClr val="FF0000"/>
                </a:solidFill>
              </a:endParaRPr>
            </a:p>
          </p:txBody>
        </p:sp>
        <p:sp>
          <p:nvSpPr>
            <p:cNvPr id="36" name="Rectangle 85">
              <a:extLst>
                <a:ext uri="{FF2B5EF4-FFF2-40B4-BE49-F238E27FC236}">
                  <a16:creationId xmlns:a16="http://schemas.microsoft.com/office/drawing/2014/main" xmlns="" id="{57178632-AA26-8B88-3353-9516435E04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95671" y="4773862"/>
              <a:ext cx="2960374" cy="950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ja-JP" altLang="ja-JP" sz="1761" dirty="0">
                  <a:solidFill>
                    <a:schemeClr val="accent1"/>
                  </a:solidFill>
                  <a:latin typeface="Helvetica" panose="020B0604020202020204" pitchFamily="34" charset="0"/>
                </a:rPr>
                <a:t>CA19-9</a:t>
              </a:r>
              <a:endParaRPr lang="ja-JP" altLang="ja-JP" sz="1761" dirty="0">
                <a:solidFill>
                  <a:schemeClr val="accent1"/>
                </a:solidFill>
              </a:endParaRPr>
            </a:p>
            <a:p>
              <a:pPr defTabSz="894435"/>
              <a:r>
                <a:rPr lang="ja-JP" altLang="ja-JP" sz="1761" dirty="0">
                  <a:solidFill>
                    <a:schemeClr val="accent1"/>
                  </a:solidFill>
                  <a:latin typeface="Helvetica" panose="020B0604020202020204" pitchFamily="34" charset="0"/>
                </a:rPr>
                <a:t>AUC: </a:t>
              </a:r>
              <a:r>
                <a:rPr lang="en-US" altLang="ja-JP" sz="1761" dirty="0">
                  <a:solidFill>
                    <a:schemeClr val="accent1"/>
                  </a:solidFill>
                  <a:latin typeface="Helvetica" panose="020B0604020202020204" pitchFamily="34" charset="0"/>
                </a:rPr>
                <a:t>0.783</a:t>
              </a:r>
            </a:p>
            <a:p>
              <a:pPr defTabSz="894435"/>
              <a:r>
                <a:rPr lang="en-US" altLang="ja-JP" sz="1761" dirty="0">
                  <a:solidFill>
                    <a:schemeClr val="accent1"/>
                  </a:solidFill>
                  <a:latin typeface="Helvetica" panose="020B0604020202020204" pitchFamily="34" charset="0"/>
                </a:rPr>
                <a:t>(95% CI</a:t>
              </a:r>
              <a:r>
                <a:rPr lang="en-US" altLang="ja-JP" sz="1761">
                  <a:solidFill>
                    <a:schemeClr val="accent1"/>
                  </a:solidFill>
                  <a:latin typeface="Helvetica" panose="020B0604020202020204" pitchFamily="34" charset="0"/>
                </a:rPr>
                <a:t>, 0.710-0.855 </a:t>
              </a:r>
              <a:r>
                <a:rPr lang="ja-JP" altLang="ja-JP" sz="1761" dirty="0">
                  <a:solidFill>
                    <a:schemeClr val="accent1"/>
                  </a:solidFill>
                  <a:latin typeface="Helvetica" panose="020B0604020202020204" pitchFamily="34" charset="0"/>
                </a:rPr>
                <a:t>)</a:t>
              </a:r>
              <a:endParaRPr lang="ja-JP" altLang="ja-JP" sz="1761" dirty="0">
                <a:solidFill>
                  <a:schemeClr val="accent1"/>
                </a:solidFill>
              </a:endParaRPr>
            </a:p>
          </p:txBody>
        </p:sp>
      </p:grpSp>
      <p:sp>
        <p:nvSpPr>
          <p:cNvPr id="38" name="タイトル 1">
            <a:extLst>
              <a:ext uri="{FF2B5EF4-FFF2-40B4-BE49-F238E27FC236}">
                <a16:creationId xmlns:a16="http://schemas.microsoft.com/office/drawing/2014/main" xmlns="" id="{5013F604-5486-D88D-7AD1-460A1AE46772}"/>
              </a:ext>
            </a:extLst>
          </p:cNvPr>
          <p:cNvSpPr txBox="1">
            <a:spLocks/>
          </p:cNvSpPr>
          <p:nvPr/>
        </p:nvSpPr>
        <p:spPr>
          <a:xfrm rot="10800000" flipV="1">
            <a:off x="281419" y="6463581"/>
            <a:ext cx="6029433" cy="626154"/>
          </a:xfrm>
          <a:prstGeom prst="rect">
            <a:avLst/>
          </a:prstGeom>
        </p:spPr>
        <p:txBody>
          <a:bodyPr vert="horz" lIns="89548" tIns="44774" rIns="89548" bIns="44774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71595"/>
            <a:r>
              <a:rPr lang="en-US" altLang="ja-JP" sz="1174" b="1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5. </a:t>
            </a:r>
            <a:r>
              <a:rPr lang="en-US" altLang="ja-JP" sz="1174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Blinded confirmation study for ROCs and AUCs of apoA2-ATQ/AT and CA19-9 (red line: apoA2-ATQ/AT, blue line: CA19-9) between healthy controls and all stages of pancreatic cancer by NCI EDRN.</a:t>
            </a:r>
            <a:endParaRPr lang="ja-JP" altLang="en-US" sz="1174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4720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AutoShape 3">
            <a:extLst>
              <a:ext uri="{FF2B5EF4-FFF2-40B4-BE49-F238E27FC236}">
                <a16:creationId xmlns:a16="http://schemas.microsoft.com/office/drawing/2014/main" xmlns="" id="{546E8001-4EFB-DA5A-EFA3-61CB13EDD91F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833227" y="469502"/>
            <a:ext cx="5445552" cy="5445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dirty="0"/>
          </a:p>
        </p:txBody>
      </p:sp>
      <p:sp>
        <p:nvSpPr>
          <p:cNvPr id="12" name="Rectangle 5">
            <a:extLst>
              <a:ext uri="{FF2B5EF4-FFF2-40B4-BE49-F238E27FC236}">
                <a16:creationId xmlns:a16="http://schemas.microsoft.com/office/drawing/2014/main" xmlns="" id="{82785B6D-70B4-04B5-D9AD-121B89405C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0666" y="2339033"/>
            <a:ext cx="416141" cy="673901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6">
            <a:extLst>
              <a:ext uri="{FF2B5EF4-FFF2-40B4-BE49-F238E27FC236}">
                <a16:creationId xmlns:a16="http://schemas.microsoft.com/office/drawing/2014/main" xmlns="" id="{63365CAE-8D51-EB01-1E44-79E64F829543}"/>
              </a:ext>
            </a:extLst>
          </p:cNvPr>
          <p:cNvSpPr>
            <a:spLocks noChangeShapeType="1"/>
          </p:cNvSpPr>
          <p:nvPr/>
        </p:nvSpPr>
        <p:spPr bwMode="auto">
          <a:xfrm>
            <a:off x="1640666" y="2722567"/>
            <a:ext cx="416141" cy="0"/>
          </a:xfrm>
          <a:prstGeom prst="line">
            <a:avLst/>
          </a:prstGeom>
          <a:noFill/>
          <a:ln w="238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7">
            <a:extLst>
              <a:ext uri="{FF2B5EF4-FFF2-40B4-BE49-F238E27FC236}">
                <a16:creationId xmlns:a16="http://schemas.microsoft.com/office/drawing/2014/main" xmlns="" id="{9491A71F-75BB-8F98-A2A9-CE1DE68D542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847183" y="3012935"/>
            <a:ext cx="0" cy="520177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8">
            <a:extLst>
              <a:ext uri="{FF2B5EF4-FFF2-40B4-BE49-F238E27FC236}">
                <a16:creationId xmlns:a16="http://schemas.microsoft.com/office/drawing/2014/main" xmlns="" id="{61EAEDBF-C508-148C-850D-5D0DF39756D4}"/>
              </a:ext>
            </a:extLst>
          </p:cNvPr>
          <p:cNvSpPr>
            <a:spLocks noChangeShapeType="1"/>
          </p:cNvSpPr>
          <p:nvPr/>
        </p:nvSpPr>
        <p:spPr bwMode="auto">
          <a:xfrm>
            <a:off x="1847183" y="1669791"/>
            <a:ext cx="0" cy="669243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9">
            <a:extLst>
              <a:ext uri="{FF2B5EF4-FFF2-40B4-BE49-F238E27FC236}">
                <a16:creationId xmlns:a16="http://schemas.microsoft.com/office/drawing/2014/main" xmlns="" id="{D1B6DF52-81AF-8397-8432-454D3C23BB06}"/>
              </a:ext>
            </a:extLst>
          </p:cNvPr>
          <p:cNvSpPr>
            <a:spLocks noChangeShapeType="1"/>
          </p:cNvSpPr>
          <p:nvPr/>
        </p:nvSpPr>
        <p:spPr bwMode="auto">
          <a:xfrm>
            <a:off x="1744701" y="3533111"/>
            <a:ext cx="208071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10">
            <a:extLst>
              <a:ext uri="{FF2B5EF4-FFF2-40B4-BE49-F238E27FC236}">
                <a16:creationId xmlns:a16="http://schemas.microsoft.com/office/drawing/2014/main" xmlns="" id="{825A71AE-B212-5F51-C66D-150DDFE4AB4E}"/>
              </a:ext>
            </a:extLst>
          </p:cNvPr>
          <p:cNvSpPr>
            <a:spLocks noChangeShapeType="1"/>
          </p:cNvSpPr>
          <p:nvPr/>
        </p:nvSpPr>
        <p:spPr bwMode="auto">
          <a:xfrm>
            <a:off x="1744701" y="1669791"/>
            <a:ext cx="208071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1">
            <a:extLst>
              <a:ext uri="{FF2B5EF4-FFF2-40B4-BE49-F238E27FC236}">
                <a16:creationId xmlns:a16="http://schemas.microsoft.com/office/drawing/2014/main" xmlns="" id="{B80FCC86-97AC-76F9-97AF-B1CBC0F4D3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0666" y="2339033"/>
            <a:ext cx="416141" cy="673901"/>
          </a:xfrm>
          <a:prstGeom prst="rect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Oval 12">
            <a:extLst>
              <a:ext uri="{FF2B5EF4-FFF2-40B4-BE49-F238E27FC236}">
                <a16:creationId xmlns:a16="http://schemas.microsoft.com/office/drawing/2014/main" xmlns="" id="{EAD9C117-307E-4DD3-C6FD-418F067780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9234" y="4935260"/>
            <a:ext cx="59005" cy="57453"/>
          </a:xfrm>
          <a:prstGeom prst="ellips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3">
            <a:extLst>
              <a:ext uri="{FF2B5EF4-FFF2-40B4-BE49-F238E27FC236}">
                <a16:creationId xmlns:a16="http://schemas.microsoft.com/office/drawing/2014/main" xmlns="" id="{FB148983-3408-5795-4C24-464FC7ED08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9290" y="2955481"/>
            <a:ext cx="413036" cy="200772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Line 14">
            <a:extLst>
              <a:ext uri="{FF2B5EF4-FFF2-40B4-BE49-F238E27FC236}">
                <a16:creationId xmlns:a16="http://schemas.microsoft.com/office/drawing/2014/main" xmlns="" id="{44856511-A2B2-297C-2F7C-066D46A1134A}"/>
              </a:ext>
            </a:extLst>
          </p:cNvPr>
          <p:cNvSpPr>
            <a:spLocks noChangeShapeType="1"/>
          </p:cNvSpPr>
          <p:nvPr/>
        </p:nvSpPr>
        <p:spPr bwMode="auto">
          <a:xfrm>
            <a:off x="2159290" y="3528453"/>
            <a:ext cx="413036" cy="0"/>
          </a:xfrm>
          <a:prstGeom prst="line">
            <a:avLst/>
          </a:prstGeom>
          <a:noFill/>
          <a:ln w="238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Line 15">
            <a:extLst>
              <a:ext uri="{FF2B5EF4-FFF2-40B4-BE49-F238E27FC236}">
                <a16:creationId xmlns:a16="http://schemas.microsoft.com/office/drawing/2014/main" xmlns="" id="{DBE04A29-AA20-F105-5F68-A4DB62D9AF99}"/>
              </a:ext>
            </a:extLst>
          </p:cNvPr>
          <p:cNvSpPr>
            <a:spLocks noChangeShapeType="1"/>
          </p:cNvSpPr>
          <p:nvPr/>
        </p:nvSpPr>
        <p:spPr bwMode="auto">
          <a:xfrm>
            <a:off x="2365807" y="1244333"/>
            <a:ext cx="0" cy="1711149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Line 16">
            <a:extLst>
              <a:ext uri="{FF2B5EF4-FFF2-40B4-BE49-F238E27FC236}">
                <a16:creationId xmlns:a16="http://schemas.microsoft.com/office/drawing/2014/main" xmlns="" id="{220FDC64-62B5-8D37-CD1E-B09BBB4B92B4}"/>
              </a:ext>
            </a:extLst>
          </p:cNvPr>
          <p:cNvSpPr>
            <a:spLocks noChangeShapeType="1"/>
          </p:cNvSpPr>
          <p:nvPr/>
        </p:nvSpPr>
        <p:spPr bwMode="auto">
          <a:xfrm>
            <a:off x="2263325" y="4963209"/>
            <a:ext cx="20651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Line 17">
            <a:extLst>
              <a:ext uri="{FF2B5EF4-FFF2-40B4-BE49-F238E27FC236}">
                <a16:creationId xmlns:a16="http://schemas.microsoft.com/office/drawing/2014/main" xmlns="" id="{7DF99BD5-44E9-8BD7-10D0-14F9CE222CBD}"/>
              </a:ext>
            </a:extLst>
          </p:cNvPr>
          <p:cNvSpPr>
            <a:spLocks noChangeShapeType="1"/>
          </p:cNvSpPr>
          <p:nvPr/>
        </p:nvSpPr>
        <p:spPr bwMode="auto">
          <a:xfrm>
            <a:off x="2263325" y="1244332"/>
            <a:ext cx="206518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18">
            <a:extLst>
              <a:ext uri="{FF2B5EF4-FFF2-40B4-BE49-F238E27FC236}">
                <a16:creationId xmlns:a16="http://schemas.microsoft.com/office/drawing/2014/main" xmlns="" id="{2D436499-3F5F-F5E4-AB80-3F12DD7805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9290" y="2955481"/>
            <a:ext cx="413036" cy="2007728"/>
          </a:xfrm>
          <a:prstGeom prst="rect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19">
            <a:extLst>
              <a:ext uri="{FF2B5EF4-FFF2-40B4-BE49-F238E27FC236}">
                <a16:creationId xmlns:a16="http://schemas.microsoft.com/office/drawing/2014/main" xmlns="" id="{FDEE6C0C-A82B-B508-41D8-963DE9501D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7914" y="2919769"/>
            <a:ext cx="413036" cy="104190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Line 20">
            <a:extLst>
              <a:ext uri="{FF2B5EF4-FFF2-40B4-BE49-F238E27FC236}">
                <a16:creationId xmlns:a16="http://schemas.microsoft.com/office/drawing/2014/main" xmlns="" id="{CB607E18-6E90-41CA-7884-0E947AD467C4}"/>
              </a:ext>
            </a:extLst>
          </p:cNvPr>
          <p:cNvSpPr>
            <a:spLocks noChangeShapeType="1"/>
          </p:cNvSpPr>
          <p:nvPr/>
        </p:nvSpPr>
        <p:spPr bwMode="auto">
          <a:xfrm>
            <a:off x="2677914" y="3283116"/>
            <a:ext cx="413036" cy="0"/>
          </a:xfrm>
          <a:prstGeom prst="line">
            <a:avLst/>
          </a:prstGeom>
          <a:noFill/>
          <a:ln w="238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Line 21">
            <a:extLst>
              <a:ext uri="{FF2B5EF4-FFF2-40B4-BE49-F238E27FC236}">
                <a16:creationId xmlns:a16="http://schemas.microsoft.com/office/drawing/2014/main" xmlns="" id="{CE74CE18-E273-D48D-9B11-6FB0EF52660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884431" y="3961674"/>
            <a:ext cx="0" cy="1001535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Line 22">
            <a:extLst>
              <a:ext uri="{FF2B5EF4-FFF2-40B4-BE49-F238E27FC236}">
                <a16:creationId xmlns:a16="http://schemas.microsoft.com/office/drawing/2014/main" xmlns="" id="{CBDD64C6-C0F5-5AED-7E9D-009C6A6AEF47}"/>
              </a:ext>
            </a:extLst>
          </p:cNvPr>
          <p:cNvSpPr>
            <a:spLocks noChangeShapeType="1"/>
          </p:cNvSpPr>
          <p:nvPr/>
        </p:nvSpPr>
        <p:spPr bwMode="auto">
          <a:xfrm>
            <a:off x="2884431" y="1486565"/>
            <a:ext cx="0" cy="1433204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Line 23">
            <a:extLst>
              <a:ext uri="{FF2B5EF4-FFF2-40B4-BE49-F238E27FC236}">
                <a16:creationId xmlns:a16="http://schemas.microsoft.com/office/drawing/2014/main" xmlns="" id="{DC10EA78-5BCD-1A62-89A7-0DB167BFD73F}"/>
              </a:ext>
            </a:extLst>
          </p:cNvPr>
          <p:cNvSpPr>
            <a:spLocks noChangeShapeType="1"/>
          </p:cNvSpPr>
          <p:nvPr/>
        </p:nvSpPr>
        <p:spPr bwMode="auto">
          <a:xfrm>
            <a:off x="2781949" y="4963209"/>
            <a:ext cx="206518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Line 24">
            <a:extLst>
              <a:ext uri="{FF2B5EF4-FFF2-40B4-BE49-F238E27FC236}">
                <a16:creationId xmlns:a16="http://schemas.microsoft.com/office/drawing/2014/main" xmlns="" id="{AA2C2CBF-456D-B8D5-70E7-81DB11D62F1C}"/>
              </a:ext>
            </a:extLst>
          </p:cNvPr>
          <p:cNvSpPr>
            <a:spLocks noChangeShapeType="1"/>
          </p:cNvSpPr>
          <p:nvPr/>
        </p:nvSpPr>
        <p:spPr bwMode="auto">
          <a:xfrm>
            <a:off x="2781949" y="1486565"/>
            <a:ext cx="206518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25">
            <a:extLst>
              <a:ext uri="{FF2B5EF4-FFF2-40B4-BE49-F238E27FC236}">
                <a16:creationId xmlns:a16="http://schemas.microsoft.com/office/drawing/2014/main" xmlns="" id="{36678092-6E70-708D-70D1-54D064D990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7914" y="2919769"/>
            <a:ext cx="413036" cy="1041907"/>
          </a:xfrm>
          <a:prstGeom prst="rect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26">
            <a:extLst>
              <a:ext uri="{FF2B5EF4-FFF2-40B4-BE49-F238E27FC236}">
                <a16:creationId xmlns:a16="http://schemas.microsoft.com/office/drawing/2014/main" xmlns="" id="{12120E7F-BB67-D5CE-20CC-BCCF958743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4985" y="3208583"/>
            <a:ext cx="414588" cy="175462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Line 27">
            <a:extLst>
              <a:ext uri="{FF2B5EF4-FFF2-40B4-BE49-F238E27FC236}">
                <a16:creationId xmlns:a16="http://schemas.microsoft.com/office/drawing/2014/main" xmlns="" id="{BA3FBE9B-5F5C-18BE-DEEF-99ADAADA465C}"/>
              </a:ext>
            </a:extLst>
          </p:cNvPr>
          <p:cNvSpPr>
            <a:spLocks noChangeShapeType="1"/>
          </p:cNvSpPr>
          <p:nvPr/>
        </p:nvSpPr>
        <p:spPr bwMode="auto">
          <a:xfrm>
            <a:off x="3194985" y="4089002"/>
            <a:ext cx="414588" cy="0"/>
          </a:xfrm>
          <a:prstGeom prst="line">
            <a:avLst/>
          </a:prstGeom>
          <a:noFill/>
          <a:ln w="238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Line 28">
            <a:extLst>
              <a:ext uri="{FF2B5EF4-FFF2-40B4-BE49-F238E27FC236}">
                <a16:creationId xmlns:a16="http://schemas.microsoft.com/office/drawing/2014/main" xmlns="" id="{A5B2F718-3EFD-47BB-DF0B-3D65803A66D7}"/>
              </a:ext>
            </a:extLst>
          </p:cNvPr>
          <p:cNvSpPr>
            <a:spLocks noChangeShapeType="1"/>
          </p:cNvSpPr>
          <p:nvPr/>
        </p:nvSpPr>
        <p:spPr bwMode="auto">
          <a:xfrm>
            <a:off x="3403055" y="3134050"/>
            <a:ext cx="0" cy="74533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Line 29">
            <a:extLst>
              <a:ext uri="{FF2B5EF4-FFF2-40B4-BE49-F238E27FC236}">
                <a16:creationId xmlns:a16="http://schemas.microsoft.com/office/drawing/2014/main" xmlns="" id="{4B080E00-7CAD-CD37-7BE7-B156642AC335}"/>
              </a:ext>
            </a:extLst>
          </p:cNvPr>
          <p:cNvSpPr>
            <a:spLocks noChangeShapeType="1"/>
          </p:cNvSpPr>
          <p:nvPr/>
        </p:nvSpPr>
        <p:spPr bwMode="auto">
          <a:xfrm>
            <a:off x="3297468" y="4963209"/>
            <a:ext cx="20962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Line 30">
            <a:extLst>
              <a:ext uri="{FF2B5EF4-FFF2-40B4-BE49-F238E27FC236}">
                <a16:creationId xmlns:a16="http://schemas.microsoft.com/office/drawing/2014/main" xmlns="" id="{1FD4FF89-84B2-C17D-D59C-586301F8E9B4}"/>
              </a:ext>
            </a:extLst>
          </p:cNvPr>
          <p:cNvSpPr>
            <a:spLocks noChangeShapeType="1"/>
          </p:cNvSpPr>
          <p:nvPr/>
        </p:nvSpPr>
        <p:spPr bwMode="auto">
          <a:xfrm>
            <a:off x="3297468" y="3134050"/>
            <a:ext cx="209623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1">
            <a:extLst>
              <a:ext uri="{FF2B5EF4-FFF2-40B4-BE49-F238E27FC236}">
                <a16:creationId xmlns:a16="http://schemas.microsoft.com/office/drawing/2014/main" xmlns="" id="{A275DDF3-A6AE-000A-E2E0-E7EDDC5206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4985" y="3208583"/>
            <a:ext cx="414588" cy="1754627"/>
          </a:xfrm>
          <a:prstGeom prst="rect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2">
            <a:extLst>
              <a:ext uri="{FF2B5EF4-FFF2-40B4-BE49-F238E27FC236}">
                <a16:creationId xmlns:a16="http://schemas.microsoft.com/office/drawing/2014/main" xmlns="" id="{899CFACA-EAE1-A4B5-DC7E-B20A33880F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3609" y="2865421"/>
            <a:ext cx="416141" cy="15714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Line 33">
            <a:extLst>
              <a:ext uri="{FF2B5EF4-FFF2-40B4-BE49-F238E27FC236}">
                <a16:creationId xmlns:a16="http://schemas.microsoft.com/office/drawing/2014/main" xmlns="" id="{9A24DB7C-8C80-C640-770C-C13AD7DA85CB}"/>
              </a:ext>
            </a:extLst>
          </p:cNvPr>
          <p:cNvSpPr>
            <a:spLocks noChangeShapeType="1"/>
          </p:cNvSpPr>
          <p:nvPr/>
        </p:nvSpPr>
        <p:spPr bwMode="auto">
          <a:xfrm>
            <a:off x="3713609" y="3789318"/>
            <a:ext cx="416141" cy="0"/>
          </a:xfrm>
          <a:prstGeom prst="line">
            <a:avLst/>
          </a:prstGeom>
          <a:noFill/>
          <a:ln w="238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Line 34">
            <a:extLst>
              <a:ext uri="{FF2B5EF4-FFF2-40B4-BE49-F238E27FC236}">
                <a16:creationId xmlns:a16="http://schemas.microsoft.com/office/drawing/2014/main" xmlns="" id="{799AE767-5965-800C-929F-9035570A7E3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920127" y="4436822"/>
            <a:ext cx="0" cy="526389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Line 35">
            <a:extLst>
              <a:ext uri="{FF2B5EF4-FFF2-40B4-BE49-F238E27FC236}">
                <a16:creationId xmlns:a16="http://schemas.microsoft.com/office/drawing/2014/main" xmlns="" id="{FD1E225A-BCF0-A10A-0108-0676048E29BD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0127" y="2116988"/>
            <a:ext cx="0" cy="748434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Line 36">
            <a:extLst>
              <a:ext uri="{FF2B5EF4-FFF2-40B4-BE49-F238E27FC236}">
                <a16:creationId xmlns:a16="http://schemas.microsoft.com/office/drawing/2014/main" xmlns="" id="{B494041B-23C2-D6CF-D392-0EA9862D5562}"/>
              </a:ext>
            </a:extLst>
          </p:cNvPr>
          <p:cNvSpPr>
            <a:spLocks noChangeShapeType="1"/>
          </p:cNvSpPr>
          <p:nvPr/>
        </p:nvSpPr>
        <p:spPr bwMode="auto">
          <a:xfrm>
            <a:off x="3816091" y="4963209"/>
            <a:ext cx="209623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Line 37">
            <a:extLst>
              <a:ext uri="{FF2B5EF4-FFF2-40B4-BE49-F238E27FC236}">
                <a16:creationId xmlns:a16="http://schemas.microsoft.com/office/drawing/2014/main" xmlns="" id="{4EDC58C7-A01E-608D-C891-171C364FA9AA}"/>
              </a:ext>
            </a:extLst>
          </p:cNvPr>
          <p:cNvSpPr>
            <a:spLocks noChangeShapeType="1"/>
          </p:cNvSpPr>
          <p:nvPr/>
        </p:nvSpPr>
        <p:spPr bwMode="auto">
          <a:xfrm>
            <a:off x="3816091" y="2116988"/>
            <a:ext cx="209623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38">
            <a:extLst>
              <a:ext uri="{FF2B5EF4-FFF2-40B4-BE49-F238E27FC236}">
                <a16:creationId xmlns:a16="http://schemas.microsoft.com/office/drawing/2014/main" xmlns="" id="{BE319825-5DF4-FB06-B3CE-AAD21C8A10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3609" y="2865421"/>
            <a:ext cx="416141" cy="1571400"/>
          </a:xfrm>
          <a:prstGeom prst="rect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39">
            <a:extLst>
              <a:ext uri="{FF2B5EF4-FFF2-40B4-BE49-F238E27FC236}">
                <a16:creationId xmlns:a16="http://schemas.microsoft.com/office/drawing/2014/main" xmlns="" id="{205658FE-6AD8-1B8A-4186-B41AB5969C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2233" y="3118523"/>
            <a:ext cx="413036" cy="184468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Line 40">
            <a:extLst>
              <a:ext uri="{FF2B5EF4-FFF2-40B4-BE49-F238E27FC236}">
                <a16:creationId xmlns:a16="http://schemas.microsoft.com/office/drawing/2014/main" xmlns="" id="{690D734D-7D59-B399-F5F2-BC86A5848468}"/>
              </a:ext>
            </a:extLst>
          </p:cNvPr>
          <p:cNvSpPr>
            <a:spLocks noChangeShapeType="1"/>
          </p:cNvSpPr>
          <p:nvPr/>
        </p:nvSpPr>
        <p:spPr bwMode="auto">
          <a:xfrm>
            <a:off x="4232233" y="3453920"/>
            <a:ext cx="413036" cy="0"/>
          </a:xfrm>
          <a:prstGeom prst="line">
            <a:avLst/>
          </a:prstGeom>
          <a:noFill/>
          <a:ln w="238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Line 41">
            <a:extLst>
              <a:ext uri="{FF2B5EF4-FFF2-40B4-BE49-F238E27FC236}">
                <a16:creationId xmlns:a16="http://schemas.microsoft.com/office/drawing/2014/main" xmlns="" id="{706D8624-5F1C-7C64-BC2E-961BEBB479AD}"/>
              </a:ext>
            </a:extLst>
          </p:cNvPr>
          <p:cNvSpPr>
            <a:spLocks noChangeShapeType="1"/>
          </p:cNvSpPr>
          <p:nvPr/>
        </p:nvSpPr>
        <p:spPr bwMode="auto">
          <a:xfrm>
            <a:off x="4438751" y="2339033"/>
            <a:ext cx="0" cy="779489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Line 42">
            <a:extLst>
              <a:ext uri="{FF2B5EF4-FFF2-40B4-BE49-F238E27FC236}">
                <a16:creationId xmlns:a16="http://schemas.microsoft.com/office/drawing/2014/main" xmlns="" id="{AB7955D0-A3D2-1408-2C8C-F667FD7F7C06}"/>
              </a:ext>
            </a:extLst>
          </p:cNvPr>
          <p:cNvSpPr>
            <a:spLocks noChangeShapeType="1"/>
          </p:cNvSpPr>
          <p:nvPr/>
        </p:nvSpPr>
        <p:spPr bwMode="auto">
          <a:xfrm>
            <a:off x="4336269" y="4963209"/>
            <a:ext cx="20651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Line 43">
            <a:extLst>
              <a:ext uri="{FF2B5EF4-FFF2-40B4-BE49-F238E27FC236}">
                <a16:creationId xmlns:a16="http://schemas.microsoft.com/office/drawing/2014/main" xmlns="" id="{9A6828BA-281C-760E-ECFB-983DE77C98B1}"/>
              </a:ext>
            </a:extLst>
          </p:cNvPr>
          <p:cNvSpPr>
            <a:spLocks noChangeShapeType="1"/>
          </p:cNvSpPr>
          <p:nvPr/>
        </p:nvSpPr>
        <p:spPr bwMode="auto">
          <a:xfrm>
            <a:off x="4336269" y="2339033"/>
            <a:ext cx="206518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44">
            <a:extLst>
              <a:ext uri="{FF2B5EF4-FFF2-40B4-BE49-F238E27FC236}">
                <a16:creationId xmlns:a16="http://schemas.microsoft.com/office/drawing/2014/main" xmlns="" id="{5F7AFBB6-3FFC-E2CE-2D78-BA5B0A7079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2233" y="3118523"/>
            <a:ext cx="413036" cy="1844687"/>
          </a:xfrm>
          <a:prstGeom prst="rect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45">
            <a:extLst>
              <a:ext uri="{FF2B5EF4-FFF2-40B4-BE49-F238E27FC236}">
                <a16:creationId xmlns:a16="http://schemas.microsoft.com/office/drawing/2014/main" xmlns="" id="{A8E227ED-2FB6-87F6-00C0-3A64173A87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0857" y="3317277"/>
            <a:ext cx="413036" cy="164593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Line 46">
            <a:extLst>
              <a:ext uri="{FF2B5EF4-FFF2-40B4-BE49-F238E27FC236}">
                <a16:creationId xmlns:a16="http://schemas.microsoft.com/office/drawing/2014/main" xmlns="" id="{3DF6E606-93ED-44C5-3A8C-7DD227B6B398}"/>
              </a:ext>
            </a:extLst>
          </p:cNvPr>
          <p:cNvSpPr>
            <a:spLocks noChangeShapeType="1"/>
          </p:cNvSpPr>
          <p:nvPr/>
        </p:nvSpPr>
        <p:spPr bwMode="auto">
          <a:xfrm>
            <a:off x="4750857" y="4186826"/>
            <a:ext cx="413036" cy="0"/>
          </a:xfrm>
          <a:prstGeom prst="line">
            <a:avLst/>
          </a:prstGeom>
          <a:noFill/>
          <a:ln w="238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Line 47">
            <a:extLst>
              <a:ext uri="{FF2B5EF4-FFF2-40B4-BE49-F238E27FC236}">
                <a16:creationId xmlns:a16="http://schemas.microsoft.com/office/drawing/2014/main" xmlns="" id="{62FD26EF-9AC8-E7A2-DACE-ED1570C38170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7375" y="1997425"/>
            <a:ext cx="0" cy="1319852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Line 48">
            <a:extLst>
              <a:ext uri="{FF2B5EF4-FFF2-40B4-BE49-F238E27FC236}">
                <a16:creationId xmlns:a16="http://schemas.microsoft.com/office/drawing/2014/main" xmlns="" id="{64717C97-995D-BCA2-A7F9-7511D65FB155}"/>
              </a:ext>
            </a:extLst>
          </p:cNvPr>
          <p:cNvSpPr>
            <a:spLocks noChangeShapeType="1"/>
          </p:cNvSpPr>
          <p:nvPr/>
        </p:nvSpPr>
        <p:spPr bwMode="auto">
          <a:xfrm>
            <a:off x="4854893" y="4963209"/>
            <a:ext cx="20651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Line 49">
            <a:extLst>
              <a:ext uri="{FF2B5EF4-FFF2-40B4-BE49-F238E27FC236}">
                <a16:creationId xmlns:a16="http://schemas.microsoft.com/office/drawing/2014/main" xmlns="" id="{2DE2A29B-C505-B252-7842-CF7DA6319506}"/>
              </a:ext>
            </a:extLst>
          </p:cNvPr>
          <p:cNvSpPr>
            <a:spLocks noChangeShapeType="1"/>
          </p:cNvSpPr>
          <p:nvPr/>
        </p:nvSpPr>
        <p:spPr bwMode="auto">
          <a:xfrm>
            <a:off x="4854893" y="1997424"/>
            <a:ext cx="206518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0">
            <a:extLst>
              <a:ext uri="{FF2B5EF4-FFF2-40B4-BE49-F238E27FC236}">
                <a16:creationId xmlns:a16="http://schemas.microsoft.com/office/drawing/2014/main" xmlns="" id="{A82EB3C0-40E4-0588-15F4-E7CB3D71C1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0857" y="3317277"/>
            <a:ext cx="413036" cy="1645933"/>
          </a:xfrm>
          <a:prstGeom prst="rect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1">
            <a:extLst>
              <a:ext uri="{FF2B5EF4-FFF2-40B4-BE49-F238E27FC236}">
                <a16:creationId xmlns:a16="http://schemas.microsoft.com/office/drawing/2014/main" xmlns="" id="{AADBA55A-132A-5395-BB22-F170B47EA0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7929" y="3141814"/>
            <a:ext cx="414588" cy="182139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Line 52">
            <a:extLst>
              <a:ext uri="{FF2B5EF4-FFF2-40B4-BE49-F238E27FC236}">
                <a16:creationId xmlns:a16="http://schemas.microsoft.com/office/drawing/2014/main" xmlns="" id="{6253B032-7582-C3A5-144C-E3EB905FE721}"/>
              </a:ext>
            </a:extLst>
          </p:cNvPr>
          <p:cNvSpPr>
            <a:spLocks noChangeShapeType="1"/>
          </p:cNvSpPr>
          <p:nvPr/>
        </p:nvSpPr>
        <p:spPr bwMode="auto">
          <a:xfrm>
            <a:off x="5267929" y="3925961"/>
            <a:ext cx="414588" cy="0"/>
          </a:xfrm>
          <a:prstGeom prst="line">
            <a:avLst/>
          </a:prstGeom>
          <a:noFill/>
          <a:ln w="238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Line 53">
            <a:extLst>
              <a:ext uri="{FF2B5EF4-FFF2-40B4-BE49-F238E27FC236}">
                <a16:creationId xmlns:a16="http://schemas.microsoft.com/office/drawing/2014/main" xmlns="" id="{3D09E6FF-41A9-8121-D1B5-8039969F9460}"/>
              </a:ext>
            </a:extLst>
          </p:cNvPr>
          <p:cNvSpPr>
            <a:spLocks noChangeShapeType="1"/>
          </p:cNvSpPr>
          <p:nvPr/>
        </p:nvSpPr>
        <p:spPr bwMode="auto">
          <a:xfrm>
            <a:off x="5475999" y="1997424"/>
            <a:ext cx="0" cy="114439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Line 54">
            <a:extLst>
              <a:ext uri="{FF2B5EF4-FFF2-40B4-BE49-F238E27FC236}">
                <a16:creationId xmlns:a16="http://schemas.microsoft.com/office/drawing/2014/main" xmlns="" id="{520D6F2E-B215-8F76-52DD-FE5F9044E24A}"/>
              </a:ext>
            </a:extLst>
          </p:cNvPr>
          <p:cNvSpPr>
            <a:spLocks noChangeShapeType="1"/>
          </p:cNvSpPr>
          <p:nvPr/>
        </p:nvSpPr>
        <p:spPr bwMode="auto">
          <a:xfrm>
            <a:off x="5370412" y="4963209"/>
            <a:ext cx="20962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Line 55">
            <a:extLst>
              <a:ext uri="{FF2B5EF4-FFF2-40B4-BE49-F238E27FC236}">
                <a16:creationId xmlns:a16="http://schemas.microsoft.com/office/drawing/2014/main" xmlns="" id="{3CFF947E-FDDD-2BBB-8F1A-E25DE69376F6}"/>
              </a:ext>
            </a:extLst>
          </p:cNvPr>
          <p:cNvSpPr>
            <a:spLocks noChangeShapeType="1"/>
          </p:cNvSpPr>
          <p:nvPr/>
        </p:nvSpPr>
        <p:spPr bwMode="auto">
          <a:xfrm>
            <a:off x="5370412" y="1997424"/>
            <a:ext cx="209623" cy="0"/>
          </a:xfrm>
          <a:prstGeom prst="line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56">
            <a:extLst>
              <a:ext uri="{FF2B5EF4-FFF2-40B4-BE49-F238E27FC236}">
                <a16:creationId xmlns:a16="http://schemas.microsoft.com/office/drawing/2014/main" xmlns="" id="{96B5F222-6281-35B8-9CF9-3610D21A06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7929" y="3141814"/>
            <a:ext cx="414588" cy="1821396"/>
          </a:xfrm>
          <a:prstGeom prst="rect">
            <a:avLst/>
          </a:prstGeom>
          <a:noFill/>
          <a:ln w="190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Line 57">
            <a:extLst>
              <a:ext uri="{FF2B5EF4-FFF2-40B4-BE49-F238E27FC236}">
                <a16:creationId xmlns:a16="http://schemas.microsoft.com/office/drawing/2014/main" xmlns="" id="{B7F3A1FF-F8D5-DE21-0F73-4E3322B51E2D}"/>
              </a:ext>
            </a:extLst>
          </p:cNvPr>
          <p:cNvSpPr>
            <a:spLocks noChangeShapeType="1"/>
          </p:cNvSpPr>
          <p:nvPr/>
        </p:nvSpPr>
        <p:spPr bwMode="auto">
          <a:xfrm>
            <a:off x="1847184" y="5113828"/>
            <a:ext cx="3628815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Line 58">
            <a:extLst>
              <a:ext uri="{FF2B5EF4-FFF2-40B4-BE49-F238E27FC236}">
                <a16:creationId xmlns:a16="http://schemas.microsoft.com/office/drawing/2014/main" xmlns="" id="{194AA8BF-B1E0-FEAB-46F5-641943A824A7}"/>
              </a:ext>
            </a:extLst>
          </p:cNvPr>
          <p:cNvSpPr>
            <a:spLocks noChangeShapeType="1"/>
          </p:cNvSpPr>
          <p:nvPr/>
        </p:nvSpPr>
        <p:spPr bwMode="auto">
          <a:xfrm>
            <a:off x="1847183" y="5113829"/>
            <a:ext cx="0" cy="776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Line 59">
            <a:extLst>
              <a:ext uri="{FF2B5EF4-FFF2-40B4-BE49-F238E27FC236}">
                <a16:creationId xmlns:a16="http://schemas.microsoft.com/office/drawing/2014/main" xmlns="" id="{CCF5D1D2-C7E7-477E-A354-FA4575098B08}"/>
              </a:ext>
            </a:extLst>
          </p:cNvPr>
          <p:cNvSpPr>
            <a:spLocks noChangeShapeType="1"/>
          </p:cNvSpPr>
          <p:nvPr/>
        </p:nvSpPr>
        <p:spPr bwMode="auto">
          <a:xfrm>
            <a:off x="2365807" y="5113829"/>
            <a:ext cx="0" cy="776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Line 60">
            <a:extLst>
              <a:ext uri="{FF2B5EF4-FFF2-40B4-BE49-F238E27FC236}">
                <a16:creationId xmlns:a16="http://schemas.microsoft.com/office/drawing/2014/main" xmlns="" id="{347ACA81-D977-2DF0-28D6-22F8C393267A}"/>
              </a:ext>
            </a:extLst>
          </p:cNvPr>
          <p:cNvSpPr>
            <a:spLocks noChangeShapeType="1"/>
          </p:cNvSpPr>
          <p:nvPr/>
        </p:nvSpPr>
        <p:spPr bwMode="auto">
          <a:xfrm>
            <a:off x="2884431" y="5113829"/>
            <a:ext cx="0" cy="776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Line 61">
            <a:extLst>
              <a:ext uri="{FF2B5EF4-FFF2-40B4-BE49-F238E27FC236}">
                <a16:creationId xmlns:a16="http://schemas.microsoft.com/office/drawing/2014/main" xmlns="" id="{16524FF8-E935-1B3F-7C6C-E99ADFE3812F}"/>
              </a:ext>
            </a:extLst>
          </p:cNvPr>
          <p:cNvSpPr>
            <a:spLocks noChangeShapeType="1"/>
          </p:cNvSpPr>
          <p:nvPr/>
        </p:nvSpPr>
        <p:spPr bwMode="auto">
          <a:xfrm>
            <a:off x="3403055" y="5113829"/>
            <a:ext cx="0" cy="776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Line 62">
            <a:extLst>
              <a:ext uri="{FF2B5EF4-FFF2-40B4-BE49-F238E27FC236}">
                <a16:creationId xmlns:a16="http://schemas.microsoft.com/office/drawing/2014/main" xmlns="" id="{4ADEE128-84DE-4E08-C8AF-46B08F83650C}"/>
              </a:ext>
            </a:extLst>
          </p:cNvPr>
          <p:cNvSpPr>
            <a:spLocks noChangeShapeType="1"/>
          </p:cNvSpPr>
          <p:nvPr/>
        </p:nvSpPr>
        <p:spPr bwMode="auto">
          <a:xfrm>
            <a:off x="3920127" y="5113829"/>
            <a:ext cx="0" cy="776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Line 63">
            <a:extLst>
              <a:ext uri="{FF2B5EF4-FFF2-40B4-BE49-F238E27FC236}">
                <a16:creationId xmlns:a16="http://schemas.microsoft.com/office/drawing/2014/main" xmlns="" id="{43E26A81-EE29-62D1-323E-6013A7EEF7F8}"/>
              </a:ext>
            </a:extLst>
          </p:cNvPr>
          <p:cNvSpPr>
            <a:spLocks noChangeShapeType="1"/>
          </p:cNvSpPr>
          <p:nvPr/>
        </p:nvSpPr>
        <p:spPr bwMode="auto">
          <a:xfrm>
            <a:off x="4438751" y="5113829"/>
            <a:ext cx="0" cy="776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Line 64">
            <a:extLst>
              <a:ext uri="{FF2B5EF4-FFF2-40B4-BE49-F238E27FC236}">
                <a16:creationId xmlns:a16="http://schemas.microsoft.com/office/drawing/2014/main" xmlns="" id="{C031D9A7-82D0-9F36-8F17-90FFA2857BCE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7375" y="5113829"/>
            <a:ext cx="0" cy="776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Line 65">
            <a:extLst>
              <a:ext uri="{FF2B5EF4-FFF2-40B4-BE49-F238E27FC236}">
                <a16:creationId xmlns:a16="http://schemas.microsoft.com/office/drawing/2014/main" xmlns="" id="{98F106FF-32DC-CDE7-73D6-32D024763F67}"/>
              </a:ext>
            </a:extLst>
          </p:cNvPr>
          <p:cNvSpPr>
            <a:spLocks noChangeShapeType="1"/>
          </p:cNvSpPr>
          <p:nvPr/>
        </p:nvSpPr>
        <p:spPr bwMode="auto">
          <a:xfrm>
            <a:off x="5475999" y="5113829"/>
            <a:ext cx="0" cy="7763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2">
            <a:extLst>
              <a:ext uri="{FF2B5EF4-FFF2-40B4-BE49-F238E27FC236}">
                <a16:creationId xmlns:a16="http://schemas.microsoft.com/office/drawing/2014/main" xmlns="" id="{424B2D56-DBBA-F145-3606-1AF49B51EDFF}"/>
              </a:ext>
            </a:extLst>
          </p:cNvPr>
          <p:cNvSpPr>
            <a:spLocks noChangeArrowheads="1"/>
          </p:cNvSpPr>
          <p:nvPr/>
        </p:nvSpPr>
        <p:spPr bwMode="auto">
          <a:xfrm rot="332999">
            <a:off x="3338890" y="6189730"/>
            <a:ext cx="32060" cy="1354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894435"/>
            <a:r>
              <a:rPr lang="ja-JP" altLang="ja-JP" sz="880" b="1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endParaRPr lang="ja-JP" altLang="ja-JP" sz="1761" b="1" dirty="0">
              <a:cs typeface="Arial" panose="020B0604020202020204" pitchFamily="34" charset="0"/>
            </a:endParaRPr>
          </a:p>
        </p:txBody>
      </p:sp>
      <p:sp>
        <p:nvSpPr>
          <p:cNvPr id="80" name="Line 80">
            <a:extLst>
              <a:ext uri="{FF2B5EF4-FFF2-40B4-BE49-F238E27FC236}">
                <a16:creationId xmlns:a16="http://schemas.microsoft.com/office/drawing/2014/main" xmlns="" id="{632DD01C-297A-F3DA-2CE1-1E48EEB5281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423278" y="1210172"/>
            <a:ext cx="0" cy="3753037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Line 81">
            <a:extLst>
              <a:ext uri="{FF2B5EF4-FFF2-40B4-BE49-F238E27FC236}">
                <a16:creationId xmlns:a16="http://schemas.microsoft.com/office/drawing/2014/main" xmlns="" id="{D4FE3198-26CF-42A4-F051-1FCB34D3AFD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345641" y="4963209"/>
            <a:ext cx="776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Line 82">
            <a:extLst>
              <a:ext uri="{FF2B5EF4-FFF2-40B4-BE49-F238E27FC236}">
                <a16:creationId xmlns:a16="http://schemas.microsoft.com/office/drawing/2014/main" xmlns="" id="{154218B7-FEBE-B1A3-F042-692C23D2371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345641" y="4429057"/>
            <a:ext cx="776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Line 83">
            <a:extLst>
              <a:ext uri="{FF2B5EF4-FFF2-40B4-BE49-F238E27FC236}">
                <a16:creationId xmlns:a16="http://schemas.microsoft.com/office/drawing/2014/main" xmlns="" id="{92E41E94-6D61-326A-3959-44B8B59BE7A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345641" y="3891801"/>
            <a:ext cx="776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Line 84">
            <a:extLst>
              <a:ext uri="{FF2B5EF4-FFF2-40B4-BE49-F238E27FC236}">
                <a16:creationId xmlns:a16="http://schemas.microsoft.com/office/drawing/2014/main" xmlns="" id="{C8EF984C-8A1B-BA19-5D59-398CF623C1E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345641" y="3356095"/>
            <a:ext cx="776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Line 85">
            <a:extLst>
              <a:ext uri="{FF2B5EF4-FFF2-40B4-BE49-F238E27FC236}">
                <a16:creationId xmlns:a16="http://schemas.microsoft.com/office/drawing/2014/main" xmlns="" id="{0044212A-4D2C-5DC2-8A67-4E9F6CEAD66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345641" y="2818838"/>
            <a:ext cx="776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Line 86">
            <a:extLst>
              <a:ext uri="{FF2B5EF4-FFF2-40B4-BE49-F238E27FC236}">
                <a16:creationId xmlns:a16="http://schemas.microsoft.com/office/drawing/2014/main" xmlns="" id="{F20678DF-5892-EBF6-2EB5-72DF015FE5C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345641" y="2281581"/>
            <a:ext cx="776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Line 87">
            <a:extLst>
              <a:ext uri="{FF2B5EF4-FFF2-40B4-BE49-F238E27FC236}">
                <a16:creationId xmlns:a16="http://schemas.microsoft.com/office/drawing/2014/main" xmlns="" id="{5FD9E7F9-63F7-3E46-9033-94050672232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345641" y="1747429"/>
            <a:ext cx="776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Line 88">
            <a:extLst>
              <a:ext uri="{FF2B5EF4-FFF2-40B4-BE49-F238E27FC236}">
                <a16:creationId xmlns:a16="http://schemas.microsoft.com/office/drawing/2014/main" xmlns="" id="{BF45C8AD-07BA-66DA-FD96-24986FAD6D2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345641" y="1210172"/>
            <a:ext cx="7763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89">
            <a:extLst>
              <a:ext uri="{FF2B5EF4-FFF2-40B4-BE49-F238E27FC236}">
                <a16:creationId xmlns:a16="http://schemas.microsoft.com/office/drawing/2014/main" xmlns="" id="{DA902D3D-D6A9-8913-6DFC-6D41B25136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7755" y="4905758"/>
            <a:ext cx="6412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894435"/>
            <a:r>
              <a:rPr lang="en-US" altLang="ja-JP" sz="901" b="1" dirty="0">
                <a:cs typeface="Arial" panose="020B0604020202020204" pitchFamily="34" charset="0"/>
              </a:rPr>
              <a:t>0</a:t>
            </a:r>
          </a:p>
        </p:txBody>
      </p:sp>
      <p:sp>
        <p:nvSpPr>
          <p:cNvPr id="90" name="Rectangle 90">
            <a:extLst>
              <a:ext uri="{FF2B5EF4-FFF2-40B4-BE49-F238E27FC236}">
                <a16:creationId xmlns:a16="http://schemas.microsoft.com/office/drawing/2014/main" xmlns="" id="{2AA514F5-EA11-046D-42DC-D345E6315F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7198" y="4370053"/>
            <a:ext cx="12824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894435"/>
            <a:r>
              <a:rPr lang="en-US" altLang="ja-JP" sz="901" b="1" dirty="0">
                <a:solidFill>
                  <a:srgbClr val="000000"/>
                </a:solidFill>
                <a:cs typeface="Arial" panose="020B0604020202020204" pitchFamily="34" charset="0"/>
              </a:rPr>
              <a:t>20</a:t>
            </a:r>
            <a:endParaRPr lang="ja-JP" altLang="ja-JP" sz="901" b="1" dirty="0">
              <a:cs typeface="Arial" panose="020B0604020202020204" pitchFamily="34" charset="0"/>
            </a:endParaRPr>
          </a:p>
        </p:txBody>
      </p:sp>
      <p:sp>
        <p:nvSpPr>
          <p:cNvPr id="91" name="Rectangle 91">
            <a:extLst>
              <a:ext uri="{FF2B5EF4-FFF2-40B4-BE49-F238E27FC236}">
                <a16:creationId xmlns:a16="http://schemas.microsoft.com/office/drawing/2014/main" xmlns="" id="{6D3201F6-8111-493B-5832-AD4406CF7F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7198" y="3832796"/>
            <a:ext cx="12824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894435"/>
            <a:r>
              <a:rPr lang="en-US" altLang="ja-JP" sz="901" b="1" dirty="0">
                <a:solidFill>
                  <a:srgbClr val="000000"/>
                </a:solidFill>
                <a:cs typeface="Arial" panose="020B0604020202020204" pitchFamily="34" charset="0"/>
              </a:rPr>
              <a:t>40</a:t>
            </a:r>
            <a:endParaRPr lang="ja-JP" altLang="ja-JP" sz="901" b="1" dirty="0">
              <a:cs typeface="Arial" panose="020B0604020202020204" pitchFamily="34" charset="0"/>
            </a:endParaRPr>
          </a:p>
        </p:txBody>
      </p:sp>
      <p:sp>
        <p:nvSpPr>
          <p:cNvPr id="92" name="Rectangle 92">
            <a:extLst>
              <a:ext uri="{FF2B5EF4-FFF2-40B4-BE49-F238E27FC236}">
                <a16:creationId xmlns:a16="http://schemas.microsoft.com/office/drawing/2014/main" xmlns="" id="{0780DC23-7504-2EC7-EED5-0BEEA5BE6B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7198" y="3298644"/>
            <a:ext cx="12824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894435"/>
            <a:r>
              <a:rPr lang="en-US" altLang="ja-JP" sz="901" b="1" dirty="0">
                <a:solidFill>
                  <a:srgbClr val="000000"/>
                </a:solidFill>
                <a:cs typeface="Arial" panose="020B0604020202020204" pitchFamily="34" charset="0"/>
              </a:rPr>
              <a:t>60</a:t>
            </a:r>
            <a:endParaRPr lang="ja-JP" altLang="ja-JP" sz="901" b="1" dirty="0">
              <a:cs typeface="Arial" panose="020B0604020202020204" pitchFamily="34" charset="0"/>
            </a:endParaRPr>
          </a:p>
        </p:txBody>
      </p:sp>
      <p:sp>
        <p:nvSpPr>
          <p:cNvPr id="93" name="Rectangle 93">
            <a:extLst>
              <a:ext uri="{FF2B5EF4-FFF2-40B4-BE49-F238E27FC236}">
                <a16:creationId xmlns:a16="http://schemas.microsoft.com/office/drawing/2014/main" xmlns="" id="{EB2DAB99-51EC-9829-4DE1-9677F0EECC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7198" y="2761387"/>
            <a:ext cx="12824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894435"/>
            <a:r>
              <a:rPr lang="en-US" altLang="ja-JP" sz="901" b="1" dirty="0">
                <a:solidFill>
                  <a:srgbClr val="000000"/>
                </a:solidFill>
                <a:cs typeface="Arial" panose="020B0604020202020204" pitchFamily="34" charset="0"/>
              </a:rPr>
              <a:t>80</a:t>
            </a:r>
            <a:endParaRPr lang="ja-JP" altLang="ja-JP" sz="901" b="1" dirty="0">
              <a:cs typeface="Arial" panose="020B0604020202020204" pitchFamily="34" charset="0"/>
            </a:endParaRPr>
          </a:p>
        </p:txBody>
      </p:sp>
      <p:sp>
        <p:nvSpPr>
          <p:cNvPr id="94" name="Rectangle 94">
            <a:extLst>
              <a:ext uri="{FF2B5EF4-FFF2-40B4-BE49-F238E27FC236}">
                <a16:creationId xmlns:a16="http://schemas.microsoft.com/office/drawing/2014/main" xmlns="" id="{77EF9A5B-3F21-4E6E-53EF-BC384BE8FD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5087" y="2224128"/>
            <a:ext cx="19236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894435"/>
            <a:r>
              <a:rPr lang="en-US" altLang="ja-JP" sz="901" b="1" dirty="0">
                <a:solidFill>
                  <a:srgbClr val="000000"/>
                </a:solidFill>
                <a:cs typeface="Arial" panose="020B0604020202020204" pitchFamily="34" charset="0"/>
              </a:rPr>
              <a:t>100</a:t>
            </a:r>
            <a:endParaRPr lang="ja-JP" altLang="ja-JP" sz="901" b="1" dirty="0">
              <a:cs typeface="Arial" panose="020B0604020202020204" pitchFamily="34" charset="0"/>
            </a:endParaRPr>
          </a:p>
        </p:txBody>
      </p:sp>
      <p:sp>
        <p:nvSpPr>
          <p:cNvPr id="95" name="Rectangle 95">
            <a:extLst>
              <a:ext uri="{FF2B5EF4-FFF2-40B4-BE49-F238E27FC236}">
                <a16:creationId xmlns:a16="http://schemas.microsoft.com/office/drawing/2014/main" xmlns="" id="{8E668712-D728-BB7E-404E-DA56D6DE00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5087" y="1686871"/>
            <a:ext cx="19236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894435"/>
            <a:r>
              <a:rPr lang="en-US" altLang="ja-JP" sz="901" b="1" dirty="0">
                <a:solidFill>
                  <a:srgbClr val="000000"/>
                </a:solidFill>
                <a:cs typeface="Arial" panose="020B0604020202020204" pitchFamily="34" charset="0"/>
              </a:rPr>
              <a:t>120</a:t>
            </a:r>
            <a:endParaRPr lang="ja-JP" altLang="ja-JP" sz="901" b="1" dirty="0">
              <a:cs typeface="Arial" panose="020B0604020202020204" pitchFamily="34" charset="0"/>
            </a:endParaRPr>
          </a:p>
        </p:txBody>
      </p:sp>
      <p:sp>
        <p:nvSpPr>
          <p:cNvPr id="96" name="Rectangle 96">
            <a:extLst>
              <a:ext uri="{FF2B5EF4-FFF2-40B4-BE49-F238E27FC236}">
                <a16:creationId xmlns:a16="http://schemas.microsoft.com/office/drawing/2014/main" xmlns="" id="{6EEBD756-0E14-4CBF-4B78-B08D22398D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5087" y="1149614"/>
            <a:ext cx="19236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894435"/>
            <a:r>
              <a:rPr lang="en-US" altLang="ja-JP" sz="901" b="1" dirty="0">
                <a:solidFill>
                  <a:srgbClr val="000000"/>
                </a:solidFill>
                <a:cs typeface="Arial" panose="020B0604020202020204" pitchFamily="34" charset="0"/>
              </a:rPr>
              <a:t>140</a:t>
            </a:r>
            <a:endParaRPr lang="ja-JP" altLang="ja-JP" sz="901" b="1" dirty="0">
              <a:cs typeface="Arial" panose="020B0604020202020204" pitchFamily="34" charset="0"/>
            </a:endParaRPr>
          </a:p>
        </p:txBody>
      </p:sp>
      <p:sp>
        <p:nvSpPr>
          <p:cNvPr id="97" name="Rectangle 98">
            <a:extLst>
              <a:ext uri="{FF2B5EF4-FFF2-40B4-BE49-F238E27FC236}">
                <a16:creationId xmlns:a16="http://schemas.microsoft.com/office/drawing/2014/main" xmlns="" id="{3B240558-0812-2C12-6B33-B86A1C194D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3278" y="1093715"/>
            <a:ext cx="4476626" cy="4020114"/>
          </a:xfrm>
          <a:prstGeom prst="rect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E7D1186F-4AAF-F4AA-1E39-76361CC08715}"/>
              </a:ext>
            </a:extLst>
          </p:cNvPr>
          <p:cNvSpPr txBox="1"/>
          <p:nvPr/>
        </p:nvSpPr>
        <p:spPr>
          <a:xfrm rot="16200000">
            <a:off x="-251491" y="2918264"/>
            <a:ext cx="2059345" cy="4537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74" b="1" dirty="0">
                <a:latin typeface="Arial" panose="020B0604020202020204" pitchFamily="34" charset="0"/>
                <a:cs typeface="Arial" panose="020B0604020202020204" pitchFamily="34" charset="0"/>
              </a:rPr>
              <a:t>ApoA2-ATQ/AT (</a:t>
            </a:r>
            <a:r>
              <a:rPr lang="el-GR" altLang="ja-JP" sz="1174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ja-JP" sz="1174" b="1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</a:p>
          <a:p>
            <a:pPr algn="ctr"/>
            <a:r>
              <a:rPr kumimoji="1" lang="en-US" altLang="ja-JP" sz="1174" b="1" dirty="0">
                <a:latin typeface="Arial" panose="020B0604020202020204" pitchFamily="34" charset="0"/>
                <a:cs typeface="Arial" panose="020B0604020202020204" pitchFamily="34" charset="0"/>
              </a:rPr>
              <a:t>ApoA2-i Index</a:t>
            </a:r>
            <a:endParaRPr kumimoji="1" lang="ja-JP" altLang="en-US" sz="117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6" name="グループ化 105">
            <a:extLst>
              <a:ext uri="{FF2B5EF4-FFF2-40B4-BE49-F238E27FC236}">
                <a16:creationId xmlns:a16="http://schemas.microsoft.com/office/drawing/2014/main" xmlns="" id="{701F16FB-6785-0C5C-D104-467CC1DA05B8}"/>
              </a:ext>
            </a:extLst>
          </p:cNvPr>
          <p:cNvGrpSpPr/>
          <p:nvPr/>
        </p:nvGrpSpPr>
        <p:grpSpPr>
          <a:xfrm>
            <a:off x="1386590" y="5228120"/>
            <a:ext cx="4939838" cy="846346"/>
            <a:chOff x="1339093" y="5242672"/>
            <a:chExt cx="5050335" cy="865277"/>
          </a:xfrm>
        </p:grpSpPr>
        <p:sp>
          <p:nvSpPr>
            <p:cNvPr id="73" name="Rectangle 68">
              <a:extLst>
                <a:ext uri="{FF2B5EF4-FFF2-40B4-BE49-F238E27FC236}">
                  <a16:creationId xmlns:a16="http://schemas.microsoft.com/office/drawing/2014/main" xmlns="" id="{2DBC5BD3-1017-159D-ECB0-8D164F132B7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027477" y="5366720"/>
              <a:ext cx="430213" cy="2770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xmlns="" id="{D4B71DB1-1053-E573-F1FF-CB1506AF23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8752" y="5282986"/>
              <a:ext cx="116360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IA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xmlns="" id="{39147CD1-C412-6B18-55D5-25800CAC9D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8977" y="5282986"/>
              <a:ext cx="116360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IB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xmlns="" id="{2772CD2D-FFA2-2DFF-5AF6-129D71FAA16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2249">
              <a:off x="4396862" y="5306629"/>
              <a:ext cx="149137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IIA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xmlns="" id="{85740B04-72C2-AFC9-1EEF-527E099B85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1964" y="5297274"/>
              <a:ext cx="149137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IIB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79" name="Rectangle 79">
              <a:extLst>
                <a:ext uri="{FF2B5EF4-FFF2-40B4-BE49-F238E27FC236}">
                  <a16:creationId xmlns:a16="http://schemas.microsoft.com/office/drawing/2014/main" xmlns="" id="{4D74F5C6-A426-882E-1698-68278106A5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2976" y="5298861"/>
              <a:ext cx="604740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All </a:t>
              </a:r>
              <a:r>
                <a:rPr lang="ja-JP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Cancer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5" name="Rectangle 70">
              <a:extLst>
                <a:ext uri="{FF2B5EF4-FFF2-40B4-BE49-F238E27FC236}">
                  <a16:creationId xmlns:a16="http://schemas.microsoft.com/office/drawing/2014/main" xmlns="" id="{A2F1AEE3-D9B3-5333-89FA-FB562B38FF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9817" y="5277244"/>
              <a:ext cx="652266" cy="8307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Acute</a:t>
              </a:r>
            </a:p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Benign</a:t>
              </a:r>
            </a:p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Biliary</a:t>
              </a:r>
            </a:p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Obstruction</a:t>
              </a:r>
            </a:p>
            <a:p>
              <a:pPr defTabSz="894435"/>
              <a:endParaRPr lang="en-US" altLang="ja-JP" sz="880" b="1" dirty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defTabSz="894435"/>
              <a:endParaRPr lang="en-US" altLang="ja-JP" sz="880" b="1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xmlns="" id="{EC83E0E6-AC1C-D0CD-57B3-2C30942477A4}"/>
                </a:ext>
              </a:extLst>
            </p:cNvPr>
            <p:cNvGrpSpPr/>
            <p:nvPr/>
          </p:nvGrpSpPr>
          <p:grpSpPr>
            <a:xfrm>
              <a:off x="1339093" y="5242672"/>
              <a:ext cx="1451108" cy="379807"/>
              <a:chOff x="4624951" y="4856517"/>
              <a:chExt cx="1451108" cy="379807"/>
            </a:xfrm>
          </p:grpSpPr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xmlns="" id="{589D720B-073C-9F5C-845F-1E2DD62183B8}"/>
                  </a:ext>
                </a:extLst>
              </p:cNvPr>
              <p:cNvSpPr txBox="1"/>
              <p:nvPr/>
            </p:nvSpPr>
            <p:spPr>
              <a:xfrm>
                <a:off x="4624951" y="4865025"/>
                <a:ext cx="673441" cy="371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8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althy controls</a:t>
                </a:r>
                <a:endParaRPr kumimoji="1" lang="ja-JP" altLang="en-US" sz="88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xmlns="" id="{3A083E20-A1AC-2EFB-D69D-F1F0CC43D1CA}"/>
                  </a:ext>
                </a:extLst>
              </p:cNvPr>
              <p:cNvSpPr txBox="1"/>
              <p:nvPr/>
            </p:nvSpPr>
            <p:spPr>
              <a:xfrm>
                <a:off x="5123977" y="4856517"/>
                <a:ext cx="952082" cy="371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47217"/>
                <a:r>
                  <a:rPr lang="en-US" altLang="ja-JP" sz="88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ronic pancreatitis</a:t>
                </a:r>
                <a:endParaRPr lang="ja-JP" altLang="en-US" sz="88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xmlns="" id="{61DC63FB-FDB8-F5E7-66D2-39C65A16EB79}"/>
                </a:ext>
              </a:extLst>
            </p:cNvPr>
            <p:cNvCxnSpPr/>
            <p:nvPr/>
          </p:nvCxnSpPr>
          <p:spPr>
            <a:xfrm>
              <a:off x="3373932" y="5557212"/>
              <a:ext cx="254042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Rectangle 70">
              <a:extLst>
                <a:ext uri="{FF2B5EF4-FFF2-40B4-BE49-F238E27FC236}">
                  <a16:creationId xmlns:a16="http://schemas.microsoft.com/office/drawing/2014/main" xmlns="" id="{D6C37E80-B059-80F4-E1B5-D8B719F6DA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4393" y="5635024"/>
              <a:ext cx="2405035" cy="2769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Pancreatic cancer</a:t>
              </a:r>
            </a:p>
            <a:p>
              <a:pPr defTabSz="894435"/>
              <a:endParaRPr lang="en-US" altLang="ja-JP" sz="880" b="1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</p:grpSp>
      <p:sp>
        <p:nvSpPr>
          <p:cNvPr id="101" name="タイトル 1">
            <a:extLst>
              <a:ext uri="{FF2B5EF4-FFF2-40B4-BE49-F238E27FC236}">
                <a16:creationId xmlns:a16="http://schemas.microsoft.com/office/drawing/2014/main" xmlns="" id="{0EEAABB3-5D20-552A-0690-A8447AD96492}"/>
              </a:ext>
            </a:extLst>
          </p:cNvPr>
          <p:cNvSpPr txBox="1">
            <a:spLocks/>
          </p:cNvSpPr>
          <p:nvPr/>
        </p:nvSpPr>
        <p:spPr>
          <a:xfrm rot="10800000" flipV="1">
            <a:off x="219124" y="137685"/>
            <a:ext cx="2603520" cy="358936"/>
          </a:xfrm>
          <a:prstGeom prst="rect">
            <a:avLst/>
          </a:prstGeom>
        </p:spPr>
        <p:txBody>
          <a:bodyPr vert="horz" lIns="89548" tIns="44774" rIns="89548" bIns="44774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71595"/>
            <a:r>
              <a:rPr lang="en-US" altLang="ja-JP" sz="1763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6</a:t>
            </a:r>
            <a:endParaRPr lang="ja-JP" altLang="en-US" sz="1763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02" name="タイトル 1">
                <a:extLst>
                  <a:ext uri="{FF2B5EF4-FFF2-40B4-BE49-F238E27FC236}">
                    <a16:creationId xmlns:a16="http://schemas.microsoft.com/office/drawing/2014/main" xmlns="" id="{516EE146-B2B2-FB66-0F6D-2AA072BC2361}"/>
                  </a:ext>
                </a:extLst>
              </p:cNvPr>
              <p:cNvSpPr txBox="1">
                <a:spLocks/>
              </p:cNvSpPr>
              <p:nvPr/>
            </p:nvSpPr>
            <p:spPr>
              <a:xfrm rot="10800000" flipV="1">
                <a:off x="248348" y="6146030"/>
                <a:ext cx="6332978" cy="795793"/>
              </a:xfrm>
              <a:prstGeom prst="rect">
                <a:avLst/>
              </a:prstGeom>
            </p:spPr>
            <p:txBody>
              <a:bodyPr vert="horz" lIns="89548" tIns="44774" rIns="89548" bIns="44774" rtlCol="0" anchor="ctr">
                <a:noAutofit/>
              </a:bodyPr>
              <a:lstStyle>
                <a:lvl1pPr algn="l" defTabSz="6858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33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defTabSz="671595"/>
                <a:r>
                  <a:rPr lang="en-US" altLang="ja-JP" sz="1174" b="1" dirty="0">
                    <a:solidFill>
                      <a:prstClr val="black"/>
                    </a:solidFill>
                    <a:latin typeface="Arial" panose="020B0604020202020204" pitchFamily="34" charset="0"/>
                    <a:ea typeface="游ゴシック Light" panose="020B0300000000000000" pitchFamily="50" charset="-128"/>
                    <a:cs typeface="Arial" panose="020B0604020202020204" pitchFamily="34" charset="0"/>
                  </a:rPr>
                  <a:t>Supplemental Figure 6. </a:t>
                </a:r>
                <a:r>
                  <a:rPr lang="en-US" altLang="ja-JP" sz="1174" dirty="0">
                    <a:solidFill>
                      <a:srgbClr val="000000"/>
                    </a:solidFill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Distribution of apoA2-ATQ/AT [APOA2-i Index; (apoA2</a:t>
                </a:r>
                <a:r>
                  <a:rPr lang="en-US" altLang="ja-JP" sz="1174" baseline="-25000" dirty="0">
                    <a:solidFill>
                      <a:srgbClr val="000000"/>
                    </a:solidFill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ATQ/AT</a:t>
                </a:r>
                <a:r>
                  <a:rPr lang="en-US" altLang="ja-JP" sz="1174" dirty="0">
                    <a:solidFill>
                      <a:srgbClr val="000000"/>
                    </a:solidFill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) =</a:t>
                </a:r>
                <a14:m>
                  <m:oMath xmlns:m="http://schemas.openxmlformats.org/officeDocument/2006/math">
                    <m:rad>
                      <m:radPr>
                        <m:degHide m:val="on"/>
                        <m:ctrlPr>
                          <a:rPr lang="ja-JP" altLang="ja-JP" sz="1174" i="1" kern="100">
                            <a:solidFill>
                              <a:srgbClr val="000000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  <a:cs typeface="Arial" panose="020B0604020202020204" pitchFamily="34" charset="0"/>
                          </a:rPr>
                        </m:ctrlPr>
                      </m:radPr>
                      <m:deg/>
                      <m:e>
                        <m:r>
                          <a:rPr lang="en-US" altLang="ja-JP" sz="1174" kern="100">
                            <a:solidFill>
                              <a:srgbClr val="000000"/>
                            </a:solidFill>
                            <a:latin typeface="Cambria Math" panose="02040503050406030204" pitchFamily="18" charset="0"/>
                            <a:ea typeface="游明朝" panose="02020400000000000000" pitchFamily="18" charset="-128"/>
                            <a:cs typeface="Arial" panose="020B0604020202020204" pitchFamily="34" charset="0"/>
                          </a:rPr>
                          <m:t>(</m:t>
                        </m:r>
                        <m:r>
                          <m:rPr>
                            <m:sty m:val="p"/>
                          </m:rPr>
                          <a:rPr lang="en-US" altLang="ja-JP" sz="1174" kern="100">
                            <a:solidFill>
                              <a:srgbClr val="000000"/>
                            </a:solidFill>
                            <a:latin typeface="Cambria Math" panose="02040503050406030204" pitchFamily="18" charset="0"/>
                            <a:ea typeface="游明朝" panose="02020400000000000000" pitchFamily="18" charset="-128"/>
                            <a:cs typeface="Arial" panose="020B0604020202020204" pitchFamily="34" charset="0"/>
                          </a:rPr>
                          <m:t>apoA</m:t>
                        </m:r>
                        <m:sSub>
                          <m:sSubPr>
                            <m:ctrlPr>
                              <a:rPr lang="ja-JP" altLang="ja-JP" sz="1174" i="1" kern="100">
                                <a:solidFill>
                                  <a:srgbClr val="000000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  <a:cs typeface="Arial" panose="020B0604020202020204" pitchFamily="34" charset="0"/>
                              </a:rPr>
                            </m:ctrlPr>
                          </m:sSubPr>
                          <m:e>
                            <m:r>
                              <a:rPr lang="en-US" altLang="ja-JP" sz="1174" kern="100">
                                <a:solidFill>
                                  <a:srgbClr val="000000"/>
                                </a:solidFill>
                                <a:latin typeface="Cambria Math" panose="02040503050406030204" pitchFamily="18" charset="0"/>
                                <a:ea typeface="游明朝" panose="02020400000000000000" pitchFamily="18" charset="-128"/>
                                <a:cs typeface="Arial" panose="020B0604020202020204" pitchFamily="34" charset="0"/>
                              </a:rPr>
                              <m:t>2</m:t>
                            </m:r>
                          </m:e>
                          <m:sub>
                            <m:r>
                              <m:rPr>
                                <m:sty m:val="p"/>
                              </m:rPr>
                              <a:rPr lang="en-US" altLang="ja-JP" sz="1174" kern="100">
                                <a:solidFill>
                                  <a:srgbClr val="000000"/>
                                </a:solidFill>
                                <a:latin typeface="Cambria Math" panose="02040503050406030204" pitchFamily="18" charset="0"/>
                                <a:ea typeface="游明朝" panose="02020400000000000000" pitchFamily="18" charset="-128"/>
                                <a:cs typeface="Arial" panose="020B0604020202020204" pitchFamily="34" charset="0"/>
                              </a:rPr>
                              <m:t>ATQ</m:t>
                            </m:r>
                          </m:sub>
                        </m:sSub>
                        <m:r>
                          <a:rPr lang="en-US" altLang="ja-JP" sz="1174" i="1" kern="100">
                            <a:solidFill>
                              <a:srgbClr val="000000"/>
                            </a:solidFill>
                            <a:latin typeface="Cambria Math" panose="02040503050406030204" pitchFamily="18" charset="0"/>
                            <a:ea typeface="游明朝" panose="02020400000000000000" pitchFamily="18" charset="-128"/>
                            <a:cs typeface="Arial" panose="020B0604020202020204" pitchFamily="34" charset="0"/>
                          </a:rPr>
                          <m:t>∗</m:t>
                        </m:r>
                        <m:r>
                          <m:rPr>
                            <m:sty m:val="p"/>
                          </m:rPr>
                          <a:rPr lang="en-US" altLang="ja-JP" sz="1174" kern="100">
                            <a:solidFill>
                              <a:srgbClr val="000000"/>
                            </a:solidFill>
                            <a:latin typeface="Cambria Math" panose="02040503050406030204" pitchFamily="18" charset="0"/>
                            <a:ea typeface="游明朝" panose="02020400000000000000" pitchFamily="18" charset="-128"/>
                            <a:cs typeface="Arial" panose="020B0604020202020204" pitchFamily="34" charset="0"/>
                          </a:rPr>
                          <m:t>apoA</m:t>
                        </m:r>
                        <m:sSub>
                          <m:sSubPr>
                            <m:ctrlPr>
                              <a:rPr lang="ja-JP" altLang="ja-JP" sz="1174" i="1" kern="100">
                                <a:solidFill>
                                  <a:srgbClr val="000000"/>
                                </a:solidFill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  <a:cs typeface="Arial" panose="020B0604020202020204" pitchFamily="34" charset="0"/>
                              </a:rPr>
                            </m:ctrlPr>
                          </m:sSubPr>
                          <m:e>
                            <m:r>
                              <a:rPr lang="en-US" altLang="ja-JP" sz="1174" kern="100">
                                <a:solidFill>
                                  <a:srgbClr val="000000"/>
                                </a:solidFill>
                                <a:latin typeface="Cambria Math" panose="02040503050406030204" pitchFamily="18" charset="0"/>
                                <a:ea typeface="游明朝" panose="02020400000000000000" pitchFamily="18" charset="-128"/>
                                <a:cs typeface="Arial" panose="020B0604020202020204" pitchFamily="34" charset="0"/>
                              </a:rPr>
                              <m:t>2</m:t>
                            </m:r>
                          </m:e>
                          <m:sub>
                            <m:r>
                              <m:rPr>
                                <m:sty m:val="p"/>
                              </m:rPr>
                              <a:rPr lang="en-US" altLang="ja-JP" sz="1174" kern="100">
                                <a:solidFill>
                                  <a:srgbClr val="000000"/>
                                </a:solidFill>
                                <a:latin typeface="Cambria Math" panose="02040503050406030204" pitchFamily="18" charset="0"/>
                                <a:ea typeface="游明朝" panose="02020400000000000000" pitchFamily="18" charset="-128"/>
                                <a:cs typeface="Arial" panose="020B0604020202020204" pitchFamily="34" charset="0"/>
                              </a:rPr>
                              <m:t>AT</m:t>
                            </m:r>
                          </m:sub>
                        </m:sSub>
                        <m:r>
                          <a:rPr lang="en-US" altLang="ja-JP" sz="1174" kern="100">
                            <a:solidFill>
                              <a:srgbClr val="000000"/>
                            </a:solidFill>
                            <a:latin typeface="Cambria Math" panose="02040503050406030204" pitchFamily="18" charset="0"/>
                            <a:ea typeface="游明朝" panose="02020400000000000000" pitchFamily="18" charset="-128"/>
                            <a:cs typeface="Arial" panose="020B0604020202020204" pitchFamily="34" charset="0"/>
                          </a:rPr>
                          <m:t>)</m:t>
                        </m:r>
                      </m:e>
                    </m:rad>
                  </m:oMath>
                </a14:m>
                <a:r>
                  <a:rPr lang="en-US" altLang="ja-JP" sz="1174" kern="100" dirty="0">
                    <a:solidFill>
                      <a:srgbClr val="000000"/>
                    </a:solidFill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 ] </a:t>
                </a:r>
                <a:r>
                  <a:rPr lang="en-US" altLang="ja-JP" sz="1174" dirty="0">
                    <a:solidFill>
                      <a:srgbClr val="000000"/>
                    </a:solidFill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in the plasma of healthy controls, chronic pancreatitis, acute benign biliary obstruction and each stage of pancreatic cancer in reference set of NCI EDRN. Black bars: median values. The asterisks indicate significance on the </a:t>
                </a:r>
                <a:r>
                  <a:rPr lang="en-US" altLang="ja-JP" sz="1171" dirty="0">
                    <a:latin typeface="Arial" panose="020B0604020202020204" pitchFamily="34" charset="0"/>
                    <a:cs typeface="Arial" panose="020B0604020202020204" pitchFamily="34" charset="0"/>
                  </a:rPr>
                  <a:t>Wilcoxon rank sum test </a:t>
                </a:r>
                <a:r>
                  <a:rPr lang="en-US" altLang="ja-JP" sz="1174" dirty="0">
                    <a:solidFill>
                      <a:srgbClr val="000000"/>
                    </a:solidFill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compared to healthy controls (* p &lt; 0.05, ** p &lt; 0.01, </a:t>
                </a:r>
                <a:r>
                  <a:rPr lang="ja-JP" altLang="en-US" sz="1174" dirty="0">
                    <a:solidFill>
                      <a:srgbClr val="000000"/>
                    </a:solidFill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***</a:t>
                </a:r>
                <a:r>
                  <a:rPr lang="en-US" altLang="ja-JP" sz="1174" dirty="0">
                    <a:solidFill>
                      <a:srgbClr val="000000"/>
                    </a:solidFill>
                    <a:latin typeface="Arial" panose="020B0604020202020204" pitchFamily="34" charset="0"/>
                    <a:ea typeface="游明朝" panose="02020400000000000000" pitchFamily="18" charset="-128"/>
                    <a:cs typeface="Arial" panose="020B0604020202020204" pitchFamily="34" charset="0"/>
                  </a:rPr>
                  <a:t> p &lt; 0.001).</a:t>
                </a:r>
              </a:p>
              <a:p>
                <a:pPr defTabSz="671595"/>
                <a:endParaRPr lang="en-US" altLang="ja-JP" sz="1174" dirty="0">
                  <a:solidFill>
                    <a:srgbClr val="000000"/>
                  </a:solidFill>
                  <a:highlight>
                    <a:srgbClr val="FFFF00"/>
                  </a:highlight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endParaRPr>
              </a:p>
              <a:p>
                <a:pPr defTabSz="671595"/>
                <a:endParaRPr lang="ja-JP" altLang="ja-JP" sz="1174" kern="100" dirty="0">
                  <a:latin typeface="游明朝" panose="02020400000000000000" pitchFamily="18" charset="-128"/>
                  <a:ea typeface="游明朝" panose="02020400000000000000" pitchFamily="18" charset="-128"/>
                  <a:cs typeface="Arial" panose="020B0604020202020204" pitchFamily="34" charset="0"/>
                </a:endParaRPr>
              </a:p>
              <a:p>
                <a:pPr defTabSz="671595"/>
                <a:endParaRPr lang="ja-JP" altLang="en-US" sz="1174" dirty="0">
                  <a:solidFill>
                    <a:prstClr val="black"/>
                  </a:solidFill>
                  <a:latin typeface="Arial" panose="020B0604020202020204" pitchFamily="34" charset="0"/>
                  <a:ea typeface="游ゴシック Light" panose="020B0300000000000000" pitchFamily="50" charset="-128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02" name="タイトル 1">
                <a:extLst>
                  <a:ext uri="{FF2B5EF4-FFF2-40B4-BE49-F238E27FC236}">
                    <a16:creationId xmlns:a16="http://schemas.microsoft.com/office/drawing/2014/main" id="{516EE146-B2B2-FB66-0F6D-2AA072BC236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0800000" flipV="1">
                <a:off x="248348" y="6146030"/>
                <a:ext cx="6332978" cy="795793"/>
              </a:xfrm>
              <a:prstGeom prst="rect">
                <a:avLst/>
              </a:prstGeom>
              <a:blipFill>
                <a:blip r:embed="rId3"/>
                <a:stretch>
                  <a:fillRect l="-96" t="-41221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xmlns="" id="{18076B4F-1236-4DD1-9AA1-55B8E2D2A808}"/>
              </a:ext>
            </a:extLst>
          </p:cNvPr>
          <p:cNvGrpSpPr/>
          <p:nvPr/>
        </p:nvGrpSpPr>
        <p:grpSpPr>
          <a:xfrm>
            <a:off x="2231768" y="915072"/>
            <a:ext cx="3516322" cy="312288"/>
            <a:chOff x="3826413" y="1624818"/>
            <a:chExt cx="6243651" cy="554505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xmlns="" id="{78E67F94-C5FF-0863-FB11-548365A12268}"/>
                </a:ext>
              </a:extLst>
            </p:cNvPr>
            <p:cNvSpPr txBox="1"/>
            <p:nvPr/>
          </p:nvSpPr>
          <p:spPr>
            <a:xfrm>
              <a:off x="3826413" y="1645920"/>
              <a:ext cx="686533" cy="5334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xmlns="" id="{FE92DC77-DE85-3267-EF48-6A4FBF00871C}"/>
                </a:ext>
              </a:extLst>
            </p:cNvPr>
            <p:cNvSpPr txBox="1"/>
            <p:nvPr/>
          </p:nvSpPr>
          <p:spPr>
            <a:xfrm>
              <a:off x="5610666" y="1643576"/>
              <a:ext cx="686533" cy="5334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xmlns="" id="{2711FA07-E9B0-BB05-6471-3F51BF7284A5}"/>
                </a:ext>
              </a:extLst>
            </p:cNvPr>
            <p:cNvSpPr txBox="1"/>
            <p:nvPr/>
          </p:nvSpPr>
          <p:spPr>
            <a:xfrm>
              <a:off x="6522722" y="1641232"/>
              <a:ext cx="686533" cy="5334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xmlns="" id="{2C2F8630-84A0-9F4D-81B3-66ED51F642FC}"/>
                </a:ext>
              </a:extLst>
            </p:cNvPr>
            <p:cNvSpPr txBox="1"/>
            <p:nvPr/>
          </p:nvSpPr>
          <p:spPr>
            <a:xfrm>
              <a:off x="9333913" y="1645919"/>
              <a:ext cx="736151" cy="533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xmlns="" id="{1E9D4967-3C65-784B-AA02-EA1596756F61}"/>
                </a:ext>
              </a:extLst>
            </p:cNvPr>
            <p:cNvSpPr txBox="1"/>
            <p:nvPr/>
          </p:nvSpPr>
          <p:spPr>
            <a:xfrm>
              <a:off x="4679852" y="1641232"/>
              <a:ext cx="686533" cy="533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xmlns="" id="{6831752B-60EE-3438-16CD-90763B94C73D}"/>
                </a:ext>
              </a:extLst>
            </p:cNvPr>
            <p:cNvSpPr txBox="1"/>
            <p:nvPr/>
          </p:nvSpPr>
          <p:spPr>
            <a:xfrm>
              <a:off x="7448846" y="1638886"/>
              <a:ext cx="566987" cy="533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xmlns="" id="{5073408A-245A-6EF0-BBF4-46F02A9EC3BA}"/>
                </a:ext>
              </a:extLst>
            </p:cNvPr>
            <p:cNvSpPr txBox="1"/>
            <p:nvPr/>
          </p:nvSpPr>
          <p:spPr>
            <a:xfrm>
              <a:off x="8377310" y="1624818"/>
              <a:ext cx="686533" cy="533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046472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5">
            <a:extLst>
              <a:ext uri="{FF2B5EF4-FFF2-40B4-BE49-F238E27FC236}">
                <a16:creationId xmlns:a16="http://schemas.microsoft.com/office/drawing/2014/main" xmlns="" id="{4935F12C-B793-9CCF-D82D-F4A4A15B9FA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935723" y="916803"/>
            <a:ext cx="4890530" cy="4271355"/>
            <a:chOff x="1796" y="496"/>
            <a:chExt cx="3931" cy="3419"/>
          </a:xfrm>
        </p:grpSpPr>
        <p:sp>
          <p:nvSpPr>
            <p:cNvPr id="16" name="Rectangle 6">
              <a:extLst>
                <a:ext uri="{FF2B5EF4-FFF2-40B4-BE49-F238E27FC236}">
                  <a16:creationId xmlns:a16="http://schemas.microsoft.com/office/drawing/2014/main" xmlns="" id="{09B2F7FB-CBF4-55FC-FB1A-2333A76955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8" y="2032"/>
              <a:ext cx="329" cy="32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17" name="Line 7">
              <a:extLst>
                <a:ext uri="{FF2B5EF4-FFF2-40B4-BE49-F238E27FC236}">
                  <a16:creationId xmlns:a16="http://schemas.microsoft.com/office/drawing/2014/main" xmlns="" id="{2010EE40-74BC-60BA-D910-C332F7E397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48" y="2191"/>
              <a:ext cx="329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18" name="Line 8">
              <a:extLst>
                <a:ext uri="{FF2B5EF4-FFF2-40B4-BE49-F238E27FC236}">
                  <a16:creationId xmlns:a16="http://schemas.microsoft.com/office/drawing/2014/main" xmlns="" id="{72C3EFF3-815E-0760-D958-A6665B6A12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11" y="2361"/>
              <a:ext cx="0" cy="463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19" name="Line 9">
              <a:extLst>
                <a:ext uri="{FF2B5EF4-FFF2-40B4-BE49-F238E27FC236}">
                  <a16:creationId xmlns:a16="http://schemas.microsoft.com/office/drawing/2014/main" xmlns="" id="{8DA71820-C892-F258-10D3-6B973B6F5F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1" y="1694"/>
              <a:ext cx="0" cy="338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0" name="Line 10">
              <a:extLst>
                <a:ext uri="{FF2B5EF4-FFF2-40B4-BE49-F238E27FC236}">
                  <a16:creationId xmlns:a16="http://schemas.microsoft.com/office/drawing/2014/main" xmlns="" id="{7B7BF74C-BC89-DEEF-D57D-38125CCF74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0" y="2824"/>
              <a:ext cx="165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1" name="Line 11">
              <a:extLst>
                <a:ext uri="{FF2B5EF4-FFF2-40B4-BE49-F238E27FC236}">
                  <a16:creationId xmlns:a16="http://schemas.microsoft.com/office/drawing/2014/main" xmlns="" id="{743A57A6-3BCB-48A1-3E58-FDAFDFA94A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0" y="1694"/>
              <a:ext cx="165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2" name="Rectangle 12">
              <a:extLst>
                <a:ext uri="{FF2B5EF4-FFF2-40B4-BE49-F238E27FC236}">
                  <a16:creationId xmlns:a16="http://schemas.microsoft.com/office/drawing/2014/main" xmlns="" id="{FBEE58AB-F31A-646C-C577-F2049BB17B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8" y="2032"/>
              <a:ext cx="329" cy="329"/>
            </a:xfrm>
            <a:prstGeom prst="rect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3" name="Oval 13">
              <a:extLst>
                <a:ext uri="{FF2B5EF4-FFF2-40B4-BE49-F238E27FC236}">
                  <a16:creationId xmlns:a16="http://schemas.microsoft.com/office/drawing/2014/main" xmlns="" id="{6DE6DAAF-3B10-174C-7F73-7F9BC97784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9" y="1130"/>
              <a:ext cx="47" cy="4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4" name="Rectangle 14">
              <a:extLst>
                <a:ext uri="{FF2B5EF4-FFF2-40B4-BE49-F238E27FC236}">
                  <a16:creationId xmlns:a16="http://schemas.microsoft.com/office/drawing/2014/main" xmlns="" id="{CE06E9B1-5B98-9D8F-8564-8515206391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9" y="1931"/>
              <a:ext cx="328" cy="37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5" name="Line 15">
              <a:extLst>
                <a:ext uri="{FF2B5EF4-FFF2-40B4-BE49-F238E27FC236}">
                  <a16:creationId xmlns:a16="http://schemas.microsoft.com/office/drawing/2014/main" xmlns="" id="{9AC40819-0F02-5A32-0D4D-0D12754C7F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59" y="2044"/>
              <a:ext cx="328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6" name="Line 16">
              <a:extLst>
                <a:ext uri="{FF2B5EF4-FFF2-40B4-BE49-F238E27FC236}">
                  <a16:creationId xmlns:a16="http://schemas.microsoft.com/office/drawing/2014/main" xmlns="" id="{A0705529-51B6-B17E-2D93-920255A387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23" y="2302"/>
              <a:ext cx="0" cy="42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7" name="Line 17">
              <a:extLst>
                <a:ext uri="{FF2B5EF4-FFF2-40B4-BE49-F238E27FC236}">
                  <a16:creationId xmlns:a16="http://schemas.microsoft.com/office/drawing/2014/main" xmlns="" id="{712F35F7-8CF6-9F4D-2C85-31A01DFC6C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23" y="1444"/>
              <a:ext cx="0" cy="487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8" name="Line 18">
              <a:extLst>
                <a:ext uri="{FF2B5EF4-FFF2-40B4-BE49-F238E27FC236}">
                  <a16:creationId xmlns:a16="http://schemas.microsoft.com/office/drawing/2014/main" xmlns="" id="{7EDA6A93-73EA-DB9A-8020-A32B7285CE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41" y="2722"/>
              <a:ext cx="164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29" name="Line 19">
              <a:extLst>
                <a:ext uri="{FF2B5EF4-FFF2-40B4-BE49-F238E27FC236}">
                  <a16:creationId xmlns:a16="http://schemas.microsoft.com/office/drawing/2014/main" xmlns="" id="{EF141D3F-9761-D448-9674-93CAEB8420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41" y="1444"/>
              <a:ext cx="164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0" name="Rectangle 20">
              <a:extLst>
                <a:ext uri="{FF2B5EF4-FFF2-40B4-BE49-F238E27FC236}">
                  <a16:creationId xmlns:a16="http://schemas.microsoft.com/office/drawing/2014/main" xmlns="" id="{05BFF365-74B9-5B59-C0CA-E976159DFC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9" y="1931"/>
              <a:ext cx="328" cy="371"/>
            </a:xfrm>
            <a:prstGeom prst="rect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1" name="Oval 21">
              <a:extLst>
                <a:ext uri="{FF2B5EF4-FFF2-40B4-BE49-F238E27FC236}">
                  <a16:creationId xmlns:a16="http://schemas.microsoft.com/office/drawing/2014/main" xmlns="" id="{B31D5190-67F6-F7B9-4BC2-DED35D5AF6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1" y="2918"/>
              <a:ext cx="45" cy="4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2" name="Oval 22">
              <a:extLst>
                <a:ext uri="{FF2B5EF4-FFF2-40B4-BE49-F238E27FC236}">
                  <a16:creationId xmlns:a16="http://schemas.microsoft.com/office/drawing/2014/main" xmlns="" id="{178DE246-758D-7EC0-6D36-B1D2E1B7CE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1" y="1298"/>
              <a:ext cx="45" cy="45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3" name="Rectangle 23">
              <a:extLst>
                <a:ext uri="{FF2B5EF4-FFF2-40B4-BE49-F238E27FC236}">
                  <a16:creationId xmlns:a16="http://schemas.microsoft.com/office/drawing/2014/main" xmlns="" id="{341C5AD3-B680-FF53-F52B-A1A54CA0C7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1" y="1606"/>
              <a:ext cx="328" cy="5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4" name="Line 24">
              <a:extLst>
                <a:ext uri="{FF2B5EF4-FFF2-40B4-BE49-F238E27FC236}">
                  <a16:creationId xmlns:a16="http://schemas.microsoft.com/office/drawing/2014/main" xmlns="" id="{6393CEAB-74F0-1EE4-BEA2-7C06E7AF55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" y="1831"/>
              <a:ext cx="328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5" name="Line 25">
              <a:extLst>
                <a:ext uri="{FF2B5EF4-FFF2-40B4-BE49-F238E27FC236}">
                  <a16:creationId xmlns:a16="http://schemas.microsoft.com/office/drawing/2014/main" xmlns="" id="{5A1A2C89-326F-16EF-26B8-623BE767B0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5" y="2118"/>
              <a:ext cx="0" cy="139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6" name="Line 26">
              <a:extLst>
                <a:ext uri="{FF2B5EF4-FFF2-40B4-BE49-F238E27FC236}">
                  <a16:creationId xmlns:a16="http://schemas.microsoft.com/office/drawing/2014/main" xmlns="" id="{43F99363-8909-53A5-5BE7-1A075409C3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5" y="1008"/>
              <a:ext cx="0" cy="598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7" name="Line 27">
              <a:extLst>
                <a:ext uri="{FF2B5EF4-FFF2-40B4-BE49-F238E27FC236}">
                  <a16:creationId xmlns:a16="http://schemas.microsoft.com/office/drawing/2014/main" xmlns="" id="{BA499BA5-78E7-C6F0-BE07-1835018DB9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3" y="2257"/>
              <a:ext cx="164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8" name="Line 28">
              <a:extLst>
                <a:ext uri="{FF2B5EF4-FFF2-40B4-BE49-F238E27FC236}">
                  <a16:creationId xmlns:a16="http://schemas.microsoft.com/office/drawing/2014/main" xmlns="" id="{6BA142A9-EC6C-AC46-F853-0138DC6329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3" y="1008"/>
              <a:ext cx="164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39" name="Rectangle 29">
              <a:extLst>
                <a:ext uri="{FF2B5EF4-FFF2-40B4-BE49-F238E27FC236}">
                  <a16:creationId xmlns:a16="http://schemas.microsoft.com/office/drawing/2014/main" xmlns="" id="{233369FE-5B7E-F53A-06BE-40A6727EC8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1" y="1606"/>
              <a:ext cx="328" cy="512"/>
            </a:xfrm>
            <a:prstGeom prst="rect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0" name="Oval 30">
              <a:extLst>
                <a:ext uri="{FF2B5EF4-FFF2-40B4-BE49-F238E27FC236}">
                  <a16:creationId xmlns:a16="http://schemas.microsoft.com/office/drawing/2014/main" xmlns="" id="{4E7BBBE7-9F5D-0AFF-FC2A-3E42C59553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2" y="3518"/>
              <a:ext cx="45" cy="45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1" name="Oval 31">
              <a:extLst>
                <a:ext uri="{FF2B5EF4-FFF2-40B4-BE49-F238E27FC236}">
                  <a16:creationId xmlns:a16="http://schemas.microsoft.com/office/drawing/2014/main" xmlns="" id="{2486EA9E-8A98-F960-4280-9379025EC9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2" y="641"/>
              <a:ext cx="45" cy="45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2" name="Rectangle 32">
              <a:extLst>
                <a:ext uri="{FF2B5EF4-FFF2-40B4-BE49-F238E27FC236}">
                  <a16:creationId xmlns:a16="http://schemas.microsoft.com/office/drawing/2014/main" xmlns="" id="{0AD48203-DD59-5DA6-67D9-7051A02DAA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0" y="1708"/>
              <a:ext cx="330" cy="840"/>
            </a:xfrm>
            <a:prstGeom prst="rect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3" name="Line 33">
              <a:extLst>
                <a:ext uri="{FF2B5EF4-FFF2-40B4-BE49-F238E27FC236}">
                  <a16:creationId xmlns:a16="http://schemas.microsoft.com/office/drawing/2014/main" xmlns="" id="{8B4B0FAD-89BC-F889-C83A-458430CED0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0" y="1970"/>
              <a:ext cx="330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4" name="Line 34">
              <a:extLst>
                <a:ext uri="{FF2B5EF4-FFF2-40B4-BE49-F238E27FC236}">
                  <a16:creationId xmlns:a16="http://schemas.microsoft.com/office/drawing/2014/main" xmlns="" id="{B9209288-7A24-2AE5-B9FB-0BDB1894D9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46" y="2548"/>
              <a:ext cx="0" cy="843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5" name="Line 35">
              <a:extLst>
                <a:ext uri="{FF2B5EF4-FFF2-40B4-BE49-F238E27FC236}">
                  <a16:creationId xmlns:a16="http://schemas.microsoft.com/office/drawing/2014/main" xmlns="" id="{6FE6FB24-26AF-6372-8089-94FB8CF260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46" y="1313"/>
              <a:ext cx="0" cy="395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6" name="Line 36">
              <a:extLst>
                <a:ext uri="{FF2B5EF4-FFF2-40B4-BE49-F238E27FC236}">
                  <a16:creationId xmlns:a16="http://schemas.microsoft.com/office/drawing/2014/main" xmlns="" id="{EEF44E65-9A06-D0A4-677A-A903B212F4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62" y="3391"/>
              <a:ext cx="166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7" name="Line 37">
              <a:extLst>
                <a:ext uri="{FF2B5EF4-FFF2-40B4-BE49-F238E27FC236}">
                  <a16:creationId xmlns:a16="http://schemas.microsoft.com/office/drawing/2014/main" xmlns="" id="{B1E652B5-25DC-FFBF-D48E-3CE76BBA5D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62" y="1313"/>
              <a:ext cx="166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8" name="Rectangle 38">
              <a:extLst>
                <a:ext uri="{FF2B5EF4-FFF2-40B4-BE49-F238E27FC236}">
                  <a16:creationId xmlns:a16="http://schemas.microsoft.com/office/drawing/2014/main" xmlns="" id="{13262321-F96C-22D1-E0EC-4F414AF928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0" y="1708"/>
              <a:ext cx="330" cy="840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49" name="Rectangle 39">
              <a:extLst>
                <a:ext uri="{FF2B5EF4-FFF2-40B4-BE49-F238E27FC236}">
                  <a16:creationId xmlns:a16="http://schemas.microsoft.com/office/drawing/2014/main" xmlns="" id="{02A7DE89-9E24-ABD3-165F-8C60C3906E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2" y="1202"/>
              <a:ext cx="330" cy="979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0" name="Line 40">
              <a:extLst>
                <a:ext uri="{FF2B5EF4-FFF2-40B4-BE49-F238E27FC236}">
                  <a16:creationId xmlns:a16="http://schemas.microsoft.com/office/drawing/2014/main" xmlns="" id="{AE43CD70-91E0-B87E-E399-3C194F17E7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92" y="1728"/>
              <a:ext cx="330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1" name="Line 41">
              <a:extLst>
                <a:ext uri="{FF2B5EF4-FFF2-40B4-BE49-F238E27FC236}">
                  <a16:creationId xmlns:a16="http://schemas.microsoft.com/office/drawing/2014/main" xmlns="" id="{03C69455-5C2A-9A73-FE54-94BB8922ED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6" y="2181"/>
              <a:ext cx="0" cy="1384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2" name="Line 42">
              <a:extLst>
                <a:ext uri="{FF2B5EF4-FFF2-40B4-BE49-F238E27FC236}">
                  <a16:creationId xmlns:a16="http://schemas.microsoft.com/office/drawing/2014/main" xmlns="" id="{39F4E7DD-18D9-1B51-05B7-A2FCDFF930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56" y="614"/>
              <a:ext cx="0" cy="588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3" name="Line 43">
              <a:extLst>
                <a:ext uri="{FF2B5EF4-FFF2-40B4-BE49-F238E27FC236}">
                  <a16:creationId xmlns:a16="http://schemas.microsoft.com/office/drawing/2014/main" xmlns="" id="{15F0CEE4-3E18-8BA7-60D2-65C84C5962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74" y="3565"/>
              <a:ext cx="166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4" name="Line 44">
              <a:extLst>
                <a:ext uri="{FF2B5EF4-FFF2-40B4-BE49-F238E27FC236}">
                  <a16:creationId xmlns:a16="http://schemas.microsoft.com/office/drawing/2014/main" xmlns="" id="{38A535B9-41B4-321E-033F-9623716536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74" y="614"/>
              <a:ext cx="166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5" name="Rectangle 45">
              <a:extLst>
                <a:ext uri="{FF2B5EF4-FFF2-40B4-BE49-F238E27FC236}">
                  <a16:creationId xmlns:a16="http://schemas.microsoft.com/office/drawing/2014/main" xmlns="" id="{0DBBB346-0F73-70E8-F9A0-CFFDFE54BE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2" y="1202"/>
              <a:ext cx="330" cy="979"/>
            </a:xfrm>
            <a:prstGeom prst="rect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6" name="Rectangle 46">
              <a:extLst>
                <a:ext uri="{FF2B5EF4-FFF2-40B4-BE49-F238E27FC236}">
                  <a16:creationId xmlns:a16="http://schemas.microsoft.com/office/drawing/2014/main" xmlns="" id="{821F7F64-0BB9-D23B-217F-BB457EB0FD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4" y="1122"/>
              <a:ext cx="327" cy="971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7" name="Line 47">
              <a:extLst>
                <a:ext uri="{FF2B5EF4-FFF2-40B4-BE49-F238E27FC236}">
                  <a16:creationId xmlns:a16="http://schemas.microsoft.com/office/drawing/2014/main" xmlns="" id="{6E6470EB-7568-3446-BD52-D8793B96DE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04" y="1837"/>
              <a:ext cx="327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8" name="Line 48">
              <a:extLst>
                <a:ext uri="{FF2B5EF4-FFF2-40B4-BE49-F238E27FC236}">
                  <a16:creationId xmlns:a16="http://schemas.microsoft.com/office/drawing/2014/main" xmlns="" id="{26F710B7-3F39-2716-36FA-1A54CF4191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68" y="2093"/>
              <a:ext cx="0" cy="1028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59" name="Line 49">
              <a:extLst>
                <a:ext uri="{FF2B5EF4-FFF2-40B4-BE49-F238E27FC236}">
                  <a16:creationId xmlns:a16="http://schemas.microsoft.com/office/drawing/2014/main" xmlns="" id="{DB74B700-FC20-4860-610B-93D5C38191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8" y="655"/>
              <a:ext cx="0" cy="467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0" name="Line 50">
              <a:extLst>
                <a:ext uri="{FF2B5EF4-FFF2-40B4-BE49-F238E27FC236}">
                  <a16:creationId xmlns:a16="http://schemas.microsoft.com/office/drawing/2014/main" xmlns="" id="{F9F118D2-5D86-94F2-F1B2-F28FB1838E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6" y="3121"/>
              <a:ext cx="163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1" name="Line 51">
              <a:extLst>
                <a:ext uri="{FF2B5EF4-FFF2-40B4-BE49-F238E27FC236}">
                  <a16:creationId xmlns:a16="http://schemas.microsoft.com/office/drawing/2014/main" xmlns="" id="{82F4CD7A-070C-6965-7C5C-220890E1F6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6" y="655"/>
              <a:ext cx="163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2" name="Rectangle 52">
              <a:extLst>
                <a:ext uri="{FF2B5EF4-FFF2-40B4-BE49-F238E27FC236}">
                  <a16:creationId xmlns:a16="http://schemas.microsoft.com/office/drawing/2014/main" xmlns="" id="{FF7C714A-6E63-3300-ADF5-76E32AD087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4" y="1122"/>
              <a:ext cx="327" cy="971"/>
            </a:xfrm>
            <a:prstGeom prst="rect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3" name="Rectangle 53">
              <a:extLst>
                <a:ext uri="{FF2B5EF4-FFF2-40B4-BE49-F238E27FC236}">
                  <a16:creationId xmlns:a16="http://schemas.microsoft.com/office/drawing/2014/main" xmlns="" id="{9217E286-8A27-FFAE-2B2D-6CF279CED3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5" y="1417"/>
              <a:ext cx="328" cy="59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4" name="Line 54">
              <a:extLst>
                <a:ext uri="{FF2B5EF4-FFF2-40B4-BE49-F238E27FC236}">
                  <a16:creationId xmlns:a16="http://schemas.microsoft.com/office/drawing/2014/main" xmlns="" id="{1FD51BCD-4710-25DA-701C-B4981BD9C2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15" y="1704"/>
              <a:ext cx="328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5" name="Line 55">
              <a:extLst>
                <a:ext uri="{FF2B5EF4-FFF2-40B4-BE49-F238E27FC236}">
                  <a16:creationId xmlns:a16="http://schemas.microsoft.com/office/drawing/2014/main" xmlns="" id="{BC458530-E680-69F4-259B-23A1521C99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79" y="2013"/>
              <a:ext cx="0" cy="709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6" name="Line 56">
              <a:extLst>
                <a:ext uri="{FF2B5EF4-FFF2-40B4-BE49-F238E27FC236}">
                  <a16:creationId xmlns:a16="http://schemas.microsoft.com/office/drawing/2014/main" xmlns="" id="{88C16933-2A68-F318-1EAE-9855E516D0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9" y="938"/>
              <a:ext cx="0" cy="479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7" name="Line 57">
              <a:extLst>
                <a:ext uri="{FF2B5EF4-FFF2-40B4-BE49-F238E27FC236}">
                  <a16:creationId xmlns:a16="http://schemas.microsoft.com/office/drawing/2014/main" xmlns="" id="{840FEBFB-1E51-F340-F0BD-29A9B04888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97" y="2722"/>
              <a:ext cx="164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8" name="Line 58">
              <a:extLst>
                <a:ext uri="{FF2B5EF4-FFF2-40B4-BE49-F238E27FC236}">
                  <a16:creationId xmlns:a16="http://schemas.microsoft.com/office/drawing/2014/main" xmlns="" id="{C055BD09-AAF9-743D-A313-A0AACA96F7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97" y="938"/>
              <a:ext cx="164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69" name="Rectangle 59">
              <a:extLst>
                <a:ext uri="{FF2B5EF4-FFF2-40B4-BE49-F238E27FC236}">
                  <a16:creationId xmlns:a16="http://schemas.microsoft.com/office/drawing/2014/main" xmlns="" id="{7A078847-A67F-C67B-5086-45F132D867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5" y="1417"/>
              <a:ext cx="328" cy="596"/>
            </a:xfrm>
            <a:prstGeom prst="rect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0" name="Oval 60">
              <a:extLst>
                <a:ext uri="{FF2B5EF4-FFF2-40B4-BE49-F238E27FC236}">
                  <a16:creationId xmlns:a16="http://schemas.microsoft.com/office/drawing/2014/main" xmlns="" id="{53E69875-81BE-9422-28E9-C79B39E1B7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57" y="3258"/>
              <a:ext cx="45" cy="45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1" name="Rectangle 61">
              <a:extLst>
                <a:ext uri="{FF2B5EF4-FFF2-40B4-BE49-F238E27FC236}">
                  <a16:creationId xmlns:a16="http://schemas.microsoft.com/office/drawing/2014/main" xmlns="" id="{3DFF57AE-0236-CEF2-A958-A8C833A631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5" y="1313"/>
              <a:ext cx="330" cy="75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2" name="Line 62">
              <a:extLst>
                <a:ext uri="{FF2B5EF4-FFF2-40B4-BE49-F238E27FC236}">
                  <a16:creationId xmlns:a16="http://schemas.microsoft.com/office/drawing/2014/main" xmlns="" id="{A77C3B6E-43AE-0895-8071-9427C61130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5" y="1737"/>
              <a:ext cx="330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3" name="Line 63">
              <a:extLst>
                <a:ext uri="{FF2B5EF4-FFF2-40B4-BE49-F238E27FC236}">
                  <a16:creationId xmlns:a16="http://schemas.microsoft.com/office/drawing/2014/main" xmlns="" id="{98DE91DE-09AC-D3F9-D07F-A7B8C649A2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91" y="2068"/>
              <a:ext cx="0" cy="1053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4" name="Line 64">
              <a:extLst>
                <a:ext uri="{FF2B5EF4-FFF2-40B4-BE49-F238E27FC236}">
                  <a16:creationId xmlns:a16="http://schemas.microsoft.com/office/drawing/2014/main" xmlns="" id="{A8235FA9-476B-FE43-D5A0-EF03B38BDB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91" y="614"/>
              <a:ext cx="0" cy="699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ys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5" name="Line 65">
              <a:extLst>
                <a:ext uri="{FF2B5EF4-FFF2-40B4-BE49-F238E27FC236}">
                  <a16:creationId xmlns:a16="http://schemas.microsoft.com/office/drawing/2014/main" xmlns="" id="{251B0593-DB19-678C-2DB4-5C0304E6E9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7" y="3121"/>
              <a:ext cx="166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6" name="Line 66">
              <a:extLst>
                <a:ext uri="{FF2B5EF4-FFF2-40B4-BE49-F238E27FC236}">
                  <a16:creationId xmlns:a16="http://schemas.microsoft.com/office/drawing/2014/main" xmlns="" id="{AFF5F094-3243-2895-DE5D-F5D8C23B3B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7" y="614"/>
              <a:ext cx="166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7" name="Rectangle 67">
              <a:extLst>
                <a:ext uri="{FF2B5EF4-FFF2-40B4-BE49-F238E27FC236}">
                  <a16:creationId xmlns:a16="http://schemas.microsoft.com/office/drawing/2014/main" xmlns="" id="{C1FB0A89-8664-8A72-5A84-AB4BD6F470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5" y="1313"/>
              <a:ext cx="330" cy="755"/>
            </a:xfrm>
            <a:prstGeom prst="rect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8" name="Oval 68">
              <a:extLst>
                <a:ext uri="{FF2B5EF4-FFF2-40B4-BE49-F238E27FC236}">
                  <a16:creationId xmlns:a16="http://schemas.microsoft.com/office/drawing/2014/main" xmlns="" id="{B6575A4D-0ACA-B41A-75D9-0C8B423E9C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6" y="3543"/>
              <a:ext cx="47" cy="45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79" name="Oval 69">
              <a:extLst>
                <a:ext uri="{FF2B5EF4-FFF2-40B4-BE49-F238E27FC236}">
                  <a16:creationId xmlns:a16="http://schemas.microsoft.com/office/drawing/2014/main" xmlns="" id="{386BE4A5-751A-5EDD-0671-67C7BE09C8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6" y="3434"/>
              <a:ext cx="47" cy="45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0" name="Oval 70">
              <a:extLst>
                <a:ext uri="{FF2B5EF4-FFF2-40B4-BE49-F238E27FC236}">
                  <a16:creationId xmlns:a16="http://schemas.microsoft.com/office/drawing/2014/main" xmlns="" id="{C5F9F800-6CB9-21E9-6A12-824E0351C1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6" y="3258"/>
              <a:ext cx="47" cy="45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1" name="Oval 71">
              <a:extLst>
                <a:ext uri="{FF2B5EF4-FFF2-40B4-BE49-F238E27FC236}">
                  <a16:creationId xmlns:a16="http://schemas.microsoft.com/office/drawing/2014/main" xmlns="" id="{B0C4C30E-51F9-268B-E281-944AE0B386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6" y="3228"/>
              <a:ext cx="47" cy="47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2" name="Oval 72">
              <a:extLst>
                <a:ext uri="{FF2B5EF4-FFF2-40B4-BE49-F238E27FC236}">
                  <a16:creationId xmlns:a16="http://schemas.microsoft.com/office/drawing/2014/main" xmlns="" id="{F665D5A1-0CB5-A03D-00BB-F3ADADBA44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6" y="3369"/>
              <a:ext cx="47" cy="45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3" name="Line 73">
              <a:extLst>
                <a:ext uri="{FF2B5EF4-FFF2-40B4-BE49-F238E27FC236}">
                  <a16:creationId xmlns:a16="http://schemas.microsoft.com/office/drawing/2014/main" xmlns="" id="{6F150308-2642-3808-A32C-4CB8212AFA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1" y="3684"/>
              <a:ext cx="288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4" name="Line 74">
              <a:extLst>
                <a:ext uri="{FF2B5EF4-FFF2-40B4-BE49-F238E27FC236}">
                  <a16:creationId xmlns:a16="http://schemas.microsoft.com/office/drawing/2014/main" xmlns="" id="{0FC639B4-02DB-C316-7788-DEA19DB048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1" y="3684"/>
              <a:ext cx="0" cy="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5" name="Line 75">
              <a:extLst>
                <a:ext uri="{FF2B5EF4-FFF2-40B4-BE49-F238E27FC236}">
                  <a16:creationId xmlns:a16="http://schemas.microsoft.com/office/drawing/2014/main" xmlns="" id="{5181E0D5-18E0-6DC4-09D2-6B4D9522E7D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23" y="3684"/>
              <a:ext cx="0" cy="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6" name="Line 76">
              <a:extLst>
                <a:ext uri="{FF2B5EF4-FFF2-40B4-BE49-F238E27FC236}">
                  <a16:creationId xmlns:a16="http://schemas.microsoft.com/office/drawing/2014/main" xmlns="" id="{1471FC62-E51E-AA53-359B-C0C4E1748C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5" y="3684"/>
              <a:ext cx="0" cy="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7" name="Line 77">
              <a:extLst>
                <a:ext uri="{FF2B5EF4-FFF2-40B4-BE49-F238E27FC236}">
                  <a16:creationId xmlns:a16="http://schemas.microsoft.com/office/drawing/2014/main" xmlns="" id="{C269E4D3-8D5C-0A6D-CC58-8D93E9DD4F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46" y="3684"/>
              <a:ext cx="0" cy="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8" name="Line 78">
              <a:extLst>
                <a:ext uri="{FF2B5EF4-FFF2-40B4-BE49-F238E27FC236}">
                  <a16:creationId xmlns:a16="http://schemas.microsoft.com/office/drawing/2014/main" xmlns="" id="{1D6C1C96-D5D7-BE45-8F1F-A92A816606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56" y="3684"/>
              <a:ext cx="0" cy="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89" name="Line 79">
              <a:extLst>
                <a:ext uri="{FF2B5EF4-FFF2-40B4-BE49-F238E27FC236}">
                  <a16:creationId xmlns:a16="http://schemas.microsoft.com/office/drawing/2014/main" xmlns="" id="{B959612C-B851-E712-EE45-B1537730CD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68" y="3684"/>
              <a:ext cx="0" cy="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90" name="Line 80">
              <a:extLst>
                <a:ext uri="{FF2B5EF4-FFF2-40B4-BE49-F238E27FC236}">
                  <a16:creationId xmlns:a16="http://schemas.microsoft.com/office/drawing/2014/main" xmlns="" id="{4FBD70C9-0007-4FED-9454-531E5A8382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9" y="3684"/>
              <a:ext cx="0" cy="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91" name="Line 81">
              <a:extLst>
                <a:ext uri="{FF2B5EF4-FFF2-40B4-BE49-F238E27FC236}">
                  <a16:creationId xmlns:a16="http://schemas.microsoft.com/office/drawing/2014/main" xmlns="" id="{2D935F89-5178-32AC-1941-1414970158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91" y="3684"/>
              <a:ext cx="0" cy="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92" name="Rectangle 90">
              <a:extLst>
                <a:ext uri="{FF2B5EF4-FFF2-40B4-BE49-F238E27FC236}">
                  <a16:creationId xmlns:a16="http://schemas.microsoft.com/office/drawing/2014/main" xmlns="" id="{5DAD0D74-B808-DD52-6B88-8C67ECC580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6" y="3807"/>
              <a:ext cx="0" cy="1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endParaRPr lang="ja-JP" altLang="ja-JP" sz="880" b="1" dirty="0"/>
            </a:p>
          </p:txBody>
        </p:sp>
        <p:sp>
          <p:nvSpPr>
            <p:cNvPr id="93" name="Rectangle 97">
              <a:extLst>
                <a:ext uri="{FF2B5EF4-FFF2-40B4-BE49-F238E27FC236}">
                  <a16:creationId xmlns:a16="http://schemas.microsoft.com/office/drawing/2014/main" xmlns="" id="{22DD2CD6-9414-16AA-9912-4457F900DA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6" y="496"/>
              <a:ext cx="3551" cy="3188"/>
            </a:xfrm>
            <a:prstGeom prst="rect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 dirty="0"/>
            </a:p>
          </p:txBody>
        </p:sp>
        <p:sp>
          <p:nvSpPr>
            <p:cNvPr id="94" name="Line 98">
              <a:extLst>
                <a:ext uri="{FF2B5EF4-FFF2-40B4-BE49-F238E27FC236}">
                  <a16:creationId xmlns:a16="http://schemas.microsoft.com/office/drawing/2014/main" xmlns="" id="{A37F6B2B-1185-DEA2-CFAA-89AD4FC08C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76" y="1034"/>
              <a:ext cx="0" cy="249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95" name="Line 99">
              <a:extLst>
                <a:ext uri="{FF2B5EF4-FFF2-40B4-BE49-F238E27FC236}">
                  <a16:creationId xmlns:a16="http://schemas.microsoft.com/office/drawing/2014/main" xmlns="" id="{BBED227D-EA5A-D1FD-BF4F-643799A838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4" y="3529"/>
              <a:ext cx="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96" name="Line 100">
              <a:extLst>
                <a:ext uri="{FF2B5EF4-FFF2-40B4-BE49-F238E27FC236}">
                  <a16:creationId xmlns:a16="http://schemas.microsoft.com/office/drawing/2014/main" xmlns="" id="{1A252F18-6D52-6B1B-2B82-E37926B051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4" y="2906"/>
              <a:ext cx="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97" name="Line 101">
              <a:extLst>
                <a:ext uri="{FF2B5EF4-FFF2-40B4-BE49-F238E27FC236}">
                  <a16:creationId xmlns:a16="http://schemas.microsoft.com/office/drawing/2014/main" xmlns="" id="{777ED6F9-F0C1-2300-9470-37126492E8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4" y="2281"/>
              <a:ext cx="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98" name="Line 102">
              <a:extLst>
                <a:ext uri="{FF2B5EF4-FFF2-40B4-BE49-F238E27FC236}">
                  <a16:creationId xmlns:a16="http://schemas.microsoft.com/office/drawing/2014/main" xmlns="" id="{B5C8DBE2-3CCF-8FAB-271E-EED829175D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4" y="1659"/>
              <a:ext cx="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99" name="Line 103">
              <a:extLst>
                <a:ext uri="{FF2B5EF4-FFF2-40B4-BE49-F238E27FC236}">
                  <a16:creationId xmlns:a16="http://schemas.microsoft.com/office/drawing/2014/main" xmlns="" id="{EBECDA91-B527-9360-BAE5-AA4A8D3803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4" y="1034"/>
              <a:ext cx="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89439" tIns="44720" rIns="89439" bIns="44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761"/>
            </a:p>
          </p:txBody>
        </p:sp>
        <p:sp>
          <p:nvSpPr>
            <p:cNvPr id="100" name="Rectangle 104">
              <a:extLst>
                <a:ext uri="{FF2B5EF4-FFF2-40B4-BE49-F238E27FC236}">
                  <a16:creationId xmlns:a16="http://schemas.microsoft.com/office/drawing/2014/main" xmlns="" id="{698BDED2-6686-3C46-9B5C-94428CBAE5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4" y="3461"/>
              <a:ext cx="12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901" b="1" dirty="0">
                  <a:solidFill>
                    <a:srgbClr val="000000"/>
                  </a:solidFill>
                  <a:cs typeface="Arial" panose="020B0604020202020204" pitchFamily="34" charset="0"/>
                </a:rPr>
                <a:t>0.1</a:t>
              </a:r>
              <a:endParaRPr lang="ja-JP" altLang="ja-JP" sz="901" b="1" dirty="0">
                <a:cs typeface="Arial" panose="020B0604020202020204" pitchFamily="34" charset="0"/>
              </a:endParaRPr>
            </a:p>
          </p:txBody>
        </p:sp>
        <p:sp>
          <p:nvSpPr>
            <p:cNvPr id="101" name="Rectangle 105">
              <a:extLst>
                <a:ext uri="{FF2B5EF4-FFF2-40B4-BE49-F238E27FC236}">
                  <a16:creationId xmlns:a16="http://schemas.microsoft.com/office/drawing/2014/main" xmlns="" id="{FFB757F1-9DB4-3C71-DC58-C2D9BD6785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0" y="2833"/>
              <a:ext cx="5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901" b="1" dirty="0">
                  <a:solidFill>
                    <a:srgbClr val="000000"/>
                  </a:solidFill>
                  <a:cs typeface="Arial" panose="020B0604020202020204" pitchFamily="34" charset="0"/>
                </a:rPr>
                <a:t>1</a:t>
              </a:r>
              <a:endParaRPr lang="ja-JP" altLang="ja-JP" sz="901" b="1" dirty="0">
                <a:cs typeface="Arial" panose="020B0604020202020204" pitchFamily="34" charset="0"/>
              </a:endParaRPr>
            </a:p>
          </p:txBody>
        </p:sp>
        <p:sp>
          <p:nvSpPr>
            <p:cNvPr id="102" name="Rectangle 106">
              <a:extLst>
                <a:ext uri="{FF2B5EF4-FFF2-40B4-BE49-F238E27FC236}">
                  <a16:creationId xmlns:a16="http://schemas.microsoft.com/office/drawing/2014/main" xmlns="" id="{15DD6D39-E182-E8FE-A675-845F8DDD65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7" y="2195"/>
              <a:ext cx="12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901" b="1" dirty="0">
                  <a:solidFill>
                    <a:srgbClr val="000000"/>
                  </a:solidFill>
                  <a:cs typeface="Arial" panose="020B0604020202020204" pitchFamily="34" charset="0"/>
                </a:rPr>
                <a:t>7.4</a:t>
              </a:r>
              <a:endParaRPr lang="ja-JP" altLang="ja-JP" sz="901" b="1" dirty="0">
                <a:cs typeface="Arial" panose="020B0604020202020204" pitchFamily="34" charset="0"/>
              </a:endParaRPr>
            </a:p>
          </p:txBody>
        </p:sp>
        <p:sp>
          <p:nvSpPr>
            <p:cNvPr id="103" name="Rectangle 107">
              <a:extLst>
                <a:ext uri="{FF2B5EF4-FFF2-40B4-BE49-F238E27FC236}">
                  <a16:creationId xmlns:a16="http://schemas.microsoft.com/office/drawing/2014/main" xmlns="" id="{5A39BFA2-C834-EE26-1D8F-7690134656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2" y="1576"/>
              <a:ext cx="18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901" b="1" dirty="0">
                  <a:solidFill>
                    <a:srgbClr val="000000"/>
                  </a:solidFill>
                  <a:cs typeface="Arial" panose="020B0604020202020204" pitchFamily="34" charset="0"/>
                </a:rPr>
                <a:t>54.6</a:t>
              </a:r>
              <a:endParaRPr lang="ja-JP" altLang="ja-JP" sz="901" b="1" dirty="0">
                <a:cs typeface="Arial" panose="020B0604020202020204" pitchFamily="34" charset="0"/>
              </a:endParaRPr>
            </a:p>
          </p:txBody>
        </p:sp>
        <p:sp>
          <p:nvSpPr>
            <p:cNvPr id="104" name="Rectangle 108">
              <a:extLst>
                <a:ext uri="{FF2B5EF4-FFF2-40B4-BE49-F238E27FC236}">
                  <a16:creationId xmlns:a16="http://schemas.microsoft.com/office/drawing/2014/main" xmlns="" id="{8915F0C4-BF6C-C2EF-9AEA-4FFF775295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" y="961"/>
              <a:ext cx="23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901" b="1" dirty="0">
                  <a:solidFill>
                    <a:srgbClr val="000000"/>
                  </a:solidFill>
                  <a:cs typeface="Arial" panose="020B0604020202020204" pitchFamily="34" charset="0"/>
                </a:rPr>
                <a:t>403.4</a:t>
              </a:r>
              <a:endParaRPr lang="ja-JP" altLang="ja-JP" sz="901" b="1" dirty="0">
                <a:cs typeface="Arial" panose="020B0604020202020204" pitchFamily="34" charset="0"/>
              </a:endParaRPr>
            </a:p>
          </p:txBody>
        </p:sp>
      </p:grp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EF824043-6438-3FE3-0F3B-790AFA8CE5A3}"/>
              </a:ext>
            </a:extLst>
          </p:cNvPr>
          <p:cNvSpPr txBox="1"/>
          <p:nvPr/>
        </p:nvSpPr>
        <p:spPr>
          <a:xfrm rot="16200000">
            <a:off x="-333280" y="2778121"/>
            <a:ext cx="2191201" cy="2730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47217"/>
            <a:r>
              <a:rPr lang="en-US" altLang="ja-JP" sz="1174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19-9 (U/mL)</a:t>
            </a:r>
            <a:endParaRPr lang="ja-JP" altLang="en-US" sz="1174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タイトル 1">
            <a:extLst>
              <a:ext uri="{FF2B5EF4-FFF2-40B4-BE49-F238E27FC236}">
                <a16:creationId xmlns:a16="http://schemas.microsoft.com/office/drawing/2014/main" xmlns="" id="{DFA0D797-3C62-8F3B-8AF4-7648E8125BF0}"/>
              </a:ext>
            </a:extLst>
          </p:cNvPr>
          <p:cNvSpPr txBox="1">
            <a:spLocks/>
          </p:cNvSpPr>
          <p:nvPr/>
        </p:nvSpPr>
        <p:spPr>
          <a:xfrm rot="10800000" flipV="1">
            <a:off x="219124" y="137685"/>
            <a:ext cx="2603520" cy="358936"/>
          </a:xfrm>
          <a:prstGeom prst="rect">
            <a:avLst/>
          </a:prstGeom>
        </p:spPr>
        <p:txBody>
          <a:bodyPr vert="horz" lIns="89548" tIns="44774" rIns="89548" bIns="44774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defTabSz="671595"/>
            <a:r>
              <a:rPr lang="en-US" altLang="ja-JP" sz="1763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7</a:t>
            </a:r>
            <a:endParaRPr lang="ja-JP" altLang="en-US" sz="1763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6" name="AutoShape 3">
            <a:extLst>
              <a:ext uri="{FF2B5EF4-FFF2-40B4-BE49-F238E27FC236}">
                <a16:creationId xmlns:a16="http://schemas.microsoft.com/office/drawing/2014/main" xmlns="" id="{5780FCB8-19D7-F542-0EA5-449A128239D0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833227" y="469502"/>
            <a:ext cx="5445552" cy="5445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89439" tIns="44720" rIns="89439" bIns="44720" numCol="1" anchor="t" anchorCtr="0" compatLnSpc="1">
            <a:prstTxWarp prst="textNoShape">
              <a:avLst/>
            </a:prstTxWarp>
          </a:bodyPr>
          <a:lstStyle/>
          <a:p>
            <a:endParaRPr lang="ja-JP" altLang="en-US" sz="1761" dirty="0"/>
          </a:p>
        </p:txBody>
      </p: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xmlns="" id="{99597E7D-5257-74DE-7BDF-3F0F9F19810F}"/>
              </a:ext>
            </a:extLst>
          </p:cNvPr>
          <p:cNvGrpSpPr/>
          <p:nvPr/>
        </p:nvGrpSpPr>
        <p:grpSpPr>
          <a:xfrm>
            <a:off x="1363890" y="5083443"/>
            <a:ext cx="4939838" cy="846346"/>
            <a:chOff x="1339093" y="5242672"/>
            <a:chExt cx="5050335" cy="865277"/>
          </a:xfrm>
        </p:grpSpPr>
        <p:sp>
          <p:nvSpPr>
            <p:cNvPr id="109" name="Rectangle 68">
              <a:extLst>
                <a:ext uri="{FF2B5EF4-FFF2-40B4-BE49-F238E27FC236}">
                  <a16:creationId xmlns:a16="http://schemas.microsoft.com/office/drawing/2014/main" xmlns="" id="{104F9F94-8233-92FD-EEF6-0A1093D21F4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027477" y="5366720"/>
              <a:ext cx="430213" cy="2770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110" name="Rectangle 74">
              <a:extLst>
                <a:ext uri="{FF2B5EF4-FFF2-40B4-BE49-F238E27FC236}">
                  <a16:creationId xmlns:a16="http://schemas.microsoft.com/office/drawing/2014/main" xmlns="" id="{B3E69755-468D-D66D-36AB-DDBFD636D9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8752" y="5282986"/>
              <a:ext cx="116360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IA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111" name="Rectangle 75">
              <a:extLst>
                <a:ext uri="{FF2B5EF4-FFF2-40B4-BE49-F238E27FC236}">
                  <a16:creationId xmlns:a16="http://schemas.microsoft.com/office/drawing/2014/main" xmlns="" id="{C743792B-753C-0B27-BB5F-52BE5E74B9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8977" y="5282986"/>
              <a:ext cx="116360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IB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112" name="Rectangle 76">
              <a:extLst>
                <a:ext uri="{FF2B5EF4-FFF2-40B4-BE49-F238E27FC236}">
                  <a16:creationId xmlns:a16="http://schemas.microsoft.com/office/drawing/2014/main" xmlns="" id="{AE6BA048-FE55-E584-FD3F-EE1D753CADE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2249">
              <a:off x="4396862" y="5306629"/>
              <a:ext cx="149137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IIA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113" name="Rectangle 77">
              <a:extLst>
                <a:ext uri="{FF2B5EF4-FFF2-40B4-BE49-F238E27FC236}">
                  <a16:creationId xmlns:a16="http://schemas.microsoft.com/office/drawing/2014/main" xmlns="" id="{A4DCAB78-88DD-F473-1BA7-1DC423620B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1964" y="5297274"/>
              <a:ext cx="149137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IIB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114" name="Rectangle 79">
              <a:extLst>
                <a:ext uri="{FF2B5EF4-FFF2-40B4-BE49-F238E27FC236}">
                  <a16:creationId xmlns:a16="http://schemas.microsoft.com/office/drawing/2014/main" xmlns="" id="{7DF634D0-4C2C-988A-0DD3-58975A3E00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2976" y="5298861"/>
              <a:ext cx="604740" cy="138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ja-JP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All </a:t>
              </a:r>
              <a:r>
                <a:rPr lang="ja-JP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Cancer</a:t>
              </a:r>
              <a:endParaRPr lang="ja-JP" altLang="ja-JP" sz="1761" b="1" dirty="0">
                <a:cs typeface="Arial" panose="020B0604020202020204" pitchFamily="34" charset="0"/>
              </a:endParaRPr>
            </a:p>
          </p:txBody>
        </p:sp>
        <p:sp>
          <p:nvSpPr>
            <p:cNvPr id="115" name="Rectangle 70">
              <a:extLst>
                <a:ext uri="{FF2B5EF4-FFF2-40B4-BE49-F238E27FC236}">
                  <a16:creationId xmlns:a16="http://schemas.microsoft.com/office/drawing/2014/main" xmlns="" id="{8098C22D-2771-62A7-3F67-29E2A7C712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9817" y="5277244"/>
              <a:ext cx="652266" cy="8307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Acute</a:t>
              </a:r>
            </a:p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Benign</a:t>
              </a:r>
            </a:p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Biliary</a:t>
              </a:r>
            </a:p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Obstruction</a:t>
              </a:r>
            </a:p>
            <a:p>
              <a:pPr defTabSz="894435"/>
              <a:endParaRPr lang="en-US" altLang="ja-JP" sz="880" b="1" dirty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defTabSz="894435"/>
              <a:endParaRPr lang="en-US" altLang="ja-JP" sz="880" b="1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  <p:grpSp>
          <p:nvGrpSpPr>
            <p:cNvPr id="116" name="グループ化 115">
              <a:extLst>
                <a:ext uri="{FF2B5EF4-FFF2-40B4-BE49-F238E27FC236}">
                  <a16:creationId xmlns:a16="http://schemas.microsoft.com/office/drawing/2014/main" xmlns="" id="{DFC529E4-8767-1078-406E-4ECFE3EE1A06}"/>
                </a:ext>
              </a:extLst>
            </p:cNvPr>
            <p:cNvGrpSpPr/>
            <p:nvPr/>
          </p:nvGrpSpPr>
          <p:grpSpPr>
            <a:xfrm>
              <a:off x="1339093" y="5242672"/>
              <a:ext cx="1451108" cy="379807"/>
              <a:chOff x="4624951" y="4856517"/>
              <a:chExt cx="1451108" cy="379807"/>
            </a:xfrm>
          </p:grpSpPr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xmlns="" id="{665AFD62-03A9-E9CF-962E-A98574D14779}"/>
                  </a:ext>
                </a:extLst>
              </p:cNvPr>
              <p:cNvSpPr txBox="1"/>
              <p:nvPr/>
            </p:nvSpPr>
            <p:spPr>
              <a:xfrm>
                <a:off x="4624951" y="4865025"/>
                <a:ext cx="673441" cy="3712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8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althy controls</a:t>
                </a:r>
                <a:endParaRPr kumimoji="1" lang="ja-JP" altLang="en-US" sz="88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テキスト ボックス 119">
                <a:extLst>
                  <a:ext uri="{FF2B5EF4-FFF2-40B4-BE49-F238E27FC236}">
                    <a16:creationId xmlns:a16="http://schemas.microsoft.com/office/drawing/2014/main" xmlns="" id="{81537636-FDB3-4892-EBAC-EC681CB69E92}"/>
                  </a:ext>
                </a:extLst>
              </p:cNvPr>
              <p:cNvSpPr txBox="1"/>
              <p:nvPr/>
            </p:nvSpPr>
            <p:spPr>
              <a:xfrm>
                <a:off x="5123977" y="4856517"/>
                <a:ext cx="952082" cy="3713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447217"/>
                <a:r>
                  <a:rPr lang="en-US" altLang="ja-JP" sz="88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ronic pancreatitis</a:t>
                </a:r>
                <a:endParaRPr lang="ja-JP" altLang="en-US" sz="88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17" name="直線コネクタ 116">
              <a:extLst>
                <a:ext uri="{FF2B5EF4-FFF2-40B4-BE49-F238E27FC236}">
                  <a16:creationId xmlns:a16="http://schemas.microsoft.com/office/drawing/2014/main" xmlns="" id="{0EB44CA8-B734-D1DE-1D33-6A56A5F9447E}"/>
                </a:ext>
              </a:extLst>
            </p:cNvPr>
            <p:cNvCxnSpPr/>
            <p:nvPr/>
          </p:nvCxnSpPr>
          <p:spPr>
            <a:xfrm>
              <a:off x="3373932" y="5557212"/>
              <a:ext cx="254042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Rectangle 70">
              <a:extLst>
                <a:ext uri="{FF2B5EF4-FFF2-40B4-BE49-F238E27FC236}">
                  <a16:creationId xmlns:a16="http://schemas.microsoft.com/office/drawing/2014/main" xmlns="" id="{9A510223-11CA-7BA1-8377-433C346177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4393" y="5635024"/>
              <a:ext cx="2405035" cy="2769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894435"/>
              <a:r>
                <a:rPr lang="en-US" altLang="ja-JP" sz="880" b="1" dirty="0">
                  <a:solidFill>
                    <a:srgbClr val="000000"/>
                  </a:solidFill>
                  <a:cs typeface="Arial" panose="020B0604020202020204" pitchFamily="34" charset="0"/>
                </a:rPr>
                <a:t>Pancreatic cancer</a:t>
              </a:r>
            </a:p>
            <a:p>
              <a:pPr defTabSz="894435"/>
              <a:endParaRPr lang="en-US" altLang="ja-JP" sz="880" b="1" dirty="0">
                <a:solidFill>
                  <a:srgbClr val="000000"/>
                </a:solidFill>
                <a:cs typeface="Arial" panose="020B0604020202020204" pitchFamily="34" charset="0"/>
              </a:endParaRPr>
            </a:p>
          </p:txBody>
        </p:sp>
      </p:grp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xmlns="" id="{443DC32B-9150-F7B2-A278-0A71ACCF1125}"/>
              </a:ext>
            </a:extLst>
          </p:cNvPr>
          <p:cNvSpPr txBox="1"/>
          <p:nvPr/>
        </p:nvSpPr>
        <p:spPr>
          <a:xfrm>
            <a:off x="3131417" y="6205361"/>
            <a:ext cx="10422264" cy="4722421"/>
          </a:xfrm>
          <a:prstGeom prst="rect">
            <a:avLst/>
          </a:prstGeom>
        </p:spPr>
        <p:txBody>
          <a:bodyPr vert="horz" wrap="none" lIns="89548" tIns="44774" rIns="89548" bIns="44774" rtlCol="0" anchor="ctr">
            <a:noAutofit/>
          </a:bodyPr>
          <a:lstStyle/>
          <a:p>
            <a:pPr defTabSz="671595"/>
            <a:endParaRPr kumimoji="1" lang="ja-JP" altLang="en-US" sz="1174" b="1" dirty="0">
              <a:solidFill>
                <a:prstClr val="black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xmlns="" id="{10762041-1BD0-AF50-894D-8E3C92A14C30}"/>
              </a:ext>
            </a:extLst>
          </p:cNvPr>
          <p:cNvSpPr txBox="1"/>
          <p:nvPr/>
        </p:nvSpPr>
        <p:spPr>
          <a:xfrm>
            <a:off x="140490" y="5968106"/>
            <a:ext cx="6738945" cy="8150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71595"/>
            <a:r>
              <a:rPr lang="en-US" altLang="ja-JP" sz="1174" b="1" dirty="0">
                <a:solidFill>
                  <a:prstClr val="black"/>
                </a:solidFill>
                <a:latin typeface="Arial" panose="020B0604020202020204" pitchFamily="34" charset="0"/>
                <a:ea typeface="游ゴシック Light" panose="020B0300000000000000" pitchFamily="50" charset="-128"/>
                <a:cs typeface="Arial" panose="020B0604020202020204" pitchFamily="34" charset="0"/>
              </a:rPr>
              <a:t>Supplemental Figure 7. </a:t>
            </a:r>
            <a:r>
              <a:rPr lang="en-US" altLang="ja-JP" sz="1174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stribution CA19-9</a:t>
            </a:r>
            <a:r>
              <a:rPr lang="en-US" altLang="ja-JP" sz="1174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174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 the plasma of healthy controls, chronic pancreatitis, acute benign biliary obstruction and each stage of pancreatic cancer in reference set of NCI EDRN. Black bars: median values. The asterisks indicate significance on the Wilcoxon </a:t>
            </a:r>
            <a:r>
              <a:rPr lang="en-US" altLang="ja-JP" sz="1171" dirty="0">
                <a:latin typeface="Arial" panose="020B0604020202020204" pitchFamily="34" charset="0"/>
                <a:cs typeface="Arial" panose="020B0604020202020204" pitchFamily="34" charset="0"/>
              </a:rPr>
              <a:t>rank sum test </a:t>
            </a:r>
            <a:r>
              <a:rPr lang="en-US" altLang="ja-JP" sz="1174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174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ompared to healthy controls (* p &lt; 0.05, ** p &lt; 0.01, ***, p &lt; 0.001).</a:t>
            </a: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xmlns="" id="{1FC689B5-4E11-D8A4-76A8-0EB0F2941D29}"/>
              </a:ext>
            </a:extLst>
          </p:cNvPr>
          <p:cNvSpPr txBox="1"/>
          <p:nvPr/>
        </p:nvSpPr>
        <p:spPr>
          <a:xfrm>
            <a:off x="136265" y="7041836"/>
            <a:ext cx="3008803" cy="1356914"/>
          </a:xfrm>
          <a:prstGeom prst="rect">
            <a:avLst/>
          </a:prstGeom>
        </p:spPr>
        <p:txBody>
          <a:bodyPr vert="horz" wrap="none" lIns="89548" tIns="44774" rIns="89548" bIns="44774" rtlCol="0" anchor="ctr">
            <a:noAutofit/>
          </a:bodyPr>
          <a:lstStyle/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en-US" altLang="ja-JP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  <a:p>
            <a:pPr defTabSz="671595"/>
            <a:endParaRPr kumimoji="1" lang="ja-JP" altLang="en-US" sz="1565" b="1" dirty="0">
              <a:solidFill>
                <a:srgbClr val="FF0000"/>
              </a:solidFill>
              <a:latin typeface="Arial" panose="020B0604020202020204" pitchFamily="34" charset="0"/>
              <a:ea typeface="游ゴシック Light" panose="020B03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6DF2E6C7-236F-5D55-5ED4-FBF9E111C7B8}"/>
              </a:ext>
            </a:extLst>
          </p:cNvPr>
          <p:cNvGrpSpPr/>
          <p:nvPr/>
        </p:nvGrpSpPr>
        <p:grpSpPr>
          <a:xfrm>
            <a:off x="2192155" y="748696"/>
            <a:ext cx="3472533" cy="312288"/>
            <a:chOff x="3854549" y="1624818"/>
            <a:chExt cx="6165899" cy="554505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xmlns="" id="{3B9F5845-B015-A2B0-EDC0-26CE8CC1CB45}"/>
                </a:ext>
              </a:extLst>
            </p:cNvPr>
            <p:cNvSpPr txBox="1"/>
            <p:nvPr/>
          </p:nvSpPr>
          <p:spPr>
            <a:xfrm>
              <a:off x="3854549" y="1645920"/>
              <a:ext cx="447442" cy="5334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xmlns="" id="{1C74B7E5-D343-573D-5E42-D6FB354FE03E}"/>
                </a:ext>
              </a:extLst>
            </p:cNvPr>
            <p:cNvSpPr txBox="1"/>
            <p:nvPr/>
          </p:nvSpPr>
          <p:spPr>
            <a:xfrm>
              <a:off x="6522722" y="1641232"/>
              <a:ext cx="686533" cy="5334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xmlns="" id="{CB50351A-0CA3-44A2-F233-96C4C2FA7CF6}"/>
                </a:ext>
              </a:extLst>
            </p:cNvPr>
            <p:cNvSpPr txBox="1"/>
            <p:nvPr/>
          </p:nvSpPr>
          <p:spPr>
            <a:xfrm>
              <a:off x="9333915" y="1645919"/>
              <a:ext cx="686533" cy="533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xmlns="" id="{501714BD-406C-8FA6-98EE-A5562EEDD023}"/>
                </a:ext>
              </a:extLst>
            </p:cNvPr>
            <p:cNvSpPr txBox="1"/>
            <p:nvPr/>
          </p:nvSpPr>
          <p:spPr>
            <a:xfrm>
              <a:off x="4679852" y="1641232"/>
              <a:ext cx="686533" cy="533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xmlns="" id="{737E319F-FC29-C664-280E-5099333741C9}"/>
                </a:ext>
              </a:extLst>
            </p:cNvPr>
            <p:cNvSpPr txBox="1"/>
            <p:nvPr/>
          </p:nvSpPr>
          <p:spPr>
            <a:xfrm>
              <a:off x="7603591" y="1638886"/>
              <a:ext cx="447442" cy="533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xmlns="" id="{18098F6E-4193-3F00-9C12-7D007692603C}"/>
                </a:ext>
              </a:extLst>
            </p:cNvPr>
            <p:cNvSpPr txBox="1"/>
            <p:nvPr/>
          </p:nvSpPr>
          <p:spPr>
            <a:xfrm>
              <a:off x="8377310" y="1624818"/>
              <a:ext cx="686533" cy="5334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352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35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1271606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/>
      <a:bodyPr vert="horz" lIns="91551" tIns="45776" rIns="91551" bIns="45776" rtlCol="0" anchor="ctr">
        <a:noAutofit/>
      </a:bodyPr>
      <a:lstStyle>
        <a:defPPr algn="l" defTabSz="686586">
          <a:defRPr sz="1200" b="1" dirty="0">
            <a:solidFill>
              <a:prstClr val="black"/>
            </a:solidFill>
            <a:latin typeface="Arial" panose="020B0604020202020204" pitchFamily="34" charset="0"/>
            <a:ea typeface="游ゴシック Light" panose="020B0300000000000000" pitchFamily="50" charset="-128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236</TotalTime>
  <Words>748</Words>
  <Application>Microsoft Office PowerPoint</Application>
  <PresentationFormat>Custom</PresentationFormat>
  <Paragraphs>286</Paragraphs>
  <Slides>8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10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20" baseType="lpstr">
      <vt:lpstr>Arial Unicode MS</vt:lpstr>
      <vt:lpstr>ＭＳ Ｐゴシック</vt:lpstr>
      <vt:lpstr>游ゴシック</vt:lpstr>
      <vt:lpstr>游ゴシック Light</vt:lpstr>
      <vt:lpstr>Arial</vt:lpstr>
      <vt:lpstr>Calibri</vt:lpstr>
      <vt:lpstr>Calibri Light</vt:lpstr>
      <vt:lpstr>Cambria Math</vt:lpstr>
      <vt:lpstr>Helvetica</vt:lpstr>
      <vt:lpstr>游明朝</vt:lpstr>
      <vt:lpstr>1_Office テーマ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本田一文</dc:creator>
  <cp:lastModifiedBy>Sushmitha N.</cp:lastModifiedBy>
  <cp:revision>44</cp:revision>
  <cp:lastPrinted>2023-01-18T04:50:43Z</cp:lastPrinted>
  <dcterms:created xsi:type="dcterms:W3CDTF">2022-10-26T00:18:08Z</dcterms:created>
  <dcterms:modified xsi:type="dcterms:W3CDTF">2024-01-16T09:24:42Z</dcterms:modified>
</cp:coreProperties>
</file>